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9" r:id="rId3"/>
    <p:sldId id="280" r:id="rId4"/>
    <p:sldId id="281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7E1"/>
    <a:srgbClr val="83F0F5"/>
    <a:srgbClr val="C71728"/>
    <a:srgbClr val="E9618E"/>
    <a:srgbClr val="FF5050"/>
    <a:srgbClr val="FD0000"/>
    <a:srgbClr val="704210"/>
    <a:srgbClr val="E60000"/>
    <a:srgbClr val="D5F1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472" y="52"/>
      </p:cViewPr>
      <p:guideLst>
        <p:guide orient="horz" pos="3397"/>
        <p:guide pos="3766"/>
        <p:guide pos="6335"/>
        <p:guide pos="1277"/>
        <p:guide orient="horz" pos="37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/>
          <p:cNvGrpSpPr/>
          <p:nvPr/>
        </p:nvGrpSpPr>
        <p:grpSpPr>
          <a:xfrm>
            <a:off x="2083273" y="503433"/>
            <a:ext cx="8761881" cy="5294410"/>
            <a:chOff x="2083273" y="503433"/>
            <a:chExt cx="8761881" cy="5294410"/>
          </a:xfrm>
        </p:grpSpPr>
        <p:sp>
          <p:nvSpPr>
            <p:cNvPr id="40" name="矩形 39"/>
            <p:cNvSpPr/>
            <p:nvPr/>
          </p:nvSpPr>
          <p:spPr>
            <a:xfrm>
              <a:off x="2116475" y="503433"/>
              <a:ext cx="8626075" cy="5249530"/>
            </a:xfrm>
            <a:prstGeom prst="rect">
              <a:avLst/>
            </a:prstGeom>
            <a:gradFill flip="none" rotWithShape="1">
              <a:gsLst>
                <a:gs pos="37000">
                  <a:srgbClr val="FFF7E1"/>
                </a:gs>
                <a:gs pos="83000">
                  <a:schemeClr val="accent3">
                    <a:lumMod val="20000"/>
                    <a:lumOff val="80000"/>
                  </a:schemeClr>
                </a:gs>
                <a:gs pos="96000">
                  <a:schemeClr val="accent1">
                    <a:lumMod val="20000"/>
                    <a:lumOff val="80000"/>
                  </a:schemeClr>
                </a:gs>
                <a:gs pos="100000">
                  <a:schemeClr val="accent3">
                    <a:lumMod val="20000"/>
                    <a:lumOff val="80000"/>
                  </a:schemeClr>
                </a:gs>
              </a:gsLst>
              <a:lin ang="54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017484" y="860141"/>
              <a:ext cx="518424" cy="20487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4" name="直接连接符 3"/>
            <p:cNvCxnSpPr/>
            <p:nvPr/>
          </p:nvCxnSpPr>
          <p:spPr>
            <a:xfrm flipH="1">
              <a:off x="8111018" y="2404547"/>
              <a:ext cx="1104869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grpSp>
          <p:nvGrpSpPr>
            <p:cNvPr id="21" name="组合 20"/>
            <p:cNvGrpSpPr/>
            <p:nvPr/>
          </p:nvGrpSpPr>
          <p:grpSpPr>
            <a:xfrm>
              <a:off x="7516700" y="2967184"/>
              <a:ext cx="965267" cy="531352"/>
              <a:chOff x="8301654" y="2428616"/>
              <a:chExt cx="2685143" cy="1422400"/>
            </a:xfrm>
          </p:grpSpPr>
          <p:sp>
            <p:nvSpPr>
              <p:cNvPr id="17" name="立方体 16"/>
              <p:cNvSpPr/>
              <p:nvPr/>
            </p:nvSpPr>
            <p:spPr>
              <a:xfrm>
                <a:off x="8301654" y="2428616"/>
                <a:ext cx="2685143" cy="1422400"/>
              </a:xfrm>
              <a:prstGeom prst="cub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8665575" y="3097906"/>
                <a:ext cx="653144" cy="400115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8541456" y="2938047"/>
                <a:ext cx="1135195" cy="679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>
                    <a:solidFill>
                      <a:srgbClr val="C00000"/>
                    </a:solidFill>
                  </a:rPr>
                  <a:t>KV</a:t>
                </a:r>
                <a:endParaRPr lang="zh-CN" altLang="en-US" sz="1050" b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20" name="椭圆 19"/>
              <p:cNvSpPr/>
              <p:nvPr/>
            </p:nvSpPr>
            <p:spPr>
              <a:xfrm>
                <a:off x="9600498" y="3101102"/>
                <a:ext cx="359999" cy="360001"/>
              </a:xfrm>
              <a:prstGeom prst="ellips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" name="椭圆 21"/>
              <p:cNvSpPr/>
              <p:nvPr/>
            </p:nvSpPr>
            <p:spPr>
              <a:xfrm>
                <a:off x="10144747" y="3097906"/>
                <a:ext cx="359999" cy="360001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cxnSp>
          <p:nvCxnSpPr>
            <p:cNvPr id="24" name="直接连接符 23"/>
            <p:cNvCxnSpPr/>
            <p:nvPr/>
          </p:nvCxnSpPr>
          <p:spPr>
            <a:xfrm>
              <a:off x="7977035" y="3507022"/>
              <a:ext cx="0" cy="1704330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 flipH="1">
              <a:off x="7959458" y="4998323"/>
              <a:ext cx="385218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pic>
          <p:nvPicPr>
            <p:cNvPr id="39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45581" y="565262"/>
              <a:ext cx="1045936" cy="17312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0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3892427">
              <a:off x="2302891" y="823953"/>
              <a:ext cx="1243806" cy="14208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20054" y="1826161"/>
              <a:ext cx="1243806" cy="14208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35" name="TextBox 1034"/>
            <p:cNvSpPr txBox="1"/>
            <p:nvPr/>
          </p:nvSpPr>
          <p:spPr>
            <a:xfrm>
              <a:off x="2387628" y="2296533"/>
              <a:ext cx="127470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LA/BSA</a:t>
              </a:r>
              <a:endParaRPr lang="en-US" altLang="zh-CN" dirty="0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solution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6" name="TextBox 1035"/>
            <p:cNvSpPr txBox="1"/>
            <p:nvPr/>
          </p:nvSpPr>
          <p:spPr>
            <a:xfrm>
              <a:off x="3937560" y="3262461"/>
              <a:ext cx="16209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err="1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HAp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lution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5" name="矩形 1044"/>
            <p:cNvSpPr/>
            <p:nvPr/>
          </p:nvSpPr>
          <p:spPr>
            <a:xfrm>
              <a:off x="5538002" y="2340993"/>
              <a:ext cx="2252325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irred </a:t>
              </a:r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r 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 hours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Picture 2" descr="C:\Users\Administrator\Desktop\立体图纤维.pn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12826" y="4172604"/>
              <a:ext cx="2602915" cy="14641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4702221" y="5217308"/>
              <a:ext cx="13388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culture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任意多边形: 形状 77"/>
            <p:cNvSpPr/>
            <p:nvPr/>
          </p:nvSpPr>
          <p:spPr>
            <a:xfrm rot="6952584">
              <a:off x="4886523" y="1112386"/>
              <a:ext cx="1002414" cy="1097361"/>
            </a:xfrm>
            <a:custGeom>
              <a:avLst/>
              <a:gdLst>
                <a:gd name="connsiteX0" fmla="*/ 0 w 3772698"/>
                <a:gd name="connsiteY0" fmla="*/ 1485900 h 4130041"/>
                <a:gd name="connsiteX1" fmla="*/ 861822 w 3772698"/>
                <a:gd name="connsiteY1" fmla="*/ 0 h 4130041"/>
                <a:gd name="connsiteX2" fmla="*/ 1723644 w 3772698"/>
                <a:gd name="connsiteY2" fmla="*/ 1485900 h 4130041"/>
                <a:gd name="connsiteX3" fmla="*/ 1227062 w 3772698"/>
                <a:gd name="connsiteY3" fmla="*/ 1485900 h 4130041"/>
                <a:gd name="connsiteX4" fmla="*/ 1236927 w 3772698"/>
                <a:gd name="connsiteY4" fmla="*/ 1690770 h 4130041"/>
                <a:gd name="connsiteX5" fmla="*/ 3556058 w 3772698"/>
                <a:gd name="connsiteY5" fmla="*/ 4075605 h 4130041"/>
                <a:gd name="connsiteX6" fmla="*/ 3772698 w 3772698"/>
                <a:gd name="connsiteY6" fmla="*/ 4105955 h 4130041"/>
                <a:gd name="connsiteX7" fmla="*/ 3699512 w 3772698"/>
                <a:gd name="connsiteY7" fmla="*/ 4116207 h 4130041"/>
                <a:gd name="connsiteX8" fmla="*/ 3401064 w 3772698"/>
                <a:gd name="connsiteY8" fmla="*/ 4130041 h 4130041"/>
                <a:gd name="connsiteX9" fmla="*/ 485896 w 3772698"/>
                <a:gd name="connsiteY9" fmla="*/ 1588538 h 4130041"/>
                <a:gd name="connsiteX10" fmla="*/ 483069 w 3772698"/>
                <a:gd name="connsiteY10" fmla="*/ 1485900 h 41300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3772698" h="4130041">
                  <a:moveTo>
                    <a:pt x="0" y="1485900"/>
                  </a:moveTo>
                  <a:lnTo>
                    <a:pt x="861822" y="0"/>
                  </a:lnTo>
                  <a:lnTo>
                    <a:pt x="1723644" y="1485900"/>
                  </a:lnTo>
                  <a:lnTo>
                    <a:pt x="1227062" y="1485900"/>
                  </a:lnTo>
                  <a:lnTo>
                    <a:pt x="1236927" y="1690770"/>
                  </a:lnTo>
                  <a:cubicBezTo>
                    <a:pt x="1351724" y="2877260"/>
                    <a:pt x="2309068" y="3841378"/>
                    <a:pt x="3556058" y="4075605"/>
                  </a:cubicBezTo>
                  <a:lnTo>
                    <a:pt x="3772698" y="4105955"/>
                  </a:lnTo>
                  <a:lnTo>
                    <a:pt x="3699512" y="4116207"/>
                  </a:lnTo>
                  <a:cubicBezTo>
                    <a:pt x="3601385" y="4125355"/>
                    <a:pt x="3501821" y="4130041"/>
                    <a:pt x="3401064" y="4130041"/>
                  </a:cubicBezTo>
                  <a:cubicBezTo>
                    <a:pt x="1839342" y="4130041"/>
                    <a:pt x="564075" y="3004243"/>
                    <a:pt x="485896" y="1588538"/>
                  </a:cubicBezTo>
                  <a:lnTo>
                    <a:pt x="483069" y="1485900"/>
                  </a:lnTo>
                  <a:close/>
                </a:path>
              </a:pathLst>
            </a:custGeom>
            <a:gradFill>
              <a:gsLst>
                <a:gs pos="0">
                  <a:srgbClr val="5E9EFF"/>
                </a:gs>
                <a:gs pos="39999">
                  <a:srgbClr val="85C2FF"/>
                </a:gs>
                <a:gs pos="70000">
                  <a:srgbClr val="C4D6EB"/>
                </a:gs>
                <a:gs pos="100000">
                  <a:srgbClr val="FFEBFA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165100" prst="coolSlant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zh-CN" altLang="en-US"/>
            </a:p>
          </p:txBody>
        </p:sp>
        <p:sp>
          <p:nvSpPr>
            <p:cNvPr id="36" name="任意多边形: 形状 77"/>
            <p:cNvSpPr/>
            <p:nvPr/>
          </p:nvSpPr>
          <p:spPr>
            <a:xfrm rot="6952584">
              <a:off x="7520058" y="1112387"/>
              <a:ext cx="1002414" cy="1097361"/>
            </a:xfrm>
            <a:custGeom>
              <a:avLst/>
              <a:gdLst>
                <a:gd name="connsiteX0" fmla="*/ 0 w 3772698"/>
                <a:gd name="connsiteY0" fmla="*/ 1485900 h 4130041"/>
                <a:gd name="connsiteX1" fmla="*/ 861822 w 3772698"/>
                <a:gd name="connsiteY1" fmla="*/ 0 h 4130041"/>
                <a:gd name="connsiteX2" fmla="*/ 1723644 w 3772698"/>
                <a:gd name="connsiteY2" fmla="*/ 1485900 h 4130041"/>
                <a:gd name="connsiteX3" fmla="*/ 1227062 w 3772698"/>
                <a:gd name="connsiteY3" fmla="*/ 1485900 h 4130041"/>
                <a:gd name="connsiteX4" fmla="*/ 1236927 w 3772698"/>
                <a:gd name="connsiteY4" fmla="*/ 1690770 h 4130041"/>
                <a:gd name="connsiteX5" fmla="*/ 3556058 w 3772698"/>
                <a:gd name="connsiteY5" fmla="*/ 4075605 h 4130041"/>
                <a:gd name="connsiteX6" fmla="*/ 3772698 w 3772698"/>
                <a:gd name="connsiteY6" fmla="*/ 4105955 h 4130041"/>
                <a:gd name="connsiteX7" fmla="*/ 3699512 w 3772698"/>
                <a:gd name="connsiteY7" fmla="*/ 4116207 h 4130041"/>
                <a:gd name="connsiteX8" fmla="*/ 3401064 w 3772698"/>
                <a:gd name="connsiteY8" fmla="*/ 4130041 h 4130041"/>
                <a:gd name="connsiteX9" fmla="*/ 485896 w 3772698"/>
                <a:gd name="connsiteY9" fmla="*/ 1588538 h 4130041"/>
                <a:gd name="connsiteX10" fmla="*/ 483069 w 3772698"/>
                <a:gd name="connsiteY10" fmla="*/ 1485900 h 41300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3772698" h="4130041">
                  <a:moveTo>
                    <a:pt x="0" y="1485900"/>
                  </a:moveTo>
                  <a:lnTo>
                    <a:pt x="861822" y="0"/>
                  </a:lnTo>
                  <a:lnTo>
                    <a:pt x="1723644" y="1485900"/>
                  </a:lnTo>
                  <a:lnTo>
                    <a:pt x="1227062" y="1485900"/>
                  </a:lnTo>
                  <a:lnTo>
                    <a:pt x="1236927" y="1690770"/>
                  </a:lnTo>
                  <a:cubicBezTo>
                    <a:pt x="1351724" y="2877260"/>
                    <a:pt x="2309068" y="3841378"/>
                    <a:pt x="3556058" y="4075605"/>
                  </a:cubicBezTo>
                  <a:lnTo>
                    <a:pt x="3772698" y="4105955"/>
                  </a:lnTo>
                  <a:lnTo>
                    <a:pt x="3699512" y="4116207"/>
                  </a:lnTo>
                  <a:cubicBezTo>
                    <a:pt x="3601385" y="4125355"/>
                    <a:pt x="3501821" y="4130041"/>
                    <a:pt x="3401064" y="4130041"/>
                  </a:cubicBezTo>
                  <a:cubicBezTo>
                    <a:pt x="1839342" y="4130041"/>
                    <a:pt x="564075" y="3004243"/>
                    <a:pt x="485896" y="1588538"/>
                  </a:cubicBezTo>
                  <a:lnTo>
                    <a:pt x="483069" y="1485900"/>
                  </a:lnTo>
                  <a:close/>
                </a:path>
              </a:pathLst>
            </a:custGeom>
            <a:gradFill>
              <a:gsLst>
                <a:gs pos="0">
                  <a:srgbClr val="5E9EFF"/>
                </a:gs>
                <a:gs pos="36000">
                  <a:srgbClr val="85C2FF"/>
                </a:gs>
                <a:gs pos="70000">
                  <a:srgbClr val="C4D6EB"/>
                </a:gs>
                <a:gs pos="100000">
                  <a:srgbClr val="FFEBFA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165100" prst="coolSlant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zh-CN" altLang="en-US"/>
            </a:p>
          </p:txBody>
        </p:sp>
        <p:sp>
          <p:nvSpPr>
            <p:cNvPr id="37" name="任意多边形: 形状 77"/>
            <p:cNvSpPr/>
            <p:nvPr/>
          </p:nvSpPr>
          <p:spPr>
            <a:xfrm rot="14647416" flipH="1">
              <a:off x="6456211" y="4081840"/>
              <a:ext cx="998632" cy="1036899"/>
            </a:xfrm>
            <a:custGeom>
              <a:avLst/>
              <a:gdLst>
                <a:gd name="connsiteX0" fmla="*/ 0 w 3772698"/>
                <a:gd name="connsiteY0" fmla="*/ 1485900 h 4130041"/>
                <a:gd name="connsiteX1" fmla="*/ 861822 w 3772698"/>
                <a:gd name="connsiteY1" fmla="*/ 0 h 4130041"/>
                <a:gd name="connsiteX2" fmla="*/ 1723644 w 3772698"/>
                <a:gd name="connsiteY2" fmla="*/ 1485900 h 4130041"/>
                <a:gd name="connsiteX3" fmla="*/ 1227062 w 3772698"/>
                <a:gd name="connsiteY3" fmla="*/ 1485900 h 4130041"/>
                <a:gd name="connsiteX4" fmla="*/ 1236927 w 3772698"/>
                <a:gd name="connsiteY4" fmla="*/ 1690770 h 4130041"/>
                <a:gd name="connsiteX5" fmla="*/ 3556058 w 3772698"/>
                <a:gd name="connsiteY5" fmla="*/ 4075605 h 4130041"/>
                <a:gd name="connsiteX6" fmla="*/ 3772698 w 3772698"/>
                <a:gd name="connsiteY6" fmla="*/ 4105955 h 4130041"/>
                <a:gd name="connsiteX7" fmla="*/ 3699512 w 3772698"/>
                <a:gd name="connsiteY7" fmla="*/ 4116207 h 4130041"/>
                <a:gd name="connsiteX8" fmla="*/ 3401064 w 3772698"/>
                <a:gd name="connsiteY8" fmla="*/ 4130041 h 4130041"/>
                <a:gd name="connsiteX9" fmla="*/ 485896 w 3772698"/>
                <a:gd name="connsiteY9" fmla="*/ 1588538 h 4130041"/>
                <a:gd name="connsiteX10" fmla="*/ 483069 w 3772698"/>
                <a:gd name="connsiteY10" fmla="*/ 1485900 h 41300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3772698" h="4130041">
                  <a:moveTo>
                    <a:pt x="0" y="1485900"/>
                  </a:moveTo>
                  <a:lnTo>
                    <a:pt x="861822" y="0"/>
                  </a:lnTo>
                  <a:lnTo>
                    <a:pt x="1723644" y="1485900"/>
                  </a:lnTo>
                  <a:lnTo>
                    <a:pt x="1227062" y="1485900"/>
                  </a:lnTo>
                  <a:lnTo>
                    <a:pt x="1236927" y="1690770"/>
                  </a:lnTo>
                  <a:cubicBezTo>
                    <a:pt x="1351724" y="2877260"/>
                    <a:pt x="2309068" y="3841378"/>
                    <a:pt x="3556058" y="4075605"/>
                  </a:cubicBezTo>
                  <a:lnTo>
                    <a:pt x="3772698" y="4105955"/>
                  </a:lnTo>
                  <a:lnTo>
                    <a:pt x="3699512" y="4116207"/>
                  </a:lnTo>
                  <a:cubicBezTo>
                    <a:pt x="3601385" y="4125355"/>
                    <a:pt x="3501821" y="4130041"/>
                    <a:pt x="3401064" y="4130041"/>
                  </a:cubicBezTo>
                  <a:cubicBezTo>
                    <a:pt x="1839342" y="4130041"/>
                    <a:pt x="564075" y="3004243"/>
                    <a:pt x="485896" y="1588538"/>
                  </a:cubicBezTo>
                  <a:lnTo>
                    <a:pt x="483069" y="1485900"/>
                  </a:lnTo>
                  <a:close/>
                </a:path>
              </a:pathLst>
            </a:custGeom>
            <a:gradFill>
              <a:gsLst>
                <a:gs pos="0">
                  <a:srgbClr val="5E9EFF"/>
                </a:gs>
                <a:gs pos="39999">
                  <a:srgbClr val="85C2FF"/>
                </a:gs>
                <a:gs pos="70000">
                  <a:srgbClr val="C4D6EB"/>
                </a:gs>
                <a:gs pos="100000">
                  <a:srgbClr val="FFEBFA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165100" prst="coolSlant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zh-CN" altLang="en-US"/>
            </a:p>
          </p:txBody>
        </p:sp>
        <p:sp>
          <p:nvSpPr>
            <p:cNvPr id="31" name="任意多边形: 形状 77"/>
            <p:cNvSpPr/>
            <p:nvPr/>
          </p:nvSpPr>
          <p:spPr>
            <a:xfrm rot="9379015">
              <a:off x="3657131" y="1012298"/>
              <a:ext cx="871820" cy="954397"/>
            </a:xfrm>
            <a:custGeom>
              <a:avLst/>
              <a:gdLst>
                <a:gd name="connsiteX0" fmla="*/ 0 w 3772698"/>
                <a:gd name="connsiteY0" fmla="*/ 1485900 h 4130041"/>
                <a:gd name="connsiteX1" fmla="*/ 861822 w 3772698"/>
                <a:gd name="connsiteY1" fmla="*/ 0 h 4130041"/>
                <a:gd name="connsiteX2" fmla="*/ 1723644 w 3772698"/>
                <a:gd name="connsiteY2" fmla="*/ 1485900 h 4130041"/>
                <a:gd name="connsiteX3" fmla="*/ 1227062 w 3772698"/>
                <a:gd name="connsiteY3" fmla="*/ 1485900 h 4130041"/>
                <a:gd name="connsiteX4" fmla="*/ 1236927 w 3772698"/>
                <a:gd name="connsiteY4" fmla="*/ 1690770 h 4130041"/>
                <a:gd name="connsiteX5" fmla="*/ 3556058 w 3772698"/>
                <a:gd name="connsiteY5" fmla="*/ 4075605 h 4130041"/>
                <a:gd name="connsiteX6" fmla="*/ 3772698 w 3772698"/>
                <a:gd name="connsiteY6" fmla="*/ 4105955 h 4130041"/>
                <a:gd name="connsiteX7" fmla="*/ 3699512 w 3772698"/>
                <a:gd name="connsiteY7" fmla="*/ 4116207 h 4130041"/>
                <a:gd name="connsiteX8" fmla="*/ 3401064 w 3772698"/>
                <a:gd name="connsiteY8" fmla="*/ 4130041 h 4130041"/>
                <a:gd name="connsiteX9" fmla="*/ 485896 w 3772698"/>
                <a:gd name="connsiteY9" fmla="*/ 1588538 h 4130041"/>
                <a:gd name="connsiteX10" fmla="*/ 483069 w 3772698"/>
                <a:gd name="connsiteY10" fmla="*/ 1485900 h 41300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3772698" h="4130041">
                  <a:moveTo>
                    <a:pt x="0" y="1485900"/>
                  </a:moveTo>
                  <a:lnTo>
                    <a:pt x="861822" y="0"/>
                  </a:lnTo>
                  <a:lnTo>
                    <a:pt x="1723644" y="1485900"/>
                  </a:lnTo>
                  <a:lnTo>
                    <a:pt x="1227062" y="1485900"/>
                  </a:lnTo>
                  <a:lnTo>
                    <a:pt x="1236927" y="1690770"/>
                  </a:lnTo>
                  <a:cubicBezTo>
                    <a:pt x="1351724" y="2877260"/>
                    <a:pt x="2309068" y="3841378"/>
                    <a:pt x="3556058" y="4075605"/>
                  </a:cubicBezTo>
                  <a:lnTo>
                    <a:pt x="3772698" y="4105955"/>
                  </a:lnTo>
                  <a:lnTo>
                    <a:pt x="3699512" y="4116207"/>
                  </a:lnTo>
                  <a:cubicBezTo>
                    <a:pt x="3601385" y="4125355"/>
                    <a:pt x="3501821" y="4130041"/>
                    <a:pt x="3401064" y="4130041"/>
                  </a:cubicBezTo>
                  <a:cubicBezTo>
                    <a:pt x="1839342" y="4130041"/>
                    <a:pt x="564075" y="3004243"/>
                    <a:pt x="485896" y="1588538"/>
                  </a:cubicBezTo>
                  <a:lnTo>
                    <a:pt x="483069" y="1485900"/>
                  </a:lnTo>
                  <a:close/>
                </a:path>
              </a:pathLst>
            </a:custGeom>
            <a:gradFill>
              <a:gsLst>
                <a:gs pos="0">
                  <a:srgbClr val="5E9EFF"/>
                </a:gs>
                <a:gs pos="39999">
                  <a:srgbClr val="85C2FF"/>
                </a:gs>
                <a:gs pos="70000">
                  <a:srgbClr val="C4D6EB"/>
                </a:gs>
                <a:gs pos="100000">
                  <a:srgbClr val="FFEBFA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165100" prst="coolSlant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zh-CN" altLang="en-US"/>
            </a:p>
          </p:txBody>
        </p:sp>
        <p:grpSp>
          <p:nvGrpSpPr>
            <p:cNvPr id="164" name="组合 163"/>
            <p:cNvGrpSpPr/>
            <p:nvPr/>
          </p:nvGrpSpPr>
          <p:grpSpPr>
            <a:xfrm>
              <a:off x="4530482" y="3995818"/>
              <a:ext cx="1680587" cy="1654437"/>
              <a:chOff x="2250630" y="2284847"/>
              <a:chExt cx="1680587" cy="1654437"/>
            </a:xfrm>
          </p:grpSpPr>
          <p:sp>
            <p:nvSpPr>
              <p:cNvPr id="165" name="椭圆 164"/>
              <p:cNvSpPr/>
              <p:nvPr/>
            </p:nvSpPr>
            <p:spPr>
              <a:xfrm>
                <a:off x="2250630" y="2284847"/>
                <a:ext cx="1676264" cy="1596656"/>
              </a:xfrm>
              <a:prstGeom prst="ellipse">
                <a:avLst/>
              </a:prstGeom>
              <a:blipFill>
                <a:blip r:embed="rId5"/>
                <a:stretch>
                  <a:fillRect/>
                </a:stretch>
              </a:blipFill>
              <a:ln>
                <a:noFill/>
              </a:ln>
              <a:scene3d>
                <a:camera prst="isometricOffAxis2Top"/>
                <a:lightRig rig="balanced" dir="t">
                  <a:rot lat="0" lon="0" rev="16200000"/>
                </a:lightRig>
              </a:scene3d>
              <a:sp3d z="-63500" prstMaterial="clear">
                <a:bevelB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66" name="组合 165"/>
              <p:cNvGrpSpPr/>
              <p:nvPr/>
            </p:nvGrpSpPr>
            <p:grpSpPr>
              <a:xfrm rot="1447043">
                <a:off x="2626459" y="3155824"/>
                <a:ext cx="291733" cy="105954"/>
                <a:chOff x="8377112" y="4045382"/>
                <a:chExt cx="1447698" cy="1473194"/>
              </a:xfrm>
            </p:grpSpPr>
            <p:sp>
              <p:nvSpPr>
                <p:cNvPr id="248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9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0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1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2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3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4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5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6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7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8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9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60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61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62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sp>
            <p:nvSpPr>
              <p:cNvPr id="167" name="圆: 空心 30"/>
              <p:cNvSpPr/>
              <p:nvPr/>
            </p:nvSpPr>
            <p:spPr>
              <a:xfrm>
                <a:off x="2254953" y="2285069"/>
                <a:ext cx="1676264" cy="1654215"/>
              </a:xfrm>
              <a:prstGeom prst="donut">
                <a:avLst>
                  <a:gd name="adj" fmla="val 2544"/>
                </a:avLst>
              </a:prstGeom>
              <a:solidFill>
                <a:schemeClr val="accent1">
                  <a:lumMod val="50000"/>
                </a:schemeClr>
              </a:solidFill>
              <a:ln>
                <a:solidFill>
                  <a:schemeClr val="accent1">
                    <a:lumMod val="50000"/>
                  </a:schemeClr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isometricOffAxis2Top"/>
                <a:lightRig rig="balanced" dir="t">
                  <a:rot lat="0" lon="0" rev="16200000"/>
                </a:lightRig>
              </a:scene3d>
              <a:sp3d z="381000" extrusionH="381000" prstMaterial="clear"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68" name="组合 167"/>
              <p:cNvGrpSpPr/>
              <p:nvPr/>
            </p:nvGrpSpPr>
            <p:grpSpPr>
              <a:xfrm rot="3009645">
                <a:off x="3215564" y="3173454"/>
                <a:ext cx="265877" cy="96563"/>
                <a:chOff x="8377112" y="4045382"/>
                <a:chExt cx="1447698" cy="1473194"/>
              </a:xfrm>
            </p:grpSpPr>
            <p:sp>
              <p:nvSpPr>
                <p:cNvPr id="233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4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5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6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7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8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9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0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1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2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3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4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5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6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7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69" name="组合 168"/>
              <p:cNvGrpSpPr/>
              <p:nvPr/>
            </p:nvGrpSpPr>
            <p:grpSpPr>
              <a:xfrm>
                <a:off x="2841476" y="3056178"/>
                <a:ext cx="216416" cy="78600"/>
                <a:chOff x="8377112" y="4045382"/>
                <a:chExt cx="1447698" cy="1473194"/>
              </a:xfrm>
            </p:grpSpPr>
            <p:sp>
              <p:nvSpPr>
                <p:cNvPr id="218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9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0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1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2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3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4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5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6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7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8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9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0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1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2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70" name="组合 169"/>
              <p:cNvGrpSpPr/>
              <p:nvPr/>
            </p:nvGrpSpPr>
            <p:grpSpPr>
              <a:xfrm rot="6565485">
                <a:off x="2977130" y="3201446"/>
                <a:ext cx="245609" cy="89202"/>
                <a:chOff x="8377112" y="4045382"/>
                <a:chExt cx="1447698" cy="1473194"/>
              </a:xfrm>
            </p:grpSpPr>
            <p:sp>
              <p:nvSpPr>
                <p:cNvPr id="203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4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5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6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7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8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9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0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1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2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3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4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5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6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7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71" name="组合 170"/>
              <p:cNvGrpSpPr/>
              <p:nvPr/>
            </p:nvGrpSpPr>
            <p:grpSpPr>
              <a:xfrm rot="478775">
                <a:off x="3069581" y="2956250"/>
                <a:ext cx="312794" cy="113603"/>
                <a:chOff x="8377112" y="4045382"/>
                <a:chExt cx="1447698" cy="1473194"/>
              </a:xfrm>
            </p:grpSpPr>
            <p:sp>
              <p:nvSpPr>
                <p:cNvPr id="188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9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0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1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2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3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4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5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6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7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8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9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0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1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2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72" name="组合 171"/>
              <p:cNvGrpSpPr/>
              <p:nvPr/>
            </p:nvGrpSpPr>
            <p:grpSpPr>
              <a:xfrm rot="6702604">
                <a:off x="3408976" y="3134306"/>
                <a:ext cx="170561" cy="61946"/>
                <a:chOff x="8377112" y="4045382"/>
                <a:chExt cx="1447698" cy="1473194"/>
              </a:xfrm>
            </p:grpSpPr>
            <p:sp>
              <p:nvSpPr>
                <p:cNvPr id="173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4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5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6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7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8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9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0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1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2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3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4" name="Freeform 70"/>
                <p:cNvSpPr/>
                <p:nvPr/>
              </p:nvSpPr>
              <p:spPr bwMode="auto">
                <a:xfrm>
                  <a:off x="8784996" y="4448615"/>
                  <a:ext cx="650874" cy="500547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5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6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7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</p:grpSp>
        <p:cxnSp>
          <p:nvCxnSpPr>
            <p:cNvPr id="141" name="直接连接符 140"/>
            <p:cNvCxnSpPr/>
            <p:nvPr/>
          </p:nvCxnSpPr>
          <p:spPr>
            <a:xfrm>
              <a:off x="8116444" y="2419481"/>
              <a:ext cx="6784" cy="567769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/>
            <p:cNvSpPr txBox="1"/>
            <p:nvPr/>
          </p:nvSpPr>
          <p:spPr>
            <a:xfrm>
              <a:off x="6715211" y="5273524"/>
              <a:ext cx="10312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ound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9749982" y="4056385"/>
              <a:ext cx="10951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lector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6790711" y="3465313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wer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接连接符 151"/>
            <p:cNvCxnSpPr/>
            <p:nvPr/>
          </p:nvCxnSpPr>
          <p:spPr>
            <a:xfrm>
              <a:off x="7753650" y="5213706"/>
              <a:ext cx="432000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sp>
          <p:nvSpPr>
            <p:cNvPr id="45" name="矩形 44"/>
            <p:cNvSpPr/>
            <p:nvPr/>
          </p:nvSpPr>
          <p:spPr>
            <a:xfrm>
              <a:off x="9398938" y="1506227"/>
              <a:ext cx="96693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ringe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任意多边形 46"/>
            <p:cNvSpPr/>
            <p:nvPr/>
          </p:nvSpPr>
          <p:spPr>
            <a:xfrm>
              <a:off x="8672302" y="2891776"/>
              <a:ext cx="1033810" cy="2188395"/>
            </a:xfrm>
            <a:custGeom>
              <a:avLst/>
              <a:gdLst>
                <a:gd name="connsiteX0" fmla="*/ 606465 w 1033810"/>
                <a:gd name="connsiteY0" fmla="*/ 0 h 2188395"/>
                <a:gd name="connsiteX1" fmla="*/ 472901 w 1033810"/>
                <a:gd name="connsiteY1" fmla="*/ 236305 h 2188395"/>
                <a:gd name="connsiteX2" fmla="*/ 688658 w 1033810"/>
                <a:gd name="connsiteY2" fmla="*/ 452062 h 2188395"/>
                <a:gd name="connsiteX3" fmla="*/ 329062 w 1033810"/>
                <a:gd name="connsiteY3" fmla="*/ 688368 h 2188395"/>
                <a:gd name="connsiteX4" fmla="*/ 811948 w 1033810"/>
                <a:gd name="connsiteY4" fmla="*/ 976044 h 2188395"/>
                <a:gd name="connsiteX5" fmla="*/ 164676 w 1033810"/>
                <a:gd name="connsiteY5" fmla="*/ 1150705 h 2188395"/>
                <a:gd name="connsiteX6" fmla="*/ 914689 w 1033810"/>
                <a:gd name="connsiteY6" fmla="*/ 1417833 h 2188395"/>
                <a:gd name="connsiteX7" fmla="*/ 289 w 1033810"/>
                <a:gd name="connsiteY7" fmla="*/ 1623316 h 2188395"/>
                <a:gd name="connsiteX8" fmla="*/ 1027705 w 1033810"/>
                <a:gd name="connsiteY8" fmla="*/ 1859622 h 2188395"/>
                <a:gd name="connsiteX9" fmla="*/ 349611 w 1033810"/>
                <a:gd name="connsiteY9" fmla="*/ 2188395 h 21883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1033810" h="2188395">
                  <a:moveTo>
                    <a:pt x="606465" y="0"/>
                  </a:moveTo>
                  <a:cubicBezTo>
                    <a:pt x="532833" y="80480"/>
                    <a:pt x="459202" y="160961"/>
                    <a:pt x="472901" y="236305"/>
                  </a:cubicBezTo>
                  <a:cubicBezTo>
                    <a:pt x="486600" y="311649"/>
                    <a:pt x="712631" y="376718"/>
                    <a:pt x="688658" y="452062"/>
                  </a:cubicBezTo>
                  <a:cubicBezTo>
                    <a:pt x="664685" y="527406"/>
                    <a:pt x="308514" y="601038"/>
                    <a:pt x="329062" y="688368"/>
                  </a:cubicBezTo>
                  <a:cubicBezTo>
                    <a:pt x="349610" y="775698"/>
                    <a:pt x="839346" y="898988"/>
                    <a:pt x="811948" y="976044"/>
                  </a:cubicBezTo>
                  <a:cubicBezTo>
                    <a:pt x="784550" y="1053100"/>
                    <a:pt x="147552" y="1077074"/>
                    <a:pt x="164676" y="1150705"/>
                  </a:cubicBezTo>
                  <a:cubicBezTo>
                    <a:pt x="181799" y="1224337"/>
                    <a:pt x="942087" y="1339065"/>
                    <a:pt x="914689" y="1417833"/>
                  </a:cubicBezTo>
                  <a:cubicBezTo>
                    <a:pt x="887291" y="1496601"/>
                    <a:pt x="-18547" y="1549685"/>
                    <a:pt x="289" y="1623316"/>
                  </a:cubicBezTo>
                  <a:cubicBezTo>
                    <a:pt x="19125" y="1696947"/>
                    <a:pt x="969485" y="1765442"/>
                    <a:pt x="1027705" y="1859622"/>
                  </a:cubicBezTo>
                  <a:cubicBezTo>
                    <a:pt x="1085925" y="1953802"/>
                    <a:pt x="717768" y="2071098"/>
                    <a:pt x="349611" y="2188395"/>
                  </a:cubicBezTo>
                </a:path>
              </a:pathLst>
            </a:cu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58" name="直接连接符 157"/>
            <p:cNvCxnSpPr/>
            <p:nvPr/>
          </p:nvCxnSpPr>
          <p:spPr>
            <a:xfrm>
              <a:off x="7815458" y="5316448"/>
              <a:ext cx="288000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159" name="直接连接符 158"/>
            <p:cNvCxnSpPr/>
            <p:nvPr/>
          </p:nvCxnSpPr>
          <p:spPr>
            <a:xfrm>
              <a:off x="7877102" y="5429464"/>
              <a:ext cx="144000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sp>
          <p:nvSpPr>
            <p:cNvPr id="160" name="文本框 159"/>
            <p:cNvSpPr txBox="1"/>
            <p:nvPr/>
          </p:nvSpPr>
          <p:spPr>
            <a:xfrm>
              <a:off x="7214539" y="824919"/>
              <a:ext cx="17620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err="1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ectrospinning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1034"/>
            <p:cNvSpPr txBox="1"/>
            <p:nvPr/>
          </p:nvSpPr>
          <p:spPr>
            <a:xfrm>
              <a:off x="8217357" y="5428511"/>
              <a:ext cx="17107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err="1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anofibers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at</a:t>
              </a:r>
              <a:endParaRPr lang="en-US" altLang="zh-CN" dirty="0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直接连接符 161"/>
            <p:cNvCxnSpPr/>
            <p:nvPr/>
          </p:nvCxnSpPr>
          <p:spPr>
            <a:xfrm>
              <a:off x="10433795" y="4397830"/>
              <a:ext cx="129413" cy="357651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grpSp>
          <p:nvGrpSpPr>
            <p:cNvPr id="51" name="组合 50"/>
            <p:cNvGrpSpPr/>
            <p:nvPr/>
          </p:nvGrpSpPr>
          <p:grpSpPr>
            <a:xfrm>
              <a:off x="2317528" y="4175165"/>
              <a:ext cx="1485721" cy="906929"/>
              <a:chOff x="214718" y="3351686"/>
              <a:chExt cx="1485721" cy="906929"/>
            </a:xfrm>
          </p:grpSpPr>
          <p:sp>
            <p:nvSpPr>
              <p:cNvPr id="264" name="Freeform 51"/>
              <p:cNvSpPr/>
              <p:nvPr/>
            </p:nvSpPr>
            <p:spPr bwMode="auto">
              <a:xfrm>
                <a:off x="214718" y="3384295"/>
                <a:ext cx="1485721" cy="874320"/>
              </a:xfrm>
              <a:custGeom>
                <a:avLst/>
                <a:gdLst>
                  <a:gd name="T0" fmla="*/ 3113 w 634"/>
                  <a:gd name="T1" fmla="*/ 0 h 322"/>
                  <a:gd name="T2" fmla="*/ 3470 w 634"/>
                  <a:gd name="T3" fmla="*/ 1386 h 322"/>
                  <a:gd name="T4" fmla="*/ 2675 w 634"/>
                  <a:gd name="T5" fmla="*/ 1740 h 322"/>
                  <a:gd name="T6" fmla="*/ 2020 w 634"/>
                  <a:gd name="T7" fmla="*/ 1100 h 322"/>
                  <a:gd name="T8" fmla="*/ 2050 w 634"/>
                  <a:gd name="T9" fmla="*/ 2363 h 322"/>
                  <a:gd name="T10" fmla="*/ 675 w 634"/>
                  <a:gd name="T11" fmla="*/ 2401 h 322"/>
                  <a:gd name="T12" fmla="*/ 1908 w 634"/>
                  <a:gd name="T13" fmla="*/ 2726 h 322"/>
                  <a:gd name="T14" fmla="*/ 1425 w 634"/>
                  <a:gd name="T15" fmla="*/ 4522 h 322"/>
                  <a:gd name="T16" fmla="*/ 0 w 634"/>
                  <a:gd name="T17" fmla="*/ 5788 h 322"/>
                  <a:gd name="T18" fmla="*/ 2125 w 634"/>
                  <a:gd name="T19" fmla="*/ 4487 h 322"/>
                  <a:gd name="T20" fmla="*/ 2583 w 634"/>
                  <a:gd name="T21" fmla="*/ 6091 h 322"/>
                  <a:gd name="T22" fmla="*/ 3720 w 634"/>
                  <a:gd name="T23" fmla="*/ 4274 h 322"/>
                  <a:gd name="T24" fmla="*/ 6083 w 634"/>
                  <a:gd name="T25" fmla="*/ 4218 h 322"/>
                  <a:gd name="T26" fmla="*/ 7720 w 634"/>
                  <a:gd name="T27" fmla="*/ 3579 h 322"/>
                  <a:gd name="T28" fmla="*/ 8863 w 634"/>
                  <a:gd name="T29" fmla="*/ 5468 h 322"/>
                  <a:gd name="T30" fmla="*/ 9908 w 634"/>
                  <a:gd name="T31" fmla="*/ 3805 h 322"/>
                  <a:gd name="T32" fmla="*/ 8625 w 634"/>
                  <a:gd name="T33" fmla="*/ 3080 h 322"/>
                  <a:gd name="T34" fmla="*/ 9533 w 634"/>
                  <a:gd name="T35" fmla="*/ 661 h 322"/>
                  <a:gd name="T36" fmla="*/ 8595 w 634"/>
                  <a:gd name="T37" fmla="*/ 1386 h 322"/>
                  <a:gd name="T38" fmla="*/ 7908 w 634"/>
                  <a:gd name="T39" fmla="*/ 1966 h 322"/>
                  <a:gd name="T40" fmla="*/ 6113 w 634"/>
                  <a:gd name="T41" fmla="*/ 1740 h 322"/>
                  <a:gd name="T42" fmla="*/ 3988 w 634"/>
                  <a:gd name="T43" fmla="*/ 930 h 322"/>
                  <a:gd name="T44" fmla="*/ 3113 w 634"/>
                  <a:gd name="T45" fmla="*/ 0 h 322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</a:gdLst>
                <a:ahLst/>
                <a:cxnLst>
                  <a:cxn ang="T46">
                    <a:pos x="T0" y="T1"/>
                  </a:cxn>
                  <a:cxn ang="T47">
                    <a:pos x="T2" y="T3"/>
                  </a:cxn>
                  <a:cxn ang="T48">
                    <a:pos x="T4" y="T5"/>
                  </a:cxn>
                  <a:cxn ang="T49">
                    <a:pos x="T6" y="T7"/>
                  </a:cxn>
                  <a:cxn ang="T50">
                    <a:pos x="T8" y="T9"/>
                  </a:cxn>
                  <a:cxn ang="T51">
                    <a:pos x="T10" y="T11"/>
                  </a:cxn>
                  <a:cxn ang="T52">
                    <a:pos x="T12" y="T13"/>
                  </a:cxn>
                  <a:cxn ang="T53">
                    <a:pos x="T14" y="T15"/>
                  </a:cxn>
                  <a:cxn ang="T54">
                    <a:pos x="T16" y="T17"/>
                  </a:cxn>
                  <a:cxn ang="T55">
                    <a:pos x="T18" y="T19"/>
                  </a:cxn>
                  <a:cxn ang="T56">
                    <a:pos x="T20" y="T21"/>
                  </a:cxn>
                  <a:cxn ang="T57">
                    <a:pos x="T22" y="T23"/>
                  </a:cxn>
                  <a:cxn ang="T58">
                    <a:pos x="T24" y="T25"/>
                  </a:cxn>
                  <a:cxn ang="T59">
                    <a:pos x="T26" y="T27"/>
                  </a:cxn>
                  <a:cxn ang="T60">
                    <a:pos x="T28" y="T29"/>
                  </a:cxn>
                  <a:cxn ang="T61">
                    <a:pos x="T30" y="T31"/>
                  </a:cxn>
                  <a:cxn ang="T62">
                    <a:pos x="T32" y="T33"/>
                  </a:cxn>
                  <a:cxn ang="T63">
                    <a:pos x="T34" y="T35"/>
                  </a:cxn>
                  <a:cxn ang="T64">
                    <a:pos x="T36" y="T37"/>
                  </a:cxn>
                  <a:cxn ang="T65">
                    <a:pos x="T38" y="T39"/>
                  </a:cxn>
                  <a:cxn ang="T66">
                    <a:pos x="T40" y="T41"/>
                  </a:cxn>
                  <a:cxn ang="T67">
                    <a:pos x="T42" y="T43"/>
                  </a:cxn>
                  <a:cxn ang="T68">
                    <a:pos x="T44" y="T45"/>
                  </a:cxn>
                </a:cxnLst>
                <a:rect l="0" t="0" r="r" b="b"/>
                <a:pathLst>
                  <a:path w="634" h="322">
                    <a:moveTo>
                      <a:pt x="199" y="0"/>
                    </a:moveTo>
                    <a:cubicBezTo>
                      <a:pt x="212" y="13"/>
                      <a:pt x="239" y="31"/>
                      <a:pt x="222" y="73"/>
                    </a:cubicBezTo>
                    <a:cubicBezTo>
                      <a:pt x="217" y="88"/>
                      <a:pt x="194" y="98"/>
                      <a:pt x="171" y="92"/>
                    </a:cubicBezTo>
                    <a:cubicBezTo>
                      <a:pt x="153" y="87"/>
                      <a:pt x="134" y="68"/>
                      <a:pt x="129" y="58"/>
                    </a:cubicBezTo>
                    <a:cubicBezTo>
                      <a:pt x="140" y="76"/>
                      <a:pt x="168" y="118"/>
                      <a:pt x="131" y="125"/>
                    </a:cubicBezTo>
                    <a:cubicBezTo>
                      <a:pt x="105" y="130"/>
                      <a:pt x="67" y="150"/>
                      <a:pt x="43" y="127"/>
                    </a:cubicBezTo>
                    <a:cubicBezTo>
                      <a:pt x="51" y="159"/>
                      <a:pt x="113" y="133"/>
                      <a:pt x="122" y="144"/>
                    </a:cubicBezTo>
                    <a:cubicBezTo>
                      <a:pt x="153" y="177"/>
                      <a:pt x="118" y="224"/>
                      <a:pt x="91" y="239"/>
                    </a:cubicBezTo>
                    <a:cubicBezTo>
                      <a:pt x="56" y="258"/>
                      <a:pt x="29" y="278"/>
                      <a:pt x="0" y="306"/>
                    </a:cubicBezTo>
                    <a:cubicBezTo>
                      <a:pt x="35" y="276"/>
                      <a:pt x="94" y="259"/>
                      <a:pt x="136" y="237"/>
                    </a:cubicBezTo>
                    <a:cubicBezTo>
                      <a:pt x="194" y="206"/>
                      <a:pt x="164" y="286"/>
                      <a:pt x="165" y="322"/>
                    </a:cubicBezTo>
                    <a:cubicBezTo>
                      <a:pt x="166" y="297"/>
                      <a:pt x="205" y="213"/>
                      <a:pt x="238" y="226"/>
                    </a:cubicBezTo>
                    <a:cubicBezTo>
                      <a:pt x="280" y="241"/>
                      <a:pt x="351" y="234"/>
                      <a:pt x="389" y="223"/>
                    </a:cubicBezTo>
                    <a:cubicBezTo>
                      <a:pt x="427" y="212"/>
                      <a:pt x="464" y="179"/>
                      <a:pt x="494" y="189"/>
                    </a:cubicBezTo>
                    <a:cubicBezTo>
                      <a:pt x="524" y="199"/>
                      <a:pt x="547" y="252"/>
                      <a:pt x="567" y="289"/>
                    </a:cubicBezTo>
                    <a:cubicBezTo>
                      <a:pt x="538" y="197"/>
                      <a:pt x="573" y="197"/>
                      <a:pt x="634" y="201"/>
                    </a:cubicBezTo>
                    <a:cubicBezTo>
                      <a:pt x="602" y="184"/>
                      <a:pt x="573" y="196"/>
                      <a:pt x="552" y="163"/>
                    </a:cubicBezTo>
                    <a:cubicBezTo>
                      <a:pt x="519" y="110"/>
                      <a:pt x="576" y="49"/>
                      <a:pt x="610" y="35"/>
                    </a:cubicBezTo>
                    <a:cubicBezTo>
                      <a:pt x="585" y="43"/>
                      <a:pt x="569" y="56"/>
                      <a:pt x="550" y="73"/>
                    </a:cubicBezTo>
                    <a:cubicBezTo>
                      <a:pt x="536" y="85"/>
                      <a:pt x="524" y="98"/>
                      <a:pt x="506" y="104"/>
                    </a:cubicBezTo>
                    <a:cubicBezTo>
                      <a:pt x="472" y="115"/>
                      <a:pt x="425" y="98"/>
                      <a:pt x="391" y="92"/>
                    </a:cubicBezTo>
                    <a:cubicBezTo>
                      <a:pt x="339" y="82"/>
                      <a:pt x="293" y="86"/>
                      <a:pt x="255" y="49"/>
                    </a:cubicBezTo>
                    <a:cubicBezTo>
                      <a:pt x="237" y="33"/>
                      <a:pt x="233" y="20"/>
                      <a:pt x="199" y="0"/>
                    </a:cubicBezTo>
                    <a:close/>
                  </a:path>
                </a:pathLst>
              </a:custGeom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5" name="Freeform 52"/>
              <p:cNvSpPr/>
              <p:nvPr/>
            </p:nvSpPr>
            <p:spPr bwMode="auto">
              <a:xfrm>
                <a:off x="384380" y="3779118"/>
                <a:ext cx="1183890" cy="319973"/>
              </a:xfrm>
              <a:custGeom>
                <a:avLst/>
                <a:gdLst>
                  <a:gd name="T0" fmla="*/ 0 w 505"/>
                  <a:gd name="T1" fmla="*/ 1996 h 118"/>
                  <a:gd name="T2" fmla="*/ 908 w 505"/>
                  <a:gd name="T3" fmla="*/ 1488 h 118"/>
                  <a:gd name="T4" fmla="*/ 1551 w 505"/>
                  <a:gd name="T5" fmla="*/ 1543 h 118"/>
                  <a:gd name="T6" fmla="*/ 1583 w 505"/>
                  <a:gd name="T7" fmla="*/ 2225 h 118"/>
                  <a:gd name="T8" fmla="*/ 2408 w 505"/>
                  <a:gd name="T9" fmla="*/ 1245 h 118"/>
                  <a:gd name="T10" fmla="*/ 3992 w 505"/>
                  <a:gd name="T11" fmla="*/ 1416 h 118"/>
                  <a:gd name="T12" fmla="*/ 5817 w 505"/>
                  <a:gd name="T13" fmla="*/ 695 h 118"/>
                  <a:gd name="T14" fmla="*/ 6850 w 505"/>
                  <a:gd name="T15" fmla="*/ 772 h 118"/>
                  <a:gd name="T16" fmla="*/ 7493 w 505"/>
                  <a:gd name="T17" fmla="*/ 1974 h 118"/>
                  <a:gd name="T18" fmla="*/ 7901 w 505"/>
                  <a:gd name="T19" fmla="*/ 865 h 118"/>
                  <a:gd name="T20" fmla="*/ 7318 w 505"/>
                  <a:gd name="T21" fmla="*/ 149 h 118"/>
                  <a:gd name="T22" fmla="*/ 7255 w 505"/>
                  <a:gd name="T23" fmla="*/ 865 h 118"/>
                  <a:gd name="T24" fmla="*/ 6525 w 505"/>
                  <a:gd name="T25" fmla="*/ 56 h 118"/>
                  <a:gd name="T26" fmla="*/ 5410 w 505"/>
                  <a:gd name="T27" fmla="*/ 490 h 118"/>
                  <a:gd name="T28" fmla="*/ 3379 w 505"/>
                  <a:gd name="T29" fmla="*/ 1035 h 118"/>
                  <a:gd name="T30" fmla="*/ 1813 w 505"/>
                  <a:gd name="T31" fmla="*/ 1075 h 118"/>
                  <a:gd name="T32" fmla="*/ 895 w 505"/>
                  <a:gd name="T33" fmla="*/ 1283 h 118"/>
                  <a:gd name="T34" fmla="*/ 0 w 505"/>
                  <a:gd name="T35" fmla="*/ 1996 h 11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0" t="0" r="r" b="b"/>
                <a:pathLst>
                  <a:path w="505" h="118">
                    <a:moveTo>
                      <a:pt x="0" y="106"/>
                    </a:moveTo>
                    <a:cubicBezTo>
                      <a:pt x="22" y="98"/>
                      <a:pt x="34" y="90"/>
                      <a:pt x="58" y="79"/>
                    </a:cubicBezTo>
                    <a:cubicBezTo>
                      <a:pt x="82" y="68"/>
                      <a:pt x="93" y="67"/>
                      <a:pt x="99" y="82"/>
                    </a:cubicBezTo>
                    <a:cubicBezTo>
                      <a:pt x="105" y="97"/>
                      <a:pt x="101" y="118"/>
                      <a:pt x="101" y="118"/>
                    </a:cubicBezTo>
                    <a:cubicBezTo>
                      <a:pt x="117" y="74"/>
                      <a:pt x="136" y="68"/>
                      <a:pt x="154" y="66"/>
                    </a:cubicBezTo>
                    <a:cubicBezTo>
                      <a:pt x="172" y="64"/>
                      <a:pt x="197" y="82"/>
                      <a:pt x="255" y="75"/>
                    </a:cubicBezTo>
                    <a:cubicBezTo>
                      <a:pt x="313" y="68"/>
                      <a:pt x="330" y="55"/>
                      <a:pt x="372" y="37"/>
                    </a:cubicBezTo>
                    <a:cubicBezTo>
                      <a:pt x="414" y="19"/>
                      <a:pt x="421" y="23"/>
                      <a:pt x="438" y="41"/>
                    </a:cubicBezTo>
                    <a:cubicBezTo>
                      <a:pt x="455" y="59"/>
                      <a:pt x="476" y="95"/>
                      <a:pt x="479" y="105"/>
                    </a:cubicBezTo>
                    <a:cubicBezTo>
                      <a:pt x="476" y="83"/>
                      <a:pt x="470" y="53"/>
                      <a:pt x="505" y="46"/>
                    </a:cubicBezTo>
                    <a:cubicBezTo>
                      <a:pt x="497" y="45"/>
                      <a:pt x="472" y="28"/>
                      <a:pt x="468" y="8"/>
                    </a:cubicBezTo>
                    <a:cubicBezTo>
                      <a:pt x="472" y="23"/>
                      <a:pt x="474" y="44"/>
                      <a:pt x="464" y="46"/>
                    </a:cubicBezTo>
                    <a:cubicBezTo>
                      <a:pt x="454" y="48"/>
                      <a:pt x="452" y="0"/>
                      <a:pt x="417" y="3"/>
                    </a:cubicBezTo>
                    <a:cubicBezTo>
                      <a:pt x="382" y="6"/>
                      <a:pt x="370" y="12"/>
                      <a:pt x="346" y="26"/>
                    </a:cubicBezTo>
                    <a:cubicBezTo>
                      <a:pt x="322" y="40"/>
                      <a:pt x="281" y="65"/>
                      <a:pt x="216" y="55"/>
                    </a:cubicBezTo>
                    <a:cubicBezTo>
                      <a:pt x="151" y="45"/>
                      <a:pt x="135" y="45"/>
                      <a:pt x="116" y="57"/>
                    </a:cubicBezTo>
                    <a:cubicBezTo>
                      <a:pt x="97" y="69"/>
                      <a:pt x="83" y="51"/>
                      <a:pt x="57" y="68"/>
                    </a:cubicBezTo>
                    <a:cubicBezTo>
                      <a:pt x="31" y="85"/>
                      <a:pt x="0" y="106"/>
                      <a:pt x="0" y="106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6" name="Freeform 53"/>
              <p:cNvSpPr/>
              <p:nvPr/>
            </p:nvSpPr>
            <p:spPr bwMode="auto">
              <a:xfrm>
                <a:off x="821192" y="3785789"/>
                <a:ext cx="403066" cy="185462"/>
              </a:xfrm>
              <a:custGeom>
                <a:avLst/>
                <a:gdLst>
                  <a:gd name="T0" fmla="*/ 0 w 172"/>
                  <a:gd name="T1" fmla="*/ 444 h 68"/>
                  <a:gd name="T2" fmla="*/ 1188 w 172"/>
                  <a:gd name="T3" fmla="*/ 1226 h 68"/>
                  <a:gd name="T4" fmla="*/ 2458 w 172"/>
                  <a:gd name="T5" fmla="*/ 731 h 68"/>
                  <a:gd name="T6" fmla="*/ 2408 w 172"/>
                  <a:gd name="T7" fmla="*/ 0 h 68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172" h="68">
                    <a:moveTo>
                      <a:pt x="0" y="23"/>
                    </a:moveTo>
                    <a:cubicBezTo>
                      <a:pt x="2" y="57"/>
                      <a:pt x="29" y="68"/>
                      <a:pt x="76" y="64"/>
                    </a:cubicBezTo>
                    <a:cubicBezTo>
                      <a:pt x="123" y="60"/>
                      <a:pt x="157" y="38"/>
                      <a:pt x="157" y="38"/>
                    </a:cubicBezTo>
                    <a:cubicBezTo>
                      <a:pt x="157" y="38"/>
                      <a:pt x="172" y="2"/>
                      <a:pt x="154" y="0"/>
                    </a:cubicBezTo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7" name="Freeform 54"/>
              <p:cNvSpPr/>
              <p:nvPr/>
            </p:nvSpPr>
            <p:spPr bwMode="auto">
              <a:xfrm>
                <a:off x="880246" y="3848968"/>
                <a:ext cx="304643" cy="143682"/>
              </a:xfrm>
              <a:custGeom>
                <a:avLst/>
                <a:gdLst>
                  <a:gd name="T0" fmla="*/ 0 w 130"/>
                  <a:gd name="T1" fmla="*/ 431 h 53"/>
                  <a:gd name="T2" fmla="*/ 2033 w 130"/>
                  <a:gd name="T3" fmla="*/ 0 h 5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30" h="53">
                    <a:moveTo>
                      <a:pt x="0" y="23"/>
                    </a:moveTo>
                    <a:cubicBezTo>
                      <a:pt x="29" y="36"/>
                      <a:pt x="116" y="53"/>
                      <a:pt x="130" y="0"/>
                    </a:cubicBezTo>
                  </a:path>
                </a:pathLst>
              </a:custGeom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8" name="Freeform 55"/>
              <p:cNvSpPr/>
              <p:nvPr/>
            </p:nvSpPr>
            <p:spPr bwMode="auto">
              <a:xfrm>
                <a:off x="791196" y="3702229"/>
                <a:ext cx="403066" cy="228261"/>
              </a:xfrm>
              <a:custGeom>
                <a:avLst/>
                <a:gdLst>
                  <a:gd name="T0" fmla="*/ 188 w 172"/>
                  <a:gd name="T1" fmla="*/ 605 h 84"/>
                  <a:gd name="T2" fmla="*/ 1533 w 172"/>
                  <a:gd name="T3" fmla="*/ 1515 h 84"/>
                  <a:gd name="T4" fmla="*/ 2658 w 172"/>
                  <a:gd name="T5" fmla="*/ 683 h 84"/>
                  <a:gd name="T6" fmla="*/ 1438 w 172"/>
                  <a:gd name="T7" fmla="*/ 227 h 84"/>
                  <a:gd name="T8" fmla="*/ 188 w 172"/>
                  <a:gd name="T9" fmla="*/ 605 h 8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2" h="84">
                    <a:moveTo>
                      <a:pt x="12" y="32"/>
                    </a:moveTo>
                    <a:cubicBezTo>
                      <a:pt x="0" y="82"/>
                      <a:pt x="58" y="84"/>
                      <a:pt x="98" y="80"/>
                    </a:cubicBezTo>
                    <a:cubicBezTo>
                      <a:pt x="138" y="76"/>
                      <a:pt x="172" y="64"/>
                      <a:pt x="170" y="36"/>
                    </a:cubicBezTo>
                    <a:cubicBezTo>
                      <a:pt x="168" y="8"/>
                      <a:pt x="126" y="20"/>
                      <a:pt x="92" y="12"/>
                    </a:cubicBezTo>
                    <a:cubicBezTo>
                      <a:pt x="58" y="4"/>
                      <a:pt x="22" y="0"/>
                      <a:pt x="12" y="32"/>
                    </a:cubicBezTo>
                    <a:close/>
                  </a:path>
                </a:pathLst>
              </a:custGeom>
              <a:solidFill>
                <a:srgbClr val="8019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9" name="Freeform 56"/>
              <p:cNvSpPr/>
              <p:nvPr/>
            </p:nvSpPr>
            <p:spPr bwMode="auto">
              <a:xfrm>
                <a:off x="519361" y="3531034"/>
                <a:ext cx="703023" cy="377038"/>
              </a:xfrm>
              <a:custGeom>
                <a:avLst/>
                <a:gdLst>
                  <a:gd name="T0" fmla="*/ 113 w 300"/>
                  <a:gd name="T1" fmla="*/ 2622 h 139"/>
                  <a:gd name="T2" fmla="*/ 63 w 300"/>
                  <a:gd name="T3" fmla="*/ 1680 h 139"/>
                  <a:gd name="T4" fmla="*/ 270 w 300"/>
                  <a:gd name="T5" fmla="*/ 1360 h 139"/>
                  <a:gd name="T6" fmla="*/ 520 w 300"/>
                  <a:gd name="T7" fmla="*/ 921 h 139"/>
                  <a:gd name="T8" fmla="*/ 1238 w 300"/>
                  <a:gd name="T9" fmla="*/ 751 h 139"/>
                  <a:gd name="T10" fmla="*/ 1645 w 300"/>
                  <a:gd name="T11" fmla="*/ 170 h 139"/>
                  <a:gd name="T12" fmla="*/ 2363 w 300"/>
                  <a:gd name="T13" fmla="*/ 418 h 139"/>
                  <a:gd name="T14" fmla="*/ 3708 w 300"/>
                  <a:gd name="T15" fmla="*/ 737 h 139"/>
                  <a:gd name="T16" fmla="*/ 4688 w 300"/>
                  <a:gd name="T17" fmla="*/ 998 h 139"/>
                  <a:gd name="T18" fmla="*/ 3458 w 300"/>
                  <a:gd name="T19" fmla="*/ 886 h 139"/>
                  <a:gd name="T20" fmla="*/ 1833 w 300"/>
                  <a:gd name="T21" fmla="*/ 793 h 139"/>
                  <a:gd name="T22" fmla="*/ 750 w 300"/>
                  <a:gd name="T23" fmla="*/ 1416 h 139"/>
                  <a:gd name="T24" fmla="*/ 113 w 300"/>
                  <a:gd name="T25" fmla="*/ 2622 h 139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300" h="139">
                    <a:moveTo>
                      <a:pt x="7" y="139"/>
                    </a:moveTo>
                    <a:cubicBezTo>
                      <a:pt x="15" y="115"/>
                      <a:pt x="8" y="99"/>
                      <a:pt x="4" y="89"/>
                    </a:cubicBezTo>
                    <a:cubicBezTo>
                      <a:pt x="0" y="79"/>
                      <a:pt x="4" y="80"/>
                      <a:pt x="17" y="72"/>
                    </a:cubicBezTo>
                    <a:cubicBezTo>
                      <a:pt x="30" y="64"/>
                      <a:pt x="25" y="57"/>
                      <a:pt x="33" y="49"/>
                    </a:cubicBezTo>
                    <a:cubicBezTo>
                      <a:pt x="41" y="41"/>
                      <a:pt x="50" y="54"/>
                      <a:pt x="79" y="40"/>
                    </a:cubicBezTo>
                    <a:cubicBezTo>
                      <a:pt x="108" y="26"/>
                      <a:pt x="94" y="18"/>
                      <a:pt x="105" y="9"/>
                    </a:cubicBezTo>
                    <a:cubicBezTo>
                      <a:pt x="116" y="0"/>
                      <a:pt x="125" y="9"/>
                      <a:pt x="151" y="22"/>
                    </a:cubicBezTo>
                    <a:cubicBezTo>
                      <a:pt x="177" y="35"/>
                      <a:pt x="206" y="37"/>
                      <a:pt x="237" y="39"/>
                    </a:cubicBezTo>
                    <a:cubicBezTo>
                      <a:pt x="268" y="41"/>
                      <a:pt x="291" y="51"/>
                      <a:pt x="300" y="53"/>
                    </a:cubicBezTo>
                    <a:cubicBezTo>
                      <a:pt x="276" y="48"/>
                      <a:pt x="253" y="46"/>
                      <a:pt x="221" y="47"/>
                    </a:cubicBezTo>
                    <a:cubicBezTo>
                      <a:pt x="189" y="48"/>
                      <a:pt x="146" y="27"/>
                      <a:pt x="117" y="42"/>
                    </a:cubicBezTo>
                    <a:cubicBezTo>
                      <a:pt x="88" y="57"/>
                      <a:pt x="78" y="59"/>
                      <a:pt x="48" y="75"/>
                    </a:cubicBezTo>
                    <a:cubicBezTo>
                      <a:pt x="18" y="91"/>
                      <a:pt x="26" y="116"/>
                      <a:pt x="7" y="139"/>
                    </a:cubicBezTo>
                    <a:close/>
                  </a:path>
                </a:pathLst>
              </a:custGeom>
              <a:solidFill>
                <a:schemeClr val="accent1">
                  <a:lumMod val="20000"/>
                  <a:lumOff val="8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0" name="Freeform 57"/>
              <p:cNvSpPr/>
              <p:nvPr/>
            </p:nvSpPr>
            <p:spPr bwMode="auto">
              <a:xfrm>
                <a:off x="539983" y="3585042"/>
                <a:ext cx="307455" cy="220109"/>
              </a:xfrm>
              <a:custGeom>
                <a:avLst/>
                <a:gdLst>
                  <a:gd name="T0" fmla="*/ 50 w 131"/>
                  <a:gd name="T1" fmla="*/ 1288 h 81"/>
                  <a:gd name="T2" fmla="*/ 83 w 131"/>
                  <a:gd name="T3" fmla="*/ 1536 h 81"/>
                  <a:gd name="T4" fmla="*/ 488 w 131"/>
                  <a:gd name="T5" fmla="*/ 989 h 81"/>
                  <a:gd name="T6" fmla="*/ 971 w 131"/>
                  <a:gd name="T7" fmla="*/ 704 h 81"/>
                  <a:gd name="T8" fmla="*/ 2056 w 131"/>
                  <a:gd name="T9" fmla="*/ 171 h 81"/>
                  <a:gd name="T10" fmla="*/ 1755 w 131"/>
                  <a:gd name="T11" fmla="*/ 21 h 81"/>
                  <a:gd name="T12" fmla="*/ 1585 w 131"/>
                  <a:gd name="T13" fmla="*/ 136 h 81"/>
                  <a:gd name="T14" fmla="*/ 992 w 131"/>
                  <a:gd name="T15" fmla="*/ 533 h 81"/>
                  <a:gd name="T16" fmla="*/ 709 w 131"/>
                  <a:gd name="T17" fmla="*/ 704 h 81"/>
                  <a:gd name="T18" fmla="*/ 426 w 131"/>
                  <a:gd name="T19" fmla="*/ 760 h 81"/>
                  <a:gd name="T20" fmla="*/ 238 w 131"/>
                  <a:gd name="T21" fmla="*/ 1059 h 81"/>
                  <a:gd name="T22" fmla="*/ 0 w 131"/>
                  <a:gd name="T23" fmla="*/ 1272 h 81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</a:gdLst>
                <a:ahLst/>
                <a:cxnLst>
                  <a:cxn ang="T24">
                    <a:pos x="T0" y="T1"/>
                  </a:cxn>
                  <a:cxn ang="T25">
                    <a:pos x="T2" y="T3"/>
                  </a:cxn>
                  <a:cxn ang="T26">
                    <a:pos x="T4" y="T5"/>
                  </a:cxn>
                  <a:cxn ang="T27">
                    <a:pos x="T6" y="T7"/>
                  </a:cxn>
                  <a:cxn ang="T28">
                    <a:pos x="T8" y="T9"/>
                  </a:cxn>
                  <a:cxn ang="T29">
                    <a:pos x="T10" y="T11"/>
                  </a:cxn>
                  <a:cxn ang="T30">
                    <a:pos x="T12" y="T13"/>
                  </a:cxn>
                  <a:cxn ang="T31">
                    <a:pos x="T14" y="T15"/>
                  </a:cxn>
                  <a:cxn ang="T32">
                    <a:pos x="T16" y="T17"/>
                  </a:cxn>
                  <a:cxn ang="T33">
                    <a:pos x="T18" y="T19"/>
                  </a:cxn>
                  <a:cxn ang="T34">
                    <a:pos x="T20" y="T21"/>
                  </a:cxn>
                  <a:cxn ang="T35">
                    <a:pos x="T22" y="T23"/>
                  </a:cxn>
                </a:cxnLst>
                <a:rect l="0" t="0" r="r" b="b"/>
                <a:pathLst>
                  <a:path w="131" h="81">
                    <a:moveTo>
                      <a:pt x="3" y="68"/>
                    </a:moveTo>
                    <a:cubicBezTo>
                      <a:pt x="4" y="72"/>
                      <a:pt x="5" y="77"/>
                      <a:pt x="5" y="81"/>
                    </a:cubicBezTo>
                    <a:cubicBezTo>
                      <a:pt x="14" y="70"/>
                      <a:pt x="18" y="60"/>
                      <a:pt x="31" y="52"/>
                    </a:cubicBezTo>
                    <a:cubicBezTo>
                      <a:pt x="41" y="46"/>
                      <a:pt x="52" y="42"/>
                      <a:pt x="62" y="37"/>
                    </a:cubicBezTo>
                    <a:cubicBezTo>
                      <a:pt x="84" y="27"/>
                      <a:pt x="106" y="9"/>
                      <a:pt x="131" y="9"/>
                    </a:cubicBezTo>
                    <a:cubicBezTo>
                      <a:pt x="125" y="7"/>
                      <a:pt x="118" y="2"/>
                      <a:pt x="112" y="1"/>
                    </a:cubicBezTo>
                    <a:cubicBezTo>
                      <a:pt x="104" y="0"/>
                      <a:pt x="106" y="1"/>
                      <a:pt x="101" y="7"/>
                    </a:cubicBezTo>
                    <a:cubicBezTo>
                      <a:pt x="91" y="18"/>
                      <a:pt x="76" y="21"/>
                      <a:pt x="63" y="28"/>
                    </a:cubicBezTo>
                    <a:cubicBezTo>
                      <a:pt x="57" y="31"/>
                      <a:pt x="52" y="36"/>
                      <a:pt x="45" y="37"/>
                    </a:cubicBezTo>
                    <a:cubicBezTo>
                      <a:pt x="38" y="38"/>
                      <a:pt x="34" y="35"/>
                      <a:pt x="27" y="40"/>
                    </a:cubicBezTo>
                    <a:cubicBezTo>
                      <a:pt x="22" y="44"/>
                      <a:pt x="20" y="51"/>
                      <a:pt x="15" y="56"/>
                    </a:cubicBezTo>
                    <a:cubicBezTo>
                      <a:pt x="11" y="60"/>
                      <a:pt x="5" y="63"/>
                      <a:pt x="0" y="67"/>
                    </a:cubicBezTo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1" name="Freeform 58"/>
              <p:cNvSpPr/>
              <p:nvPr/>
            </p:nvSpPr>
            <p:spPr bwMode="auto">
              <a:xfrm>
                <a:off x="655279" y="3829607"/>
                <a:ext cx="812694" cy="211956"/>
              </a:xfrm>
              <a:custGeom>
                <a:avLst/>
                <a:gdLst>
                  <a:gd name="T0" fmla="*/ 0 w 347"/>
                  <a:gd name="T1" fmla="*/ 1480 h 78"/>
                  <a:gd name="T2" fmla="*/ 842 w 347"/>
                  <a:gd name="T3" fmla="*/ 1024 h 78"/>
                  <a:gd name="T4" fmla="*/ 2946 w 347"/>
                  <a:gd name="T5" fmla="*/ 989 h 78"/>
                  <a:gd name="T6" fmla="*/ 4757 w 347"/>
                  <a:gd name="T7" fmla="*/ 248 h 78"/>
                  <a:gd name="T8" fmla="*/ 5412 w 347"/>
                  <a:gd name="T9" fmla="*/ 1045 h 78"/>
                  <a:gd name="T10" fmla="*/ 4745 w 347"/>
                  <a:gd name="T11" fmla="*/ 21 h 78"/>
                  <a:gd name="T12" fmla="*/ 3291 w 347"/>
                  <a:gd name="T13" fmla="*/ 589 h 78"/>
                  <a:gd name="T14" fmla="*/ 1229 w 347"/>
                  <a:gd name="T15" fmla="*/ 875 h 78"/>
                  <a:gd name="T16" fmla="*/ 0 w 347"/>
                  <a:gd name="T17" fmla="*/ 1480 h 7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347" h="78">
                    <a:moveTo>
                      <a:pt x="0" y="78"/>
                    </a:moveTo>
                    <a:cubicBezTo>
                      <a:pt x="19" y="59"/>
                      <a:pt x="24" y="47"/>
                      <a:pt x="54" y="54"/>
                    </a:cubicBezTo>
                    <a:cubicBezTo>
                      <a:pt x="84" y="61"/>
                      <a:pt x="124" y="72"/>
                      <a:pt x="189" y="52"/>
                    </a:cubicBezTo>
                    <a:cubicBezTo>
                      <a:pt x="254" y="32"/>
                      <a:pt x="282" y="7"/>
                      <a:pt x="305" y="13"/>
                    </a:cubicBezTo>
                    <a:cubicBezTo>
                      <a:pt x="328" y="19"/>
                      <a:pt x="341" y="45"/>
                      <a:pt x="347" y="55"/>
                    </a:cubicBezTo>
                    <a:cubicBezTo>
                      <a:pt x="343" y="34"/>
                      <a:pt x="317" y="2"/>
                      <a:pt x="304" y="1"/>
                    </a:cubicBezTo>
                    <a:cubicBezTo>
                      <a:pt x="291" y="0"/>
                      <a:pt x="240" y="18"/>
                      <a:pt x="211" y="31"/>
                    </a:cubicBezTo>
                    <a:cubicBezTo>
                      <a:pt x="182" y="44"/>
                      <a:pt x="109" y="54"/>
                      <a:pt x="79" y="46"/>
                    </a:cubicBezTo>
                    <a:cubicBezTo>
                      <a:pt x="49" y="38"/>
                      <a:pt x="16" y="46"/>
                      <a:pt x="0" y="78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2" name="Freeform 59"/>
              <p:cNvSpPr/>
              <p:nvPr/>
            </p:nvSpPr>
            <p:spPr bwMode="auto">
              <a:xfrm>
                <a:off x="828691" y="3710382"/>
                <a:ext cx="295269" cy="165081"/>
              </a:xfrm>
              <a:custGeom>
                <a:avLst/>
                <a:gdLst>
                  <a:gd name="T0" fmla="*/ 1970 w 126"/>
                  <a:gd name="T1" fmla="*/ 353 h 61"/>
                  <a:gd name="T2" fmla="*/ 1125 w 126"/>
                  <a:gd name="T3" fmla="*/ 247 h 61"/>
                  <a:gd name="T4" fmla="*/ 20 w 126"/>
                  <a:gd name="T5" fmla="*/ 656 h 61"/>
                  <a:gd name="T6" fmla="*/ 145 w 126"/>
                  <a:gd name="T7" fmla="*/ 1142 h 61"/>
                  <a:gd name="T8" fmla="*/ 583 w 126"/>
                  <a:gd name="T9" fmla="*/ 451 h 61"/>
                  <a:gd name="T10" fmla="*/ 1970 w 126"/>
                  <a:gd name="T11" fmla="*/ 353 h 61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26" h="61">
                    <a:moveTo>
                      <a:pt x="126" y="19"/>
                    </a:moveTo>
                    <a:cubicBezTo>
                      <a:pt x="105" y="18"/>
                      <a:pt x="94" y="17"/>
                      <a:pt x="72" y="13"/>
                    </a:cubicBezTo>
                    <a:cubicBezTo>
                      <a:pt x="49" y="8"/>
                      <a:pt x="9" y="0"/>
                      <a:pt x="1" y="35"/>
                    </a:cubicBezTo>
                    <a:cubicBezTo>
                      <a:pt x="0" y="45"/>
                      <a:pt x="6" y="54"/>
                      <a:pt x="9" y="61"/>
                    </a:cubicBezTo>
                    <a:cubicBezTo>
                      <a:pt x="5" y="46"/>
                      <a:pt x="19" y="30"/>
                      <a:pt x="37" y="24"/>
                    </a:cubicBezTo>
                    <a:cubicBezTo>
                      <a:pt x="55" y="17"/>
                      <a:pt x="108" y="29"/>
                      <a:pt x="126" y="19"/>
                    </a:cubicBezTo>
                    <a:close/>
                  </a:path>
                </a:pathLst>
              </a:custGeom>
              <a:solidFill>
                <a:srgbClr val="B789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3" name="Freeform 60"/>
              <p:cNvSpPr/>
              <p:nvPr/>
            </p:nvSpPr>
            <p:spPr bwMode="auto">
              <a:xfrm>
                <a:off x="894306" y="3764390"/>
                <a:ext cx="290583" cy="154891"/>
              </a:xfrm>
              <a:custGeom>
                <a:avLst/>
                <a:gdLst>
                  <a:gd name="T0" fmla="*/ 0 w 124"/>
                  <a:gd name="T1" fmla="*/ 947 h 57"/>
                  <a:gd name="T2" fmla="*/ 1908 w 124"/>
                  <a:gd name="T3" fmla="*/ 264 h 57"/>
                  <a:gd name="T4" fmla="*/ 1708 w 124"/>
                  <a:gd name="T5" fmla="*/ 0 h 57"/>
                  <a:gd name="T6" fmla="*/ 1395 w 124"/>
                  <a:gd name="T7" fmla="*/ 605 h 57"/>
                  <a:gd name="T8" fmla="*/ 0 w 124"/>
                  <a:gd name="T9" fmla="*/ 947 h 5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24" h="57">
                    <a:moveTo>
                      <a:pt x="0" y="50"/>
                    </a:moveTo>
                    <a:cubicBezTo>
                      <a:pt x="35" y="57"/>
                      <a:pt x="118" y="55"/>
                      <a:pt x="122" y="14"/>
                    </a:cubicBezTo>
                    <a:cubicBezTo>
                      <a:pt x="124" y="3"/>
                      <a:pt x="109" y="0"/>
                      <a:pt x="109" y="0"/>
                    </a:cubicBezTo>
                    <a:cubicBezTo>
                      <a:pt x="116" y="8"/>
                      <a:pt x="119" y="18"/>
                      <a:pt x="89" y="32"/>
                    </a:cubicBezTo>
                    <a:cubicBezTo>
                      <a:pt x="60" y="45"/>
                      <a:pt x="8" y="50"/>
                      <a:pt x="0" y="50"/>
                    </a:cubicBezTo>
                    <a:close/>
                  </a:path>
                </a:pathLst>
              </a:custGeom>
              <a:solidFill>
                <a:srgbClr val="6B136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4" name="Freeform 61"/>
              <p:cNvSpPr/>
              <p:nvPr/>
            </p:nvSpPr>
            <p:spPr bwMode="auto">
              <a:xfrm>
                <a:off x="835253" y="3728724"/>
                <a:ext cx="119983" cy="89674"/>
              </a:xfrm>
              <a:custGeom>
                <a:avLst/>
                <a:gdLst>
                  <a:gd name="T0" fmla="*/ 806 w 51"/>
                  <a:gd name="T1" fmla="*/ 35 h 33"/>
                  <a:gd name="T2" fmla="*/ 0 w 51"/>
                  <a:gd name="T3" fmla="*/ 627 h 33"/>
                  <a:gd name="T4" fmla="*/ 806 w 51"/>
                  <a:gd name="T5" fmla="*/ 35 h 3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1" h="33">
                    <a:moveTo>
                      <a:pt x="51" y="2"/>
                    </a:moveTo>
                    <a:cubicBezTo>
                      <a:pt x="30" y="0"/>
                      <a:pt x="0" y="2"/>
                      <a:pt x="0" y="33"/>
                    </a:cubicBezTo>
                    <a:cubicBezTo>
                      <a:pt x="8" y="17"/>
                      <a:pt x="31" y="0"/>
                      <a:pt x="51" y="2"/>
                    </a:cubicBezTo>
                    <a:close/>
                  </a:path>
                </a:pathLst>
              </a:custGeom>
              <a:solidFill>
                <a:srgbClr val="E7DA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5" name="Freeform 62"/>
              <p:cNvSpPr/>
              <p:nvPr/>
            </p:nvSpPr>
            <p:spPr bwMode="auto">
              <a:xfrm>
                <a:off x="844626" y="3604403"/>
                <a:ext cx="23434" cy="16304"/>
              </a:xfrm>
              <a:custGeom>
                <a:avLst/>
                <a:gdLst>
                  <a:gd name="T0" fmla="*/ 83 w 10"/>
                  <a:gd name="T1" fmla="*/ 0 h 6"/>
                  <a:gd name="T2" fmla="*/ 158 w 10"/>
                  <a:gd name="T3" fmla="*/ 115 h 6"/>
                  <a:gd name="T4" fmla="*/ 95 w 10"/>
                  <a:gd name="T5" fmla="*/ 21 h 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" h="6">
                    <a:moveTo>
                      <a:pt x="5" y="0"/>
                    </a:moveTo>
                    <a:cubicBezTo>
                      <a:pt x="0" y="4"/>
                      <a:pt x="6" y="6"/>
                      <a:pt x="10" y="6"/>
                    </a:cubicBezTo>
                    <a:cubicBezTo>
                      <a:pt x="10" y="4"/>
                      <a:pt x="8" y="2"/>
                      <a:pt x="6" y="1"/>
                    </a:cubicBezTo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6" name="Freeform 63"/>
              <p:cNvSpPr/>
              <p:nvPr/>
            </p:nvSpPr>
            <p:spPr bwMode="auto">
              <a:xfrm>
                <a:off x="214718" y="3384295"/>
                <a:ext cx="1485721" cy="874320"/>
              </a:xfrm>
              <a:custGeom>
                <a:avLst/>
                <a:gdLst>
                  <a:gd name="T0" fmla="*/ 3113 w 634"/>
                  <a:gd name="T1" fmla="*/ 0 h 322"/>
                  <a:gd name="T2" fmla="*/ 3470 w 634"/>
                  <a:gd name="T3" fmla="*/ 1386 h 322"/>
                  <a:gd name="T4" fmla="*/ 2675 w 634"/>
                  <a:gd name="T5" fmla="*/ 1740 h 322"/>
                  <a:gd name="T6" fmla="*/ 2020 w 634"/>
                  <a:gd name="T7" fmla="*/ 1100 h 322"/>
                  <a:gd name="T8" fmla="*/ 2050 w 634"/>
                  <a:gd name="T9" fmla="*/ 2363 h 322"/>
                  <a:gd name="T10" fmla="*/ 675 w 634"/>
                  <a:gd name="T11" fmla="*/ 2401 h 322"/>
                  <a:gd name="T12" fmla="*/ 1908 w 634"/>
                  <a:gd name="T13" fmla="*/ 2726 h 322"/>
                  <a:gd name="T14" fmla="*/ 1425 w 634"/>
                  <a:gd name="T15" fmla="*/ 4522 h 322"/>
                  <a:gd name="T16" fmla="*/ 0 w 634"/>
                  <a:gd name="T17" fmla="*/ 5788 h 322"/>
                  <a:gd name="T18" fmla="*/ 2125 w 634"/>
                  <a:gd name="T19" fmla="*/ 4487 h 322"/>
                  <a:gd name="T20" fmla="*/ 2583 w 634"/>
                  <a:gd name="T21" fmla="*/ 6091 h 322"/>
                  <a:gd name="T22" fmla="*/ 3720 w 634"/>
                  <a:gd name="T23" fmla="*/ 4274 h 322"/>
                  <a:gd name="T24" fmla="*/ 6083 w 634"/>
                  <a:gd name="T25" fmla="*/ 4218 h 322"/>
                  <a:gd name="T26" fmla="*/ 7720 w 634"/>
                  <a:gd name="T27" fmla="*/ 3579 h 322"/>
                  <a:gd name="T28" fmla="*/ 8863 w 634"/>
                  <a:gd name="T29" fmla="*/ 5468 h 322"/>
                  <a:gd name="T30" fmla="*/ 9908 w 634"/>
                  <a:gd name="T31" fmla="*/ 3805 h 322"/>
                  <a:gd name="T32" fmla="*/ 8625 w 634"/>
                  <a:gd name="T33" fmla="*/ 3080 h 322"/>
                  <a:gd name="T34" fmla="*/ 9533 w 634"/>
                  <a:gd name="T35" fmla="*/ 661 h 322"/>
                  <a:gd name="T36" fmla="*/ 8595 w 634"/>
                  <a:gd name="T37" fmla="*/ 1386 h 322"/>
                  <a:gd name="T38" fmla="*/ 7908 w 634"/>
                  <a:gd name="T39" fmla="*/ 1966 h 322"/>
                  <a:gd name="T40" fmla="*/ 6113 w 634"/>
                  <a:gd name="T41" fmla="*/ 1740 h 322"/>
                  <a:gd name="T42" fmla="*/ 3988 w 634"/>
                  <a:gd name="T43" fmla="*/ 930 h 322"/>
                  <a:gd name="T44" fmla="*/ 3113 w 634"/>
                  <a:gd name="T45" fmla="*/ 0 h 322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</a:gdLst>
                <a:ahLst/>
                <a:cxnLst>
                  <a:cxn ang="T46">
                    <a:pos x="T0" y="T1"/>
                  </a:cxn>
                  <a:cxn ang="T47">
                    <a:pos x="T2" y="T3"/>
                  </a:cxn>
                  <a:cxn ang="T48">
                    <a:pos x="T4" y="T5"/>
                  </a:cxn>
                  <a:cxn ang="T49">
                    <a:pos x="T6" y="T7"/>
                  </a:cxn>
                  <a:cxn ang="T50">
                    <a:pos x="T8" y="T9"/>
                  </a:cxn>
                  <a:cxn ang="T51">
                    <a:pos x="T10" y="T11"/>
                  </a:cxn>
                  <a:cxn ang="T52">
                    <a:pos x="T12" y="T13"/>
                  </a:cxn>
                  <a:cxn ang="T53">
                    <a:pos x="T14" y="T15"/>
                  </a:cxn>
                  <a:cxn ang="T54">
                    <a:pos x="T16" y="T17"/>
                  </a:cxn>
                  <a:cxn ang="T55">
                    <a:pos x="T18" y="T19"/>
                  </a:cxn>
                  <a:cxn ang="T56">
                    <a:pos x="T20" y="T21"/>
                  </a:cxn>
                  <a:cxn ang="T57">
                    <a:pos x="T22" y="T23"/>
                  </a:cxn>
                  <a:cxn ang="T58">
                    <a:pos x="T24" y="T25"/>
                  </a:cxn>
                  <a:cxn ang="T59">
                    <a:pos x="T26" y="T27"/>
                  </a:cxn>
                  <a:cxn ang="T60">
                    <a:pos x="T28" y="T29"/>
                  </a:cxn>
                  <a:cxn ang="T61">
                    <a:pos x="T30" y="T31"/>
                  </a:cxn>
                  <a:cxn ang="T62">
                    <a:pos x="T32" y="T33"/>
                  </a:cxn>
                  <a:cxn ang="T63">
                    <a:pos x="T34" y="T35"/>
                  </a:cxn>
                  <a:cxn ang="T64">
                    <a:pos x="T36" y="T37"/>
                  </a:cxn>
                  <a:cxn ang="T65">
                    <a:pos x="T38" y="T39"/>
                  </a:cxn>
                  <a:cxn ang="T66">
                    <a:pos x="T40" y="T41"/>
                  </a:cxn>
                  <a:cxn ang="T67">
                    <a:pos x="T42" y="T43"/>
                  </a:cxn>
                  <a:cxn ang="T68">
                    <a:pos x="T44" y="T45"/>
                  </a:cxn>
                </a:cxnLst>
                <a:rect l="0" t="0" r="r" b="b"/>
                <a:pathLst>
                  <a:path w="634" h="322">
                    <a:moveTo>
                      <a:pt x="199" y="0"/>
                    </a:moveTo>
                    <a:cubicBezTo>
                      <a:pt x="212" y="13"/>
                      <a:pt x="239" y="31"/>
                      <a:pt x="222" y="73"/>
                    </a:cubicBezTo>
                    <a:cubicBezTo>
                      <a:pt x="217" y="88"/>
                      <a:pt x="194" y="98"/>
                      <a:pt x="171" y="92"/>
                    </a:cubicBezTo>
                    <a:cubicBezTo>
                      <a:pt x="153" y="87"/>
                      <a:pt x="134" y="68"/>
                      <a:pt x="129" y="58"/>
                    </a:cubicBezTo>
                    <a:cubicBezTo>
                      <a:pt x="140" y="76"/>
                      <a:pt x="168" y="118"/>
                      <a:pt x="131" y="125"/>
                    </a:cubicBezTo>
                    <a:cubicBezTo>
                      <a:pt x="105" y="130"/>
                      <a:pt x="67" y="150"/>
                      <a:pt x="43" y="127"/>
                    </a:cubicBezTo>
                    <a:cubicBezTo>
                      <a:pt x="51" y="159"/>
                      <a:pt x="113" y="133"/>
                      <a:pt x="122" y="144"/>
                    </a:cubicBezTo>
                    <a:cubicBezTo>
                      <a:pt x="153" y="177"/>
                      <a:pt x="118" y="224"/>
                      <a:pt x="91" y="239"/>
                    </a:cubicBezTo>
                    <a:cubicBezTo>
                      <a:pt x="56" y="258"/>
                      <a:pt x="29" y="278"/>
                      <a:pt x="0" y="306"/>
                    </a:cubicBezTo>
                    <a:cubicBezTo>
                      <a:pt x="35" y="276"/>
                      <a:pt x="94" y="259"/>
                      <a:pt x="136" y="237"/>
                    </a:cubicBezTo>
                    <a:cubicBezTo>
                      <a:pt x="194" y="206"/>
                      <a:pt x="164" y="286"/>
                      <a:pt x="165" y="322"/>
                    </a:cubicBezTo>
                    <a:cubicBezTo>
                      <a:pt x="166" y="297"/>
                      <a:pt x="205" y="213"/>
                      <a:pt x="238" y="226"/>
                    </a:cubicBezTo>
                    <a:cubicBezTo>
                      <a:pt x="280" y="241"/>
                      <a:pt x="351" y="234"/>
                      <a:pt x="389" y="223"/>
                    </a:cubicBezTo>
                    <a:cubicBezTo>
                      <a:pt x="427" y="212"/>
                      <a:pt x="464" y="179"/>
                      <a:pt x="494" y="189"/>
                    </a:cubicBezTo>
                    <a:cubicBezTo>
                      <a:pt x="524" y="199"/>
                      <a:pt x="547" y="252"/>
                      <a:pt x="567" y="289"/>
                    </a:cubicBezTo>
                    <a:cubicBezTo>
                      <a:pt x="538" y="197"/>
                      <a:pt x="573" y="197"/>
                      <a:pt x="634" y="201"/>
                    </a:cubicBezTo>
                    <a:cubicBezTo>
                      <a:pt x="602" y="184"/>
                      <a:pt x="573" y="196"/>
                      <a:pt x="552" y="163"/>
                    </a:cubicBezTo>
                    <a:cubicBezTo>
                      <a:pt x="519" y="110"/>
                      <a:pt x="576" y="49"/>
                      <a:pt x="610" y="35"/>
                    </a:cubicBezTo>
                    <a:cubicBezTo>
                      <a:pt x="585" y="43"/>
                      <a:pt x="569" y="56"/>
                      <a:pt x="550" y="73"/>
                    </a:cubicBezTo>
                    <a:cubicBezTo>
                      <a:pt x="536" y="85"/>
                      <a:pt x="524" y="98"/>
                      <a:pt x="506" y="104"/>
                    </a:cubicBezTo>
                    <a:cubicBezTo>
                      <a:pt x="472" y="115"/>
                      <a:pt x="425" y="98"/>
                      <a:pt x="391" y="92"/>
                    </a:cubicBezTo>
                    <a:cubicBezTo>
                      <a:pt x="339" y="82"/>
                      <a:pt x="293" y="86"/>
                      <a:pt x="255" y="49"/>
                    </a:cubicBezTo>
                    <a:cubicBezTo>
                      <a:pt x="237" y="33"/>
                      <a:pt x="233" y="20"/>
                      <a:pt x="199" y="0"/>
                    </a:cubicBezTo>
                    <a:close/>
                  </a:path>
                </a:pathLst>
              </a:custGeom>
              <a:noFill/>
              <a:ln w="11113" cap="rnd">
                <a:solidFill>
                  <a:srgbClr val="000000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7" name="Freeform 64"/>
              <p:cNvSpPr/>
              <p:nvPr/>
            </p:nvSpPr>
            <p:spPr bwMode="auto">
              <a:xfrm>
                <a:off x="791196" y="3702229"/>
                <a:ext cx="403066" cy="228261"/>
              </a:xfrm>
              <a:custGeom>
                <a:avLst/>
                <a:gdLst>
                  <a:gd name="T0" fmla="*/ 188 w 172"/>
                  <a:gd name="T1" fmla="*/ 605 h 84"/>
                  <a:gd name="T2" fmla="*/ 1533 w 172"/>
                  <a:gd name="T3" fmla="*/ 1515 h 84"/>
                  <a:gd name="T4" fmla="*/ 2658 w 172"/>
                  <a:gd name="T5" fmla="*/ 683 h 84"/>
                  <a:gd name="T6" fmla="*/ 1438 w 172"/>
                  <a:gd name="T7" fmla="*/ 227 h 84"/>
                  <a:gd name="T8" fmla="*/ 188 w 172"/>
                  <a:gd name="T9" fmla="*/ 605 h 8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2" h="84">
                    <a:moveTo>
                      <a:pt x="12" y="32"/>
                    </a:moveTo>
                    <a:cubicBezTo>
                      <a:pt x="0" y="82"/>
                      <a:pt x="58" y="84"/>
                      <a:pt x="98" y="80"/>
                    </a:cubicBezTo>
                    <a:cubicBezTo>
                      <a:pt x="138" y="76"/>
                      <a:pt x="172" y="64"/>
                      <a:pt x="170" y="36"/>
                    </a:cubicBezTo>
                    <a:cubicBezTo>
                      <a:pt x="168" y="8"/>
                      <a:pt x="126" y="20"/>
                      <a:pt x="92" y="12"/>
                    </a:cubicBezTo>
                    <a:cubicBezTo>
                      <a:pt x="58" y="4"/>
                      <a:pt x="22" y="0"/>
                      <a:pt x="12" y="32"/>
                    </a:cubicBezTo>
                    <a:close/>
                  </a:path>
                </a:pathLst>
              </a:custGeom>
              <a:noFill/>
              <a:ln w="11113" cap="rnd">
                <a:solidFill>
                  <a:srgbClr val="000000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8" name="Freeform 65"/>
              <p:cNvSpPr/>
              <p:nvPr/>
            </p:nvSpPr>
            <p:spPr bwMode="auto">
              <a:xfrm>
                <a:off x="586851" y="3351686"/>
                <a:ext cx="98423" cy="34647"/>
              </a:xfrm>
              <a:custGeom>
                <a:avLst/>
                <a:gdLst>
                  <a:gd name="T0" fmla="*/ 0 w 42"/>
                  <a:gd name="T1" fmla="*/ 0 h 13"/>
                  <a:gd name="T2" fmla="*/ 658 w 42"/>
                  <a:gd name="T3" fmla="*/ 233 h 1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42" h="13">
                    <a:moveTo>
                      <a:pt x="0" y="0"/>
                    </a:moveTo>
                    <a:cubicBezTo>
                      <a:pt x="16" y="1"/>
                      <a:pt x="33" y="5"/>
                      <a:pt x="42" y="13"/>
                    </a:cubicBezTo>
                  </a:path>
                </a:pathLst>
              </a:custGeom>
              <a:noFill/>
              <a:ln w="11113" cap="rnd">
                <a:solidFill>
                  <a:srgbClr val="000000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9" name="Oval 66"/>
              <p:cNvSpPr>
                <a:spLocks noChangeArrowheads="1"/>
              </p:cNvSpPr>
              <p:nvPr/>
            </p:nvSpPr>
            <p:spPr bwMode="auto">
              <a:xfrm>
                <a:off x="821192" y="3715477"/>
                <a:ext cx="35620" cy="40761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pPr eaLnBrk="1" hangingPunct="1"/>
                <a:endParaRPr lang="zh-CN"/>
              </a:p>
            </p:txBody>
          </p:sp>
          <p:sp>
            <p:nvSpPr>
              <p:cNvPr id="280" name="Oval 67"/>
              <p:cNvSpPr>
                <a:spLocks noChangeArrowheads="1"/>
              </p:cNvSpPr>
              <p:nvPr/>
            </p:nvSpPr>
            <p:spPr bwMode="auto">
              <a:xfrm>
                <a:off x="863373" y="3710382"/>
                <a:ext cx="18747" cy="21399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pPr eaLnBrk="1" hangingPunct="1"/>
                <a:endParaRPr lang="zh-CN"/>
              </a:p>
            </p:txBody>
          </p:sp>
          <p:sp>
            <p:nvSpPr>
              <p:cNvPr id="281" name="Oval 68"/>
              <p:cNvSpPr>
                <a:spLocks noChangeArrowheads="1"/>
              </p:cNvSpPr>
              <p:nvPr/>
            </p:nvSpPr>
            <p:spPr bwMode="auto">
              <a:xfrm>
                <a:off x="811818" y="3759295"/>
                <a:ext cx="18747" cy="24457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pPr eaLnBrk="1" hangingPunct="1"/>
                <a:endParaRPr lang="zh-CN"/>
              </a:p>
            </p:txBody>
          </p:sp>
        </p:grpSp>
        <p:sp>
          <p:nvSpPr>
            <p:cNvPr id="282" name="任意多边形: 形状 77"/>
            <p:cNvSpPr/>
            <p:nvPr/>
          </p:nvSpPr>
          <p:spPr>
            <a:xfrm rot="13571375" flipH="1">
              <a:off x="3888808" y="3607729"/>
              <a:ext cx="998632" cy="1036899"/>
            </a:xfrm>
            <a:custGeom>
              <a:avLst/>
              <a:gdLst>
                <a:gd name="connsiteX0" fmla="*/ 0 w 3772698"/>
                <a:gd name="connsiteY0" fmla="*/ 1485900 h 4130041"/>
                <a:gd name="connsiteX1" fmla="*/ 861822 w 3772698"/>
                <a:gd name="connsiteY1" fmla="*/ 0 h 4130041"/>
                <a:gd name="connsiteX2" fmla="*/ 1723644 w 3772698"/>
                <a:gd name="connsiteY2" fmla="*/ 1485900 h 4130041"/>
                <a:gd name="connsiteX3" fmla="*/ 1227062 w 3772698"/>
                <a:gd name="connsiteY3" fmla="*/ 1485900 h 4130041"/>
                <a:gd name="connsiteX4" fmla="*/ 1236927 w 3772698"/>
                <a:gd name="connsiteY4" fmla="*/ 1690770 h 4130041"/>
                <a:gd name="connsiteX5" fmla="*/ 3556058 w 3772698"/>
                <a:gd name="connsiteY5" fmla="*/ 4075605 h 4130041"/>
                <a:gd name="connsiteX6" fmla="*/ 3772698 w 3772698"/>
                <a:gd name="connsiteY6" fmla="*/ 4105955 h 4130041"/>
                <a:gd name="connsiteX7" fmla="*/ 3699512 w 3772698"/>
                <a:gd name="connsiteY7" fmla="*/ 4116207 h 4130041"/>
                <a:gd name="connsiteX8" fmla="*/ 3401064 w 3772698"/>
                <a:gd name="connsiteY8" fmla="*/ 4130041 h 4130041"/>
                <a:gd name="connsiteX9" fmla="*/ 485896 w 3772698"/>
                <a:gd name="connsiteY9" fmla="*/ 1588538 h 4130041"/>
                <a:gd name="connsiteX10" fmla="*/ 483069 w 3772698"/>
                <a:gd name="connsiteY10" fmla="*/ 1485900 h 41300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3772698" h="4130041">
                  <a:moveTo>
                    <a:pt x="0" y="1485900"/>
                  </a:moveTo>
                  <a:lnTo>
                    <a:pt x="861822" y="0"/>
                  </a:lnTo>
                  <a:lnTo>
                    <a:pt x="1723644" y="1485900"/>
                  </a:lnTo>
                  <a:lnTo>
                    <a:pt x="1227062" y="1485900"/>
                  </a:lnTo>
                  <a:lnTo>
                    <a:pt x="1236927" y="1690770"/>
                  </a:lnTo>
                  <a:cubicBezTo>
                    <a:pt x="1351724" y="2877260"/>
                    <a:pt x="2309068" y="3841378"/>
                    <a:pt x="3556058" y="4075605"/>
                  </a:cubicBezTo>
                  <a:lnTo>
                    <a:pt x="3772698" y="4105955"/>
                  </a:lnTo>
                  <a:lnTo>
                    <a:pt x="3699512" y="4116207"/>
                  </a:lnTo>
                  <a:cubicBezTo>
                    <a:pt x="3601385" y="4125355"/>
                    <a:pt x="3501821" y="4130041"/>
                    <a:pt x="3401064" y="4130041"/>
                  </a:cubicBezTo>
                  <a:cubicBezTo>
                    <a:pt x="1839342" y="4130041"/>
                    <a:pt x="564075" y="3004243"/>
                    <a:pt x="485896" y="1588538"/>
                  </a:cubicBezTo>
                  <a:lnTo>
                    <a:pt x="483069" y="1485900"/>
                  </a:lnTo>
                  <a:close/>
                </a:path>
              </a:pathLst>
            </a:custGeom>
            <a:gradFill>
              <a:gsLst>
                <a:gs pos="0">
                  <a:srgbClr val="5E9EFF"/>
                </a:gs>
                <a:gs pos="39999">
                  <a:srgbClr val="85C2FF"/>
                </a:gs>
                <a:gs pos="70000">
                  <a:srgbClr val="C4D6EB"/>
                </a:gs>
                <a:gs pos="100000">
                  <a:srgbClr val="FFEBFA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165100" prst="coolSlant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zh-CN" altLang="en-US"/>
            </a:p>
          </p:txBody>
        </p:sp>
        <p:sp>
          <p:nvSpPr>
            <p:cNvPr id="283" name="TextBox 26"/>
            <p:cNvSpPr txBox="1"/>
            <p:nvPr/>
          </p:nvSpPr>
          <p:spPr>
            <a:xfrm>
              <a:off x="2083273" y="5085323"/>
              <a:ext cx="226215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rfectly 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enotypic</a:t>
              </a:r>
              <a:endParaRPr lang="en-US" altLang="zh-CN" dirty="0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one cell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50"/>
          <p:cNvGrpSpPr/>
          <p:nvPr/>
        </p:nvGrpSpPr>
        <p:grpSpPr bwMode="auto">
          <a:xfrm>
            <a:off x="6234680" y="998766"/>
            <a:ext cx="2516187" cy="1412875"/>
            <a:chOff x="1989" y="1751"/>
            <a:chExt cx="1585" cy="890"/>
          </a:xfrm>
        </p:grpSpPr>
        <p:sp>
          <p:nvSpPr>
            <p:cNvPr id="6" name="Freeform 51"/>
            <p:cNvSpPr/>
            <p:nvPr/>
          </p:nvSpPr>
          <p:spPr bwMode="auto">
            <a:xfrm>
              <a:off x="1989" y="1783"/>
              <a:ext cx="1585" cy="858"/>
            </a:xfrm>
            <a:custGeom>
              <a:avLst/>
              <a:gdLst>
                <a:gd name="T0" fmla="*/ 3113 w 634"/>
                <a:gd name="T1" fmla="*/ 0 h 322"/>
                <a:gd name="T2" fmla="*/ 3470 w 634"/>
                <a:gd name="T3" fmla="*/ 1386 h 322"/>
                <a:gd name="T4" fmla="*/ 2675 w 634"/>
                <a:gd name="T5" fmla="*/ 1740 h 322"/>
                <a:gd name="T6" fmla="*/ 2020 w 634"/>
                <a:gd name="T7" fmla="*/ 1100 h 322"/>
                <a:gd name="T8" fmla="*/ 2050 w 634"/>
                <a:gd name="T9" fmla="*/ 2363 h 322"/>
                <a:gd name="T10" fmla="*/ 675 w 634"/>
                <a:gd name="T11" fmla="*/ 2401 h 322"/>
                <a:gd name="T12" fmla="*/ 1908 w 634"/>
                <a:gd name="T13" fmla="*/ 2726 h 322"/>
                <a:gd name="T14" fmla="*/ 1425 w 634"/>
                <a:gd name="T15" fmla="*/ 4522 h 322"/>
                <a:gd name="T16" fmla="*/ 0 w 634"/>
                <a:gd name="T17" fmla="*/ 5788 h 322"/>
                <a:gd name="T18" fmla="*/ 2125 w 634"/>
                <a:gd name="T19" fmla="*/ 4487 h 322"/>
                <a:gd name="T20" fmla="*/ 2583 w 634"/>
                <a:gd name="T21" fmla="*/ 6091 h 322"/>
                <a:gd name="T22" fmla="*/ 3720 w 634"/>
                <a:gd name="T23" fmla="*/ 4274 h 322"/>
                <a:gd name="T24" fmla="*/ 6083 w 634"/>
                <a:gd name="T25" fmla="*/ 4218 h 322"/>
                <a:gd name="T26" fmla="*/ 7720 w 634"/>
                <a:gd name="T27" fmla="*/ 3579 h 322"/>
                <a:gd name="T28" fmla="*/ 8863 w 634"/>
                <a:gd name="T29" fmla="*/ 5468 h 322"/>
                <a:gd name="T30" fmla="*/ 9908 w 634"/>
                <a:gd name="T31" fmla="*/ 3805 h 322"/>
                <a:gd name="T32" fmla="*/ 8625 w 634"/>
                <a:gd name="T33" fmla="*/ 3080 h 322"/>
                <a:gd name="T34" fmla="*/ 9533 w 634"/>
                <a:gd name="T35" fmla="*/ 661 h 322"/>
                <a:gd name="T36" fmla="*/ 8595 w 634"/>
                <a:gd name="T37" fmla="*/ 1386 h 322"/>
                <a:gd name="T38" fmla="*/ 7908 w 634"/>
                <a:gd name="T39" fmla="*/ 1966 h 322"/>
                <a:gd name="T40" fmla="*/ 6113 w 634"/>
                <a:gd name="T41" fmla="*/ 1740 h 322"/>
                <a:gd name="T42" fmla="*/ 3988 w 634"/>
                <a:gd name="T43" fmla="*/ 930 h 322"/>
                <a:gd name="T44" fmla="*/ 3113 w 634"/>
                <a:gd name="T45" fmla="*/ 0 h 322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</a:gdLst>
              <a:ahLst/>
              <a:cxnLst>
                <a:cxn ang="T46">
                  <a:pos x="T0" y="T1"/>
                </a:cxn>
                <a:cxn ang="T47">
                  <a:pos x="T2" y="T3"/>
                </a:cxn>
                <a:cxn ang="T48">
                  <a:pos x="T4" y="T5"/>
                </a:cxn>
                <a:cxn ang="T49">
                  <a:pos x="T6" y="T7"/>
                </a:cxn>
                <a:cxn ang="T50">
                  <a:pos x="T8" y="T9"/>
                </a:cxn>
                <a:cxn ang="T51">
                  <a:pos x="T10" y="T11"/>
                </a:cxn>
                <a:cxn ang="T52">
                  <a:pos x="T12" y="T13"/>
                </a:cxn>
                <a:cxn ang="T53">
                  <a:pos x="T14" y="T15"/>
                </a:cxn>
                <a:cxn ang="T54">
                  <a:pos x="T16" y="T17"/>
                </a:cxn>
                <a:cxn ang="T55">
                  <a:pos x="T18" y="T19"/>
                </a:cxn>
                <a:cxn ang="T56">
                  <a:pos x="T20" y="T21"/>
                </a:cxn>
                <a:cxn ang="T57">
                  <a:pos x="T22" y="T23"/>
                </a:cxn>
                <a:cxn ang="T58">
                  <a:pos x="T24" y="T25"/>
                </a:cxn>
                <a:cxn ang="T59">
                  <a:pos x="T26" y="T27"/>
                </a:cxn>
                <a:cxn ang="T60">
                  <a:pos x="T28" y="T29"/>
                </a:cxn>
                <a:cxn ang="T61">
                  <a:pos x="T30" y="T31"/>
                </a:cxn>
                <a:cxn ang="T62">
                  <a:pos x="T32" y="T33"/>
                </a:cxn>
                <a:cxn ang="T63">
                  <a:pos x="T34" y="T35"/>
                </a:cxn>
                <a:cxn ang="T64">
                  <a:pos x="T36" y="T37"/>
                </a:cxn>
                <a:cxn ang="T65">
                  <a:pos x="T38" y="T39"/>
                </a:cxn>
                <a:cxn ang="T66">
                  <a:pos x="T40" y="T41"/>
                </a:cxn>
                <a:cxn ang="T67">
                  <a:pos x="T42" y="T43"/>
                </a:cxn>
                <a:cxn ang="T68">
                  <a:pos x="T44" y="T45"/>
                </a:cxn>
              </a:cxnLst>
              <a:rect l="0" t="0" r="r" b="b"/>
              <a:pathLst>
                <a:path w="634" h="322">
                  <a:moveTo>
                    <a:pt x="199" y="0"/>
                  </a:moveTo>
                  <a:cubicBezTo>
                    <a:pt x="212" y="13"/>
                    <a:pt x="239" y="31"/>
                    <a:pt x="222" y="73"/>
                  </a:cubicBezTo>
                  <a:cubicBezTo>
                    <a:pt x="217" y="88"/>
                    <a:pt x="194" y="98"/>
                    <a:pt x="171" y="92"/>
                  </a:cubicBezTo>
                  <a:cubicBezTo>
                    <a:pt x="153" y="87"/>
                    <a:pt x="134" y="68"/>
                    <a:pt x="129" y="58"/>
                  </a:cubicBezTo>
                  <a:cubicBezTo>
                    <a:pt x="140" y="76"/>
                    <a:pt x="168" y="118"/>
                    <a:pt x="131" y="125"/>
                  </a:cubicBezTo>
                  <a:cubicBezTo>
                    <a:pt x="105" y="130"/>
                    <a:pt x="67" y="150"/>
                    <a:pt x="43" y="127"/>
                  </a:cubicBezTo>
                  <a:cubicBezTo>
                    <a:pt x="51" y="159"/>
                    <a:pt x="113" y="133"/>
                    <a:pt x="122" y="144"/>
                  </a:cubicBezTo>
                  <a:cubicBezTo>
                    <a:pt x="153" y="177"/>
                    <a:pt x="118" y="224"/>
                    <a:pt x="91" y="239"/>
                  </a:cubicBezTo>
                  <a:cubicBezTo>
                    <a:pt x="56" y="258"/>
                    <a:pt x="29" y="278"/>
                    <a:pt x="0" y="306"/>
                  </a:cubicBezTo>
                  <a:cubicBezTo>
                    <a:pt x="35" y="276"/>
                    <a:pt x="94" y="259"/>
                    <a:pt x="136" y="237"/>
                  </a:cubicBezTo>
                  <a:cubicBezTo>
                    <a:pt x="194" y="206"/>
                    <a:pt x="164" y="286"/>
                    <a:pt x="165" y="322"/>
                  </a:cubicBezTo>
                  <a:cubicBezTo>
                    <a:pt x="166" y="297"/>
                    <a:pt x="205" y="213"/>
                    <a:pt x="238" y="226"/>
                  </a:cubicBezTo>
                  <a:cubicBezTo>
                    <a:pt x="280" y="241"/>
                    <a:pt x="351" y="234"/>
                    <a:pt x="389" y="223"/>
                  </a:cubicBezTo>
                  <a:cubicBezTo>
                    <a:pt x="427" y="212"/>
                    <a:pt x="464" y="179"/>
                    <a:pt x="494" y="189"/>
                  </a:cubicBezTo>
                  <a:cubicBezTo>
                    <a:pt x="524" y="199"/>
                    <a:pt x="547" y="252"/>
                    <a:pt x="567" y="289"/>
                  </a:cubicBezTo>
                  <a:cubicBezTo>
                    <a:pt x="538" y="197"/>
                    <a:pt x="573" y="197"/>
                    <a:pt x="634" y="201"/>
                  </a:cubicBezTo>
                  <a:cubicBezTo>
                    <a:pt x="602" y="184"/>
                    <a:pt x="573" y="196"/>
                    <a:pt x="552" y="163"/>
                  </a:cubicBezTo>
                  <a:cubicBezTo>
                    <a:pt x="519" y="110"/>
                    <a:pt x="576" y="49"/>
                    <a:pt x="610" y="35"/>
                  </a:cubicBezTo>
                  <a:cubicBezTo>
                    <a:pt x="585" y="43"/>
                    <a:pt x="569" y="56"/>
                    <a:pt x="550" y="73"/>
                  </a:cubicBezTo>
                  <a:cubicBezTo>
                    <a:pt x="536" y="85"/>
                    <a:pt x="524" y="98"/>
                    <a:pt x="506" y="104"/>
                  </a:cubicBezTo>
                  <a:cubicBezTo>
                    <a:pt x="472" y="115"/>
                    <a:pt x="425" y="98"/>
                    <a:pt x="391" y="92"/>
                  </a:cubicBezTo>
                  <a:cubicBezTo>
                    <a:pt x="339" y="82"/>
                    <a:pt x="293" y="86"/>
                    <a:pt x="255" y="49"/>
                  </a:cubicBezTo>
                  <a:cubicBezTo>
                    <a:pt x="237" y="33"/>
                    <a:pt x="233" y="20"/>
                    <a:pt x="199" y="0"/>
                  </a:cubicBezTo>
                  <a:close/>
                </a:path>
              </a:pathLst>
            </a:custGeom>
            <a:solidFill>
              <a:srgbClr val="E9618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7" name="Freeform 52"/>
            <p:cNvSpPr/>
            <p:nvPr/>
          </p:nvSpPr>
          <p:spPr bwMode="auto">
            <a:xfrm>
              <a:off x="2176" y="2183"/>
              <a:ext cx="1263" cy="314"/>
            </a:xfrm>
            <a:custGeom>
              <a:avLst/>
              <a:gdLst>
                <a:gd name="T0" fmla="*/ 0 w 505"/>
                <a:gd name="T1" fmla="*/ 1996 h 118"/>
                <a:gd name="T2" fmla="*/ 908 w 505"/>
                <a:gd name="T3" fmla="*/ 1488 h 118"/>
                <a:gd name="T4" fmla="*/ 1551 w 505"/>
                <a:gd name="T5" fmla="*/ 1543 h 118"/>
                <a:gd name="T6" fmla="*/ 1583 w 505"/>
                <a:gd name="T7" fmla="*/ 2225 h 118"/>
                <a:gd name="T8" fmla="*/ 2408 w 505"/>
                <a:gd name="T9" fmla="*/ 1245 h 118"/>
                <a:gd name="T10" fmla="*/ 3992 w 505"/>
                <a:gd name="T11" fmla="*/ 1416 h 118"/>
                <a:gd name="T12" fmla="*/ 5817 w 505"/>
                <a:gd name="T13" fmla="*/ 695 h 118"/>
                <a:gd name="T14" fmla="*/ 6850 w 505"/>
                <a:gd name="T15" fmla="*/ 772 h 118"/>
                <a:gd name="T16" fmla="*/ 7493 w 505"/>
                <a:gd name="T17" fmla="*/ 1974 h 118"/>
                <a:gd name="T18" fmla="*/ 7901 w 505"/>
                <a:gd name="T19" fmla="*/ 865 h 118"/>
                <a:gd name="T20" fmla="*/ 7318 w 505"/>
                <a:gd name="T21" fmla="*/ 149 h 118"/>
                <a:gd name="T22" fmla="*/ 7255 w 505"/>
                <a:gd name="T23" fmla="*/ 865 h 118"/>
                <a:gd name="T24" fmla="*/ 6525 w 505"/>
                <a:gd name="T25" fmla="*/ 56 h 118"/>
                <a:gd name="T26" fmla="*/ 5410 w 505"/>
                <a:gd name="T27" fmla="*/ 490 h 118"/>
                <a:gd name="T28" fmla="*/ 3379 w 505"/>
                <a:gd name="T29" fmla="*/ 1035 h 118"/>
                <a:gd name="T30" fmla="*/ 1813 w 505"/>
                <a:gd name="T31" fmla="*/ 1075 h 118"/>
                <a:gd name="T32" fmla="*/ 895 w 505"/>
                <a:gd name="T33" fmla="*/ 1283 h 118"/>
                <a:gd name="T34" fmla="*/ 0 w 505"/>
                <a:gd name="T35" fmla="*/ 1996 h 118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</a:gdLst>
              <a:ahLst/>
              <a:cxnLst>
                <a:cxn ang="T36">
                  <a:pos x="T0" y="T1"/>
                </a:cxn>
                <a:cxn ang="T37">
                  <a:pos x="T2" y="T3"/>
                </a:cxn>
                <a:cxn ang="T38">
                  <a:pos x="T4" y="T5"/>
                </a:cxn>
                <a:cxn ang="T39">
                  <a:pos x="T6" y="T7"/>
                </a:cxn>
                <a:cxn ang="T40">
                  <a:pos x="T8" y="T9"/>
                </a:cxn>
                <a:cxn ang="T41">
                  <a:pos x="T10" y="T11"/>
                </a:cxn>
                <a:cxn ang="T42">
                  <a:pos x="T12" y="T13"/>
                </a:cxn>
                <a:cxn ang="T43">
                  <a:pos x="T14" y="T15"/>
                </a:cxn>
                <a:cxn ang="T44">
                  <a:pos x="T16" y="T17"/>
                </a:cxn>
                <a:cxn ang="T45">
                  <a:pos x="T18" y="T19"/>
                </a:cxn>
                <a:cxn ang="T46">
                  <a:pos x="T20" y="T21"/>
                </a:cxn>
                <a:cxn ang="T47">
                  <a:pos x="T22" y="T23"/>
                </a:cxn>
                <a:cxn ang="T48">
                  <a:pos x="T24" y="T25"/>
                </a:cxn>
                <a:cxn ang="T49">
                  <a:pos x="T26" y="T27"/>
                </a:cxn>
                <a:cxn ang="T50">
                  <a:pos x="T28" y="T29"/>
                </a:cxn>
                <a:cxn ang="T51">
                  <a:pos x="T30" y="T31"/>
                </a:cxn>
                <a:cxn ang="T52">
                  <a:pos x="T32" y="T33"/>
                </a:cxn>
                <a:cxn ang="T53">
                  <a:pos x="T34" y="T35"/>
                </a:cxn>
              </a:cxnLst>
              <a:rect l="0" t="0" r="r" b="b"/>
              <a:pathLst>
                <a:path w="505" h="118">
                  <a:moveTo>
                    <a:pt x="0" y="106"/>
                  </a:moveTo>
                  <a:cubicBezTo>
                    <a:pt x="22" y="98"/>
                    <a:pt x="34" y="90"/>
                    <a:pt x="58" y="79"/>
                  </a:cubicBezTo>
                  <a:cubicBezTo>
                    <a:pt x="82" y="68"/>
                    <a:pt x="93" y="67"/>
                    <a:pt x="99" y="82"/>
                  </a:cubicBezTo>
                  <a:cubicBezTo>
                    <a:pt x="105" y="97"/>
                    <a:pt x="101" y="118"/>
                    <a:pt x="101" y="118"/>
                  </a:cubicBezTo>
                  <a:cubicBezTo>
                    <a:pt x="117" y="74"/>
                    <a:pt x="136" y="68"/>
                    <a:pt x="154" y="66"/>
                  </a:cubicBezTo>
                  <a:cubicBezTo>
                    <a:pt x="172" y="64"/>
                    <a:pt x="197" y="82"/>
                    <a:pt x="255" y="75"/>
                  </a:cubicBezTo>
                  <a:cubicBezTo>
                    <a:pt x="313" y="68"/>
                    <a:pt x="330" y="55"/>
                    <a:pt x="372" y="37"/>
                  </a:cubicBezTo>
                  <a:cubicBezTo>
                    <a:pt x="414" y="19"/>
                    <a:pt x="421" y="23"/>
                    <a:pt x="438" y="41"/>
                  </a:cubicBezTo>
                  <a:cubicBezTo>
                    <a:pt x="455" y="59"/>
                    <a:pt x="476" y="95"/>
                    <a:pt x="479" y="105"/>
                  </a:cubicBezTo>
                  <a:cubicBezTo>
                    <a:pt x="476" y="83"/>
                    <a:pt x="470" y="53"/>
                    <a:pt x="505" y="46"/>
                  </a:cubicBezTo>
                  <a:cubicBezTo>
                    <a:pt x="497" y="45"/>
                    <a:pt x="472" y="28"/>
                    <a:pt x="468" y="8"/>
                  </a:cubicBezTo>
                  <a:cubicBezTo>
                    <a:pt x="472" y="23"/>
                    <a:pt x="474" y="44"/>
                    <a:pt x="464" y="46"/>
                  </a:cubicBezTo>
                  <a:cubicBezTo>
                    <a:pt x="454" y="48"/>
                    <a:pt x="452" y="0"/>
                    <a:pt x="417" y="3"/>
                  </a:cubicBezTo>
                  <a:cubicBezTo>
                    <a:pt x="382" y="6"/>
                    <a:pt x="370" y="12"/>
                    <a:pt x="346" y="26"/>
                  </a:cubicBezTo>
                  <a:cubicBezTo>
                    <a:pt x="322" y="40"/>
                    <a:pt x="281" y="65"/>
                    <a:pt x="216" y="55"/>
                  </a:cubicBezTo>
                  <a:cubicBezTo>
                    <a:pt x="151" y="45"/>
                    <a:pt x="135" y="45"/>
                    <a:pt x="116" y="57"/>
                  </a:cubicBezTo>
                  <a:cubicBezTo>
                    <a:pt x="97" y="69"/>
                    <a:pt x="83" y="51"/>
                    <a:pt x="57" y="68"/>
                  </a:cubicBezTo>
                  <a:cubicBezTo>
                    <a:pt x="31" y="85"/>
                    <a:pt x="0" y="106"/>
                    <a:pt x="0" y="106"/>
                  </a:cubicBezTo>
                  <a:close/>
                </a:path>
              </a:pathLst>
            </a:custGeom>
            <a:solidFill>
              <a:srgbClr val="D6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8" name="Freeform 53"/>
            <p:cNvSpPr/>
            <p:nvPr/>
          </p:nvSpPr>
          <p:spPr bwMode="auto">
            <a:xfrm>
              <a:off x="2636" y="2177"/>
              <a:ext cx="430" cy="182"/>
            </a:xfrm>
            <a:custGeom>
              <a:avLst/>
              <a:gdLst>
                <a:gd name="T0" fmla="*/ 0 w 172"/>
                <a:gd name="T1" fmla="*/ 444 h 68"/>
                <a:gd name="T2" fmla="*/ 1188 w 172"/>
                <a:gd name="T3" fmla="*/ 1226 h 68"/>
                <a:gd name="T4" fmla="*/ 2458 w 172"/>
                <a:gd name="T5" fmla="*/ 731 h 68"/>
                <a:gd name="T6" fmla="*/ 2408 w 172"/>
                <a:gd name="T7" fmla="*/ 0 h 68"/>
                <a:gd name="T8" fmla="*/ 0 60000 65536"/>
                <a:gd name="T9" fmla="*/ 0 60000 65536"/>
                <a:gd name="T10" fmla="*/ 0 60000 65536"/>
                <a:gd name="T11" fmla="*/ 0 60000 6553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0" t="0" r="r" b="b"/>
              <a:pathLst>
                <a:path w="172" h="68">
                  <a:moveTo>
                    <a:pt x="0" y="23"/>
                  </a:moveTo>
                  <a:cubicBezTo>
                    <a:pt x="2" y="57"/>
                    <a:pt x="29" y="68"/>
                    <a:pt x="76" y="64"/>
                  </a:cubicBezTo>
                  <a:cubicBezTo>
                    <a:pt x="123" y="60"/>
                    <a:pt x="157" y="38"/>
                    <a:pt x="157" y="38"/>
                  </a:cubicBezTo>
                  <a:cubicBezTo>
                    <a:pt x="157" y="38"/>
                    <a:pt x="172" y="2"/>
                    <a:pt x="154" y="0"/>
                  </a:cubicBezTo>
                </a:path>
              </a:pathLst>
            </a:custGeom>
            <a:solidFill>
              <a:srgbClr val="D600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" name="Freeform 54"/>
            <p:cNvSpPr/>
            <p:nvPr/>
          </p:nvSpPr>
          <p:spPr bwMode="auto">
            <a:xfrm>
              <a:off x="2699" y="2239"/>
              <a:ext cx="325" cy="141"/>
            </a:xfrm>
            <a:custGeom>
              <a:avLst/>
              <a:gdLst>
                <a:gd name="T0" fmla="*/ 0 w 130"/>
                <a:gd name="T1" fmla="*/ 431 h 53"/>
                <a:gd name="T2" fmla="*/ 2033 w 130"/>
                <a:gd name="T3" fmla="*/ 0 h 53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130" h="53">
                  <a:moveTo>
                    <a:pt x="0" y="23"/>
                  </a:moveTo>
                  <a:cubicBezTo>
                    <a:pt x="29" y="36"/>
                    <a:pt x="116" y="53"/>
                    <a:pt x="130" y="0"/>
                  </a:cubicBezTo>
                </a:path>
              </a:pathLst>
            </a:custGeom>
            <a:solidFill>
              <a:srgbClr val="B9005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0" name="Freeform 55"/>
            <p:cNvSpPr/>
            <p:nvPr/>
          </p:nvSpPr>
          <p:spPr bwMode="auto">
            <a:xfrm>
              <a:off x="2604" y="2095"/>
              <a:ext cx="430" cy="224"/>
            </a:xfrm>
            <a:custGeom>
              <a:avLst/>
              <a:gdLst>
                <a:gd name="T0" fmla="*/ 188 w 172"/>
                <a:gd name="T1" fmla="*/ 605 h 84"/>
                <a:gd name="T2" fmla="*/ 1533 w 172"/>
                <a:gd name="T3" fmla="*/ 1515 h 84"/>
                <a:gd name="T4" fmla="*/ 2658 w 172"/>
                <a:gd name="T5" fmla="*/ 683 h 84"/>
                <a:gd name="T6" fmla="*/ 1438 w 172"/>
                <a:gd name="T7" fmla="*/ 227 h 84"/>
                <a:gd name="T8" fmla="*/ 188 w 172"/>
                <a:gd name="T9" fmla="*/ 605 h 8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72" h="84">
                  <a:moveTo>
                    <a:pt x="12" y="32"/>
                  </a:moveTo>
                  <a:cubicBezTo>
                    <a:pt x="0" y="82"/>
                    <a:pt x="58" y="84"/>
                    <a:pt x="98" y="80"/>
                  </a:cubicBezTo>
                  <a:cubicBezTo>
                    <a:pt x="138" y="76"/>
                    <a:pt x="172" y="64"/>
                    <a:pt x="170" y="36"/>
                  </a:cubicBezTo>
                  <a:cubicBezTo>
                    <a:pt x="168" y="8"/>
                    <a:pt x="126" y="20"/>
                    <a:pt x="92" y="12"/>
                  </a:cubicBezTo>
                  <a:cubicBezTo>
                    <a:pt x="58" y="4"/>
                    <a:pt x="22" y="0"/>
                    <a:pt x="12" y="32"/>
                  </a:cubicBezTo>
                  <a:close/>
                </a:path>
              </a:pathLst>
            </a:custGeom>
            <a:solidFill>
              <a:srgbClr val="80197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1" name="Freeform 56"/>
            <p:cNvSpPr/>
            <p:nvPr/>
          </p:nvSpPr>
          <p:spPr bwMode="auto">
            <a:xfrm>
              <a:off x="2314" y="1927"/>
              <a:ext cx="750" cy="370"/>
            </a:xfrm>
            <a:custGeom>
              <a:avLst/>
              <a:gdLst>
                <a:gd name="T0" fmla="*/ 113 w 300"/>
                <a:gd name="T1" fmla="*/ 2622 h 139"/>
                <a:gd name="T2" fmla="*/ 63 w 300"/>
                <a:gd name="T3" fmla="*/ 1680 h 139"/>
                <a:gd name="T4" fmla="*/ 270 w 300"/>
                <a:gd name="T5" fmla="*/ 1360 h 139"/>
                <a:gd name="T6" fmla="*/ 520 w 300"/>
                <a:gd name="T7" fmla="*/ 921 h 139"/>
                <a:gd name="T8" fmla="*/ 1238 w 300"/>
                <a:gd name="T9" fmla="*/ 751 h 139"/>
                <a:gd name="T10" fmla="*/ 1645 w 300"/>
                <a:gd name="T11" fmla="*/ 170 h 139"/>
                <a:gd name="T12" fmla="*/ 2363 w 300"/>
                <a:gd name="T13" fmla="*/ 418 h 139"/>
                <a:gd name="T14" fmla="*/ 3708 w 300"/>
                <a:gd name="T15" fmla="*/ 737 h 139"/>
                <a:gd name="T16" fmla="*/ 4688 w 300"/>
                <a:gd name="T17" fmla="*/ 998 h 139"/>
                <a:gd name="T18" fmla="*/ 3458 w 300"/>
                <a:gd name="T19" fmla="*/ 886 h 139"/>
                <a:gd name="T20" fmla="*/ 1833 w 300"/>
                <a:gd name="T21" fmla="*/ 793 h 139"/>
                <a:gd name="T22" fmla="*/ 750 w 300"/>
                <a:gd name="T23" fmla="*/ 1416 h 139"/>
                <a:gd name="T24" fmla="*/ 113 w 300"/>
                <a:gd name="T25" fmla="*/ 2622 h 139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  <a:gd name="T36" fmla="*/ 0 60000 65536"/>
                <a:gd name="T37" fmla="*/ 0 60000 65536"/>
                <a:gd name="T38" fmla="*/ 0 60000 65536"/>
              </a:gdLst>
              <a:ahLst/>
              <a:cxnLst>
                <a:cxn ang="T26">
                  <a:pos x="T0" y="T1"/>
                </a:cxn>
                <a:cxn ang="T27">
                  <a:pos x="T2" y="T3"/>
                </a:cxn>
                <a:cxn ang="T28">
                  <a:pos x="T4" y="T5"/>
                </a:cxn>
                <a:cxn ang="T29">
                  <a:pos x="T6" y="T7"/>
                </a:cxn>
                <a:cxn ang="T30">
                  <a:pos x="T8" y="T9"/>
                </a:cxn>
                <a:cxn ang="T31">
                  <a:pos x="T10" y="T11"/>
                </a:cxn>
                <a:cxn ang="T32">
                  <a:pos x="T12" y="T13"/>
                </a:cxn>
                <a:cxn ang="T33">
                  <a:pos x="T14" y="T15"/>
                </a:cxn>
                <a:cxn ang="T34">
                  <a:pos x="T16" y="T17"/>
                </a:cxn>
                <a:cxn ang="T35">
                  <a:pos x="T18" y="T19"/>
                </a:cxn>
                <a:cxn ang="T36">
                  <a:pos x="T20" y="T21"/>
                </a:cxn>
                <a:cxn ang="T37">
                  <a:pos x="T22" y="T23"/>
                </a:cxn>
                <a:cxn ang="T38">
                  <a:pos x="T24" y="T25"/>
                </a:cxn>
              </a:cxnLst>
              <a:rect l="0" t="0" r="r" b="b"/>
              <a:pathLst>
                <a:path w="300" h="139">
                  <a:moveTo>
                    <a:pt x="7" y="139"/>
                  </a:moveTo>
                  <a:cubicBezTo>
                    <a:pt x="15" y="115"/>
                    <a:pt x="8" y="99"/>
                    <a:pt x="4" y="89"/>
                  </a:cubicBezTo>
                  <a:cubicBezTo>
                    <a:pt x="0" y="79"/>
                    <a:pt x="4" y="80"/>
                    <a:pt x="17" y="72"/>
                  </a:cubicBezTo>
                  <a:cubicBezTo>
                    <a:pt x="30" y="64"/>
                    <a:pt x="25" y="57"/>
                    <a:pt x="33" y="49"/>
                  </a:cubicBezTo>
                  <a:cubicBezTo>
                    <a:pt x="41" y="41"/>
                    <a:pt x="50" y="54"/>
                    <a:pt x="79" y="40"/>
                  </a:cubicBezTo>
                  <a:cubicBezTo>
                    <a:pt x="108" y="26"/>
                    <a:pt x="94" y="18"/>
                    <a:pt x="105" y="9"/>
                  </a:cubicBezTo>
                  <a:cubicBezTo>
                    <a:pt x="116" y="0"/>
                    <a:pt x="125" y="9"/>
                    <a:pt x="151" y="22"/>
                  </a:cubicBezTo>
                  <a:cubicBezTo>
                    <a:pt x="177" y="35"/>
                    <a:pt x="206" y="37"/>
                    <a:pt x="237" y="39"/>
                  </a:cubicBezTo>
                  <a:cubicBezTo>
                    <a:pt x="268" y="41"/>
                    <a:pt x="291" y="51"/>
                    <a:pt x="300" y="53"/>
                  </a:cubicBezTo>
                  <a:cubicBezTo>
                    <a:pt x="276" y="48"/>
                    <a:pt x="253" y="46"/>
                    <a:pt x="221" y="47"/>
                  </a:cubicBezTo>
                  <a:cubicBezTo>
                    <a:pt x="189" y="48"/>
                    <a:pt x="146" y="27"/>
                    <a:pt x="117" y="42"/>
                  </a:cubicBezTo>
                  <a:cubicBezTo>
                    <a:pt x="88" y="57"/>
                    <a:pt x="78" y="59"/>
                    <a:pt x="48" y="75"/>
                  </a:cubicBezTo>
                  <a:cubicBezTo>
                    <a:pt x="18" y="91"/>
                    <a:pt x="26" y="116"/>
                    <a:pt x="7" y="139"/>
                  </a:cubicBezTo>
                  <a:close/>
                </a:path>
              </a:pathLst>
            </a:custGeom>
            <a:solidFill>
              <a:srgbClr val="F6BFC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2" name="Freeform 57"/>
            <p:cNvSpPr/>
            <p:nvPr/>
          </p:nvSpPr>
          <p:spPr bwMode="auto">
            <a:xfrm>
              <a:off x="2336" y="1980"/>
              <a:ext cx="328" cy="216"/>
            </a:xfrm>
            <a:custGeom>
              <a:avLst/>
              <a:gdLst>
                <a:gd name="T0" fmla="*/ 50 w 131"/>
                <a:gd name="T1" fmla="*/ 1288 h 81"/>
                <a:gd name="T2" fmla="*/ 83 w 131"/>
                <a:gd name="T3" fmla="*/ 1536 h 81"/>
                <a:gd name="T4" fmla="*/ 488 w 131"/>
                <a:gd name="T5" fmla="*/ 989 h 81"/>
                <a:gd name="T6" fmla="*/ 971 w 131"/>
                <a:gd name="T7" fmla="*/ 704 h 81"/>
                <a:gd name="T8" fmla="*/ 2056 w 131"/>
                <a:gd name="T9" fmla="*/ 171 h 81"/>
                <a:gd name="T10" fmla="*/ 1755 w 131"/>
                <a:gd name="T11" fmla="*/ 21 h 81"/>
                <a:gd name="T12" fmla="*/ 1585 w 131"/>
                <a:gd name="T13" fmla="*/ 136 h 81"/>
                <a:gd name="T14" fmla="*/ 992 w 131"/>
                <a:gd name="T15" fmla="*/ 533 h 81"/>
                <a:gd name="T16" fmla="*/ 709 w 131"/>
                <a:gd name="T17" fmla="*/ 704 h 81"/>
                <a:gd name="T18" fmla="*/ 426 w 131"/>
                <a:gd name="T19" fmla="*/ 760 h 81"/>
                <a:gd name="T20" fmla="*/ 238 w 131"/>
                <a:gd name="T21" fmla="*/ 1059 h 81"/>
                <a:gd name="T22" fmla="*/ 0 w 131"/>
                <a:gd name="T23" fmla="*/ 1272 h 81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60000 65536"/>
                <a:gd name="T31" fmla="*/ 0 60000 65536"/>
                <a:gd name="T32" fmla="*/ 0 60000 65536"/>
                <a:gd name="T33" fmla="*/ 0 60000 65536"/>
                <a:gd name="T34" fmla="*/ 0 60000 65536"/>
                <a:gd name="T35" fmla="*/ 0 60000 65536"/>
              </a:gdLst>
              <a:ahLst/>
              <a:cxnLst>
                <a:cxn ang="T24">
                  <a:pos x="T0" y="T1"/>
                </a:cxn>
                <a:cxn ang="T25">
                  <a:pos x="T2" y="T3"/>
                </a:cxn>
                <a:cxn ang="T26">
                  <a:pos x="T4" y="T5"/>
                </a:cxn>
                <a:cxn ang="T27">
                  <a:pos x="T6" y="T7"/>
                </a:cxn>
                <a:cxn ang="T28">
                  <a:pos x="T8" y="T9"/>
                </a:cxn>
                <a:cxn ang="T29">
                  <a:pos x="T10" y="T11"/>
                </a:cxn>
                <a:cxn ang="T30">
                  <a:pos x="T12" y="T13"/>
                </a:cxn>
                <a:cxn ang="T31">
                  <a:pos x="T14" y="T15"/>
                </a:cxn>
                <a:cxn ang="T32">
                  <a:pos x="T16" y="T17"/>
                </a:cxn>
                <a:cxn ang="T33">
                  <a:pos x="T18" y="T19"/>
                </a:cxn>
                <a:cxn ang="T34">
                  <a:pos x="T20" y="T21"/>
                </a:cxn>
                <a:cxn ang="T35">
                  <a:pos x="T22" y="T23"/>
                </a:cxn>
              </a:cxnLst>
              <a:rect l="0" t="0" r="r" b="b"/>
              <a:pathLst>
                <a:path w="131" h="81">
                  <a:moveTo>
                    <a:pt x="3" y="68"/>
                  </a:moveTo>
                  <a:cubicBezTo>
                    <a:pt x="4" y="72"/>
                    <a:pt x="5" y="77"/>
                    <a:pt x="5" y="81"/>
                  </a:cubicBezTo>
                  <a:cubicBezTo>
                    <a:pt x="14" y="70"/>
                    <a:pt x="18" y="60"/>
                    <a:pt x="31" y="52"/>
                  </a:cubicBezTo>
                  <a:cubicBezTo>
                    <a:pt x="41" y="46"/>
                    <a:pt x="52" y="42"/>
                    <a:pt x="62" y="37"/>
                  </a:cubicBezTo>
                  <a:cubicBezTo>
                    <a:pt x="84" y="27"/>
                    <a:pt x="106" y="9"/>
                    <a:pt x="131" y="9"/>
                  </a:cubicBezTo>
                  <a:cubicBezTo>
                    <a:pt x="125" y="7"/>
                    <a:pt x="118" y="2"/>
                    <a:pt x="112" y="1"/>
                  </a:cubicBezTo>
                  <a:cubicBezTo>
                    <a:pt x="104" y="0"/>
                    <a:pt x="106" y="1"/>
                    <a:pt x="101" y="7"/>
                  </a:cubicBezTo>
                  <a:cubicBezTo>
                    <a:pt x="91" y="18"/>
                    <a:pt x="76" y="21"/>
                    <a:pt x="63" y="28"/>
                  </a:cubicBezTo>
                  <a:cubicBezTo>
                    <a:pt x="57" y="31"/>
                    <a:pt x="52" y="36"/>
                    <a:pt x="45" y="37"/>
                  </a:cubicBezTo>
                  <a:cubicBezTo>
                    <a:pt x="38" y="38"/>
                    <a:pt x="34" y="35"/>
                    <a:pt x="27" y="40"/>
                  </a:cubicBezTo>
                  <a:cubicBezTo>
                    <a:pt x="22" y="44"/>
                    <a:pt x="20" y="51"/>
                    <a:pt x="15" y="56"/>
                  </a:cubicBezTo>
                  <a:cubicBezTo>
                    <a:pt x="11" y="60"/>
                    <a:pt x="5" y="63"/>
                    <a:pt x="0" y="67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" name="Freeform 58"/>
            <p:cNvSpPr/>
            <p:nvPr/>
          </p:nvSpPr>
          <p:spPr bwMode="auto">
            <a:xfrm>
              <a:off x="2459" y="2220"/>
              <a:ext cx="867" cy="208"/>
            </a:xfrm>
            <a:custGeom>
              <a:avLst/>
              <a:gdLst>
                <a:gd name="T0" fmla="*/ 0 w 347"/>
                <a:gd name="T1" fmla="*/ 1480 h 78"/>
                <a:gd name="T2" fmla="*/ 842 w 347"/>
                <a:gd name="T3" fmla="*/ 1024 h 78"/>
                <a:gd name="T4" fmla="*/ 2946 w 347"/>
                <a:gd name="T5" fmla="*/ 989 h 78"/>
                <a:gd name="T6" fmla="*/ 4757 w 347"/>
                <a:gd name="T7" fmla="*/ 248 h 78"/>
                <a:gd name="T8" fmla="*/ 5412 w 347"/>
                <a:gd name="T9" fmla="*/ 1045 h 78"/>
                <a:gd name="T10" fmla="*/ 4745 w 347"/>
                <a:gd name="T11" fmla="*/ 21 h 78"/>
                <a:gd name="T12" fmla="*/ 3291 w 347"/>
                <a:gd name="T13" fmla="*/ 589 h 78"/>
                <a:gd name="T14" fmla="*/ 1229 w 347"/>
                <a:gd name="T15" fmla="*/ 875 h 78"/>
                <a:gd name="T16" fmla="*/ 0 w 347"/>
                <a:gd name="T17" fmla="*/ 1480 h 78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347" h="78">
                  <a:moveTo>
                    <a:pt x="0" y="78"/>
                  </a:moveTo>
                  <a:cubicBezTo>
                    <a:pt x="19" y="59"/>
                    <a:pt x="24" y="47"/>
                    <a:pt x="54" y="54"/>
                  </a:cubicBezTo>
                  <a:cubicBezTo>
                    <a:pt x="84" y="61"/>
                    <a:pt x="124" y="72"/>
                    <a:pt x="189" y="52"/>
                  </a:cubicBezTo>
                  <a:cubicBezTo>
                    <a:pt x="254" y="32"/>
                    <a:pt x="282" y="7"/>
                    <a:pt x="305" y="13"/>
                  </a:cubicBezTo>
                  <a:cubicBezTo>
                    <a:pt x="328" y="19"/>
                    <a:pt x="341" y="45"/>
                    <a:pt x="347" y="55"/>
                  </a:cubicBezTo>
                  <a:cubicBezTo>
                    <a:pt x="343" y="34"/>
                    <a:pt x="317" y="2"/>
                    <a:pt x="304" y="1"/>
                  </a:cubicBezTo>
                  <a:cubicBezTo>
                    <a:pt x="291" y="0"/>
                    <a:pt x="240" y="18"/>
                    <a:pt x="211" y="31"/>
                  </a:cubicBezTo>
                  <a:cubicBezTo>
                    <a:pt x="182" y="44"/>
                    <a:pt x="109" y="54"/>
                    <a:pt x="79" y="46"/>
                  </a:cubicBezTo>
                  <a:cubicBezTo>
                    <a:pt x="49" y="38"/>
                    <a:pt x="16" y="46"/>
                    <a:pt x="0" y="78"/>
                  </a:cubicBezTo>
                  <a:close/>
                </a:path>
              </a:pathLst>
            </a:custGeom>
            <a:solidFill>
              <a:srgbClr val="B9005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4" name="Freeform 59"/>
            <p:cNvSpPr/>
            <p:nvPr/>
          </p:nvSpPr>
          <p:spPr bwMode="auto">
            <a:xfrm>
              <a:off x="2644" y="2103"/>
              <a:ext cx="315" cy="162"/>
            </a:xfrm>
            <a:custGeom>
              <a:avLst/>
              <a:gdLst>
                <a:gd name="T0" fmla="*/ 1970 w 126"/>
                <a:gd name="T1" fmla="*/ 353 h 61"/>
                <a:gd name="T2" fmla="*/ 1125 w 126"/>
                <a:gd name="T3" fmla="*/ 247 h 61"/>
                <a:gd name="T4" fmla="*/ 20 w 126"/>
                <a:gd name="T5" fmla="*/ 656 h 61"/>
                <a:gd name="T6" fmla="*/ 145 w 126"/>
                <a:gd name="T7" fmla="*/ 1142 h 61"/>
                <a:gd name="T8" fmla="*/ 583 w 126"/>
                <a:gd name="T9" fmla="*/ 451 h 61"/>
                <a:gd name="T10" fmla="*/ 1970 w 126"/>
                <a:gd name="T11" fmla="*/ 353 h 61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0" t="0" r="r" b="b"/>
              <a:pathLst>
                <a:path w="126" h="61">
                  <a:moveTo>
                    <a:pt x="126" y="19"/>
                  </a:moveTo>
                  <a:cubicBezTo>
                    <a:pt x="105" y="18"/>
                    <a:pt x="94" y="17"/>
                    <a:pt x="72" y="13"/>
                  </a:cubicBezTo>
                  <a:cubicBezTo>
                    <a:pt x="49" y="8"/>
                    <a:pt x="9" y="0"/>
                    <a:pt x="1" y="35"/>
                  </a:cubicBezTo>
                  <a:cubicBezTo>
                    <a:pt x="0" y="45"/>
                    <a:pt x="6" y="54"/>
                    <a:pt x="9" y="61"/>
                  </a:cubicBezTo>
                  <a:cubicBezTo>
                    <a:pt x="5" y="46"/>
                    <a:pt x="19" y="30"/>
                    <a:pt x="37" y="24"/>
                  </a:cubicBezTo>
                  <a:cubicBezTo>
                    <a:pt x="55" y="17"/>
                    <a:pt x="108" y="29"/>
                    <a:pt x="126" y="19"/>
                  </a:cubicBezTo>
                  <a:close/>
                </a:path>
              </a:pathLst>
            </a:custGeom>
            <a:solidFill>
              <a:srgbClr val="B789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5" name="Freeform 60"/>
            <p:cNvSpPr/>
            <p:nvPr/>
          </p:nvSpPr>
          <p:spPr bwMode="auto">
            <a:xfrm>
              <a:off x="2714" y="2156"/>
              <a:ext cx="310" cy="152"/>
            </a:xfrm>
            <a:custGeom>
              <a:avLst/>
              <a:gdLst>
                <a:gd name="T0" fmla="*/ 0 w 124"/>
                <a:gd name="T1" fmla="*/ 947 h 57"/>
                <a:gd name="T2" fmla="*/ 1908 w 124"/>
                <a:gd name="T3" fmla="*/ 264 h 57"/>
                <a:gd name="T4" fmla="*/ 1708 w 124"/>
                <a:gd name="T5" fmla="*/ 0 h 57"/>
                <a:gd name="T6" fmla="*/ 1395 w 124"/>
                <a:gd name="T7" fmla="*/ 605 h 57"/>
                <a:gd name="T8" fmla="*/ 0 w 124"/>
                <a:gd name="T9" fmla="*/ 947 h 5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24" h="57">
                  <a:moveTo>
                    <a:pt x="0" y="50"/>
                  </a:moveTo>
                  <a:cubicBezTo>
                    <a:pt x="35" y="57"/>
                    <a:pt x="118" y="55"/>
                    <a:pt x="122" y="14"/>
                  </a:cubicBezTo>
                  <a:cubicBezTo>
                    <a:pt x="124" y="3"/>
                    <a:pt x="109" y="0"/>
                    <a:pt x="109" y="0"/>
                  </a:cubicBezTo>
                  <a:cubicBezTo>
                    <a:pt x="116" y="8"/>
                    <a:pt x="119" y="18"/>
                    <a:pt x="89" y="32"/>
                  </a:cubicBezTo>
                  <a:cubicBezTo>
                    <a:pt x="60" y="45"/>
                    <a:pt x="8" y="50"/>
                    <a:pt x="0" y="50"/>
                  </a:cubicBezTo>
                  <a:close/>
                </a:path>
              </a:pathLst>
            </a:custGeom>
            <a:solidFill>
              <a:srgbClr val="6B136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6" name="Freeform 61"/>
            <p:cNvSpPr/>
            <p:nvPr/>
          </p:nvSpPr>
          <p:spPr bwMode="auto">
            <a:xfrm>
              <a:off x="2651" y="2121"/>
              <a:ext cx="128" cy="88"/>
            </a:xfrm>
            <a:custGeom>
              <a:avLst/>
              <a:gdLst>
                <a:gd name="T0" fmla="*/ 806 w 51"/>
                <a:gd name="T1" fmla="*/ 35 h 33"/>
                <a:gd name="T2" fmla="*/ 0 w 51"/>
                <a:gd name="T3" fmla="*/ 627 h 33"/>
                <a:gd name="T4" fmla="*/ 806 w 51"/>
                <a:gd name="T5" fmla="*/ 35 h 3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51" h="33">
                  <a:moveTo>
                    <a:pt x="51" y="2"/>
                  </a:moveTo>
                  <a:cubicBezTo>
                    <a:pt x="30" y="0"/>
                    <a:pt x="0" y="2"/>
                    <a:pt x="0" y="33"/>
                  </a:cubicBezTo>
                  <a:cubicBezTo>
                    <a:pt x="8" y="17"/>
                    <a:pt x="31" y="0"/>
                    <a:pt x="51" y="2"/>
                  </a:cubicBezTo>
                  <a:close/>
                </a:path>
              </a:pathLst>
            </a:custGeom>
            <a:solidFill>
              <a:srgbClr val="E7DAE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7" name="Freeform 62"/>
            <p:cNvSpPr/>
            <p:nvPr/>
          </p:nvSpPr>
          <p:spPr bwMode="auto">
            <a:xfrm>
              <a:off x="2661" y="1999"/>
              <a:ext cx="25" cy="16"/>
            </a:xfrm>
            <a:custGeom>
              <a:avLst/>
              <a:gdLst>
                <a:gd name="T0" fmla="*/ 83 w 10"/>
                <a:gd name="T1" fmla="*/ 0 h 6"/>
                <a:gd name="T2" fmla="*/ 158 w 10"/>
                <a:gd name="T3" fmla="*/ 115 h 6"/>
                <a:gd name="T4" fmla="*/ 95 w 10"/>
                <a:gd name="T5" fmla="*/ 21 h 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0" h="6">
                  <a:moveTo>
                    <a:pt x="5" y="0"/>
                  </a:moveTo>
                  <a:cubicBezTo>
                    <a:pt x="0" y="4"/>
                    <a:pt x="6" y="6"/>
                    <a:pt x="10" y="6"/>
                  </a:cubicBezTo>
                  <a:cubicBezTo>
                    <a:pt x="10" y="4"/>
                    <a:pt x="8" y="2"/>
                    <a:pt x="6" y="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8" name="Freeform 63"/>
            <p:cNvSpPr/>
            <p:nvPr/>
          </p:nvSpPr>
          <p:spPr bwMode="auto">
            <a:xfrm>
              <a:off x="1989" y="1783"/>
              <a:ext cx="1585" cy="858"/>
            </a:xfrm>
            <a:custGeom>
              <a:avLst/>
              <a:gdLst>
                <a:gd name="T0" fmla="*/ 3113 w 634"/>
                <a:gd name="T1" fmla="*/ 0 h 322"/>
                <a:gd name="T2" fmla="*/ 3470 w 634"/>
                <a:gd name="T3" fmla="*/ 1386 h 322"/>
                <a:gd name="T4" fmla="*/ 2675 w 634"/>
                <a:gd name="T5" fmla="*/ 1740 h 322"/>
                <a:gd name="T6" fmla="*/ 2020 w 634"/>
                <a:gd name="T7" fmla="*/ 1100 h 322"/>
                <a:gd name="T8" fmla="*/ 2050 w 634"/>
                <a:gd name="T9" fmla="*/ 2363 h 322"/>
                <a:gd name="T10" fmla="*/ 675 w 634"/>
                <a:gd name="T11" fmla="*/ 2401 h 322"/>
                <a:gd name="T12" fmla="*/ 1908 w 634"/>
                <a:gd name="T13" fmla="*/ 2726 h 322"/>
                <a:gd name="T14" fmla="*/ 1425 w 634"/>
                <a:gd name="T15" fmla="*/ 4522 h 322"/>
                <a:gd name="T16" fmla="*/ 0 w 634"/>
                <a:gd name="T17" fmla="*/ 5788 h 322"/>
                <a:gd name="T18" fmla="*/ 2125 w 634"/>
                <a:gd name="T19" fmla="*/ 4487 h 322"/>
                <a:gd name="T20" fmla="*/ 2583 w 634"/>
                <a:gd name="T21" fmla="*/ 6091 h 322"/>
                <a:gd name="T22" fmla="*/ 3720 w 634"/>
                <a:gd name="T23" fmla="*/ 4274 h 322"/>
                <a:gd name="T24" fmla="*/ 6083 w 634"/>
                <a:gd name="T25" fmla="*/ 4218 h 322"/>
                <a:gd name="T26" fmla="*/ 7720 w 634"/>
                <a:gd name="T27" fmla="*/ 3579 h 322"/>
                <a:gd name="T28" fmla="*/ 8863 w 634"/>
                <a:gd name="T29" fmla="*/ 5468 h 322"/>
                <a:gd name="T30" fmla="*/ 9908 w 634"/>
                <a:gd name="T31" fmla="*/ 3805 h 322"/>
                <a:gd name="T32" fmla="*/ 8625 w 634"/>
                <a:gd name="T33" fmla="*/ 3080 h 322"/>
                <a:gd name="T34" fmla="*/ 9533 w 634"/>
                <a:gd name="T35" fmla="*/ 661 h 322"/>
                <a:gd name="T36" fmla="*/ 8595 w 634"/>
                <a:gd name="T37" fmla="*/ 1386 h 322"/>
                <a:gd name="T38" fmla="*/ 7908 w 634"/>
                <a:gd name="T39" fmla="*/ 1966 h 322"/>
                <a:gd name="T40" fmla="*/ 6113 w 634"/>
                <a:gd name="T41" fmla="*/ 1740 h 322"/>
                <a:gd name="T42" fmla="*/ 3988 w 634"/>
                <a:gd name="T43" fmla="*/ 930 h 322"/>
                <a:gd name="T44" fmla="*/ 3113 w 634"/>
                <a:gd name="T45" fmla="*/ 0 h 322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60000 65536"/>
                <a:gd name="T55" fmla="*/ 0 60000 65536"/>
                <a:gd name="T56" fmla="*/ 0 60000 65536"/>
                <a:gd name="T57" fmla="*/ 0 60000 65536"/>
                <a:gd name="T58" fmla="*/ 0 60000 65536"/>
                <a:gd name="T59" fmla="*/ 0 60000 65536"/>
                <a:gd name="T60" fmla="*/ 0 60000 65536"/>
                <a:gd name="T61" fmla="*/ 0 60000 65536"/>
                <a:gd name="T62" fmla="*/ 0 60000 65536"/>
                <a:gd name="T63" fmla="*/ 0 60000 65536"/>
                <a:gd name="T64" fmla="*/ 0 60000 65536"/>
                <a:gd name="T65" fmla="*/ 0 60000 65536"/>
                <a:gd name="T66" fmla="*/ 0 60000 65536"/>
                <a:gd name="T67" fmla="*/ 0 60000 65536"/>
                <a:gd name="T68" fmla="*/ 0 60000 65536"/>
              </a:gdLst>
              <a:ahLst/>
              <a:cxnLst>
                <a:cxn ang="T46">
                  <a:pos x="T0" y="T1"/>
                </a:cxn>
                <a:cxn ang="T47">
                  <a:pos x="T2" y="T3"/>
                </a:cxn>
                <a:cxn ang="T48">
                  <a:pos x="T4" y="T5"/>
                </a:cxn>
                <a:cxn ang="T49">
                  <a:pos x="T6" y="T7"/>
                </a:cxn>
                <a:cxn ang="T50">
                  <a:pos x="T8" y="T9"/>
                </a:cxn>
                <a:cxn ang="T51">
                  <a:pos x="T10" y="T11"/>
                </a:cxn>
                <a:cxn ang="T52">
                  <a:pos x="T12" y="T13"/>
                </a:cxn>
                <a:cxn ang="T53">
                  <a:pos x="T14" y="T15"/>
                </a:cxn>
                <a:cxn ang="T54">
                  <a:pos x="T16" y="T17"/>
                </a:cxn>
                <a:cxn ang="T55">
                  <a:pos x="T18" y="T19"/>
                </a:cxn>
                <a:cxn ang="T56">
                  <a:pos x="T20" y="T21"/>
                </a:cxn>
                <a:cxn ang="T57">
                  <a:pos x="T22" y="T23"/>
                </a:cxn>
                <a:cxn ang="T58">
                  <a:pos x="T24" y="T25"/>
                </a:cxn>
                <a:cxn ang="T59">
                  <a:pos x="T26" y="T27"/>
                </a:cxn>
                <a:cxn ang="T60">
                  <a:pos x="T28" y="T29"/>
                </a:cxn>
                <a:cxn ang="T61">
                  <a:pos x="T30" y="T31"/>
                </a:cxn>
                <a:cxn ang="T62">
                  <a:pos x="T32" y="T33"/>
                </a:cxn>
                <a:cxn ang="T63">
                  <a:pos x="T34" y="T35"/>
                </a:cxn>
                <a:cxn ang="T64">
                  <a:pos x="T36" y="T37"/>
                </a:cxn>
                <a:cxn ang="T65">
                  <a:pos x="T38" y="T39"/>
                </a:cxn>
                <a:cxn ang="T66">
                  <a:pos x="T40" y="T41"/>
                </a:cxn>
                <a:cxn ang="T67">
                  <a:pos x="T42" y="T43"/>
                </a:cxn>
                <a:cxn ang="T68">
                  <a:pos x="T44" y="T45"/>
                </a:cxn>
              </a:cxnLst>
              <a:rect l="0" t="0" r="r" b="b"/>
              <a:pathLst>
                <a:path w="634" h="322">
                  <a:moveTo>
                    <a:pt x="199" y="0"/>
                  </a:moveTo>
                  <a:cubicBezTo>
                    <a:pt x="212" y="13"/>
                    <a:pt x="239" y="31"/>
                    <a:pt x="222" y="73"/>
                  </a:cubicBezTo>
                  <a:cubicBezTo>
                    <a:pt x="217" y="88"/>
                    <a:pt x="194" y="98"/>
                    <a:pt x="171" y="92"/>
                  </a:cubicBezTo>
                  <a:cubicBezTo>
                    <a:pt x="153" y="87"/>
                    <a:pt x="134" y="68"/>
                    <a:pt x="129" y="58"/>
                  </a:cubicBezTo>
                  <a:cubicBezTo>
                    <a:pt x="140" y="76"/>
                    <a:pt x="168" y="118"/>
                    <a:pt x="131" y="125"/>
                  </a:cubicBezTo>
                  <a:cubicBezTo>
                    <a:pt x="105" y="130"/>
                    <a:pt x="67" y="150"/>
                    <a:pt x="43" y="127"/>
                  </a:cubicBezTo>
                  <a:cubicBezTo>
                    <a:pt x="51" y="159"/>
                    <a:pt x="113" y="133"/>
                    <a:pt x="122" y="144"/>
                  </a:cubicBezTo>
                  <a:cubicBezTo>
                    <a:pt x="153" y="177"/>
                    <a:pt x="118" y="224"/>
                    <a:pt x="91" y="239"/>
                  </a:cubicBezTo>
                  <a:cubicBezTo>
                    <a:pt x="56" y="258"/>
                    <a:pt x="29" y="278"/>
                    <a:pt x="0" y="306"/>
                  </a:cubicBezTo>
                  <a:cubicBezTo>
                    <a:pt x="35" y="276"/>
                    <a:pt x="94" y="259"/>
                    <a:pt x="136" y="237"/>
                  </a:cubicBezTo>
                  <a:cubicBezTo>
                    <a:pt x="194" y="206"/>
                    <a:pt x="164" y="286"/>
                    <a:pt x="165" y="322"/>
                  </a:cubicBezTo>
                  <a:cubicBezTo>
                    <a:pt x="166" y="297"/>
                    <a:pt x="205" y="213"/>
                    <a:pt x="238" y="226"/>
                  </a:cubicBezTo>
                  <a:cubicBezTo>
                    <a:pt x="280" y="241"/>
                    <a:pt x="351" y="234"/>
                    <a:pt x="389" y="223"/>
                  </a:cubicBezTo>
                  <a:cubicBezTo>
                    <a:pt x="427" y="212"/>
                    <a:pt x="464" y="179"/>
                    <a:pt x="494" y="189"/>
                  </a:cubicBezTo>
                  <a:cubicBezTo>
                    <a:pt x="524" y="199"/>
                    <a:pt x="547" y="252"/>
                    <a:pt x="567" y="289"/>
                  </a:cubicBezTo>
                  <a:cubicBezTo>
                    <a:pt x="538" y="197"/>
                    <a:pt x="573" y="197"/>
                    <a:pt x="634" y="201"/>
                  </a:cubicBezTo>
                  <a:cubicBezTo>
                    <a:pt x="602" y="184"/>
                    <a:pt x="573" y="196"/>
                    <a:pt x="552" y="163"/>
                  </a:cubicBezTo>
                  <a:cubicBezTo>
                    <a:pt x="519" y="110"/>
                    <a:pt x="576" y="49"/>
                    <a:pt x="610" y="35"/>
                  </a:cubicBezTo>
                  <a:cubicBezTo>
                    <a:pt x="585" y="43"/>
                    <a:pt x="569" y="56"/>
                    <a:pt x="550" y="73"/>
                  </a:cubicBezTo>
                  <a:cubicBezTo>
                    <a:pt x="536" y="85"/>
                    <a:pt x="524" y="98"/>
                    <a:pt x="506" y="104"/>
                  </a:cubicBezTo>
                  <a:cubicBezTo>
                    <a:pt x="472" y="115"/>
                    <a:pt x="425" y="98"/>
                    <a:pt x="391" y="92"/>
                  </a:cubicBezTo>
                  <a:cubicBezTo>
                    <a:pt x="339" y="82"/>
                    <a:pt x="293" y="86"/>
                    <a:pt x="255" y="49"/>
                  </a:cubicBezTo>
                  <a:cubicBezTo>
                    <a:pt x="237" y="33"/>
                    <a:pt x="233" y="20"/>
                    <a:pt x="199" y="0"/>
                  </a:cubicBezTo>
                  <a:close/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9" name="Freeform 64"/>
            <p:cNvSpPr/>
            <p:nvPr/>
          </p:nvSpPr>
          <p:spPr bwMode="auto">
            <a:xfrm>
              <a:off x="2604" y="2095"/>
              <a:ext cx="430" cy="224"/>
            </a:xfrm>
            <a:custGeom>
              <a:avLst/>
              <a:gdLst>
                <a:gd name="T0" fmla="*/ 188 w 172"/>
                <a:gd name="T1" fmla="*/ 605 h 84"/>
                <a:gd name="T2" fmla="*/ 1533 w 172"/>
                <a:gd name="T3" fmla="*/ 1515 h 84"/>
                <a:gd name="T4" fmla="*/ 2658 w 172"/>
                <a:gd name="T5" fmla="*/ 683 h 84"/>
                <a:gd name="T6" fmla="*/ 1438 w 172"/>
                <a:gd name="T7" fmla="*/ 227 h 84"/>
                <a:gd name="T8" fmla="*/ 188 w 172"/>
                <a:gd name="T9" fmla="*/ 605 h 8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72" h="84">
                  <a:moveTo>
                    <a:pt x="12" y="32"/>
                  </a:moveTo>
                  <a:cubicBezTo>
                    <a:pt x="0" y="82"/>
                    <a:pt x="58" y="84"/>
                    <a:pt x="98" y="80"/>
                  </a:cubicBezTo>
                  <a:cubicBezTo>
                    <a:pt x="138" y="76"/>
                    <a:pt x="172" y="64"/>
                    <a:pt x="170" y="36"/>
                  </a:cubicBezTo>
                  <a:cubicBezTo>
                    <a:pt x="168" y="8"/>
                    <a:pt x="126" y="20"/>
                    <a:pt x="92" y="12"/>
                  </a:cubicBezTo>
                  <a:cubicBezTo>
                    <a:pt x="58" y="4"/>
                    <a:pt x="22" y="0"/>
                    <a:pt x="12" y="32"/>
                  </a:cubicBezTo>
                  <a:close/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20" name="Freeform 65"/>
            <p:cNvSpPr/>
            <p:nvPr/>
          </p:nvSpPr>
          <p:spPr bwMode="auto">
            <a:xfrm>
              <a:off x="2386" y="1751"/>
              <a:ext cx="105" cy="34"/>
            </a:xfrm>
            <a:custGeom>
              <a:avLst/>
              <a:gdLst>
                <a:gd name="T0" fmla="*/ 0 w 42"/>
                <a:gd name="T1" fmla="*/ 0 h 13"/>
                <a:gd name="T2" fmla="*/ 658 w 42"/>
                <a:gd name="T3" fmla="*/ 233 h 13"/>
                <a:gd name="T4" fmla="*/ 0 60000 65536"/>
                <a:gd name="T5" fmla="*/ 0 60000 65536"/>
              </a:gdLst>
              <a:ahLst/>
              <a:cxnLst>
                <a:cxn ang="T4">
                  <a:pos x="T0" y="T1"/>
                </a:cxn>
                <a:cxn ang="T5">
                  <a:pos x="T2" y="T3"/>
                </a:cxn>
              </a:cxnLst>
              <a:rect l="0" t="0" r="r" b="b"/>
              <a:pathLst>
                <a:path w="42" h="13">
                  <a:moveTo>
                    <a:pt x="0" y="0"/>
                  </a:moveTo>
                  <a:cubicBezTo>
                    <a:pt x="16" y="1"/>
                    <a:pt x="33" y="5"/>
                    <a:pt x="42" y="13"/>
                  </a:cubicBezTo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21" name="Oval 66"/>
            <p:cNvSpPr>
              <a:spLocks noChangeArrowheads="1"/>
            </p:cNvSpPr>
            <p:nvPr/>
          </p:nvSpPr>
          <p:spPr bwMode="auto">
            <a:xfrm>
              <a:off x="2636" y="2108"/>
              <a:ext cx="38" cy="40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pPr eaLnBrk="1" hangingPunct="1"/>
              <a:endParaRPr lang="zh-CN"/>
            </a:p>
          </p:txBody>
        </p:sp>
        <p:sp>
          <p:nvSpPr>
            <p:cNvPr id="22" name="Oval 67"/>
            <p:cNvSpPr>
              <a:spLocks noChangeArrowheads="1"/>
            </p:cNvSpPr>
            <p:nvPr/>
          </p:nvSpPr>
          <p:spPr bwMode="auto">
            <a:xfrm>
              <a:off x="2681" y="2103"/>
              <a:ext cx="20" cy="21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pPr eaLnBrk="1" hangingPunct="1"/>
              <a:endParaRPr lang="zh-CN"/>
            </a:p>
          </p:txBody>
        </p:sp>
        <p:sp>
          <p:nvSpPr>
            <p:cNvPr id="23" name="Oval 68"/>
            <p:cNvSpPr>
              <a:spLocks noChangeArrowheads="1"/>
            </p:cNvSpPr>
            <p:nvPr/>
          </p:nvSpPr>
          <p:spPr bwMode="auto">
            <a:xfrm>
              <a:off x="2626" y="2151"/>
              <a:ext cx="20" cy="24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pPr eaLnBrk="1" hangingPunct="1"/>
              <a:endParaRPr lang="zh-CN"/>
            </a:p>
          </p:txBody>
        </p:sp>
      </p:grpSp>
      <p:grpSp>
        <p:nvGrpSpPr>
          <p:cNvPr id="42" name="组合 41"/>
          <p:cNvGrpSpPr/>
          <p:nvPr/>
        </p:nvGrpSpPr>
        <p:grpSpPr>
          <a:xfrm>
            <a:off x="7052922" y="3573005"/>
            <a:ext cx="1444625" cy="1473200"/>
            <a:chOff x="8380185" y="4045379"/>
            <a:chExt cx="1444625" cy="1473200"/>
          </a:xfrm>
        </p:grpSpPr>
        <p:sp>
          <p:nvSpPr>
            <p:cNvPr id="43" name="Freeform 58"/>
            <p:cNvSpPr/>
            <p:nvPr/>
          </p:nvSpPr>
          <p:spPr bwMode="auto">
            <a:xfrm>
              <a:off x="8380185" y="4045379"/>
              <a:ext cx="1444625" cy="1473200"/>
            </a:xfrm>
            <a:custGeom>
              <a:avLst/>
              <a:gdLst>
                <a:gd name="T0" fmla="*/ 2813 w 364"/>
                <a:gd name="T1" fmla="*/ 0 h 348"/>
                <a:gd name="T2" fmla="*/ 33 w 364"/>
                <a:gd name="T3" fmla="*/ 3299 h 348"/>
                <a:gd name="T4" fmla="*/ 2750 w 364"/>
                <a:gd name="T5" fmla="*/ 6600 h 348"/>
                <a:gd name="T6" fmla="*/ 5658 w 364"/>
                <a:gd name="T7" fmla="*/ 3299 h 348"/>
                <a:gd name="T8" fmla="*/ 2813 w 364"/>
                <a:gd name="T9" fmla="*/ 0 h 34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64" h="348">
                  <a:moveTo>
                    <a:pt x="180" y="0"/>
                  </a:moveTo>
                  <a:cubicBezTo>
                    <a:pt x="86" y="0"/>
                    <a:pt x="0" y="64"/>
                    <a:pt x="2" y="174"/>
                  </a:cubicBezTo>
                  <a:cubicBezTo>
                    <a:pt x="4" y="284"/>
                    <a:pt x="76" y="348"/>
                    <a:pt x="176" y="348"/>
                  </a:cubicBezTo>
                  <a:cubicBezTo>
                    <a:pt x="277" y="348"/>
                    <a:pt x="364" y="292"/>
                    <a:pt x="362" y="174"/>
                  </a:cubicBezTo>
                  <a:cubicBezTo>
                    <a:pt x="360" y="56"/>
                    <a:pt x="274" y="0"/>
                    <a:pt x="180" y="0"/>
                  </a:cubicBezTo>
                  <a:close/>
                </a:path>
              </a:pathLst>
            </a:custGeom>
            <a:solidFill>
              <a:srgbClr val="C7172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44" name="Freeform 59"/>
            <p:cNvSpPr/>
            <p:nvPr/>
          </p:nvSpPr>
          <p:spPr bwMode="auto">
            <a:xfrm>
              <a:off x="8419873" y="4096179"/>
              <a:ext cx="1027113" cy="1346200"/>
            </a:xfrm>
            <a:custGeom>
              <a:avLst/>
              <a:gdLst>
                <a:gd name="T0" fmla="*/ 575 w 259"/>
                <a:gd name="T1" fmla="*/ 4288 h 318"/>
                <a:gd name="T2" fmla="*/ 500 w 259"/>
                <a:gd name="T3" fmla="*/ 3243 h 318"/>
                <a:gd name="T4" fmla="*/ 1809 w 259"/>
                <a:gd name="T5" fmla="*/ 512 h 318"/>
                <a:gd name="T6" fmla="*/ 3195 w 259"/>
                <a:gd name="T7" fmla="*/ 264 h 318"/>
                <a:gd name="T8" fmla="*/ 4037 w 259"/>
                <a:gd name="T9" fmla="*/ 419 h 318"/>
                <a:gd name="T10" fmla="*/ 2603 w 259"/>
                <a:gd name="T11" fmla="*/ 0 h 318"/>
                <a:gd name="T12" fmla="*/ 30 w 259"/>
                <a:gd name="T13" fmla="*/ 3072 h 318"/>
                <a:gd name="T14" fmla="*/ 1791 w 259"/>
                <a:gd name="T15" fmla="*/ 6029 h 318"/>
                <a:gd name="T16" fmla="*/ 575 w 259"/>
                <a:gd name="T17" fmla="*/ 4288 h 318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</a:gdLst>
              <a:ahLst/>
              <a:cxnLst>
                <a:cxn ang="T18">
                  <a:pos x="T0" y="T1"/>
                </a:cxn>
                <a:cxn ang="T19">
                  <a:pos x="T2" y="T3"/>
                </a:cxn>
                <a:cxn ang="T20">
                  <a:pos x="T4" y="T5"/>
                </a:cxn>
                <a:cxn ang="T21">
                  <a:pos x="T6" y="T7"/>
                </a:cxn>
                <a:cxn ang="T22">
                  <a:pos x="T8" y="T9"/>
                </a:cxn>
                <a:cxn ang="T23">
                  <a:pos x="T10" y="T11"/>
                </a:cxn>
                <a:cxn ang="T24">
                  <a:pos x="T12" y="T13"/>
                </a:cxn>
                <a:cxn ang="T25">
                  <a:pos x="T14" y="T15"/>
                </a:cxn>
                <a:cxn ang="T26">
                  <a:pos x="T16" y="T17"/>
                </a:cxn>
              </a:cxnLst>
              <a:rect l="0" t="0" r="r" b="b"/>
              <a:pathLst>
                <a:path w="259" h="318">
                  <a:moveTo>
                    <a:pt x="37" y="226"/>
                  </a:moveTo>
                  <a:cubicBezTo>
                    <a:pt x="33" y="211"/>
                    <a:pt x="32" y="188"/>
                    <a:pt x="32" y="171"/>
                  </a:cubicBezTo>
                  <a:cubicBezTo>
                    <a:pt x="30" y="105"/>
                    <a:pt x="68" y="53"/>
                    <a:pt x="116" y="27"/>
                  </a:cubicBezTo>
                  <a:cubicBezTo>
                    <a:pt x="141" y="13"/>
                    <a:pt x="174" y="14"/>
                    <a:pt x="205" y="14"/>
                  </a:cubicBezTo>
                  <a:cubicBezTo>
                    <a:pt x="223" y="14"/>
                    <a:pt x="241" y="17"/>
                    <a:pt x="259" y="22"/>
                  </a:cubicBezTo>
                  <a:cubicBezTo>
                    <a:pt x="232" y="7"/>
                    <a:pt x="200" y="0"/>
                    <a:pt x="167" y="0"/>
                  </a:cubicBezTo>
                  <a:cubicBezTo>
                    <a:pt x="80" y="0"/>
                    <a:pt x="0" y="59"/>
                    <a:pt x="2" y="162"/>
                  </a:cubicBezTo>
                  <a:cubicBezTo>
                    <a:pt x="3" y="245"/>
                    <a:pt x="48" y="300"/>
                    <a:pt x="115" y="318"/>
                  </a:cubicBezTo>
                  <a:cubicBezTo>
                    <a:pt x="80" y="298"/>
                    <a:pt x="48" y="269"/>
                    <a:pt x="37" y="226"/>
                  </a:cubicBezTo>
                  <a:close/>
                </a:path>
              </a:pathLst>
            </a:custGeom>
            <a:solidFill>
              <a:srgbClr val="E9618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45" name="Freeform 60"/>
            <p:cNvSpPr/>
            <p:nvPr/>
          </p:nvSpPr>
          <p:spPr bwMode="auto">
            <a:xfrm>
              <a:off x="8848498" y="4507342"/>
              <a:ext cx="650875" cy="690563"/>
            </a:xfrm>
            <a:custGeom>
              <a:avLst/>
              <a:gdLst>
                <a:gd name="T0" fmla="*/ 1333 w 164"/>
                <a:gd name="T1" fmla="*/ 149 h 163"/>
                <a:gd name="T2" fmla="*/ 83 w 164"/>
                <a:gd name="T3" fmla="*/ 1404 h 163"/>
                <a:gd name="T4" fmla="*/ 1208 w 164"/>
                <a:gd name="T5" fmla="*/ 3064 h 163"/>
                <a:gd name="T6" fmla="*/ 2500 w 164"/>
                <a:gd name="T7" fmla="*/ 1767 h 163"/>
                <a:gd name="T8" fmla="*/ 1333 w 164"/>
                <a:gd name="T9" fmla="*/ 149 h 16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64" h="163">
                  <a:moveTo>
                    <a:pt x="85" y="8"/>
                  </a:moveTo>
                  <a:cubicBezTo>
                    <a:pt x="33" y="0"/>
                    <a:pt x="10" y="34"/>
                    <a:pt x="5" y="74"/>
                  </a:cubicBezTo>
                  <a:cubicBezTo>
                    <a:pt x="0" y="114"/>
                    <a:pt x="34" y="159"/>
                    <a:pt x="77" y="161"/>
                  </a:cubicBezTo>
                  <a:cubicBezTo>
                    <a:pt x="120" y="163"/>
                    <a:pt x="152" y="154"/>
                    <a:pt x="160" y="93"/>
                  </a:cubicBezTo>
                  <a:cubicBezTo>
                    <a:pt x="164" y="58"/>
                    <a:pt x="137" y="16"/>
                    <a:pt x="85" y="8"/>
                  </a:cubicBezTo>
                  <a:close/>
                </a:path>
              </a:pathLst>
            </a:custGeom>
            <a:solidFill>
              <a:srgbClr val="F1AE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46" name="Freeform 61"/>
            <p:cNvSpPr/>
            <p:nvPr/>
          </p:nvSpPr>
          <p:spPr bwMode="auto">
            <a:xfrm>
              <a:off x="9065985" y="4756579"/>
              <a:ext cx="409575" cy="398463"/>
            </a:xfrm>
            <a:custGeom>
              <a:avLst/>
              <a:gdLst>
                <a:gd name="T0" fmla="*/ 0 w 103"/>
                <a:gd name="T1" fmla="*/ 1677 h 94"/>
                <a:gd name="T2" fmla="*/ 1147 w 103"/>
                <a:gd name="T3" fmla="*/ 1503 h 94"/>
                <a:gd name="T4" fmla="*/ 1368 w 103"/>
                <a:gd name="T5" fmla="*/ 0 h 94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03" h="94">
                  <a:moveTo>
                    <a:pt x="0" y="88"/>
                  </a:moveTo>
                  <a:cubicBezTo>
                    <a:pt x="18" y="93"/>
                    <a:pt x="59" y="94"/>
                    <a:pt x="73" y="79"/>
                  </a:cubicBezTo>
                  <a:cubicBezTo>
                    <a:pt x="94" y="58"/>
                    <a:pt x="103" y="23"/>
                    <a:pt x="87" y="0"/>
                  </a:cubicBezTo>
                </a:path>
              </a:pathLst>
            </a:custGeom>
            <a:solidFill>
              <a:srgbClr val="EB98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47" name="Freeform 62"/>
            <p:cNvSpPr/>
            <p:nvPr/>
          </p:nvSpPr>
          <p:spPr bwMode="auto">
            <a:xfrm>
              <a:off x="8784998" y="4448604"/>
              <a:ext cx="714375" cy="749301"/>
            </a:xfrm>
            <a:custGeom>
              <a:avLst/>
              <a:gdLst>
                <a:gd name="T0" fmla="*/ 1333 w 164"/>
                <a:gd name="T1" fmla="*/ 149 h 163"/>
                <a:gd name="T2" fmla="*/ 83 w 164"/>
                <a:gd name="T3" fmla="*/ 1398 h 163"/>
                <a:gd name="T4" fmla="*/ 1208 w 164"/>
                <a:gd name="T5" fmla="*/ 3041 h 163"/>
                <a:gd name="T6" fmla="*/ 2500 w 164"/>
                <a:gd name="T7" fmla="*/ 1757 h 163"/>
                <a:gd name="T8" fmla="*/ 1333 w 164"/>
                <a:gd name="T9" fmla="*/ 149 h 16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64" h="163">
                  <a:moveTo>
                    <a:pt x="85" y="8"/>
                  </a:moveTo>
                  <a:cubicBezTo>
                    <a:pt x="33" y="0"/>
                    <a:pt x="10" y="34"/>
                    <a:pt x="5" y="74"/>
                  </a:cubicBezTo>
                  <a:cubicBezTo>
                    <a:pt x="0" y="114"/>
                    <a:pt x="34" y="159"/>
                    <a:pt x="77" y="161"/>
                  </a:cubicBezTo>
                  <a:cubicBezTo>
                    <a:pt x="120" y="163"/>
                    <a:pt x="152" y="154"/>
                    <a:pt x="160" y="93"/>
                  </a:cubicBezTo>
                  <a:cubicBezTo>
                    <a:pt x="164" y="58"/>
                    <a:pt x="137" y="16"/>
                    <a:pt x="85" y="8"/>
                  </a:cubicBezTo>
                  <a:close/>
                </a:path>
              </a:pathLst>
            </a:custGeom>
            <a:solidFill>
              <a:srgbClr val="00ABC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48" name="Freeform 63"/>
            <p:cNvSpPr/>
            <p:nvPr/>
          </p:nvSpPr>
          <p:spPr bwMode="auto">
            <a:xfrm>
              <a:off x="8923110" y="4558142"/>
              <a:ext cx="484188" cy="550863"/>
            </a:xfrm>
            <a:custGeom>
              <a:avLst/>
              <a:gdLst>
                <a:gd name="T0" fmla="*/ 1283 w 122"/>
                <a:gd name="T1" fmla="*/ 0 h 130"/>
                <a:gd name="T2" fmla="*/ 1625 w 122"/>
                <a:gd name="T3" fmla="*/ 1046 h 130"/>
                <a:gd name="T4" fmla="*/ 1313 w 122"/>
                <a:gd name="T5" fmla="*/ 1674 h 130"/>
                <a:gd name="T6" fmla="*/ 438 w 122"/>
                <a:gd name="T7" fmla="*/ 2223 h 130"/>
                <a:gd name="T8" fmla="*/ 0 w 122"/>
                <a:gd name="T9" fmla="*/ 2074 h 130"/>
                <a:gd name="T10" fmla="*/ 675 w 122"/>
                <a:gd name="T11" fmla="*/ 2450 h 130"/>
                <a:gd name="T12" fmla="*/ 1863 w 122"/>
                <a:gd name="T13" fmla="*/ 1276 h 130"/>
                <a:gd name="T14" fmla="*/ 1283 w 122"/>
                <a:gd name="T15" fmla="*/ 0 h 130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22" h="130">
                  <a:moveTo>
                    <a:pt x="82" y="0"/>
                  </a:moveTo>
                  <a:cubicBezTo>
                    <a:pt x="98" y="15"/>
                    <a:pt x="106" y="36"/>
                    <a:pt x="104" y="55"/>
                  </a:cubicBezTo>
                  <a:cubicBezTo>
                    <a:pt x="101" y="74"/>
                    <a:pt x="90" y="79"/>
                    <a:pt x="84" y="88"/>
                  </a:cubicBezTo>
                  <a:cubicBezTo>
                    <a:pt x="70" y="107"/>
                    <a:pt x="54" y="118"/>
                    <a:pt x="28" y="117"/>
                  </a:cubicBezTo>
                  <a:cubicBezTo>
                    <a:pt x="18" y="117"/>
                    <a:pt x="9" y="113"/>
                    <a:pt x="0" y="109"/>
                  </a:cubicBezTo>
                  <a:cubicBezTo>
                    <a:pt x="12" y="120"/>
                    <a:pt x="27" y="128"/>
                    <a:pt x="43" y="129"/>
                  </a:cubicBezTo>
                  <a:cubicBezTo>
                    <a:pt x="82" y="130"/>
                    <a:pt x="112" y="122"/>
                    <a:pt x="119" y="67"/>
                  </a:cubicBezTo>
                  <a:cubicBezTo>
                    <a:pt x="122" y="43"/>
                    <a:pt x="109" y="15"/>
                    <a:pt x="82" y="0"/>
                  </a:cubicBezTo>
                  <a:close/>
                </a:path>
              </a:pathLst>
            </a:custGeom>
            <a:solidFill>
              <a:srgbClr val="0094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49" name="Freeform 64"/>
            <p:cNvSpPr/>
            <p:nvPr/>
          </p:nvSpPr>
          <p:spPr bwMode="auto">
            <a:xfrm>
              <a:off x="8819923" y="4477179"/>
              <a:ext cx="433388" cy="530225"/>
            </a:xfrm>
            <a:custGeom>
              <a:avLst/>
              <a:gdLst>
                <a:gd name="T0" fmla="*/ 301 w 109"/>
                <a:gd name="T1" fmla="*/ 1542 h 125"/>
                <a:gd name="T2" fmla="*/ 676 w 109"/>
                <a:gd name="T3" fmla="*/ 799 h 125"/>
                <a:gd name="T4" fmla="*/ 1430 w 109"/>
                <a:gd name="T5" fmla="*/ 307 h 125"/>
                <a:gd name="T6" fmla="*/ 1538 w 109"/>
                <a:gd name="T7" fmla="*/ 286 h 125"/>
                <a:gd name="T8" fmla="*/ 1180 w 109"/>
                <a:gd name="T9" fmla="*/ 150 h 125"/>
                <a:gd name="T10" fmla="*/ 50 w 109"/>
                <a:gd name="T11" fmla="*/ 1299 h 125"/>
                <a:gd name="T12" fmla="*/ 376 w 109"/>
                <a:gd name="T13" fmla="*/ 2383 h 125"/>
                <a:gd name="T14" fmla="*/ 301 w 109"/>
                <a:gd name="T15" fmla="*/ 1542 h 125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60000 65536"/>
                <a:gd name="T22" fmla="*/ 0 60000 65536"/>
                <a:gd name="T23" fmla="*/ 0 60000 65536"/>
              </a:gdLst>
              <a:ahLst/>
              <a:cxnLst>
                <a:cxn ang="T16">
                  <a:pos x="T0" y="T1"/>
                </a:cxn>
                <a:cxn ang="T17">
                  <a:pos x="T2" y="T3"/>
                </a:cxn>
                <a:cxn ang="T18">
                  <a:pos x="T4" y="T5"/>
                </a:cxn>
                <a:cxn ang="T19">
                  <a:pos x="T6" y="T7"/>
                </a:cxn>
                <a:cxn ang="T20">
                  <a:pos x="T8" y="T9"/>
                </a:cxn>
                <a:cxn ang="T21">
                  <a:pos x="T10" y="T11"/>
                </a:cxn>
                <a:cxn ang="T22">
                  <a:pos x="T12" y="T13"/>
                </a:cxn>
                <a:cxn ang="T23">
                  <a:pos x="T14" y="T15"/>
                </a:cxn>
              </a:cxnLst>
              <a:rect l="0" t="0" r="r" b="b"/>
              <a:pathLst>
                <a:path w="109" h="125">
                  <a:moveTo>
                    <a:pt x="19" y="81"/>
                  </a:moveTo>
                  <a:cubicBezTo>
                    <a:pt x="21" y="65"/>
                    <a:pt x="33" y="55"/>
                    <a:pt x="43" y="42"/>
                  </a:cubicBezTo>
                  <a:cubicBezTo>
                    <a:pt x="54" y="28"/>
                    <a:pt x="65" y="12"/>
                    <a:pt x="91" y="16"/>
                  </a:cubicBezTo>
                  <a:cubicBezTo>
                    <a:pt x="104" y="18"/>
                    <a:pt x="109" y="19"/>
                    <a:pt x="98" y="15"/>
                  </a:cubicBezTo>
                  <a:cubicBezTo>
                    <a:pt x="91" y="11"/>
                    <a:pt x="83" y="9"/>
                    <a:pt x="75" y="8"/>
                  </a:cubicBezTo>
                  <a:cubicBezTo>
                    <a:pt x="28" y="0"/>
                    <a:pt x="7" y="32"/>
                    <a:pt x="3" y="68"/>
                  </a:cubicBezTo>
                  <a:cubicBezTo>
                    <a:pt x="0" y="88"/>
                    <a:pt x="9" y="110"/>
                    <a:pt x="24" y="125"/>
                  </a:cubicBezTo>
                  <a:cubicBezTo>
                    <a:pt x="15" y="106"/>
                    <a:pt x="16" y="101"/>
                    <a:pt x="19" y="81"/>
                  </a:cubicBezTo>
                  <a:close/>
                </a:path>
              </a:pathLst>
            </a:custGeom>
            <a:solidFill>
              <a:srgbClr val="DEEEF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0" name="Freeform 65"/>
            <p:cNvSpPr/>
            <p:nvPr/>
          </p:nvSpPr>
          <p:spPr bwMode="auto">
            <a:xfrm>
              <a:off x="8907235" y="4197779"/>
              <a:ext cx="917575" cy="1274763"/>
            </a:xfrm>
            <a:custGeom>
              <a:avLst/>
              <a:gdLst>
                <a:gd name="T0" fmla="*/ 2270 w 222"/>
                <a:gd name="T1" fmla="*/ 0 h 301"/>
                <a:gd name="T2" fmla="*/ 2895 w 222"/>
                <a:gd name="T3" fmla="*/ 2428 h 301"/>
                <a:gd name="T4" fmla="*/ 2125 w 222"/>
                <a:gd name="T5" fmla="*/ 4212 h 301"/>
                <a:gd name="T6" fmla="*/ 0 w 222"/>
                <a:gd name="T7" fmla="*/ 5624 h 301"/>
                <a:gd name="T8" fmla="*/ 708 w 222"/>
                <a:gd name="T9" fmla="*/ 5714 h 301"/>
                <a:gd name="T10" fmla="*/ 3438 w 222"/>
                <a:gd name="T11" fmla="*/ 2620 h 301"/>
                <a:gd name="T12" fmla="*/ 2270 w 222"/>
                <a:gd name="T13" fmla="*/ 0 h 301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0" t="0" r="r" b="b"/>
              <a:pathLst>
                <a:path w="222" h="301">
                  <a:moveTo>
                    <a:pt x="145" y="0"/>
                  </a:moveTo>
                  <a:cubicBezTo>
                    <a:pt x="185" y="44"/>
                    <a:pt x="184" y="51"/>
                    <a:pt x="185" y="128"/>
                  </a:cubicBezTo>
                  <a:cubicBezTo>
                    <a:pt x="186" y="175"/>
                    <a:pt x="161" y="195"/>
                    <a:pt x="136" y="222"/>
                  </a:cubicBezTo>
                  <a:cubicBezTo>
                    <a:pt x="104" y="256"/>
                    <a:pt x="65" y="291"/>
                    <a:pt x="0" y="296"/>
                  </a:cubicBezTo>
                  <a:cubicBezTo>
                    <a:pt x="14" y="299"/>
                    <a:pt x="29" y="301"/>
                    <a:pt x="45" y="301"/>
                  </a:cubicBezTo>
                  <a:cubicBezTo>
                    <a:pt x="139" y="301"/>
                    <a:pt x="222" y="248"/>
                    <a:pt x="220" y="138"/>
                  </a:cubicBezTo>
                  <a:cubicBezTo>
                    <a:pt x="219" y="71"/>
                    <a:pt x="188" y="25"/>
                    <a:pt x="145" y="0"/>
                  </a:cubicBezTo>
                  <a:close/>
                </a:path>
              </a:pathLst>
            </a:custGeom>
            <a:solidFill>
              <a:srgbClr val="E9618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1" name="Freeform 66"/>
            <p:cNvSpPr/>
            <p:nvPr/>
          </p:nvSpPr>
          <p:spPr bwMode="auto">
            <a:xfrm>
              <a:off x="8419873" y="4088242"/>
              <a:ext cx="661988" cy="693738"/>
            </a:xfrm>
            <a:custGeom>
              <a:avLst/>
              <a:gdLst>
                <a:gd name="T0" fmla="*/ 30 w 167"/>
                <a:gd name="T1" fmla="*/ 3102 h 164"/>
                <a:gd name="T2" fmla="*/ 2599 w 167"/>
                <a:gd name="T3" fmla="*/ 35 h 164"/>
                <a:gd name="T4" fmla="*/ 30 w 167"/>
                <a:gd name="T5" fmla="*/ 3102 h 164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67" h="164">
                  <a:moveTo>
                    <a:pt x="2" y="164"/>
                  </a:moveTo>
                  <a:cubicBezTo>
                    <a:pt x="0" y="61"/>
                    <a:pt x="80" y="2"/>
                    <a:pt x="167" y="2"/>
                  </a:cubicBezTo>
                  <a:cubicBezTo>
                    <a:pt x="119" y="0"/>
                    <a:pt x="29" y="50"/>
                    <a:pt x="2" y="16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2" name="Freeform 67"/>
            <p:cNvSpPr/>
            <p:nvPr/>
          </p:nvSpPr>
          <p:spPr bwMode="auto">
            <a:xfrm>
              <a:off x="9086623" y="4781979"/>
              <a:ext cx="701675" cy="690563"/>
            </a:xfrm>
            <a:custGeom>
              <a:avLst/>
              <a:gdLst>
                <a:gd name="T0" fmla="*/ 0 w 177"/>
                <a:gd name="T1" fmla="*/ 3098 h 163"/>
                <a:gd name="T2" fmla="*/ 2724 w 177"/>
                <a:gd name="T3" fmla="*/ 0 h 163"/>
                <a:gd name="T4" fmla="*/ 0 w 177"/>
                <a:gd name="T5" fmla="*/ 3098 h 163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177" h="163">
                  <a:moveTo>
                    <a:pt x="0" y="163"/>
                  </a:moveTo>
                  <a:cubicBezTo>
                    <a:pt x="94" y="163"/>
                    <a:pt x="177" y="110"/>
                    <a:pt x="175" y="0"/>
                  </a:cubicBezTo>
                  <a:cubicBezTo>
                    <a:pt x="148" y="70"/>
                    <a:pt x="121" y="149"/>
                    <a:pt x="0" y="163"/>
                  </a:cubicBezTo>
                  <a:close/>
                </a:path>
              </a:pathLst>
            </a:custGeom>
            <a:solidFill>
              <a:srgbClr val="C71728"/>
            </a:solidFill>
            <a:ln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3" name="Freeform 68"/>
            <p:cNvSpPr/>
            <p:nvPr/>
          </p:nvSpPr>
          <p:spPr bwMode="auto">
            <a:xfrm>
              <a:off x="9094560" y="4829604"/>
              <a:ext cx="301625" cy="279400"/>
            </a:xfrm>
            <a:custGeom>
              <a:avLst/>
              <a:gdLst>
                <a:gd name="T0" fmla="*/ 1188 w 76"/>
                <a:gd name="T1" fmla="*/ 56 h 66"/>
                <a:gd name="T2" fmla="*/ 0 w 76"/>
                <a:gd name="T3" fmla="*/ 1229 h 66"/>
                <a:gd name="T4" fmla="*/ 1175 w 76"/>
                <a:gd name="T5" fmla="*/ 0 h 66"/>
                <a:gd name="T6" fmla="*/ 0 60000 65536"/>
                <a:gd name="T7" fmla="*/ 0 60000 65536"/>
                <a:gd name="T8" fmla="*/ 0 60000 655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0" t="0" r="r" b="b"/>
              <a:pathLst>
                <a:path w="76" h="66">
                  <a:moveTo>
                    <a:pt x="76" y="3"/>
                  </a:moveTo>
                  <a:cubicBezTo>
                    <a:pt x="69" y="58"/>
                    <a:pt x="39" y="66"/>
                    <a:pt x="0" y="65"/>
                  </a:cubicBezTo>
                  <a:cubicBezTo>
                    <a:pt x="25" y="62"/>
                    <a:pt x="60" y="46"/>
                    <a:pt x="75" y="0"/>
                  </a:cubicBezTo>
                </a:path>
              </a:pathLst>
            </a:custGeom>
            <a:solidFill>
              <a:srgbClr val="006C8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4" name="Freeform 69"/>
            <p:cNvSpPr/>
            <p:nvPr/>
          </p:nvSpPr>
          <p:spPr bwMode="auto">
            <a:xfrm>
              <a:off x="8380185" y="4045379"/>
              <a:ext cx="1444625" cy="1473200"/>
            </a:xfrm>
            <a:custGeom>
              <a:avLst/>
              <a:gdLst>
                <a:gd name="T0" fmla="*/ 2813 w 364"/>
                <a:gd name="T1" fmla="*/ 0 h 348"/>
                <a:gd name="T2" fmla="*/ 33 w 364"/>
                <a:gd name="T3" fmla="*/ 3299 h 348"/>
                <a:gd name="T4" fmla="*/ 2750 w 364"/>
                <a:gd name="T5" fmla="*/ 6600 h 348"/>
                <a:gd name="T6" fmla="*/ 5658 w 364"/>
                <a:gd name="T7" fmla="*/ 3299 h 348"/>
                <a:gd name="T8" fmla="*/ 2813 w 364"/>
                <a:gd name="T9" fmla="*/ 0 h 34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64" h="348">
                  <a:moveTo>
                    <a:pt x="180" y="0"/>
                  </a:moveTo>
                  <a:cubicBezTo>
                    <a:pt x="86" y="0"/>
                    <a:pt x="0" y="64"/>
                    <a:pt x="2" y="174"/>
                  </a:cubicBezTo>
                  <a:cubicBezTo>
                    <a:pt x="4" y="284"/>
                    <a:pt x="76" y="348"/>
                    <a:pt x="176" y="348"/>
                  </a:cubicBezTo>
                  <a:cubicBezTo>
                    <a:pt x="277" y="348"/>
                    <a:pt x="364" y="292"/>
                    <a:pt x="362" y="174"/>
                  </a:cubicBezTo>
                  <a:cubicBezTo>
                    <a:pt x="360" y="56"/>
                    <a:pt x="274" y="0"/>
                    <a:pt x="180" y="0"/>
                  </a:cubicBezTo>
                  <a:close/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5" name="Freeform 70"/>
            <p:cNvSpPr/>
            <p:nvPr/>
          </p:nvSpPr>
          <p:spPr bwMode="auto">
            <a:xfrm>
              <a:off x="8784998" y="4448604"/>
              <a:ext cx="650875" cy="688975"/>
            </a:xfrm>
            <a:custGeom>
              <a:avLst/>
              <a:gdLst>
                <a:gd name="T0" fmla="*/ 1333 w 164"/>
                <a:gd name="T1" fmla="*/ 149 h 163"/>
                <a:gd name="T2" fmla="*/ 83 w 164"/>
                <a:gd name="T3" fmla="*/ 1398 h 163"/>
                <a:gd name="T4" fmla="*/ 1208 w 164"/>
                <a:gd name="T5" fmla="*/ 3041 h 163"/>
                <a:gd name="T6" fmla="*/ 2500 w 164"/>
                <a:gd name="T7" fmla="*/ 1757 h 163"/>
                <a:gd name="T8" fmla="*/ 1333 w 164"/>
                <a:gd name="T9" fmla="*/ 149 h 16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64" h="163">
                  <a:moveTo>
                    <a:pt x="85" y="8"/>
                  </a:moveTo>
                  <a:cubicBezTo>
                    <a:pt x="33" y="0"/>
                    <a:pt x="10" y="34"/>
                    <a:pt x="5" y="74"/>
                  </a:cubicBezTo>
                  <a:cubicBezTo>
                    <a:pt x="0" y="114"/>
                    <a:pt x="34" y="159"/>
                    <a:pt x="77" y="161"/>
                  </a:cubicBezTo>
                  <a:cubicBezTo>
                    <a:pt x="120" y="163"/>
                    <a:pt x="152" y="154"/>
                    <a:pt x="160" y="93"/>
                  </a:cubicBezTo>
                  <a:cubicBezTo>
                    <a:pt x="164" y="58"/>
                    <a:pt x="137" y="16"/>
                    <a:pt x="85" y="8"/>
                  </a:cubicBezTo>
                  <a:close/>
                </a:path>
              </a:pathLst>
            </a:custGeom>
            <a:noFill/>
            <a:ln w="7938" cap="rnd">
              <a:solidFill>
                <a:srgbClr val="FFFFFF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6" name="Freeform 71"/>
            <p:cNvSpPr/>
            <p:nvPr/>
          </p:nvSpPr>
          <p:spPr bwMode="auto">
            <a:xfrm>
              <a:off x="8811985" y="4532742"/>
              <a:ext cx="111125" cy="119063"/>
            </a:xfrm>
            <a:custGeom>
              <a:avLst/>
              <a:gdLst>
                <a:gd name="T0" fmla="*/ 20 w 28"/>
                <a:gd name="T1" fmla="*/ 287 h 28"/>
                <a:gd name="T2" fmla="*/ 208 w 28"/>
                <a:gd name="T3" fmla="*/ 21 h 28"/>
                <a:gd name="T4" fmla="*/ 425 w 28"/>
                <a:gd name="T5" fmla="*/ 252 h 28"/>
                <a:gd name="T6" fmla="*/ 238 w 28"/>
                <a:gd name="T7" fmla="*/ 517 h 28"/>
                <a:gd name="T8" fmla="*/ 20 w 28"/>
                <a:gd name="T9" fmla="*/ 287 h 2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28" h="28">
                  <a:moveTo>
                    <a:pt x="1" y="15"/>
                  </a:moveTo>
                  <a:cubicBezTo>
                    <a:pt x="0" y="8"/>
                    <a:pt x="6" y="2"/>
                    <a:pt x="13" y="1"/>
                  </a:cubicBezTo>
                  <a:cubicBezTo>
                    <a:pt x="20" y="0"/>
                    <a:pt x="27" y="6"/>
                    <a:pt x="27" y="13"/>
                  </a:cubicBezTo>
                  <a:cubicBezTo>
                    <a:pt x="28" y="20"/>
                    <a:pt x="22" y="27"/>
                    <a:pt x="15" y="27"/>
                  </a:cubicBezTo>
                  <a:cubicBezTo>
                    <a:pt x="8" y="28"/>
                    <a:pt x="2" y="22"/>
                    <a:pt x="1" y="15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7" name="Freeform 72"/>
            <p:cNvSpPr/>
            <p:nvPr/>
          </p:nvSpPr>
          <p:spPr bwMode="auto">
            <a:xfrm>
              <a:off x="8907235" y="4474004"/>
              <a:ext cx="68263" cy="71438"/>
            </a:xfrm>
            <a:custGeom>
              <a:avLst/>
              <a:gdLst>
                <a:gd name="T0" fmla="*/ 20 w 17"/>
                <a:gd name="T1" fmla="*/ 169 h 17"/>
                <a:gd name="T2" fmla="*/ 129 w 17"/>
                <a:gd name="T3" fmla="*/ 0 h 17"/>
                <a:gd name="T4" fmla="*/ 276 w 17"/>
                <a:gd name="T5" fmla="*/ 148 h 17"/>
                <a:gd name="T6" fmla="*/ 147 w 17"/>
                <a:gd name="T7" fmla="*/ 315 h 17"/>
                <a:gd name="T8" fmla="*/ 20 w 17"/>
                <a:gd name="T9" fmla="*/ 169 h 1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7" h="17">
                  <a:moveTo>
                    <a:pt x="1" y="9"/>
                  </a:moveTo>
                  <a:cubicBezTo>
                    <a:pt x="0" y="5"/>
                    <a:pt x="4" y="1"/>
                    <a:pt x="8" y="0"/>
                  </a:cubicBezTo>
                  <a:cubicBezTo>
                    <a:pt x="13" y="0"/>
                    <a:pt x="16" y="3"/>
                    <a:pt x="17" y="8"/>
                  </a:cubicBezTo>
                  <a:cubicBezTo>
                    <a:pt x="17" y="12"/>
                    <a:pt x="14" y="16"/>
                    <a:pt x="9" y="17"/>
                  </a:cubicBezTo>
                  <a:cubicBezTo>
                    <a:pt x="5" y="17"/>
                    <a:pt x="1" y="14"/>
                    <a:pt x="1" y="9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58" name="Freeform 73"/>
            <p:cNvSpPr/>
            <p:nvPr/>
          </p:nvSpPr>
          <p:spPr bwMode="auto">
            <a:xfrm>
              <a:off x="8804048" y="4667679"/>
              <a:ext cx="52388" cy="60325"/>
            </a:xfrm>
            <a:custGeom>
              <a:avLst/>
              <a:gdLst>
                <a:gd name="T0" fmla="*/ 0 w 13"/>
                <a:gd name="T1" fmla="*/ 141 h 14"/>
                <a:gd name="T2" fmla="*/ 96 w 13"/>
                <a:gd name="T3" fmla="*/ 0 h 14"/>
                <a:gd name="T4" fmla="*/ 213 w 13"/>
                <a:gd name="T5" fmla="*/ 117 h 14"/>
                <a:gd name="T6" fmla="*/ 117 w 13"/>
                <a:gd name="T7" fmla="*/ 258 h 14"/>
                <a:gd name="T8" fmla="*/ 0 w 13"/>
                <a:gd name="T9" fmla="*/ 141 h 1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3" h="14">
                  <a:moveTo>
                    <a:pt x="0" y="7"/>
                  </a:moveTo>
                  <a:cubicBezTo>
                    <a:pt x="0" y="4"/>
                    <a:pt x="2" y="1"/>
                    <a:pt x="6" y="0"/>
                  </a:cubicBezTo>
                  <a:cubicBezTo>
                    <a:pt x="10" y="0"/>
                    <a:pt x="13" y="3"/>
                    <a:pt x="13" y="6"/>
                  </a:cubicBezTo>
                  <a:cubicBezTo>
                    <a:pt x="13" y="10"/>
                    <a:pt x="11" y="13"/>
                    <a:pt x="7" y="13"/>
                  </a:cubicBezTo>
                  <a:cubicBezTo>
                    <a:pt x="3" y="14"/>
                    <a:pt x="0" y="11"/>
                    <a:pt x="0" y="7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/>
            <a:lstStyle/>
            <a:p>
              <a:endParaRPr lang="zh-CN" altLang="en-US"/>
            </a:p>
          </p:txBody>
        </p:sp>
      </p:grpSp>
      <p:grpSp>
        <p:nvGrpSpPr>
          <p:cNvPr id="179" name="组合 178"/>
          <p:cNvGrpSpPr/>
          <p:nvPr/>
        </p:nvGrpSpPr>
        <p:grpSpPr>
          <a:xfrm>
            <a:off x="4981747" y="4220167"/>
            <a:ext cx="1676264" cy="1654215"/>
            <a:chOff x="612066" y="1545379"/>
            <a:chExt cx="3872450" cy="3821514"/>
          </a:xfrm>
        </p:grpSpPr>
        <p:sp>
          <p:nvSpPr>
            <p:cNvPr id="180" name="椭圆 179"/>
            <p:cNvSpPr/>
            <p:nvPr/>
          </p:nvSpPr>
          <p:spPr>
            <a:xfrm>
              <a:off x="612066" y="1642198"/>
              <a:ext cx="3872450" cy="3688542"/>
            </a:xfrm>
            <a:prstGeom prst="ellipse">
              <a:avLst/>
            </a:prstGeom>
            <a:blipFill>
              <a:blip r:embed="rId1"/>
              <a:stretch>
                <a:fillRect/>
              </a:stretch>
            </a:blipFill>
            <a:ln>
              <a:noFill/>
            </a:ln>
            <a:scene3d>
              <a:camera prst="isometricOffAxis2Top"/>
              <a:lightRig rig="balanced" dir="t">
                <a:rot lat="0" lon="0" rev="16200000"/>
              </a:lightRig>
            </a:scene3d>
            <a:sp3d z="-63500" prstMaterial="clear">
              <a:bevelB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181" name="圆: 空心 30"/>
            <p:cNvSpPr/>
            <p:nvPr/>
          </p:nvSpPr>
          <p:spPr>
            <a:xfrm>
              <a:off x="612066" y="1545379"/>
              <a:ext cx="3872450" cy="3821514"/>
            </a:xfrm>
            <a:prstGeom prst="donut">
              <a:avLst>
                <a:gd name="adj" fmla="val 2544"/>
              </a:avLst>
            </a:pr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lumMod val="75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isometricOffAxis2Top"/>
              <a:lightRig rig="balanced" dir="t">
                <a:rot lat="0" lon="0" rev="16200000"/>
              </a:lightRig>
            </a:scene3d>
            <a:sp3d z="381000" extrusionH="381000" prstMaterial="clear"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24" name="组合 23"/>
          <p:cNvGrpSpPr/>
          <p:nvPr/>
        </p:nvGrpSpPr>
        <p:grpSpPr>
          <a:xfrm>
            <a:off x="2250630" y="2284847"/>
            <a:ext cx="1680587" cy="1654437"/>
            <a:chOff x="2250630" y="2284847"/>
            <a:chExt cx="1680587" cy="1654437"/>
          </a:xfrm>
        </p:grpSpPr>
        <p:sp>
          <p:nvSpPr>
            <p:cNvPr id="3" name="椭圆 2"/>
            <p:cNvSpPr/>
            <p:nvPr/>
          </p:nvSpPr>
          <p:spPr>
            <a:xfrm>
              <a:off x="2250630" y="2284847"/>
              <a:ext cx="1676264" cy="1596656"/>
            </a:xfrm>
            <a:prstGeom prst="ellipse">
              <a:avLst/>
            </a:prstGeom>
            <a:blipFill>
              <a:blip r:embed="rId1"/>
              <a:stretch>
                <a:fillRect/>
              </a:stretch>
            </a:blipFill>
            <a:ln>
              <a:noFill/>
            </a:ln>
            <a:scene3d>
              <a:camera prst="isometricOffAxis2Top"/>
              <a:lightRig rig="balanced" dir="t">
                <a:rot lat="0" lon="0" rev="16200000"/>
              </a:lightRig>
            </a:scene3d>
            <a:sp3d z="-63500" prstMaterial="clear">
              <a:bevelB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161" name="组合 160"/>
            <p:cNvGrpSpPr/>
            <p:nvPr/>
          </p:nvGrpSpPr>
          <p:grpSpPr>
            <a:xfrm rot="1447043">
              <a:off x="2626459" y="3155824"/>
              <a:ext cx="291733" cy="105954"/>
              <a:chOff x="8377112" y="4045382"/>
              <a:chExt cx="1447698" cy="1473194"/>
            </a:xfrm>
          </p:grpSpPr>
          <p:sp>
            <p:nvSpPr>
              <p:cNvPr id="162" name="Freeform 58"/>
              <p:cNvSpPr/>
              <p:nvPr/>
            </p:nvSpPr>
            <p:spPr bwMode="auto">
              <a:xfrm>
                <a:off x="8377112" y="4045382"/>
                <a:ext cx="1444634" cy="1473194"/>
              </a:xfrm>
              <a:custGeom>
                <a:avLst/>
                <a:gdLst>
                  <a:gd name="T0" fmla="*/ 2813 w 364"/>
                  <a:gd name="T1" fmla="*/ 0 h 348"/>
                  <a:gd name="T2" fmla="*/ 33 w 364"/>
                  <a:gd name="T3" fmla="*/ 3299 h 348"/>
                  <a:gd name="T4" fmla="*/ 2750 w 364"/>
                  <a:gd name="T5" fmla="*/ 6600 h 348"/>
                  <a:gd name="T6" fmla="*/ 5658 w 364"/>
                  <a:gd name="T7" fmla="*/ 3299 h 348"/>
                  <a:gd name="T8" fmla="*/ 2813 w 364"/>
                  <a:gd name="T9" fmla="*/ 0 h 34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64" h="348">
                    <a:moveTo>
                      <a:pt x="180" y="0"/>
                    </a:moveTo>
                    <a:cubicBezTo>
                      <a:pt x="86" y="0"/>
                      <a:pt x="0" y="64"/>
                      <a:pt x="2" y="174"/>
                    </a:cubicBezTo>
                    <a:cubicBezTo>
                      <a:pt x="4" y="284"/>
                      <a:pt x="76" y="348"/>
                      <a:pt x="176" y="348"/>
                    </a:cubicBezTo>
                    <a:cubicBezTo>
                      <a:pt x="277" y="348"/>
                      <a:pt x="364" y="292"/>
                      <a:pt x="362" y="174"/>
                    </a:cubicBezTo>
                    <a:cubicBezTo>
                      <a:pt x="360" y="56"/>
                      <a:pt x="274" y="0"/>
                      <a:pt x="180" y="0"/>
                    </a:cubicBezTo>
                    <a:close/>
                  </a:path>
                </a:pathLst>
              </a:custGeom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3" name="Freeform 59"/>
              <p:cNvSpPr/>
              <p:nvPr/>
            </p:nvSpPr>
            <p:spPr bwMode="auto">
              <a:xfrm>
                <a:off x="8419873" y="4096179"/>
                <a:ext cx="1027113" cy="1346200"/>
              </a:xfrm>
              <a:custGeom>
                <a:avLst/>
                <a:gdLst>
                  <a:gd name="T0" fmla="*/ 575 w 259"/>
                  <a:gd name="T1" fmla="*/ 4288 h 318"/>
                  <a:gd name="T2" fmla="*/ 500 w 259"/>
                  <a:gd name="T3" fmla="*/ 3243 h 318"/>
                  <a:gd name="T4" fmla="*/ 1809 w 259"/>
                  <a:gd name="T5" fmla="*/ 512 h 318"/>
                  <a:gd name="T6" fmla="*/ 3195 w 259"/>
                  <a:gd name="T7" fmla="*/ 264 h 318"/>
                  <a:gd name="T8" fmla="*/ 4037 w 259"/>
                  <a:gd name="T9" fmla="*/ 419 h 318"/>
                  <a:gd name="T10" fmla="*/ 2603 w 259"/>
                  <a:gd name="T11" fmla="*/ 0 h 318"/>
                  <a:gd name="T12" fmla="*/ 30 w 259"/>
                  <a:gd name="T13" fmla="*/ 3072 h 318"/>
                  <a:gd name="T14" fmla="*/ 1791 w 259"/>
                  <a:gd name="T15" fmla="*/ 6029 h 318"/>
                  <a:gd name="T16" fmla="*/ 575 w 259"/>
                  <a:gd name="T17" fmla="*/ 4288 h 31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9" h="318">
                    <a:moveTo>
                      <a:pt x="37" y="226"/>
                    </a:moveTo>
                    <a:cubicBezTo>
                      <a:pt x="33" y="211"/>
                      <a:pt x="32" y="188"/>
                      <a:pt x="32" y="171"/>
                    </a:cubicBezTo>
                    <a:cubicBezTo>
                      <a:pt x="30" y="105"/>
                      <a:pt x="68" y="53"/>
                      <a:pt x="116" y="27"/>
                    </a:cubicBezTo>
                    <a:cubicBezTo>
                      <a:pt x="141" y="13"/>
                      <a:pt x="174" y="14"/>
                      <a:pt x="205" y="14"/>
                    </a:cubicBezTo>
                    <a:cubicBezTo>
                      <a:pt x="223" y="14"/>
                      <a:pt x="241" y="17"/>
                      <a:pt x="259" y="22"/>
                    </a:cubicBezTo>
                    <a:cubicBezTo>
                      <a:pt x="232" y="7"/>
                      <a:pt x="200" y="0"/>
                      <a:pt x="167" y="0"/>
                    </a:cubicBezTo>
                    <a:cubicBezTo>
                      <a:pt x="80" y="0"/>
                      <a:pt x="0" y="59"/>
                      <a:pt x="2" y="162"/>
                    </a:cubicBezTo>
                    <a:cubicBezTo>
                      <a:pt x="3" y="245"/>
                      <a:pt x="48" y="300"/>
                      <a:pt x="115" y="318"/>
                    </a:cubicBezTo>
                    <a:cubicBezTo>
                      <a:pt x="80" y="298"/>
                      <a:pt x="48" y="269"/>
                      <a:pt x="37" y="226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4" name="Freeform 60"/>
              <p:cNvSpPr/>
              <p:nvPr/>
            </p:nvSpPr>
            <p:spPr bwMode="auto">
              <a:xfrm>
                <a:off x="8848498" y="4507342"/>
                <a:ext cx="650875" cy="690563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404 h 163"/>
                  <a:gd name="T4" fmla="*/ 1208 w 164"/>
                  <a:gd name="T5" fmla="*/ 3064 h 163"/>
                  <a:gd name="T6" fmla="*/ 2500 w 164"/>
                  <a:gd name="T7" fmla="*/ 176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F1AE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5" name="Freeform 61"/>
              <p:cNvSpPr/>
              <p:nvPr/>
            </p:nvSpPr>
            <p:spPr bwMode="auto">
              <a:xfrm>
                <a:off x="9065985" y="4756579"/>
                <a:ext cx="409575" cy="398463"/>
              </a:xfrm>
              <a:custGeom>
                <a:avLst/>
                <a:gdLst>
                  <a:gd name="T0" fmla="*/ 0 w 103"/>
                  <a:gd name="T1" fmla="*/ 1677 h 94"/>
                  <a:gd name="T2" fmla="*/ 1147 w 103"/>
                  <a:gd name="T3" fmla="*/ 1503 h 94"/>
                  <a:gd name="T4" fmla="*/ 1368 w 103"/>
                  <a:gd name="T5" fmla="*/ 0 h 9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3" h="94">
                    <a:moveTo>
                      <a:pt x="0" y="88"/>
                    </a:moveTo>
                    <a:cubicBezTo>
                      <a:pt x="18" y="93"/>
                      <a:pt x="59" y="94"/>
                      <a:pt x="73" y="79"/>
                    </a:cubicBezTo>
                    <a:cubicBezTo>
                      <a:pt x="94" y="58"/>
                      <a:pt x="103" y="23"/>
                      <a:pt x="87" y="0"/>
                    </a:cubicBezTo>
                  </a:path>
                </a:pathLst>
              </a:custGeom>
              <a:solidFill>
                <a:srgbClr val="EB98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6" name="Freeform 62"/>
              <p:cNvSpPr/>
              <p:nvPr/>
            </p:nvSpPr>
            <p:spPr bwMode="auto">
              <a:xfrm>
                <a:off x="8784998" y="4448604"/>
                <a:ext cx="714375" cy="749301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00ABC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7" name="Freeform 63"/>
              <p:cNvSpPr/>
              <p:nvPr/>
            </p:nvSpPr>
            <p:spPr bwMode="auto">
              <a:xfrm>
                <a:off x="8923110" y="4558142"/>
                <a:ext cx="484188" cy="550863"/>
              </a:xfrm>
              <a:custGeom>
                <a:avLst/>
                <a:gdLst>
                  <a:gd name="T0" fmla="*/ 1283 w 122"/>
                  <a:gd name="T1" fmla="*/ 0 h 130"/>
                  <a:gd name="T2" fmla="*/ 1625 w 122"/>
                  <a:gd name="T3" fmla="*/ 1046 h 130"/>
                  <a:gd name="T4" fmla="*/ 1313 w 122"/>
                  <a:gd name="T5" fmla="*/ 1674 h 130"/>
                  <a:gd name="T6" fmla="*/ 438 w 122"/>
                  <a:gd name="T7" fmla="*/ 2223 h 130"/>
                  <a:gd name="T8" fmla="*/ 0 w 122"/>
                  <a:gd name="T9" fmla="*/ 2074 h 130"/>
                  <a:gd name="T10" fmla="*/ 675 w 122"/>
                  <a:gd name="T11" fmla="*/ 2450 h 130"/>
                  <a:gd name="T12" fmla="*/ 1863 w 122"/>
                  <a:gd name="T13" fmla="*/ 1276 h 130"/>
                  <a:gd name="T14" fmla="*/ 1283 w 122"/>
                  <a:gd name="T15" fmla="*/ 0 h 130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22" h="130">
                    <a:moveTo>
                      <a:pt x="82" y="0"/>
                    </a:moveTo>
                    <a:cubicBezTo>
                      <a:pt x="98" y="15"/>
                      <a:pt x="106" y="36"/>
                      <a:pt x="104" y="55"/>
                    </a:cubicBezTo>
                    <a:cubicBezTo>
                      <a:pt x="101" y="74"/>
                      <a:pt x="90" y="79"/>
                      <a:pt x="84" y="88"/>
                    </a:cubicBezTo>
                    <a:cubicBezTo>
                      <a:pt x="70" y="107"/>
                      <a:pt x="54" y="118"/>
                      <a:pt x="28" y="117"/>
                    </a:cubicBezTo>
                    <a:cubicBezTo>
                      <a:pt x="18" y="117"/>
                      <a:pt x="9" y="113"/>
                      <a:pt x="0" y="109"/>
                    </a:cubicBezTo>
                    <a:cubicBezTo>
                      <a:pt x="12" y="120"/>
                      <a:pt x="27" y="128"/>
                      <a:pt x="43" y="129"/>
                    </a:cubicBezTo>
                    <a:cubicBezTo>
                      <a:pt x="82" y="130"/>
                      <a:pt x="112" y="122"/>
                      <a:pt x="119" y="67"/>
                    </a:cubicBezTo>
                    <a:cubicBezTo>
                      <a:pt x="122" y="43"/>
                      <a:pt x="109" y="15"/>
                      <a:pt x="82" y="0"/>
                    </a:cubicBezTo>
                    <a:close/>
                  </a:path>
                </a:pathLst>
              </a:custGeom>
              <a:solidFill>
                <a:srgbClr val="0094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8" name="Freeform 64"/>
              <p:cNvSpPr/>
              <p:nvPr/>
            </p:nvSpPr>
            <p:spPr bwMode="auto">
              <a:xfrm>
                <a:off x="8819923" y="4477179"/>
                <a:ext cx="433388" cy="530225"/>
              </a:xfrm>
              <a:custGeom>
                <a:avLst/>
                <a:gdLst>
                  <a:gd name="T0" fmla="*/ 301 w 109"/>
                  <a:gd name="T1" fmla="*/ 1542 h 125"/>
                  <a:gd name="T2" fmla="*/ 676 w 109"/>
                  <a:gd name="T3" fmla="*/ 799 h 125"/>
                  <a:gd name="T4" fmla="*/ 1430 w 109"/>
                  <a:gd name="T5" fmla="*/ 307 h 125"/>
                  <a:gd name="T6" fmla="*/ 1538 w 109"/>
                  <a:gd name="T7" fmla="*/ 286 h 125"/>
                  <a:gd name="T8" fmla="*/ 1180 w 109"/>
                  <a:gd name="T9" fmla="*/ 150 h 125"/>
                  <a:gd name="T10" fmla="*/ 50 w 109"/>
                  <a:gd name="T11" fmla="*/ 1299 h 125"/>
                  <a:gd name="T12" fmla="*/ 376 w 109"/>
                  <a:gd name="T13" fmla="*/ 2383 h 125"/>
                  <a:gd name="T14" fmla="*/ 301 w 109"/>
                  <a:gd name="T15" fmla="*/ 1542 h 12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125">
                    <a:moveTo>
                      <a:pt x="19" y="81"/>
                    </a:moveTo>
                    <a:cubicBezTo>
                      <a:pt x="21" y="65"/>
                      <a:pt x="33" y="55"/>
                      <a:pt x="43" y="42"/>
                    </a:cubicBezTo>
                    <a:cubicBezTo>
                      <a:pt x="54" y="28"/>
                      <a:pt x="65" y="12"/>
                      <a:pt x="91" y="16"/>
                    </a:cubicBezTo>
                    <a:cubicBezTo>
                      <a:pt x="104" y="18"/>
                      <a:pt x="109" y="19"/>
                      <a:pt x="98" y="15"/>
                    </a:cubicBezTo>
                    <a:cubicBezTo>
                      <a:pt x="91" y="11"/>
                      <a:pt x="83" y="9"/>
                      <a:pt x="75" y="8"/>
                    </a:cubicBezTo>
                    <a:cubicBezTo>
                      <a:pt x="28" y="0"/>
                      <a:pt x="7" y="32"/>
                      <a:pt x="3" y="68"/>
                    </a:cubicBezTo>
                    <a:cubicBezTo>
                      <a:pt x="0" y="88"/>
                      <a:pt x="9" y="110"/>
                      <a:pt x="24" y="125"/>
                    </a:cubicBezTo>
                    <a:cubicBezTo>
                      <a:pt x="15" y="106"/>
                      <a:pt x="16" y="101"/>
                      <a:pt x="19" y="81"/>
                    </a:cubicBezTo>
                    <a:close/>
                  </a:path>
                </a:pathLst>
              </a:custGeom>
              <a:solidFill>
                <a:srgbClr val="DEEE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9" name="Freeform 65"/>
              <p:cNvSpPr/>
              <p:nvPr/>
            </p:nvSpPr>
            <p:spPr bwMode="auto">
              <a:xfrm>
                <a:off x="8907235" y="4197779"/>
                <a:ext cx="917575" cy="1274763"/>
              </a:xfrm>
              <a:custGeom>
                <a:avLst/>
                <a:gdLst>
                  <a:gd name="T0" fmla="*/ 2270 w 222"/>
                  <a:gd name="T1" fmla="*/ 0 h 301"/>
                  <a:gd name="T2" fmla="*/ 2895 w 222"/>
                  <a:gd name="T3" fmla="*/ 2428 h 301"/>
                  <a:gd name="T4" fmla="*/ 2125 w 222"/>
                  <a:gd name="T5" fmla="*/ 4212 h 301"/>
                  <a:gd name="T6" fmla="*/ 0 w 222"/>
                  <a:gd name="T7" fmla="*/ 5624 h 301"/>
                  <a:gd name="T8" fmla="*/ 708 w 222"/>
                  <a:gd name="T9" fmla="*/ 5714 h 301"/>
                  <a:gd name="T10" fmla="*/ 3438 w 222"/>
                  <a:gd name="T11" fmla="*/ 2620 h 301"/>
                  <a:gd name="T12" fmla="*/ 2270 w 222"/>
                  <a:gd name="T13" fmla="*/ 0 h 30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22" h="301">
                    <a:moveTo>
                      <a:pt x="145" y="0"/>
                    </a:moveTo>
                    <a:cubicBezTo>
                      <a:pt x="185" y="44"/>
                      <a:pt x="184" y="51"/>
                      <a:pt x="185" y="128"/>
                    </a:cubicBezTo>
                    <a:cubicBezTo>
                      <a:pt x="186" y="175"/>
                      <a:pt x="161" y="195"/>
                      <a:pt x="136" y="222"/>
                    </a:cubicBezTo>
                    <a:cubicBezTo>
                      <a:pt x="104" y="256"/>
                      <a:pt x="65" y="291"/>
                      <a:pt x="0" y="296"/>
                    </a:cubicBezTo>
                    <a:cubicBezTo>
                      <a:pt x="14" y="299"/>
                      <a:pt x="29" y="301"/>
                      <a:pt x="45" y="301"/>
                    </a:cubicBezTo>
                    <a:cubicBezTo>
                      <a:pt x="139" y="301"/>
                      <a:pt x="222" y="248"/>
                      <a:pt x="220" y="138"/>
                    </a:cubicBezTo>
                    <a:cubicBezTo>
                      <a:pt x="219" y="71"/>
                      <a:pt x="188" y="25"/>
                      <a:pt x="145" y="0"/>
                    </a:cubicBezTo>
                    <a:close/>
                  </a:path>
                </a:pathLst>
              </a:cu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70" name="Freeform 66"/>
              <p:cNvSpPr/>
              <p:nvPr/>
            </p:nvSpPr>
            <p:spPr bwMode="auto">
              <a:xfrm>
                <a:off x="8419873" y="4088242"/>
                <a:ext cx="661988" cy="693738"/>
              </a:xfrm>
              <a:custGeom>
                <a:avLst/>
                <a:gdLst>
                  <a:gd name="T0" fmla="*/ 30 w 167"/>
                  <a:gd name="T1" fmla="*/ 3102 h 164"/>
                  <a:gd name="T2" fmla="*/ 2599 w 167"/>
                  <a:gd name="T3" fmla="*/ 35 h 164"/>
                  <a:gd name="T4" fmla="*/ 30 w 167"/>
                  <a:gd name="T5" fmla="*/ 3102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7" h="164">
                    <a:moveTo>
                      <a:pt x="2" y="164"/>
                    </a:moveTo>
                    <a:cubicBezTo>
                      <a:pt x="0" y="61"/>
                      <a:pt x="80" y="2"/>
                      <a:pt x="167" y="2"/>
                    </a:cubicBezTo>
                    <a:cubicBezTo>
                      <a:pt x="119" y="0"/>
                      <a:pt x="29" y="50"/>
                      <a:pt x="2" y="164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71" name="Freeform 67"/>
              <p:cNvSpPr/>
              <p:nvPr/>
            </p:nvSpPr>
            <p:spPr bwMode="auto">
              <a:xfrm>
                <a:off x="9086623" y="4781979"/>
                <a:ext cx="701675" cy="690563"/>
              </a:xfrm>
              <a:custGeom>
                <a:avLst/>
                <a:gdLst>
                  <a:gd name="T0" fmla="*/ 0 w 177"/>
                  <a:gd name="T1" fmla="*/ 3098 h 163"/>
                  <a:gd name="T2" fmla="*/ 2724 w 177"/>
                  <a:gd name="T3" fmla="*/ 0 h 163"/>
                  <a:gd name="T4" fmla="*/ 0 w 177"/>
                  <a:gd name="T5" fmla="*/ 3098 h 16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7" h="163">
                    <a:moveTo>
                      <a:pt x="0" y="163"/>
                    </a:moveTo>
                    <a:cubicBezTo>
                      <a:pt x="94" y="163"/>
                      <a:pt x="177" y="110"/>
                      <a:pt x="175" y="0"/>
                    </a:cubicBezTo>
                    <a:cubicBezTo>
                      <a:pt x="148" y="70"/>
                      <a:pt x="121" y="149"/>
                      <a:pt x="0" y="163"/>
                    </a:cubicBezTo>
                    <a:close/>
                  </a:path>
                </a:pathLst>
              </a:cu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72" name="Freeform 68"/>
              <p:cNvSpPr/>
              <p:nvPr/>
            </p:nvSpPr>
            <p:spPr bwMode="auto">
              <a:xfrm>
                <a:off x="9094560" y="4829604"/>
                <a:ext cx="301625" cy="279400"/>
              </a:xfrm>
              <a:custGeom>
                <a:avLst/>
                <a:gdLst>
                  <a:gd name="T0" fmla="*/ 1188 w 76"/>
                  <a:gd name="T1" fmla="*/ 56 h 66"/>
                  <a:gd name="T2" fmla="*/ 0 w 76"/>
                  <a:gd name="T3" fmla="*/ 1229 h 66"/>
                  <a:gd name="T4" fmla="*/ 1175 w 76"/>
                  <a:gd name="T5" fmla="*/ 0 h 6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6" h="66">
                    <a:moveTo>
                      <a:pt x="76" y="3"/>
                    </a:moveTo>
                    <a:cubicBezTo>
                      <a:pt x="69" y="58"/>
                      <a:pt x="39" y="66"/>
                      <a:pt x="0" y="65"/>
                    </a:cubicBezTo>
                    <a:cubicBezTo>
                      <a:pt x="25" y="62"/>
                      <a:pt x="60" y="46"/>
                      <a:pt x="75" y="0"/>
                    </a:cubicBezTo>
                  </a:path>
                </a:pathLst>
              </a:custGeom>
              <a:solidFill>
                <a:srgbClr val="006C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74" name="Freeform 70"/>
              <p:cNvSpPr/>
              <p:nvPr/>
            </p:nvSpPr>
            <p:spPr bwMode="auto">
              <a:xfrm>
                <a:off x="8784996" y="4448605"/>
                <a:ext cx="650874" cy="688980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FFFFFF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75" name="Freeform 71"/>
              <p:cNvSpPr/>
              <p:nvPr/>
            </p:nvSpPr>
            <p:spPr bwMode="auto">
              <a:xfrm>
                <a:off x="8811985" y="4532742"/>
                <a:ext cx="111125" cy="119063"/>
              </a:xfrm>
              <a:custGeom>
                <a:avLst/>
                <a:gdLst>
                  <a:gd name="T0" fmla="*/ 20 w 28"/>
                  <a:gd name="T1" fmla="*/ 287 h 28"/>
                  <a:gd name="T2" fmla="*/ 208 w 28"/>
                  <a:gd name="T3" fmla="*/ 21 h 28"/>
                  <a:gd name="T4" fmla="*/ 425 w 28"/>
                  <a:gd name="T5" fmla="*/ 252 h 28"/>
                  <a:gd name="T6" fmla="*/ 238 w 28"/>
                  <a:gd name="T7" fmla="*/ 517 h 28"/>
                  <a:gd name="T8" fmla="*/ 20 w 28"/>
                  <a:gd name="T9" fmla="*/ 287 h 2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8" h="28">
                    <a:moveTo>
                      <a:pt x="1" y="15"/>
                    </a:moveTo>
                    <a:cubicBezTo>
                      <a:pt x="0" y="8"/>
                      <a:pt x="6" y="2"/>
                      <a:pt x="13" y="1"/>
                    </a:cubicBezTo>
                    <a:cubicBezTo>
                      <a:pt x="20" y="0"/>
                      <a:pt x="27" y="6"/>
                      <a:pt x="27" y="13"/>
                    </a:cubicBezTo>
                    <a:cubicBezTo>
                      <a:pt x="28" y="20"/>
                      <a:pt x="22" y="27"/>
                      <a:pt x="15" y="27"/>
                    </a:cubicBezTo>
                    <a:cubicBezTo>
                      <a:pt x="8" y="28"/>
                      <a:pt x="2" y="22"/>
                      <a:pt x="1" y="15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76" name="Freeform 72"/>
              <p:cNvSpPr/>
              <p:nvPr/>
            </p:nvSpPr>
            <p:spPr bwMode="auto">
              <a:xfrm>
                <a:off x="8907235" y="4474004"/>
                <a:ext cx="68263" cy="71438"/>
              </a:xfrm>
              <a:custGeom>
                <a:avLst/>
                <a:gdLst>
                  <a:gd name="T0" fmla="*/ 20 w 17"/>
                  <a:gd name="T1" fmla="*/ 169 h 17"/>
                  <a:gd name="T2" fmla="*/ 129 w 17"/>
                  <a:gd name="T3" fmla="*/ 0 h 17"/>
                  <a:gd name="T4" fmla="*/ 276 w 17"/>
                  <a:gd name="T5" fmla="*/ 148 h 17"/>
                  <a:gd name="T6" fmla="*/ 147 w 17"/>
                  <a:gd name="T7" fmla="*/ 315 h 17"/>
                  <a:gd name="T8" fmla="*/ 20 w 17"/>
                  <a:gd name="T9" fmla="*/ 169 h 1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" h="17">
                    <a:moveTo>
                      <a:pt x="1" y="9"/>
                    </a:moveTo>
                    <a:cubicBezTo>
                      <a:pt x="0" y="5"/>
                      <a:pt x="4" y="1"/>
                      <a:pt x="8" y="0"/>
                    </a:cubicBezTo>
                    <a:cubicBezTo>
                      <a:pt x="13" y="0"/>
                      <a:pt x="16" y="3"/>
                      <a:pt x="17" y="8"/>
                    </a:cubicBezTo>
                    <a:cubicBezTo>
                      <a:pt x="17" y="12"/>
                      <a:pt x="14" y="16"/>
                      <a:pt x="9" y="17"/>
                    </a:cubicBezTo>
                    <a:cubicBezTo>
                      <a:pt x="5" y="17"/>
                      <a:pt x="1" y="14"/>
                      <a:pt x="1" y="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77" name="Freeform 73"/>
              <p:cNvSpPr/>
              <p:nvPr/>
            </p:nvSpPr>
            <p:spPr bwMode="auto">
              <a:xfrm>
                <a:off x="8804048" y="4667679"/>
                <a:ext cx="52388" cy="60325"/>
              </a:xfrm>
              <a:custGeom>
                <a:avLst/>
                <a:gdLst>
                  <a:gd name="T0" fmla="*/ 0 w 13"/>
                  <a:gd name="T1" fmla="*/ 141 h 14"/>
                  <a:gd name="T2" fmla="*/ 96 w 13"/>
                  <a:gd name="T3" fmla="*/ 0 h 14"/>
                  <a:gd name="T4" fmla="*/ 213 w 13"/>
                  <a:gd name="T5" fmla="*/ 117 h 14"/>
                  <a:gd name="T6" fmla="*/ 117 w 13"/>
                  <a:gd name="T7" fmla="*/ 258 h 14"/>
                  <a:gd name="T8" fmla="*/ 0 w 13"/>
                  <a:gd name="T9" fmla="*/ 141 h 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3" h="14">
                    <a:moveTo>
                      <a:pt x="0" y="7"/>
                    </a:moveTo>
                    <a:cubicBezTo>
                      <a:pt x="0" y="4"/>
                      <a:pt x="2" y="1"/>
                      <a:pt x="6" y="0"/>
                    </a:cubicBezTo>
                    <a:cubicBezTo>
                      <a:pt x="10" y="0"/>
                      <a:pt x="13" y="3"/>
                      <a:pt x="13" y="6"/>
                    </a:cubicBezTo>
                    <a:cubicBezTo>
                      <a:pt x="13" y="10"/>
                      <a:pt x="11" y="13"/>
                      <a:pt x="7" y="13"/>
                    </a:cubicBezTo>
                    <a:cubicBezTo>
                      <a:pt x="3" y="14"/>
                      <a:pt x="0" y="11"/>
                      <a:pt x="0" y="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</p:grpSp>
        <p:sp>
          <p:nvSpPr>
            <p:cNvPr id="4" name="圆: 空心 30"/>
            <p:cNvSpPr/>
            <p:nvPr/>
          </p:nvSpPr>
          <p:spPr>
            <a:xfrm>
              <a:off x="2254953" y="2285069"/>
              <a:ext cx="1676264" cy="1654215"/>
            </a:xfrm>
            <a:prstGeom prst="donut">
              <a:avLst>
                <a:gd name="adj" fmla="val 2544"/>
              </a:avLst>
            </a:prstGeom>
            <a:solidFill>
              <a:schemeClr val="accent1">
                <a:lumMod val="50000"/>
              </a:schemeClr>
            </a:solidFill>
            <a:ln>
              <a:solidFill>
                <a:schemeClr val="accent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isometricOffAxis2Top"/>
              <a:lightRig rig="balanced" dir="t">
                <a:rot lat="0" lon="0" rev="16200000"/>
              </a:lightRig>
            </a:scene3d>
            <a:sp3d z="381000" extrusionH="381000" prstMaterial="clear">
              <a:bevelT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grpSp>
          <p:nvGrpSpPr>
            <p:cNvPr id="147" name="组合 146"/>
            <p:cNvGrpSpPr/>
            <p:nvPr/>
          </p:nvGrpSpPr>
          <p:grpSpPr>
            <a:xfrm rot="3009645">
              <a:off x="3215564" y="3173454"/>
              <a:ext cx="265877" cy="96563"/>
              <a:chOff x="8377112" y="4045382"/>
              <a:chExt cx="1447698" cy="1473194"/>
            </a:xfrm>
          </p:grpSpPr>
          <p:sp>
            <p:nvSpPr>
              <p:cNvPr id="148" name="Freeform 58"/>
              <p:cNvSpPr/>
              <p:nvPr/>
            </p:nvSpPr>
            <p:spPr bwMode="auto">
              <a:xfrm>
                <a:off x="8377112" y="4045382"/>
                <a:ext cx="1444634" cy="1473194"/>
              </a:xfrm>
              <a:custGeom>
                <a:avLst/>
                <a:gdLst>
                  <a:gd name="T0" fmla="*/ 2813 w 364"/>
                  <a:gd name="T1" fmla="*/ 0 h 348"/>
                  <a:gd name="T2" fmla="*/ 33 w 364"/>
                  <a:gd name="T3" fmla="*/ 3299 h 348"/>
                  <a:gd name="T4" fmla="*/ 2750 w 364"/>
                  <a:gd name="T5" fmla="*/ 6600 h 348"/>
                  <a:gd name="T6" fmla="*/ 5658 w 364"/>
                  <a:gd name="T7" fmla="*/ 3299 h 348"/>
                  <a:gd name="T8" fmla="*/ 2813 w 364"/>
                  <a:gd name="T9" fmla="*/ 0 h 34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64" h="348">
                    <a:moveTo>
                      <a:pt x="180" y="0"/>
                    </a:moveTo>
                    <a:cubicBezTo>
                      <a:pt x="86" y="0"/>
                      <a:pt x="0" y="64"/>
                      <a:pt x="2" y="174"/>
                    </a:cubicBezTo>
                    <a:cubicBezTo>
                      <a:pt x="4" y="284"/>
                      <a:pt x="76" y="348"/>
                      <a:pt x="176" y="348"/>
                    </a:cubicBezTo>
                    <a:cubicBezTo>
                      <a:pt x="277" y="348"/>
                      <a:pt x="364" y="292"/>
                      <a:pt x="362" y="174"/>
                    </a:cubicBezTo>
                    <a:cubicBezTo>
                      <a:pt x="360" y="56"/>
                      <a:pt x="274" y="0"/>
                      <a:pt x="180" y="0"/>
                    </a:cubicBezTo>
                    <a:close/>
                  </a:path>
                </a:pathLst>
              </a:custGeom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49" name="Freeform 59"/>
              <p:cNvSpPr/>
              <p:nvPr/>
            </p:nvSpPr>
            <p:spPr bwMode="auto">
              <a:xfrm>
                <a:off x="8419873" y="4096179"/>
                <a:ext cx="1027113" cy="1346200"/>
              </a:xfrm>
              <a:custGeom>
                <a:avLst/>
                <a:gdLst>
                  <a:gd name="T0" fmla="*/ 575 w 259"/>
                  <a:gd name="T1" fmla="*/ 4288 h 318"/>
                  <a:gd name="T2" fmla="*/ 500 w 259"/>
                  <a:gd name="T3" fmla="*/ 3243 h 318"/>
                  <a:gd name="T4" fmla="*/ 1809 w 259"/>
                  <a:gd name="T5" fmla="*/ 512 h 318"/>
                  <a:gd name="T6" fmla="*/ 3195 w 259"/>
                  <a:gd name="T7" fmla="*/ 264 h 318"/>
                  <a:gd name="T8" fmla="*/ 4037 w 259"/>
                  <a:gd name="T9" fmla="*/ 419 h 318"/>
                  <a:gd name="T10" fmla="*/ 2603 w 259"/>
                  <a:gd name="T11" fmla="*/ 0 h 318"/>
                  <a:gd name="T12" fmla="*/ 30 w 259"/>
                  <a:gd name="T13" fmla="*/ 3072 h 318"/>
                  <a:gd name="T14" fmla="*/ 1791 w 259"/>
                  <a:gd name="T15" fmla="*/ 6029 h 318"/>
                  <a:gd name="T16" fmla="*/ 575 w 259"/>
                  <a:gd name="T17" fmla="*/ 4288 h 31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9" h="318">
                    <a:moveTo>
                      <a:pt x="37" y="226"/>
                    </a:moveTo>
                    <a:cubicBezTo>
                      <a:pt x="33" y="211"/>
                      <a:pt x="32" y="188"/>
                      <a:pt x="32" y="171"/>
                    </a:cubicBezTo>
                    <a:cubicBezTo>
                      <a:pt x="30" y="105"/>
                      <a:pt x="68" y="53"/>
                      <a:pt x="116" y="27"/>
                    </a:cubicBezTo>
                    <a:cubicBezTo>
                      <a:pt x="141" y="13"/>
                      <a:pt x="174" y="14"/>
                      <a:pt x="205" y="14"/>
                    </a:cubicBezTo>
                    <a:cubicBezTo>
                      <a:pt x="223" y="14"/>
                      <a:pt x="241" y="17"/>
                      <a:pt x="259" y="22"/>
                    </a:cubicBezTo>
                    <a:cubicBezTo>
                      <a:pt x="232" y="7"/>
                      <a:pt x="200" y="0"/>
                      <a:pt x="167" y="0"/>
                    </a:cubicBezTo>
                    <a:cubicBezTo>
                      <a:pt x="80" y="0"/>
                      <a:pt x="0" y="59"/>
                      <a:pt x="2" y="162"/>
                    </a:cubicBezTo>
                    <a:cubicBezTo>
                      <a:pt x="3" y="245"/>
                      <a:pt x="48" y="300"/>
                      <a:pt x="115" y="318"/>
                    </a:cubicBezTo>
                    <a:cubicBezTo>
                      <a:pt x="80" y="298"/>
                      <a:pt x="48" y="269"/>
                      <a:pt x="37" y="226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0" name="Freeform 60"/>
              <p:cNvSpPr/>
              <p:nvPr/>
            </p:nvSpPr>
            <p:spPr bwMode="auto">
              <a:xfrm>
                <a:off x="8848498" y="4507342"/>
                <a:ext cx="650875" cy="690563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404 h 163"/>
                  <a:gd name="T4" fmla="*/ 1208 w 164"/>
                  <a:gd name="T5" fmla="*/ 3064 h 163"/>
                  <a:gd name="T6" fmla="*/ 2500 w 164"/>
                  <a:gd name="T7" fmla="*/ 176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F1AE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1" name="Freeform 61"/>
              <p:cNvSpPr/>
              <p:nvPr/>
            </p:nvSpPr>
            <p:spPr bwMode="auto">
              <a:xfrm>
                <a:off x="9065985" y="4756579"/>
                <a:ext cx="409575" cy="398463"/>
              </a:xfrm>
              <a:custGeom>
                <a:avLst/>
                <a:gdLst>
                  <a:gd name="T0" fmla="*/ 0 w 103"/>
                  <a:gd name="T1" fmla="*/ 1677 h 94"/>
                  <a:gd name="T2" fmla="*/ 1147 w 103"/>
                  <a:gd name="T3" fmla="*/ 1503 h 94"/>
                  <a:gd name="T4" fmla="*/ 1368 w 103"/>
                  <a:gd name="T5" fmla="*/ 0 h 9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3" h="94">
                    <a:moveTo>
                      <a:pt x="0" y="88"/>
                    </a:moveTo>
                    <a:cubicBezTo>
                      <a:pt x="18" y="93"/>
                      <a:pt x="59" y="94"/>
                      <a:pt x="73" y="79"/>
                    </a:cubicBezTo>
                    <a:cubicBezTo>
                      <a:pt x="94" y="58"/>
                      <a:pt x="103" y="23"/>
                      <a:pt x="87" y="0"/>
                    </a:cubicBezTo>
                  </a:path>
                </a:pathLst>
              </a:custGeom>
              <a:solidFill>
                <a:srgbClr val="EB98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2" name="Freeform 62"/>
              <p:cNvSpPr/>
              <p:nvPr/>
            </p:nvSpPr>
            <p:spPr bwMode="auto">
              <a:xfrm>
                <a:off x="8784998" y="4448604"/>
                <a:ext cx="714375" cy="749301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00ABC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3" name="Freeform 63"/>
              <p:cNvSpPr/>
              <p:nvPr/>
            </p:nvSpPr>
            <p:spPr bwMode="auto">
              <a:xfrm>
                <a:off x="8923110" y="4558142"/>
                <a:ext cx="484188" cy="550863"/>
              </a:xfrm>
              <a:custGeom>
                <a:avLst/>
                <a:gdLst>
                  <a:gd name="T0" fmla="*/ 1283 w 122"/>
                  <a:gd name="T1" fmla="*/ 0 h 130"/>
                  <a:gd name="T2" fmla="*/ 1625 w 122"/>
                  <a:gd name="T3" fmla="*/ 1046 h 130"/>
                  <a:gd name="T4" fmla="*/ 1313 w 122"/>
                  <a:gd name="T5" fmla="*/ 1674 h 130"/>
                  <a:gd name="T6" fmla="*/ 438 w 122"/>
                  <a:gd name="T7" fmla="*/ 2223 h 130"/>
                  <a:gd name="T8" fmla="*/ 0 w 122"/>
                  <a:gd name="T9" fmla="*/ 2074 h 130"/>
                  <a:gd name="T10" fmla="*/ 675 w 122"/>
                  <a:gd name="T11" fmla="*/ 2450 h 130"/>
                  <a:gd name="T12" fmla="*/ 1863 w 122"/>
                  <a:gd name="T13" fmla="*/ 1276 h 130"/>
                  <a:gd name="T14" fmla="*/ 1283 w 122"/>
                  <a:gd name="T15" fmla="*/ 0 h 130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22" h="130">
                    <a:moveTo>
                      <a:pt x="82" y="0"/>
                    </a:moveTo>
                    <a:cubicBezTo>
                      <a:pt x="98" y="15"/>
                      <a:pt x="106" y="36"/>
                      <a:pt x="104" y="55"/>
                    </a:cubicBezTo>
                    <a:cubicBezTo>
                      <a:pt x="101" y="74"/>
                      <a:pt x="90" y="79"/>
                      <a:pt x="84" y="88"/>
                    </a:cubicBezTo>
                    <a:cubicBezTo>
                      <a:pt x="70" y="107"/>
                      <a:pt x="54" y="118"/>
                      <a:pt x="28" y="117"/>
                    </a:cubicBezTo>
                    <a:cubicBezTo>
                      <a:pt x="18" y="117"/>
                      <a:pt x="9" y="113"/>
                      <a:pt x="0" y="109"/>
                    </a:cubicBezTo>
                    <a:cubicBezTo>
                      <a:pt x="12" y="120"/>
                      <a:pt x="27" y="128"/>
                      <a:pt x="43" y="129"/>
                    </a:cubicBezTo>
                    <a:cubicBezTo>
                      <a:pt x="82" y="130"/>
                      <a:pt x="112" y="122"/>
                      <a:pt x="119" y="67"/>
                    </a:cubicBezTo>
                    <a:cubicBezTo>
                      <a:pt x="122" y="43"/>
                      <a:pt x="109" y="15"/>
                      <a:pt x="82" y="0"/>
                    </a:cubicBezTo>
                    <a:close/>
                  </a:path>
                </a:pathLst>
              </a:custGeom>
              <a:solidFill>
                <a:srgbClr val="0094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4" name="Freeform 64"/>
              <p:cNvSpPr/>
              <p:nvPr/>
            </p:nvSpPr>
            <p:spPr bwMode="auto">
              <a:xfrm>
                <a:off x="8819923" y="4477179"/>
                <a:ext cx="433388" cy="530225"/>
              </a:xfrm>
              <a:custGeom>
                <a:avLst/>
                <a:gdLst>
                  <a:gd name="T0" fmla="*/ 301 w 109"/>
                  <a:gd name="T1" fmla="*/ 1542 h 125"/>
                  <a:gd name="T2" fmla="*/ 676 w 109"/>
                  <a:gd name="T3" fmla="*/ 799 h 125"/>
                  <a:gd name="T4" fmla="*/ 1430 w 109"/>
                  <a:gd name="T5" fmla="*/ 307 h 125"/>
                  <a:gd name="T6" fmla="*/ 1538 w 109"/>
                  <a:gd name="T7" fmla="*/ 286 h 125"/>
                  <a:gd name="T8" fmla="*/ 1180 w 109"/>
                  <a:gd name="T9" fmla="*/ 150 h 125"/>
                  <a:gd name="T10" fmla="*/ 50 w 109"/>
                  <a:gd name="T11" fmla="*/ 1299 h 125"/>
                  <a:gd name="T12" fmla="*/ 376 w 109"/>
                  <a:gd name="T13" fmla="*/ 2383 h 125"/>
                  <a:gd name="T14" fmla="*/ 301 w 109"/>
                  <a:gd name="T15" fmla="*/ 1542 h 12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125">
                    <a:moveTo>
                      <a:pt x="19" y="81"/>
                    </a:moveTo>
                    <a:cubicBezTo>
                      <a:pt x="21" y="65"/>
                      <a:pt x="33" y="55"/>
                      <a:pt x="43" y="42"/>
                    </a:cubicBezTo>
                    <a:cubicBezTo>
                      <a:pt x="54" y="28"/>
                      <a:pt x="65" y="12"/>
                      <a:pt x="91" y="16"/>
                    </a:cubicBezTo>
                    <a:cubicBezTo>
                      <a:pt x="104" y="18"/>
                      <a:pt x="109" y="19"/>
                      <a:pt x="98" y="15"/>
                    </a:cubicBezTo>
                    <a:cubicBezTo>
                      <a:pt x="91" y="11"/>
                      <a:pt x="83" y="9"/>
                      <a:pt x="75" y="8"/>
                    </a:cubicBezTo>
                    <a:cubicBezTo>
                      <a:pt x="28" y="0"/>
                      <a:pt x="7" y="32"/>
                      <a:pt x="3" y="68"/>
                    </a:cubicBezTo>
                    <a:cubicBezTo>
                      <a:pt x="0" y="88"/>
                      <a:pt x="9" y="110"/>
                      <a:pt x="24" y="125"/>
                    </a:cubicBezTo>
                    <a:cubicBezTo>
                      <a:pt x="15" y="106"/>
                      <a:pt x="16" y="101"/>
                      <a:pt x="19" y="81"/>
                    </a:cubicBezTo>
                    <a:close/>
                  </a:path>
                </a:pathLst>
              </a:custGeom>
              <a:solidFill>
                <a:srgbClr val="DEEE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5" name="Freeform 65"/>
              <p:cNvSpPr/>
              <p:nvPr/>
            </p:nvSpPr>
            <p:spPr bwMode="auto">
              <a:xfrm>
                <a:off x="8907235" y="4197779"/>
                <a:ext cx="917575" cy="1274763"/>
              </a:xfrm>
              <a:custGeom>
                <a:avLst/>
                <a:gdLst>
                  <a:gd name="T0" fmla="*/ 2270 w 222"/>
                  <a:gd name="T1" fmla="*/ 0 h 301"/>
                  <a:gd name="T2" fmla="*/ 2895 w 222"/>
                  <a:gd name="T3" fmla="*/ 2428 h 301"/>
                  <a:gd name="T4" fmla="*/ 2125 w 222"/>
                  <a:gd name="T5" fmla="*/ 4212 h 301"/>
                  <a:gd name="T6" fmla="*/ 0 w 222"/>
                  <a:gd name="T7" fmla="*/ 5624 h 301"/>
                  <a:gd name="T8" fmla="*/ 708 w 222"/>
                  <a:gd name="T9" fmla="*/ 5714 h 301"/>
                  <a:gd name="T10" fmla="*/ 3438 w 222"/>
                  <a:gd name="T11" fmla="*/ 2620 h 301"/>
                  <a:gd name="T12" fmla="*/ 2270 w 222"/>
                  <a:gd name="T13" fmla="*/ 0 h 30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22" h="301">
                    <a:moveTo>
                      <a:pt x="145" y="0"/>
                    </a:moveTo>
                    <a:cubicBezTo>
                      <a:pt x="185" y="44"/>
                      <a:pt x="184" y="51"/>
                      <a:pt x="185" y="128"/>
                    </a:cubicBezTo>
                    <a:cubicBezTo>
                      <a:pt x="186" y="175"/>
                      <a:pt x="161" y="195"/>
                      <a:pt x="136" y="222"/>
                    </a:cubicBezTo>
                    <a:cubicBezTo>
                      <a:pt x="104" y="256"/>
                      <a:pt x="65" y="291"/>
                      <a:pt x="0" y="296"/>
                    </a:cubicBezTo>
                    <a:cubicBezTo>
                      <a:pt x="14" y="299"/>
                      <a:pt x="29" y="301"/>
                      <a:pt x="45" y="301"/>
                    </a:cubicBezTo>
                    <a:cubicBezTo>
                      <a:pt x="139" y="301"/>
                      <a:pt x="222" y="248"/>
                      <a:pt x="220" y="138"/>
                    </a:cubicBezTo>
                    <a:cubicBezTo>
                      <a:pt x="219" y="71"/>
                      <a:pt x="188" y="25"/>
                      <a:pt x="145" y="0"/>
                    </a:cubicBezTo>
                    <a:close/>
                  </a:path>
                </a:pathLst>
              </a:cu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6" name="Freeform 66"/>
              <p:cNvSpPr/>
              <p:nvPr/>
            </p:nvSpPr>
            <p:spPr bwMode="auto">
              <a:xfrm>
                <a:off x="8419873" y="4088242"/>
                <a:ext cx="661988" cy="693738"/>
              </a:xfrm>
              <a:custGeom>
                <a:avLst/>
                <a:gdLst>
                  <a:gd name="T0" fmla="*/ 30 w 167"/>
                  <a:gd name="T1" fmla="*/ 3102 h 164"/>
                  <a:gd name="T2" fmla="*/ 2599 w 167"/>
                  <a:gd name="T3" fmla="*/ 35 h 164"/>
                  <a:gd name="T4" fmla="*/ 30 w 167"/>
                  <a:gd name="T5" fmla="*/ 3102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7" h="164">
                    <a:moveTo>
                      <a:pt x="2" y="164"/>
                    </a:moveTo>
                    <a:cubicBezTo>
                      <a:pt x="0" y="61"/>
                      <a:pt x="80" y="2"/>
                      <a:pt x="167" y="2"/>
                    </a:cubicBezTo>
                    <a:cubicBezTo>
                      <a:pt x="119" y="0"/>
                      <a:pt x="29" y="50"/>
                      <a:pt x="2" y="164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7" name="Freeform 67"/>
              <p:cNvSpPr/>
              <p:nvPr/>
            </p:nvSpPr>
            <p:spPr bwMode="auto">
              <a:xfrm>
                <a:off x="9086623" y="4781979"/>
                <a:ext cx="701675" cy="690563"/>
              </a:xfrm>
              <a:custGeom>
                <a:avLst/>
                <a:gdLst>
                  <a:gd name="T0" fmla="*/ 0 w 177"/>
                  <a:gd name="T1" fmla="*/ 3098 h 163"/>
                  <a:gd name="T2" fmla="*/ 2724 w 177"/>
                  <a:gd name="T3" fmla="*/ 0 h 163"/>
                  <a:gd name="T4" fmla="*/ 0 w 177"/>
                  <a:gd name="T5" fmla="*/ 3098 h 16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7" h="163">
                    <a:moveTo>
                      <a:pt x="0" y="163"/>
                    </a:moveTo>
                    <a:cubicBezTo>
                      <a:pt x="94" y="163"/>
                      <a:pt x="177" y="110"/>
                      <a:pt x="175" y="0"/>
                    </a:cubicBezTo>
                    <a:cubicBezTo>
                      <a:pt x="148" y="70"/>
                      <a:pt x="121" y="149"/>
                      <a:pt x="0" y="163"/>
                    </a:cubicBezTo>
                    <a:close/>
                  </a:path>
                </a:pathLst>
              </a:cu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8" name="Freeform 68"/>
              <p:cNvSpPr/>
              <p:nvPr/>
            </p:nvSpPr>
            <p:spPr bwMode="auto">
              <a:xfrm>
                <a:off x="9094560" y="4829604"/>
                <a:ext cx="301625" cy="279400"/>
              </a:xfrm>
              <a:custGeom>
                <a:avLst/>
                <a:gdLst>
                  <a:gd name="T0" fmla="*/ 1188 w 76"/>
                  <a:gd name="T1" fmla="*/ 56 h 66"/>
                  <a:gd name="T2" fmla="*/ 0 w 76"/>
                  <a:gd name="T3" fmla="*/ 1229 h 66"/>
                  <a:gd name="T4" fmla="*/ 1175 w 76"/>
                  <a:gd name="T5" fmla="*/ 0 h 6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6" h="66">
                    <a:moveTo>
                      <a:pt x="76" y="3"/>
                    </a:moveTo>
                    <a:cubicBezTo>
                      <a:pt x="69" y="58"/>
                      <a:pt x="39" y="66"/>
                      <a:pt x="0" y="65"/>
                    </a:cubicBezTo>
                    <a:cubicBezTo>
                      <a:pt x="25" y="62"/>
                      <a:pt x="60" y="46"/>
                      <a:pt x="75" y="0"/>
                    </a:cubicBezTo>
                  </a:path>
                </a:pathLst>
              </a:custGeom>
              <a:solidFill>
                <a:srgbClr val="006C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59" name="Freeform 70"/>
              <p:cNvSpPr/>
              <p:nvPr/>
            </p:nvSpPr>
            <p:spPr bwMode="auto">
              <a:xfrm>
                <a:off x="8784996" y="4448605"/>
                <a:ext cx="650874" cy="688980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FFFFFF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60" name="Freeform 71"/>
              <p:cNvSpPr/>
              <p:nvPr/>
            </p:nvSpPr>
            <p:spPr bwMode="auto">
              <a:xfrm>
                <a:off x="8811985" y="4532742"/>
                <a:ext cx="111125" cy="119063"/>
              </a:xfrm>
              <a:custGeom>
                <a:avLst/>
                <a:gdLst>
                  <a:gd name="T0" fmla="*/ 20 w 28"/>
                  <a:gd name="T1" fmla="*/ 287 h 28"/>
                  <a:gd name="T2" fmla="*/ 208 w 28"/>
                  <a:gd name="T3" fmla="*/ 21 h 28"/>
                  <a:gd name="T4" fmla="*/ 425 w 28"/>
                  <a:gd name="T5" fmla="*/ 252 h 28"/>
                  <a:gd name="T6" fmla="*/ 238 w 28"/>
                  <a:gd name="T7" fmla="*/ 517 h 28"/>
                  <a:gd name="T8" fmla="*/ 20 w 28"/>
                  <a:gd name="T9" fmla="*/ 287 h 2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8" h="28">
                    <a:moveTo>
                      <a:pt x="1" y="15"/>
                    </a:moveTo>
                    <a:cubicBezTo>
                      <a:pt x="0" y="8"/>
                      <a:pt x="6" y="2"/>
                      <a:pt x="13" y="1"/>
                    </a:cubicBezTo>
                    <a:cubicBezTo>
                      <a:pt x="20" y="0"/>
                      <a:pt x="27" y="6"/>
                      <a:pt x="27" y="13"/>
                    </a:cubicBezTo>
                    <a:cubicBezTo>
                      <a:pt x="28" y="20"/>
                      <a:pt x="22" y="27"/>
                      <a:pt x="15" y="27"/>
                    </a:cubicBezTo>
                    <a:cubicBezTo>
                      <a:pt x="8" y="28"/>
                      <a:pt x="2" y="22"/>
                      <a:pt x="1" y="15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82" name="Freeform 72"/>
              <p:cNvSpPr/>
              <p:nvPr/>
            </p:nvSpPr>
            <p:spPr bwMode="auto">
              <a:xfrm>
                <a:off x="8907235" y="4474004"/>
                <a:ext cx="68263" cy="71438"/>
              </a:xfrm>
              <a:custGeom>
                <a:avLst/>
                <a:gdLst>
                  <a:gd name="T0" fmla="*/ 20 w 17"/>
                  <a:gd name="T1" fmla="*/ 169 h 17"/>
                  <a:gd name="T2" fmla="*/ 129 w 17"/>
                  <a:gd name="T3" fmla="*/ 0 h 17"/>
                  <a:gd name="T4" fmla="*/ 276 w 17"/>
                  <a:gd name="T5" fmla="*/ 148 h 17"/>
                  <a:gd name="T6" fmla="*/ 147 w 17"/>
                  <a:gd name="T7" fmla="*/ 315 h 17"/>
                  <a:gd name="T8" fmla="*/ 20 w 17"/>
                  <a:gd name="T9" fmla="*/ 169 h 1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" h="17">
                    <a:moveTo>
                      <a:pt x="1" y="9"/>
                    </a:moveTo>
                    <a:cubicBezTo>
                      <a:pt x="0" y="5"/>
                      <a:pt x="4" y="1"/>
                      <a:pt x="8" y="0"/>
                    </a:cubicBezTo>
                    <a:cubicBezTo>
                      <a:pt x="13" y="0"/>
                      <a:pt x="16" y="3"/>
                      <a:pt x="17" y="8"/>
                    </a:cubicBezTo>
                    <a:cubicBezTo>
                      <a:pt x="17" y="12"/>
                      <a:pt x="14" y="16"/>
                      <a:pt x="9" y="17"/>
                    </a:cubicBezTo>
                    <a:cubicBezTo>
                      <a:pt x="5" y="17"/>
                      <a:pt x="1" y="14"/>
                      <a:pt x="1" y="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83" name="Freeform 73"/>
              <p:cNvSpPr/>
              <p:nvPr/>
            </p:nvSpPr>
            <p:spPr bwMode="auto">
              <a:xfrm>
                <a:off x="8804048" y="4667679"/>
                <a:ext cx="52388" cy="60325"/>
              </a:xfrm>
              <a:custGeom>
                <a:avLst/>
                <a:gdLst>
                  <a:gd name="T0" fmla="*/ 0 w 13"/>
                  <a:gd name="T1" fmla="*/ 141 h 14"/>
                  <a:gd name="T2" fmla="*/ 96 w 13"/>
                  <a:gd name="T3" fmla="*/ 0 h 14"/>
                  <a:gd name="T4" fmla="*/ 213 w 13"/>
                  <a:gd name="T5" fmla="*/ 117 h 14"/>
                  <a:gd name="T6" fmla="*/ 117 w 13"/>
                  <a:gd name="T7" fmla="*/ 258 h 14"/>
                  <a:gd name="T8" fmla="*/ 0 w 13"/>
                  <a:gd name="T9" fmla="*/ 141 h 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3" h="14">
                    <a:moveTo>
                      <a:pt x="0" y="7"/>
                    </a:moveTo>
                    <a:cubicBezTo>
                      <a:pt x="0" y="4"/>
                      <a:pt x="2" y="1"/>
                      <a:pt x="6" y="0"/>
                    </a:cubicBezTo>
                    <a:cubicBezTo>
                      <a:pt x="10" y="0"/>
                      <a:pt x="13" y="3"/>
                      <a:pt x="13" y="6"/>
                    </a:cubicBezTo>
                    <a:cubicBezTo>
                      <a:pt x="13" y="10"/>
                      <a:pt x="11" y="13"/>
                      <a:pt x="7" y="13"/>
                    </a:cubicBezTo>
                    <a:cubicBezTo>
                      <a:pt x="3" y="14"/>
                      <a:pt x="0" y="11"/>
                      <a:pt x="0" y="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</p:grpSp>
        <p:grpSp>
          <p:nvGrpSpPr>
            <p:cNvPr id="184" name="组合 183"/>
            <p:cNvGrpSpPr/>
            <p:nvPr/>
          </p:nvGrpSpPr>
          <p:grpSpPr>
            <a:xfrm>
              <a:off x="2841476" y="3056178"/>
              <a:ext cx="216416" cy="78600"/>
              <a:chOff x="8377112" y="4045382"/>
              <a:chExt cx="1447698" cy="1473194"/>
            </a:xfrm>
          </p:grpSpPr>
          <p:sp>
            <p:nvSpPr>
              <p:cNvPr id="185" name="Freeform 58"/>
              <p:cNvSpPr/>
              <p:nvPr/>
            </p:nvSpPr>
            <p:spPr bwMode="auto">
              <a:xfrm>
                <a:off x="8377112" y="4045382"/>
                <a:ext cx="1444634" cy="1473194"/>
              </a:xfrm>
              <a:custGeom>
                <a:avLst/>
                <a:gdLst>
                  <a:gd name="T0" fmla="*/ 2813 w 364"/>
                  <a:gd name="T1" fmla="*/ 0 h 348"/>
                  <a:gd name="T2" fmla="*/ 33 w 364"/>
                  <a:gd name="T3" fmla="*/ 3299 h 348"/>
                  <a:gd name="T4" fmla="*/ 2750 w 364"/>
                  <a:gd name="T5" fmla="*/ 6600 h 348"/>
                  <a:gd name="T6" fmla="*/ 5658 w 364"/>
                  <a:gd name="T7" fmla="*/ 3299 h 348"/>
                  <a:gd name="T8" fmla="*/ 2813 w 364"/>
                  <a:gd name="T9" fmla="*/ 0 h 34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64" h="348">
                    <a:moveTo>
                      <a:pt x="180" y="0"/>
                    </a:moveTo>
                    <a:cubicBezTo>
                      <a:pt x="86" y="0"/>
                      <a:pt x="0" y="64"/>
                      <a:pt x="2" y="174"/>
                    </a:cubicBezTo>
                    <a:cubicBezTo>
                      <a:pt x="4" y="284"/>
                      <a:pt x="76" y="348"/>
                      <a:pt x="176" y="348"/>
                    </a:cubicBezTo>
                    <a:cubicBezTo>
                      <a:pt x="277" y="348"/>
                      <a:pt x="364" y="292"/>
                      <a:pt x="362" y="174"/>
                    </a:cubicBezTo>
                    <a:cubicBezTo>
                      <a:pt x="360" y="56"/>
                      <a:pt x="274" y="0"/>
                      <a:pt x="180" y="0"/>
                    </a:cubicBezTo>
                    <a:close/>
                  </a:path>
                </a:pathLst>
              </a:custGeom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86" name="Freeform 59"/>
              <p:cNvSpPr/>
              <p:nvPr/>
            </p:nvSpPr>
            <p:spPr bwMode="auto">
              <a:xfrm>
                <a:off x="8419873" y="4096179"/>
                <a:ext cx="1027113" cy="1346200"/>
              </a:xfrm>
              <a:custGeom>
                <a:avLst/>
                <a:gdLst>
                  <a:gd name="T0" fmla="*/ 575 w 259"/>
                  <a:gd name="T1" fmla="*/ 4288 h 318"/>
                  <a:gd name="T2" fmla="*/ 500 w 259"/>
                  <a:gd name="T3" fmla="*/ 3243 h 318"/>
                  <a:gd name="T4" fmla="*/ 1809 w 259"/>
                  <a:gd name="T5" fmla="*/ 512 h 318"/>
                  <a:gd name="T6" fmla="*/ 3195 w 259"/>
                  <a:gd name="T7" fmla="*/ 264 h 318"/>
                  <a:gd name="T8" fmla="*/ 4037 w 259"/>
                  <a:gd name="T9" fmla="*/ 419 h 318"/>
                  <a:gd name="T10" fmla="*/ 2603 w 259"/>
                  <a:gd name="T11" fmla="*/ 0 h 318"/>
                  <a:gd name="T12" fmla="*/ 30 w 259"/>
                  <a:gd name="T13" fmla="*/ 3072 h 318"/>
                  <a:gd name="T14" fmla="*/ 1791 w 259"/>
                  <a:gd name="T15" fmla="*/ 6029 h 318"/>
                  <a:gd name="T16" fmla="*/ 575 w 259"/>
                  <a:gd name="T17" fmla="*/ 4288 h 31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9" h="318">
                    <a:moveTo>
                      <a:pt x="37" y="226"/>
                    </a:moveTo>
                    <a:cubicBezTo>
                      <a:pt x="33" y="211"/>
                      <a:pt x="32" y="188"/>
                      <a:pt x="32" y="171"/>
                    </a:cubicBezTo>
                    <a:cubicBezTo>
                      <a:pt x="30" y="105"/>
                      <a:pt x="68" y="53"/>
                      <a:pt x="116" y="27"/>
                    </a:cubicBezTo>
                    <a:cubicBezTo>
                      <a:pt x="141" y="13"/>
                      <a:pt x="174" y="14"/>
                      <a:pt x="205" y="14"/>
                    </a:cubicBezTo>
                    <a:cubicBezTo>
                      <a:pt x="223" y="14"/>
                      <a:pt x="241" y="17"/>
                      <a:pt x="259" y="22"/>
                    </a:cubicBezTo>
                    <a:cubicBezTo>
                      <a:pt x="232" y="7"/>
                      <a:pt x="200" y="0"/>
                      <a:pt x="167" y="0"/>
                    </a:cubicBezTo>
                    <a:cubicBezTo>
                      <a:pt x="80" y="0"/>
                      <a:pt x="0" y="59"/>
                      <a:pt x="2" y="162"/>
                    </a:cubicBezTo>
                    <a:cubicBezTo>
                      <a:pt x="3" y="245"/>
                      <a:pt x="48" y="300"/>
                      <a:pt x="115" y="318"/>
                    </a:cubicBezTo>
                    <a:cubicBezTo>
                      <a:pt x="80" y="298"/>
                      <a:pt x="48" y="269"/>
                      <a:pt x="37" y="226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87" name="Freeform 60"/>
              <p:cNvSpPr/>
              <p:nvPr/>
            </p:nvSpPr>
            <p:spPr bwMode="auto">
              <a:xfrm>
                <a:off x="8848498" y="4507342"/>
                <a:ext cx="650875" cy="690563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404 h 163"/>
                  <a:gd name="T4" fmla="*/ 1208 w 164"/>
                  <a:gd name="T5" fmla="*/ 3064 h 163"/>
                  <a:gd name="T6" fmla="*/ 2500 w 164"/>
                  <a:gd name="T7" fmla="*/ 176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F1AE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88" name="Freeform 61"/>
              <p:cNvSpPr/>
              <p:nvPr/>
            </p:nvSpPr>
            <p:spPr bwMode="auto">
              <a:xfrm>
                <a:off x="9065985" y="4756579"/>
                <a:ext cx="409575" cy="398463"/>
              </a:xfrm>
              <a:custGeom>
                <a:avLst/>
                <a:gdLst>
                  <a:gd name="T0" fmla="*/ 0 w 103"/>
                  <a:gd name="T1" fmla="*/ 1677 h 94"/>
                  <a:gd name="T2" fmla="*/ 1147 w 103"/>
                  <a:gd name="T3" fmla="*/ 1503 h 94"/>
                  <a:gd name="T4" fmla="*/ 1368 w 103"/>
                  <a:gd name="T5" fmla="*/ 0 h 9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3" h="94">
                    <a:moveTo>
                      <a:pt x="0" y="88"/>
                    </a:moveTo>
                    <a:cubicBezTo>
                      <a:pt x="18" y="93"/>
                      <a:pt x="59" y="94"/>
                      <a:pt x="73" y="79"/>
                    </a:cubicBezTo>
                    <a:cubicBezTo>
                      <a:pt x="94" y="58"/>
                      <a:pt x="103" y="23"/>
                      <a:pt x="87" y="0"/>
                    </a:cubicBezTo>
                  </a:path>
                </a:pathLst>
              </a:custGeom>
              <a:solidFill>
                <a:srgbClr val="EB98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89" name="Freeform 62"/>
              <p:cNvSpPr/>
              <p:nvPr/>
            </p:nvSpPr>
            <p:spPr bwMode="auto">
              <a:xfrm>
                <a:off x="8784998" y="4448604"/>
                <a:ext cx="714375" cy="749301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00ABC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0" name="Freeform 63"/>
              <p:cNvSpPr/>
              <p:nvPr/>
            </p:nvSpPr>
            <p:spPr bwMode="auto">
              <a:xfrm>
                <a:off x="8923110" y="4558142"/>
                <a:ext cx="484188" cy="550863"/>
              </a:xfrm>
              <a:custGeom>
                <a:avLst/>
                <a:gdLst>
                  <a:gd name="T0" fmla="*/ 1283 w 122"/>
                  <a:gd name="T1" fmla="*/ 0 h 130"/>
                  <a:gd name="T2" fmla="*/ 1625 w 122"/>
                  <a:gd name="T3" fmla="*/ 1046 h 130"/>
                  <a:gd name="T4" fmla="*/ 1313 w 122"/>
                  <a:gd name="T5" fmla="*/ 1674 h 130"/>
                  <a:gd name="T6" fmla="*/ 438 w 122"/>
                  <a:gd name="T7" fmla="*/ 2223 h 130"/>
                  <a:gd name="T8" fmla="*/ 0 w 122"/>
                  <a:gd name="T9" fmla="*/ 2074 h 130"/>
                  <a:gd name="T10" fmla="*/ 675 w 122"/>
                  <a:gd name="T11" fmla="*/ 2450 h 130"/>
                  <a:gd name="T12" fmla="*/ 1863 w 122"/>
                  <a:gd name="T13" fmla="*/ 1276 h 130"/>
                  <a:gd name="T14" fmla="*/ 1283 w 122"/>
                  <a:gd name="T15" fmla="*/ 0 h 130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22" h="130">
                    <a:moveTo>
                      <a:pt x="82" y="0"/>
                    </a:moveTo>
                    <a:cubicBezTo>
                      <a:pt x="98" y="15"/>
                      <a:pt x="106" y="36"/>
                      <a:pt x="104" y="55"/>
                    </a:cubicBezTo>
                    <a:cubicBezTo>
                      <a:pt x="101" y="74"/>
                      <a:pt x="90" y="79"/>
                      <a:pt x="84" y="88"/>
                    </a:cubicBezTo>
                    <a:cubicBezTo>
                      <a:pt x="70" y="107"/>
                      <a:pt x="54" y="118"/>
                      <a:pt x="28" y="117"/>
                    </a:cubicBezTo>
                    <a:cubicBezTo>
                      <a:pt x="18" y="117"/>
                      <a:pt x="9" y="113"/>
                      <a:pt x="0" y="109"/>
                    </a:cubicBezTo>
                    <a:cubicBezTo>
                      <a:pt x="12" y="120"/>
                      <a:pt x="27" y="128"/>
                      <a:pt x="43" y="129"/>
                    </a:cubicBezTo>
                    <a:cubicBezTo>
                      <a:pt x="82" y="130"/>
                      <a:pt x="112" y="122"/>
                      <a:pt x="119" y="67"/>
                    </a:cubicBezTo>
                    <a:cubicBezTo>
                      <a:pt x="122" y="43"/>
                      <a:pt x="109" y="15"/>
                      <a:pt x="82" y="0"/>
                    </a:cubicBezTo>
                    <a:close/>
                  </a:path>
                </a:pathLst>
              </a:custGeom>
              <a:solidFill>
                <a:srgbClr val="0094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1" name="Freeform 64"/>
              <p:cNvSpPr/>
              <p:nvPr/>
            </p:nvSpPr>
            <p:spPr bwMode="auto">
              <a:xfrm>
                <a:off x="8819923" y="4477179"/>
                <a:ext cx="433388" cy="530225"/>
              </a:xfrm>
              <a:custGeom>
                <a:avLst/>
                <a:gdLst>
                  <a:gd name="T0" fmla="*/ 301 w 109"/>
                  <a:gd name="T1" fmla="*/ 1542 h 125"/>
                  <a:gd name="T2" fmla="*/ 676 w 109"/>
                  <a:gd name="T3" fmla="*/ 799 h 125"/>
                  <a:gd name="T4" fmla="*/ 1430 w 109"/>
                  <a:gd name="T5" fmla="*/ 307 h 125"/>
                  <a:gd name="T6" fmla="*/ 1538 w 109"/>
                  <a:gd name="T7" fmla="*/ 286 h 125"/>
                  <a:gd name="T8" fmla="*/ 1180 w 109"/>
                  <a:gd name="T9" fmla="*/ 150 h 125"/>
                  <a:gd name="T10" fmla="*/ 50 w 109"/>
                  <a:gd name="T11" fmla="*/ 1299 h 125"/>
                  <a:gd name="T12" fmla="*/ 376 w 109"/>
                  <a:gd name="T13" fmla="*/ 2383 h 125"/>
                  <a:gd name="T14" fmla="*/ 301 w 109"/>
                  <a:gd name="T15" fmla="*/ 1542 h 12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125">
                    <a:moveTo>
                      <a:pt x="19" y="81"/>
                    </a:moveTo>
                    <a:cubicBezTo>
                      <a:pt x="21" y="65"/>
                      <a:pt x="33" y="55"/>
                      <a:pt x="43" y="42"/>
                    </a:cubicBezTo>
                    <a:cubicBezTo>
                      <a:pt x="54" y="28"/>
                      <a:pt x="65" y="12"/>
                      <a:pt x="91" y="16"/>
                    </a:cubicBezTo>
                    <a:cubicBezTo>
                      <a:pt x="104" y="18"/>
                      <a:pt x="109" y="19"/>
                      <a:pt x="98" y="15"/>
                    </a:cubicBezTo>
                    <a:cubicBezTo>
                      <a:pt x="91" y="11"/>
                      <a:pt x="83" y="9"/>
                      <a:pt x="75" y="8"/>
                    </a:cubicBezTo>
                    <a:cubicBezTo>
                      <a:pt x="28" y="0"/>
                      <a:pt x="7" y="32"/>
                      <a:pt x="3" y="68"/>
                    </a:cubicBezTo>
                    <a:cubicBezTo>
                      <a:pt x="0" y="88"/>
                      <a:pt x="9" y="110"/>
                      <a:pt x="24" y="125"/>
                    </a:cubicBezTo>
                    <a:cubicBezTo>
                      <a:pt x="15" y="106"/>
                      <a:pt x="16" y="101"/>
                      <a:pt x="19" y="81"/>
                    </a:cubicBezTo>
                    <a:close/>
                  </a:path>
                </a:pathLst>
              </a:custGeom>
              <a:solidFill>
                <a:srgbClr val="DEEE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2" name="Freeform 65"/>
              <p:cNvSpPr/>
              <p:nvPr/>
            </p:nvSpPr>
            <p:spPr bwMode="auto">
              <a:xfrm>
                <a:off x="8907235" y="4197779"/>
                <a:ext cx="917575" cy="1274763"/>
              </a:xfrm>
              <a:custGeom>
                <a:avLst/>
                <a:gdLst>
                  <a:gd name="T0" fmla="*/ 2270 w 222"/>
                  <a:gd name="T1" fmla="*/ 0 h 301"/>
                  <a:gd name="T2" fmla="*/ 2895 w 222"/>
                  <a:gd name="T3" fmla="*/ 2428 h 301"/>
                  <a:gd name="T4" fmla="*/ 2125 w 222"/>
                  <a:gd name="T5" fmla="*/ 4212 h 301"/>
                  <a:gd name="T6" fmla="*/ 0 w 222"/>
                  <a:gd name="T7" fmla="*/ 5624 h 301"/>
                  <a:gd name="T8" fmla="*/ 708 w 222"/>
                  <a:gd name="T9" fmla="*/ 5714 h 301"/>
                  <a:gd name="T10" fmla="*/ 3438 w 222"/>
                  <a:gd name="T11" fmla="*/ 2620 h 301"/>
                  <a:gd name="T12" fmla="*/ 2270 w 222"/>
                  <a:gd name="T13" fmla="*/ 0 h 30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22" h="301">
                    <a:moveTo>
                      <a:pt x="145" y="0"/>
                    </a:moveTo>
                    <a:cubicBezTo>
                      <a:pt x="185" y="44"/>
                      <a:pt x="184" y="51"/>
                      <a:pt x="185" y="128"/>
                    </a:cubicBezTo>
                    <a:cubicBezTo>
                      <a:pt x="186" y="175"/>
                      <a:pt x="161" y="195"/>
                      <a:pt x="136" y="222"/>
                    </a:cubicBezTo>
                    <a:cubicBezTo>
                      <a:pt x="104" y="256"/>
                      <a:pt x="65" y="291"/>
                      <a:pt x="0" y="296"/>
                    </a:cubicBezTo>
                    <a:cubicBezTo>
                      <a:pt x="14" y="299"/>
                      <a:pt x="29" y="301"/>
                      <a:pt x="45" y="301"/>
                    </a:cubicBezTo>
                    <a:cubicBezTo>
                      <a:pt x="139" y="301"/>
                      <a:pt x="222" y="248"/>
                      <a:pt x="220" y="138"/>
                    </a:cubicBezTo>
                    <a:cubicBezTo>
                      <a:pt x="219" y="71"/>
                      <a:pt x="188" y="25"/>
                      <a:pt x="145" y="0"/>
                    </a:cubicBezTo>
                    <a:close/>
                  </a:path>
                </a:pathLst>
              </a:cu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3" name="Freeform 66"/>
              <p:cNvSpPr/>
              <p:nvPr/>
            </p:nvSpPr>
            <p:spPr bwMode="auto">
              <a:xfrm>
                <a:off x="8419873" y="4088242"/>
                <a:ext cx="661988" cy="693738"/>
              </a:xfrm>
              <a:custGeom>
                <a:avLst/>
                <a:gdLst>
                  <a:gd name="T0" fmla="*/ 30 w 167"/>
                  <a:gd name="T1" fmla="*/ 3102 h 164"/>
                  <a:gd name="T2" fmla="*/ 2599 w 167"/>
                  <a:gd name="T3" fmla="*/ 35 h 164"/>
                  <a:gd name="T4" fmla="*/ 30 w 167"/>
                  <a:gd name="T5" fmla="*/ 3102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7" h="164">
                    <a:moveTo>
                      <a:pt x="2" y="164"/>
                    </a:moveTo>
                    <a:cubicBezTo>
                      <a:pt x="0" y="61"/>
                      <a:pt x="80" y="2"/>
                      <a:pt x="167" y="2"/>
                    </a:cubicBezTo>
                    <a:cubicBezTo>
                      <a:pt x="119" y="0"/>
                      <a:pt x="29" y="50"/>
                      <a:pt x="2" y="164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4" name="Freeform 67"/>
              <p:cNvSpPr/>
              <p:nvPr/>
            </p:nvSpPr>
            <p:spPr bwMode="auto">
              <a:xfrm>
                <a:off x="9086623" y="4781979"/>
                <a:ext cx="701675" cy="690563"/>
              </a:xfrm>
              <a:custGeom>
                <a:avLst/>
                <a:gdLst>
                  <a:gd name="T0" fmla="*/ 0 w 177"/>
                  <a:gd name="T1" fmla="*/ 3098 h 163"/>
                  <a:gd name="T2" fmla="*/ 2724 w 177"/>
                  <a:gd name="T3" fmla="*/ 0 h 163"/>
                  <a:gd name="T4" fmla="*/ 0 w 177"/>
                  <a:gd name="T5" fmla="*/ 3098 h 16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7" h="163">
                    <a:moveTo>
                      <a:pt x="0" y="163"/>
                    </a:moveTo>
                    <a:cubicBezTo>
                      <a:pt x="94" y="163"/>
                      <a:pt x="177" y="110"/>
                      <a:pt x="175" y="0"/>
                    </a:cubicBezTo>
                    <a:cubicBezTo>
                      <a:pt x="148" y="70"/>
                      <a:pt x="121" y="149"/>
                      <a:pt x="0" y="163"/>
                    </a:cubicBezTo>
                    <a:close/>
                  </a:path>
                </a:pathLst>
              </a:cu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5" name="Freeform 68"/>
              <p:cNvSpPr/>
              <p:nvPr/>
            </p:nvSpPr>
            <p:spPr bwMode="auto">
              <a:xfrm>
                <a:off x="9094560" y="4829604"/>
                <a:ext cx="301625" cy="279400"/>
              </a:xfrm>
              <a:custGeom>
                <a:avLst/>
                <a:gdLst>
                  <a:gd name="T0" fmla="*/ 1188 w 76"/>
                  <a:gd name="T1" fmla="*/ 56 h 66"/>
                  <a:gd name="T2" fmla="*/ 0 w 76"/>
                  <a:gd name="T3" fmla="*/ 1229 h 66"/>
                  <a:gd name="T4" fmla="*/ 1175 w 76"/>
                  <a:gd name="T5" fmla="*/ 0 h 6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6" h="66">
                    <a:moveTo>
                      <a:pt x="76" y="3"/>
                    </a:moveTo>
                    <a:cubicBezTo>
                      <a:pt x="69" y="58"/>
                      <a:pt x="39" y="66"/>
                      <a:pt x="0" y="65"/>
                    </a:cubicBezTo>
                    <a:cubicBezTo>
                      <a:pt x="25" y="62"/>
                      <a:pt x="60" y="46"/>
                      <a:pt x="75" y="0"/>
                    </a:cubicBezTo>
                  </a:path>
                </a:pathLst>
              </a:custGeom>
              <a:solidFill>
                <a:srgbClr val="006C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6" name="Freeform 70"/>
              <p:cNvSpPr/>
              <p:nvPr/>
            </p:nvSpPr>
            <p:spPr bwMode="auto">
              <a:xfrm>
                <a:off x="8784996" y="4448605"/>
                <a:ext cx="650874" cy="688980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FFFFFF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7" name="Freeform 71"/>
              <p:cNvSpPr/>
              <p:nvPr/>
            </p:nvSpPr>
            <p:spPr bwMode="auto">
              <a:xfrm>
                <a:off x="8811985" y="4532742"/>
                <a:ext cx="111125" cy="119063"/>
              </a:xfrm>
              <a:custGeom>
                <a:avLst/>
                <a:gdLst>
                  <a:gd name="T0" fmla="*/ 20 w 28"/>
                  <a:gd name="T1" fmla="*/ 287 h 28"/>
                  <a:gd name="T2" fmla="*/ 208 w 28"/>
                  <a:gd name="T3" fmla="*/ 21 h 28"/>
                  <a:gd name="T4" fmla="*/ 425 w 28"/>
                  <a:gd name="T5" fmla="*/ 252 h 28"/>
                  <a:gd name="T6" fmla="*/ 238 w 28"/>
                  <a:gd name="T7" fmla="*/ 517 h 28"/>
                  <a:gd name="T8" fmla="*/ 20 w 28"/>
                  <a:gd name="T9" fmla="*/ 287 h 2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8" h="28">
                    <a:moveTo>
                      <a:pt x="1" y="15"/>
                    </a:moveTo>
                    <a:cubicBezTo>
                      <a:pt x="0" y="8"/>
                      <a:pt x="6" y="2"/>
                      <a:pt x="13" y="1"/>
                    </a:cubicBezTo>
                    <a:cubicBezTo>
                      <a:pt x="20" y="0"/>
                      <a:pt x="27" y="6"/>
                      <a:pt x="27" y="13"/>
                    </a:cubicBezTo>
                    <a:cubicBezTo>
                      <a:pt x="28" y="20"/>
                      <a:pt x="22" y="27"/>
                      <a:pt x="15" y="27"/>
                    </a:cubicBezTo>
                    <a:cubicBezTo>
                      <a:pt x="8" y="28"/>
                      <a:pt x="2" y="22"/>
                      <a:pt x="1" y="15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8" name="Freeform 72"/>
              <p:cNvSpPr/>
              <p:nvPr/>
            </p:nvSpPr>
            <p:spPr bwMode="auto">
              <a:xfrm>
                <a:off x="8907235" y="4474004"/>
                <a:ext cx="68263" cy="71438"/>
              </a:xfrm>
              <a:custGeom>
                <a:avLst/>
                <a:gdLst>
                  <a:gd name="T0" fmla="*/ 20 w 17"/>
                  <a:gd name="T1" fmla="*/ 169 h 17"/>
                  <a:gd name="T2" fmla="*/ 129 w 17"/>
                  <a:gd name="T3" fmla="*/ 0 h 17"/>
                  <a:gd name="T4" fmla="*/ 276 w 17"/>
                  <a:gd name="T5" fmla="*/ 148 h 17"/>
                  <a:gd name="T6" fmla="*/ 147 w 17"/>
                  <a:gd name="T7" fmla="*/ 315 h 17"/>
                  <a:gd name="T8" fmla="*/ 20 w 17"/>
                  <a:gd name="T9" fmla="*/ 169 h 1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" h="17">
                    <a:moveTo>
                      <a:pt x="1" y="9"/>
                    </a:moveTo>
                    <a:cubicBezTo>
                      <a:pt x="0" y="5"/>
                      <a:pt x="4" y="1"/>
                      <a:pt x="8" y="0"/>
                    </a:cubicBezTo>
                    <a:cubicBezTo>
                      <a:pt x="13" y="0"/>
                      <a:pt x="16" y="3"/>
                      <a:pt x="17" y="8"/>
                    </a:cubicBezTo>
                    <a:cubicBezTo>
                      <a:pt x="17" y="12"/>
                      <a:pt x="14" y="16"/>
                      <a:pt x="9" y="17"/>
                    </a:cubicBezTo>
                    <a:cubicBezTo>
                      <a:pt x="5" y="17"/>
                      <a:pt x="1" y="14"/>
                      <a:pt x="1" y="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199" name="Freeform 73"/>
              <p:cNvSpPr/>
              <p:nvPr/>
            </p:nvSpPr>
            <p:spPr bwMode="auto">
              <a:xfrm>
                <a:off x="8804048" y="4667679"/>
                <a:ext cx="52388" cy="60325"/>
              </a:xfrm>
              <a:custGeom>
                <a:avLst/>
                <a:gdLst>
                  <a:gd name="T0" fmla="*/ 0 w 13"/>
                  <a:gd name="T1" fmla="*/ 141 h 14"/>
                  <a:gd name="T2" fmla="*/ 96 w 13"/>
                  <a:gd name="T3" fmla="*/ 0 h 14"/>
                  <a:gd name="T4" fmla="*/ 213 w 13"/>
                  <a:gd name="T5" fmla="*/ 117 h 14"/>
                  <a:gd name="T6" fmla="*/ 117 w 13"/>
                  <a:gd name="T7" fmla="*/ 258 h 14"/>
                  <a:gd name="T8" fmla="*/ 0 w 13"/>
                  <a:gd name="T9" fmla="*/ 141 h 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3" h="14">
                    <a:moveTo>
                      <a:pt x="0" y="7"/>
                    </a:moveTo>
                    <a:cubicBezTo>
                      <a:pt x="0" y="4"/>
                      <a:pt x="2" y="1"/>
                      <a:pt x="6" y="0"/>
                    </a:cubicBezTo>
                    <a:cubicBezTo>
                      <a:pt x="10" y="0"/>
                      <a:pt x="13" y="3"/>
                      <a:pt x="13" y="6"/>
                    </a:cubicBezTo>
                    <a:cubicBezTo>
                      <a:pt x="13" y="10"/>
                      <a:pt x="11" y="13"/>
                      <a:pt x="7" y="13"/>
                    </a:cubicBezTo>
                    <a:cubicBezTo>
                      <a:pt x="3" y="14"/>
                      <a:pt x="0" y="11"/>
                      <a:pt x="0" y="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</p:grpSp>
        <p:grpSp>
          <p:nvGrpSpPr>
            <p:cNvPr id="200" name="组合 199"/>
            <p:cNvGrpSpPr/>
            <p:nvPr/>
          </p:nvGrpSpPr>
          <p:grpSpPr>
            <a:xfrm rot="6565485">
              <a:off x="2977130" y="3201446"/>
              <a:ext cx="245609" cy="89202"/>
              <a:chOff x="8377112" y="4045382"/>
              <a:chExt cx="1447698" cy="1473194"/>
            </a:xfrm>
          </p:grpSpPr>
          <p:sp>
            <p:nvSpPr>
              <p:cNvPr id="201" name="Freeform 58"/>
              <p:cNvSpPr/>
              <p:nvPr/>
            </p:nvSpPr>
            <p:spPr bwMode="auto">
              <a:xfrm>
                <a:off x="8377112" y="4045382"/>
                <a:ext cx="1444634" cy="1473194"/>
              </a:xfrm>
              <a:custGeom>
                <a:avLst/>
                <a:gdLst>
                  <a:gd name="T0" fmla="*/ 2813 w 364"/>
                  <a:gd name="T1" fmla="*/ 0 h 348"/>
                  <a:gd name="T2" fmla="*/ 33 w 364"/>
                  <a:gd name="T3" fmla="*/ 3299 h 348"/>
                  <a:gd name="T4" fmla="*/ 2750 w 364"/>
                  <a:gd name="T5" fmla="*/ 6600 h 348"/>
                  <a:gd name="T6" fmla="*/ 5658 w 364"/>
                  <a:gd name="T7" fmla="*/ 3299 h 348"/>
                  <a:gd name="T8" fmla="*/ 2813 w 364"/>
                  <a:gd name="T9" fmla="*/ 0 h 34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64" h="348">
                    <a:moveTo>
                      <a:pt x="180" y="0"/>
                    </a:moveTo>
                    <a:cubicBezTo>
                      <a:pt x="86" y="0"/>
                      <a:pt x="0" y="64"/>
                      <a:pt x="2" y="174"/>
                    </a:cubicBezTo>
                    <a:cubicBezTo>
                      <a:pt x="4" y="284"/>
                      <a:pt x="76" y="348"/>
                      <a:pt x="176" y="348"/>
                    </a:cubicBezTo>
                    <a:cubicBezTo>
                      <a:pt x="277" y="348"/>
                      <a:pt x="364" y="292"/>
                      <a:pt x="362" y="174"/>
                    </a:cubicBezTo>
                    <a:cubicBezTo>
                      <a:pt x="360" y="56"/>
                      <a:pt x="274" y="0"/>
                      <a:pt x="180" y="0"/>
                    </a:cubicBezTo>
                    <a:close/>
                  </a:path>
                </a:pathLst>
              </a:custGeom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2" name="Freeform 59"/>
              <p:cNvSpPr/>
              <p:nvPr/>
            </p:nvSpPr>
            <p:spPr bwMode="auto">
              <a:xfrm>
                <a:off x="8419873" y="4096179"/>
                <a:ext cx="1027113" cy="1346200"/>
              </a:xfrm>
              <a:custGeom>
                <a:avLst/>
                <a:gdLst>
                  <a:gd name="T0" fmla="*/ 575 w 259"/>
                  <a:gd name="T1" fmla="*/ 4288 h 318"/>
                  <a:gd name="T2" fmla="*/ 500 w 259"/>
                  <a:gd name="T3" fmla="*/ 3243 h 318"/>
                  <a:gd name="T4" fmla="*/ 1809 w 259"/>
                  <a:gd name="T5" fmla="*/ 512 h 318"/>
                  <a:gd name="T6" fmla="*/ 3195 w 259"/>
                  <a:gd name="T7" fmla="*/ 264 h 318"/>
                  <a:gd name="T8" fmla="*/ 4037 w 259"/>
                  <a:gd name="T9" fmla="*/ 419 h 318"/>
                  <a:gd name="T10" fmla="*/ 2603 w 259"/>
                  <a:gd name="T11" fmla="*/ 0 h 318"/>
                  <a:gd name="T12" fmla="*/ 30 w 259"/>
                  <a:gd name="T13" fmla="*/ 3072 h 318"/>
                  <a:gd name="T14" fmla="*/ 1791 w 259"/>
                  <a:gd name="T15" fmla="*/ 6029 h 318"/>
                  <a:gd name="T16" fmla="*/ 575 w 259"/>
                  <a:gd name="T17" fmla="*/ 4288 h 31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9" h="318">
                    <a:moveTo>
                      <a:pt x="37" y="226"/>
                    </a:moveTo>
                    <a:cubicBezTo>
                      <a:pt x="33" y="211"/>
                      <a:pt x="32" y="188"/>
                      <a:pt x="32" y="171"/>
                    </a:cubicBezTo>
                    <a:cubicBezTo>
                      <a:pt x="30" y="105"/>
                      <a:pt x="68" y="53"/>
                      <a:pt x="116" y="27"/>
                    </a:cubicBezTo>
                    <a:cubicBezTo>
                      <a:pt x="141" y="13"/>
                      <a:pt x="174" y="14"/>
                      <a:pt x="205" y="14"/>
                    </a:cubicBezTo>
                    <a:cubicBezTo>
                      <a:pt x="223" y="14"/>
                      <a:pt x="241" y="17"/>
                      <a:pt x="259" y="22"/>
                    </a:cubicBezTo>
                    <a:cubicBezTo>
                      <a:pt x="232" y="7"/>
                      <a:pt x="200" y="0"/>
                      <a:pt x="167" y="0"/>
                    </a:cubicBezTo>
                    <a:cubicBezTo>
                      <a:pt x="80" y="0"/>
                      <a:pt x="0" y="59"/>
                      <a:pt x="2" y="162"/>
                    </a:cubicBezTo>
                    <a:cubicBezTo>
                      <a:pt x="3" y="245"/>
                      <a:pt x="48" y="300"/>
                      <a:pt x="115" y="318"/>
                    </a:cubicBezTo>
                    <a:cubicBezTo>
                      <a:pt x="80" y="298"/>
                      <a:pt x="48" y="269"/>
                      <a:pt x="37" y="226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3" name="Freeform 60"/>
              <p:cNvSpPr/>
              <p:nvPr/>
            </p:nvSpPr>
            <p:spPr bwMode="auto">
              <a:xfrm>
                <a:off x="8848498" y="4507342"/>
                <a:ext cx="650875" cy="690563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404 h 163"/>
                  <a:gd name="T4" fmla="*/ 1208 w 164"/>
                  <a:gd name="T5" fmla="*/ 3064 h 163"/>
                  <a:gd name="T6" fmla="*/ 2500 w 164"/>
                  <a:gd name="T7" fmla="*/ 176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F1AE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4" name="Freeform 61"/>
              <p:cNvSpPr/>
              <p:nvPr/>
            </p:nvSpPr>
            <p:spPr bwMode="auto">
              <a:xfrm>
                <a:off x="9065985" y="4756579"/>
                <a:ext cx="409575" cy="398463"/>
              </a:xfrm>
              <a:custGeom>
                <a:avLst/>
                <a:gdLst>
                  <a:gd name="T0" fmla="*/ 0 w 103"/>
                  <a:gd name="T1" fmla="*/ 1677 h 94"/>
                  <a:gd name="T2" fmla="*/ 1147 w 103"/>
                  <a:gd name="T3" fmla="*/ 1503 h 94"/>
                  <a:gd name="T4" fmla="*/ 1368 w 103"/>
                  <a:gd name="T5" fmla="*/ 0 h 9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3" h="94">
                    <a:moveTo>
                      <a:pt x="0" y="88"/>
                    </a:moveTo>
                    <a:cubicBezTo>
                      <a:pt x="18" y="93"/>
                      <a:pt x="59" y="94"/>
                      <a:pt x="73" y="79"/>
                    </a:cubicBezTo>
                    <a:cubicBezTo>
                      <a:pt x="94" y="58"/>
                      <a:pt x="103" y="23"/>
                      <a:pt x="87" y="0"/>
                    </a:cubicBezTo>
                  </a:path>
                </a:pathLst>
              </a:custGeom>
              <a:solidFill>
                <a:srgbClr val="EB98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5" name="Freeform 62"/>
              <p:cNvSpPr/>
              <p:nvPr/>
            </p:nvSpPr>
            <p:spPr bwMode="auto">
              <a:xfrm>
                <a:off x="8784998" y="4448604"/>
                <a:ext cx="714375" cy="749301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00ABC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6" name="Freeform 63"/>
              <p:cNvSpPr/>
              <p:nvPr/>
            </p:nvSpPr>
            <p:spPr bwMode="auto">
              <a:xfrm>
                <a:off x="8923110" y="4558142"/>
                <a:ext cx="484188" cy="550863"/>
              </a:xfrm>
              <a:custGeom>
                <a:avLst/>
                <a:gdLst>
                  <a:gd name="T0" fmla="*/ 1283 w 122"/>
                  <a:gd name="T1" fmla="*/ 0 h 130"/>
                  <a:gd name="T2" fmla="*/ 1625 w 122"/>
                  <a:gd name="T3" fmla="*/ 1046 h 130"/>
                  <a:gd name="T4" fmla="*/ 1313 w 122"/>
                  <a:gd name="T5" fmla="*/ 1674 h 130"/>
                  <a:gd name="T6" fmla="*/ 438 w 122"/>
                  <a:gd name="T7" fmla="*/ 2223 h 130"/>
                  <a:gd name="T8" fmla="*/ 0 w 122"/>
                  <a:gd name="T9" fmla="*/ 2074 h 130"/>
                  <a:gd name="T10" fmla="*/ 675 w 122"/>
                  <a:gd name="T11" fmla="*/ 2450 h 130"/>
                  <a:gd name="T12" fmla="*/ 1863 w 122"/>
                  <a:gd name="T13" fmla="*/ 1276 h 130"/>
                  <a:gd name="T14" fmla="*/ 1283 w 122"/>
                  <a:gd name="T15" fmla="*/ 0 h 130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22" h="130">
                    <a:moveTo>
                      <a:pt x="82" y="0"/>
                    </a:moveTo>
                    <a:cubicBezTo>
                      <a:pt x="98" y="15"/>
                      <a:pt x="106" y="36"/>
                      <a:pt x="104" y="55"/>
                    </a:cubicBezTo>
                    <a:cubicBezTo>
                      <a:pt x="101" y="74"/>
                      <a:pt x="90" y="79"/>
                      <a:pt x="84" y="88"/>
                    </a:cubicBezTo>
                    <a:cubicBezTo>
                      <a:pt x="70" y="107"/>
                      <a:pt x="54" y="118"/>
                      <a:pt x="28" y="117"/>
                    </a:cubicBezTo>
                    <a:cubicBezTo>
                      <a:pt x="18" y="117"/>
                      <a:pt x="9" y="113"/>
                      <a:pt x="0" y="109"/>
                    </a:cubicBezTo>
                    <a:cubicBezTo>
                      <a:pt x="12" y="120"/>
                      <a:pt x="27" y="128"/>
                      <a:pt x="43" y="129"/>
                    </a:cubicBezTo>
                    <a:cubicBezTo>
                      <a:pt x="82" y="130"/>
                      <a:pt x="112" y="122"/>
                      <a:pt x="119" y="67"/>
                    </a:cubicBezTo>
                    <a:cubicBezTo>
                      <a:pt x="122" y="43"/>
                      <a:pt x="109" y="15"/>
                      <a:pt x="82" y="0"/>
                    </a:cubicBezTo>
                    <a:close/>
                  </a:path>
                </a:pathLst>
              </a:custGeom>
              <a:solidFill>
                <a:srgbClr val="0094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7" name="Freeform 64"/>
              <p:cNvSpPr/>
              <p:nvPr/>
            </p:nvSpPr>
            <p:spPr bwMode="auto">
              <a:xfrm>
                <a:off x="8819923" y="4477179"/>
                <a:ext cx="433388" cy="530225"/>
              </a:xfrm>
              <a:custGeom>
                <a:avLst/>
                <a:gdLst>
                  <a:gd name="T0" fmla="*/ 301 w 109"/>
                  <a:gd name="T1" fmla="*/ 1542 h 125"/>
                  <a:gd name="T2" fmla="*/ 676 w 109"/>
                  <a:gd name="T3" fmla="*/ 799 h 125"/>
                  <a:gd name="T4" fmla="*/ 1430 w 109"/>
                  <a:gd name="T5" fmla="*/ 307 h 125"/>
                  <a:gd name="T6" fmla="*/ 1538 w 109"/>
                  <a:gd name="T7" fmla="*/ 286 h 125"/>
                  <a:gd name="T8" fmla="*/ 1180 w 109"/>
                  <a:gd name="T9" fmla="*/ 150 h 125"/>
                  <a:gd name="T10" fmla="*/ 50 w 109"/>
                  <a:gd name="T11" fmla="*/ 1299 h 125"/>
                  <a:gd name="T12" fmla="*/ 376 w 109"/>
                  <a:gd name="T13" fmla="*/ 2383 h 125"/>
                  <a:gd name="T14" fmla="*/ 301 w 109"/>
                  <a:gd name="T15" fmla="*/ 1542 h 12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125">
                    <a:moveTo>
                      <a:pt x="19" y="81"/>
                    </a:moveTo>
                    <a:cubicBezTo>
                      <a:pt x="21" y="65"/>
                      <a:pt x="33" y="55"/>
                      <a:pt x="43" y="42"/>
                    </a:cubicBezTo>
                    <a:cubicBezTo>
                      <a:pt x="54" y="28"/>
                      <a:pt x="65" y="12"/>
                      <a:pt x="91" y="16"/>
                    </a:cubicBezTo>
                    <a:cubicBezTo>
                      <a:pt x="104" y="18"/>
                      <a:pt x="109" y="19"/>
                      <a:pt x="98" y="15"/>
                    </a:cubicBezTo>
                    <a:cubicBezTo>
                      <a:pt x="91" y="11"/>
                      <a:pt x="83" y="9"/>
                      <a:pt x="75" y="8"/>
                    </a:cubicBezTo>
                    <a:cubicBezTo>
                      <a:pt x="28" y="0"/>
                      <a:pt x="7" y="32"/>
                      <a:pt x="3" y="68"/>
                    </a:cubicBezTo>
                    <a:cubicBezTo>
                      <a:pt x="0" y="88"/>
                      <a:pt x="9" y="110"/>
                      <a:pt x="24" y="125"/>
                    </a:cubicBezTo>
                    <a:cubicBezTo>
                      <a:pt x="15" y="106"/>
                      <a:pt x="16" y="101"/>
                      <a:pt x="19" y="81"/>
                    </a:cubicBezTo>
                    <a:close/>
                  </a:path>
                </a:pathLst>
              </a:custGeom>
              <a:solidFill>
                <a:srgbClr val="DEEE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8" name="Freeform 65"/>
              <p:cNvSpPr/>
              <p:nvPr/>
            </p:nvSpPr>
            <p:spPr bwMode="auto">
              <a:xfrm>
                <a:off x="8907235" y="4197779"/>
                <a:ext cx="917575" cy="1274763"/>
              </a:xfrm>
              <a:custGeom>
                <a:avLst/>
                <a:gdLst>
                  <a:gd name="T0" fmla="*/ 2270 w 222"/>
                  <a:gd name="T1" fmla="*/ 0 h 301"/>
                  <a:gd name="T2" fmla="*/ 2895 w 222"/>
                  <a:gd name="T3" fmla="*/ 2428 h 301"/>
                  <a:gd name="T4" fmla="*/ 2125 w 222"/>
                  <a:gd name="T5" fmla="*/ 4212 h 301"/>
                  <a:gd name="T6" fmla="*/ 0 w 222"/>
                  <a:gd name="T7" fmla="*/ 5624 h 301"/>
                  <a:gd name="T8" fmla="*/ 708 w 222"/>
                  <a:gd name="T9" fmla="*/ 5714 h 301"/>
                  <a:gd name="T10" fmla="*/ 3438 w 222"/>
                  <a:gd name="T11" fmla="*/ 2620 h 301"/>
                  <a:gd name="T12" fmla="*/ 2270 w 222"/>
                  <a:gd name="T13" fmla="*/ 0 h 30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22" h="301">
                    <a:moveTo>
                      <a:pt x="145" y="0"/>
                    </a:moveTo>
                    <a:cubicBezTo>
                      <a:pt x="185" y="44"/>
                      <a:pt x="184" y="51"/>
                      <a:pt x="185" y="128"/>
                    </a:cubicBezTo>
                    <a:cubicBezTo>
                      <a:pt x="186" y="175"/>
                      <a:pt x="161" y="195"/>
                      <a:pt x="136" y="222"/>
                    </a:cubicBezTo>
                    <a:cubicBezTo>
                      <a:pt x="104" y="256"/>
                      <a:pt x="65" y="291"/>
                      <a:pt x="0" y="296"/>
                    </a:cubicBezTo>
                    <a:cubicBezTo>
                      <a:pt x="14" y="299"/>
                      <a:pt x="29" y="301"/>
                      <a:pt x="45" y="301"/>
                    </a:cubicBezTo>
                    <a:cubicBezTo>
                      <a:pt x="139" y="301"/>
                      <a:pt x="222" y="248"/>
                      <a:pt x="220" y="138"/>
                    </a:cubicBezTo>
                    <a:cubicBezTo>
                      <a:pt x="219" y="71"/>
                      <a:pt x="188" y="25"/>
                      <a:pt x="145" y="0"/>
                    </a:cubicBezTo>
                    <a:close/>
                  </a:path>
                </a:pathLst>
              </a:cu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09" name="Freeform 66"/>
              <p:cNvSpPr/>
              <p:nvPr/>
            </p:nvSpPr>
            <p:spPr bwMode="auto">
              <a:xfrm>
                <a:off x="8419873" y="4088242"/>
                <a:ext cx="661988" cy="693738"/>
              </a:xfrm>
              <a:custGeom>
                <a:avLst/>
                <a:gdLst>
                  <a:gd name="T0" fmla="*/ 30 w 167"/>
                  <a:gd name="T1" fmla="*/ 3102 h 164"/>
                  <a:gd name="T2" fmla="*/ 2599 w 167"/>
                  <a:gd name="T3" fmla="*/ 35 h 164"/>
                  <a:gd name="T4" fmla="*/ 30 w 167"/>
                  <a:gd name="T5" fmla="*/ 3102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7" h="164">
                    <a:moveTo>
                      <a:pt x="2" y="164"/>
                    </a:moveTo>
                    <a:cubicBezTo>
                      <a:pt x="0" y="61"/>
                      <a:pt x="80" y="2"/>
                      <a:pt x="167" y="2"/>
                    </a:cubicBezTo>
                    <a:cubicBezTo>
                      <a:pt x="119" y="0"/>
                      <a:pt x="29" y="50"/>
                      <a:pt x="2" y="164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0" name="Freeform 67"/>
              <p:cNvSpPr/>
              <p:nvPr/>
            </p:nvSpPr>
            <p:spPr bwMode="auto">
              <a:xfrm>
                <a:off x="9086623" y="4781979"/>
                <a:ext cx="701675" cy="690563"/>
              </a:xfrm>
              <a:custGeom>
                <a:avLst/>
                <a:gdLst>
                  <a:gd name="T0" fmla="*/ 0 w 177"/>
                  <a:gd name="T1" fmla="*/ 3098 h 163"/>
                  <a:gd name="T2" fmla="*/ 2724 w 177"/>
                  <a:gd name="T3" fmla="*/ 0 h 163"/>
                  <a:gd name="T4" fmla="*/ 0 w 177"/>
                  <a:gd name="T5" fmla="*/ 3098 h 16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7" h="163">
                    <a:moveTo>
                      <a:pt x="0" y="163"/>
                    </a:moveTo>
                    <a:cubicBezTo>
                      <a:pt x="94" y="163"/>
                      <a:pt x="177" y="110"/>
                      <a:pt x="175" y="0"/>
                    </a:cubicBezTo>
                    <a:cubicBezTo>
                      <a:pt x="148" y="70"/>
                      <a:pt x="121" y="149"/>
                      <a:pt x="0" y="163"/>
                    </a:cubicBezTo>
                    <a:close/>
                  </a:path>
                </a:pathLst>
              </a:cu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1" name="Freeform 68"/>
              <p:cNvSpPr/>
              <p:nvPr/>
            </p:nvSpPr>
            <p:spPr bwMode="auto">
              <a:xfrm>
                <a:off x="9094560" y="4829604"/>
                <a:ext cx="301625" cy="279400"/>
              </a:xfrm>
              <a:custGeom>
                <a:avLst/>
                <a:gdLst>
                  <a:gd name="T0" fmla="*/ 1188 w 76"/>
                  <a:gd name="T1" fmla="*/ 56 h 66"/>
                  <a:gd name="T2" fmla="*/ 0 w 76"/>
                  <a:gd name="T3" fmla="*/ 1229 h 66"/>
                  <a:gd name="T4" fmla="*/ 1175 w 76"/>
                  <a:gd name="T5" fmla="*/ 0 h 6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6" h="66">
                    <a:moveTo>
                      <a:pt x="76" y="3"/>
                    </a:moveTo>
                    <a:cubicBezTo>
                      <a:pt x="69" y="58"/>
                      <a:pt x="39" y="66"/>
                      <a:pt x="0" y="65"/>
                    </a:cubicBezTo>
                    <a:cubicBezTo>
                      <a:pt x="25" y="62"/>
                      <a:pt x="60" y="46"/>
                      <a:pt x="75" y="0"/>
                    </a:cubicBezTo>
                  </a:path>
                </a:pathLst>
              </a:custGeom>
              <a:solidFill>
                <a:srgbClr val="006C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2" name="Freeform 70"/>
              <p:cNvSpPr/>
              <p:nvPr/>
            </p:nvSpPr>
            <p:spPr bwMode="auto">
              <a:xfrm>
                <a:off x="8784996" y="4448605"/>
                <a:ext cx="650874" cy="688980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FFFFFF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3" name="Freeform 71"/>
              <p:cNvSpPr/>
              <p:nvPr/>
            </p:nvSpPr>
            <p:spPr bwMode="auto">
              <a:xfrm>
                <a:off x="8811985" y="4532742"/>
                <a:ext cx="111125" cy="119063"/>
              </a:xfrm>
              <a:custGeom>
                <a:avLst/>
                <a:gdLst>
                  <a:gd name="T0" fmla="*/ 20 w 28"/>
                  <a:gd name="T1" fmla="*/ 287 h 28"/>
                  <a:gd name="T2" fmla="*/ 208 w 28"/>
                  <a:gd name="T3" fmla="*/ 21 h 28"/>
                  <a:gd name="T4" fmla="*/ 425 w 28"/>
                  <a:gd name="T5" fmla="*/ 252 h 28"/>
                  <a:gd name="T6" fmla="*/ 238 w 28"/>
                  <a:gd name="T7" fmla="*/ 517 h 28"/>
                  <a:gd name="T8" fmla="*/ 20 w 28"/>
                  <a:gd name="T9" fmla="*/ 287 h 2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8" h="28">
                    <a:moveTo>
                      <a:pt x="1" y="15"/>
                    </a:moveTo>
                    <a:cubicBezTo>
                      <a:pt x="0" y="8"/>
                      <a:pt x="6" y="2"/>
                      <a:pt x="13" y="1"/>
                    </a:cubicBezTo>
                    <a:cubicBezTo>
                      <a:pt x="20" y="0"/>
                      <a:pt x="27" y="6"/>
                      <a:pt x="27" y="13"/>
                    </a:cubicBezTo>
                    <a:cubicBezTo>
                      <a:pt x="28" y="20"/>
                      <a:pt x="22" y="27"/>
                      <a:pt x="15" y="27"/>
                    </a:cubicBezTo>
                    <a:cubicBezTo>
                      <a:pt x="8" y="28"/>
                      <a:pt x="2" y="22"/>
                      <a:pt x="1" y="15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4" name="Freeform 72"/>
              <p:cNvSpPr/>
              <p:nvPr/>
            </p:nvSpPr>
            <p:spPr bwMode="auto">
              <a:xfrm>
                <a:off x="8907235" y="4474004"/>
                <a:ext cx="68263" cy="71438"/>
              </a:xfrm>
              <a:custGeom>
                <a:avLst/>
                <a:gdLst>
                  <a:gd name="T0" fmla="*/ 20 w 17"/>
                  <a:gd name="T1" fmla="*/ 169 h 17"/>
                  <a:gd name="T2" fmla="*/ 129 w 17"/>
                  <a:gd name="T3" fmla="*/ 0 h 17"/>
                  <a:gd name="T4" fmla="*/ 276 w 17"/>
                  <a:gd name="T5" fmla="*/ 148 h 17"/>
                  <a:gd name="T6" fmla="*/ 147 w 17"/>
                  <a:gd name="T7" fmla="*/ 315 h 17"/>
                  <a:gd name="T8" fmla="*/ 20 w 17"/>
                  <a:gd name="T9" fmla="*/ 169 h 1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" h="17">
                    <a:moveTo>
                      <a:pt x="1" y="9"/>
                    </a:moveTo>
                    <a:cubicBezTo>
                      <a:pt x="0" y="5"/>
                      <a:pt x="4" y="1"/>
                      <a:pt x="8" y="0"/>
                    </a:cubicBezTo>
                    <a:cubicBezTo>
                      <a:pt x="13" y="0"/>
                      <a:pt x="16" y="3"/>
                      <a:pt x="17" y="8"/>
                    </a:cubicBezTo>
                    <a:cubicBezTo>
                      <a:pt x="17" y="12"/>
                      <a:pt x="14" y="16"/>
                      <a:pt x="9" y="17"/>
                    </a:cubicBezTo>
                    <a:cubicBezTo>
                      <a:pt x="5" y="17"/>
                      <a:pt x="1" y="14"/>
                      <a:pt x="1" y="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5" name="Freeform 73"/>
              <p:cNvSpPr/>
              <p:nvPr/>
            </p:nvSpPr>
            <p:spPr bwMode="auto">
              <a:xfrm>
                <a:off x="8804048" y="4667679"/>
                <a:ext cx="52388" cy="60325"/>
              </a:xfrm>
              <a:custGeom>
                <a:avLst/>
                <a:gdLst>
                  <a:gd name="T0" fmla="*/ 0 w 13"/>
                  <a:gd name="T1" fmla="*/ 141 h 14"/>
                  <a:gd name="T2" fmla="*/ 96 w 13"/>
                  <a:gd name="T3" fmla="*/ 0 h 14"/>
                  <a:gd name="T4" fmla="*/ 213 w 13"/>
                  <a:gd name="T5" fmla="*/ 117 h 14"/>
                  <a:gd name="T6" fmla="*/ 117 w 13"/>
                  <a:gd name="T7" fmla="*/ 258 h 14"/>
                  <a:gd name="T8" fmla="*/ 0 w 13"/>
                  <a:gd name="T9" fmla="*/ 141 h 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3" h="14">
                    <a:moveTo>
                      <a:pt x="0" y="7"/>
                    </a:moveTo>
                    <a:cubicBezTo>
                      <a:pt x="0" y="4"/>
                      <a:pt x="2" y="1"/>
                      <a:pt x="6" y="0"/>
                    </a:cubicBezTo>
                    <a:cubicBezTo>
                      <a:pt x="10" y="0"/>
                      <a:pt x="13" y="3"/>
                      <a:pt x="13" y="6"/>
                    </a:cubicBezTo>
                    <a:cubicBezTo>
                      <a:pt x="13" y="10"/>
                      <a:pt x="11" y="13"/>
                      <a:pt x="7" y="13"/>
                    </a:cubicBezTo>
                    <a:cubicBezTo>
                      <a:pt x="3" y="14"/>
                      <a:pt x="0" y="11"/>
                      <a:pt x="0" y="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</p:grpSp>
        <p:grpSp>
          <p:nvGrpSpPr>
            <p:cNvPr id="216" name="组合 215"/>
            <p:cNvGrpSpPr/>
            <p:nvPr/>
          </p:nvGrpSpPr>
          <p:grpSpPr>
            <a:xfrm rot="478775">
              <a:off x="3069581" y="2956250"/>
              <a:ext cx="312794" cy="113603"/>
              <a:chOff x="8377112" y="4045382"/>
              <a:chExt cx="1447698" cy="1473194"/>
            </a:xfrm>
          </p:grpSpPr>
          <p:sp>
            <p:nvSpPr>
              <p:cNvPr id="217" name="Freeform 58"/>
              <p:cNvSpPr/>
              <p:nvPr/>
            </p:nvSpPr>
            <p:spPr bwMode="auto">
              <a:xfrm>
                <a:off x="8377112" y="4045382"/>
                <a:ext cx="1444634" cy="1473194"/>
              </a:xfrm>
              <a:custGeom>
                <a:avLst/>
                <a:gdLst>
                  <a:gd name="T0" fmla="*/ 2813 w 364"/>
                  <a:gd name="T1" fmla="*/ 0 h 348"/>
                  <a:gd name="T2" fmla="*/ 33 w 364"/>
                  <a:gd name="T3" fmla="*/ 3299 h 348"/>
                  <a:gd name="T4" fmla="*/ 2750 w 364"/>
                  <a:gd name="T5" fmla="*/ 6600 h 348"/>
                  <a:gd name="T6" fmla="*/ 5658 w 364"/>
                  <a:gd name="T7" fmla="*/ 3299 h 348"/>
                  <a:gd name="T8" fmla="*/ 2813 w 364"/>
                  <a:gd name="T9" fmla="*/ 0 h 34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64" h="348">
                    <a:moveTo>
                      <a:pt x="180" y="0"/>
                    </a:moveTo>
                    <a:cubicBezTo>
                      <a:pt x="86" y="0"/>
                      <a:pt x="0" y="64"/>
                      <a:pt x="2" y="174"/>
                    </a:cubicBezTo>
                    <a:cubicBezTo>
                      <a:pt x="4" y="284"/>
                      <a:pt x="76" y="348"/>
                      <a:pt x="176" y="348"/>
                    </a:cubicBezTo>
                    <a:cubicBezTo>
                      <a:pt x="277" y="348"/>
                      <a:pt x="364" y="292"/>
                      <a:pt x="362" y="174"/>
                    </a:cubicBezTo>
                    <a:cubicBezTo>
                      <a:pt x="360" y="56"/>
                      <a:pt x="274" y="0"/>
                      <a:pt x="180" y="0"/>
                    </a:cubicBezTo>
                    <a:close/>
                  </a:path>
                </a:pathLst>
              </a:custGeom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8" name="Freeform 59"/>
              <p:cNvSpPr/>
              <p:nvPr/>
            </p:nvSpPr>
            <p:spPr bwMode="auto">
              <a:xfrm>
                <a:off x="8419873" y="4096179"/>
                <a:ext cx="1027113" cy="1346200"/>
              </a:xfrm>
              <a:custGeom>
                <a:avLst/>
                <a:gdLst>
                  <a:gd name="T0" fmla="*/ 575 w 259"/>
                  <a:gd name="T1" fmla="*/ 4288 h 318"/>
                  <a:gd name="T2" fmla="*/ 500 w 259"/>
                  <a:gd name="T3" fmla="*/ 3243 h 318"/>
                  <a:gd name="T4" fmla="*/ 1809 w 259"/>
                  <a:gd name="T5" fmla="*/ 512 h 318"/>
                  <a:gd name="T6" fmla="*/ 3195 w 259"/>
                  <a:gd name="T7" fmla="*/ 264 h 318"/>
                  <a:gd name="T8" fmla="*/ 4037 w 259"/>
                  <a:gd name="T9" fmla="*/ 419 h 318"/>
                  <a:gd name="T10" fmla="*/ 2603 w 259"/>
                  <a:gd name="T11" fmla="*/ 0 h 318"/>
                  <a:gd name="T12" fmla="*/ 30 w 259"/>
                  <a:gd name="T13" fmla="*/ 3072 h 318"/>
                  <a:gd name="T14" fmla="*/ 1791 w 259"/>
                  <a:gd name="T15" fmla="*/ 6029 h 318"/>
                  <a:gd name="T16" fmla="*/ 575 w 259"/>
                  <a:gd name="T17" fmla="*/ 4288 h 31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9" h="318">
                    <a:moveTo>
                      <a:pt x="37" y="226"/>
                    </a:moveTo>
                    <a:cubicBezTo>
                      <a:pt x="33" y="211"/>
                      <a:pt x="32" y="188"/>
                      <a:pt x="32" y="171"/>
                    </a:cubicBezTo>
                    <a:cubicBezTo>
                      <a:pt x="30" y="105"/>
                      <a:pt x="68" y="53"/>
                      <a:pt x="116" y="27"/>
                    </a:cubicBezTo>
                    <a:cubicBezTo>
                      <a:pt x="141" y="13"/>
                      <a:pt x="174" y="14"/>
                      <a:pt x="205" y="14"/>
                    </a:cubicBezTo>
                    <a:cubicBezTo>
                      <a:pt x="223" y="14"/>
                      <a:pt x="241" y="17"/>
                      <a:pt x="259" y="22"/>
                    </a:cubicBezTo>
                    <a:cubicBezTo>
                      <a:pt x="232" y="7"/>
                      <a:pt x="200" y="0"/>
                      <a:pt x="167" y="0"/>
                    </a:cubicBezTo>
                    <a:cubicBezTo>
                      <a:pt x="80" y="0"/>
                      <a:pt x="0" y="59"/>
                      <a:pt x="2" y="162"/>
                    </a:cubicBezTo>
                    <a:cubicBezTo>
                      <a:pt x="3" y="245"/>
                      <a:pt x="48" y="300"/>
                      <a:pt x="115" y="318"/>
                    </a:cubicBezTo>
                    <a:cubicBezTo>
                      <a:pt x="80" y="298"/>
                      <a:pt x="48" y="269"/>
                      <a:pt x="37" y="226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19" name="Freeform 60"/>
              <p:cNvSpPr/>
              <p:nvPr/>
            </p:nvSpPr>
            <p:spPr bwMode="auto">
              <a:xfrm>
                <a:off x="8848498" y="4507342"/>
                <a:ext cx="650875" cy="690563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404 h 163"/>
                  <a:gd name="T4" fmla="*/ 1208 w 164"/>
                  <a:gd name="T5" fmla="*/ 3064 h 163"/>
                  <a:gd name="T6" fmla="*/ 2500 w 164"/>
                  <a:gd name="T7" fmla="*/ 176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F1AE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0" name="Freeform 61"/>
              <p:cNvSpPr/>
              <p:nvPr/>
            </p:nvSpPr>
            <p:spPr bwMode="auto">
              <a:xfrm>
                <a:off x="9065985" y="4756579"/>
                <a:ext cx="409575" cy="398463"/>
              </a:xfrm>
              <a:custGeom>
                <a:avLst/>
                <a:gdLst>
                  <a:gd name="T0" fmla="*/ 0 w 103"/>
                  <a:gd name="T1" fmla="*/ 1677 h 94"/>
                  <a:gd name="T2" fmla="*/ 1147 w 103"/>
                  <a:gd name="T3" fmla="*/ 1503 h 94"/>
                  <a:gd name="T4" fmla="*/ 1368 w 103"/>
                  <a:gd name="T5" fmla="*/ 0 h 9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3" h="94">
                    <a:moveTo>
                      <a:pt x="0" y="88"/>
                    </a:moveTo>
                    <a:cubicBezTo>
                      <a:pt x="18" y="93"/>
                      <a:pt x="59" y="94"/>
                      <a:pt x="73" y="79"/>
                    </a:cubicBezTo>
                    <a:cubicBezTo>
                      <a:pt x="94" y="58"/>
                      <a:pt x="103" y="23"/>
                      <a:pt x="87" y="0"/>
                    </a:cubicBezTo>
                  </a:path>
                </a:pathLst>
              </a:custGeom>
              <a:solidFill>
                <a:srgbClr val="EB98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1" name="Freeform 62"/>
              <p:cNvSpPr/>
              <p:nvPr/>
            </p:nvSpPr>
            <p:spPr bwMode="auto">
              <a:xfrm>
                <a:off x="8784998" y="4448604"/>
                <a:ext cx="714375" cy="749301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00ABC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2" name="Freeform 63"/>
              <p:cNvSpPr/>
              <p:nvPr/>
            </p:nvSpPr>
            <p:spPr bwMode="auto">
              <a:xfrm>
                <a:off x="8923110" y="4558142"/>
                <a:ext cx="484188" cy="550863"/>
              </a:xfrm>
              <a:custGeom>
                <a:avLst/>
                <a:gdLst>
                  <a:gd name="T0" fmla="*/ 1283 w 122"/>
                  <a:gd name="T1" fmla="*/ 0 h 130"/>
                  <a:gd name="T2" fmla="*/ 1625 w 122"/>
                  <a:gd name="T3" fmla="*/ 1046 h 130"/>
                  <a:gd name="T4" fmla="*/ 1313 w 122"/>
                  <a:gd name="T5" fmla="*/ 1674 h 130"/>
                  <a:gd name="T6" fmla="*/ 438 w 122"/>
                  <a:gd name="T7" fmla="*/ 2223 h 130"/>
                  <a:gd name="T8" fmla="*/ 0 w 122"/>
                  <a:gd name="T9" fmla="*/ 2074 h 130"/>
                  <a:gd name="T10" fmla="*/ 675 w 122"/>
                  <a:gd name="T11" fmla="*/ 2450 h 130"/>
                  <a:gd name="T12" fmla="*/ 1863 w 122"/>
                  <a:gd name="T13" fmla="*/ 1276 h 130"/>
                  <a:gd name="T14" fmla="*/ 1283 w 122"/>
                  <a:gd name="T15" fmla="*/ 0 h 130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22" h="130">
                    <a:moveTo>
                      <a:pt x="82" y="0"/>
                    </a:moveTo>
                    <a:cubicBezTo>
                      <a:pt x="98" y="15"/>
                      <a:pt x="106" y="36"/>
                      <a:pt x="104" y="55"/>
                    </a:cubicBezTo>
                    <a:cubicBezTo>
                      <a:pt x="101" y="74"/>
                      <a:pt x="90" y="79"/>
                      <a:pt x="84" y="88"/>
                    </a:cubicBezTo>
                    <a:cubicBezTo>
                      <a:pt x="70" y="107"/>
                      <a:pt x="54" y="118"/>
                      <a:pt x="28" y="117"/>
                    </a:cubicBezTo>
                    <a:cubicBezTo>
                      <a:pt x="18" y="117"/>
                      <a:pt x="9" y="113"/>
                      <a:pt x="0" y="109"/>
                    </a:cubicBezTo>
                    <a:cubicBezTo>
                      <a:pt x="12" y="120"/>
                      <a:pt x="27" y="128"/>
                      <a:pt x="43" y="129"/>
                    </a:cubicBezTo>
                    <a:cubicBezTo>
                      <a:pt x="82" y="130"/>
                      <a:pt x="112" y="122"/>
                      <a:pt x="119" y="67"/>
                    </a:cubicBezTo>
                    <a:cubicBezTo>
                      <a:pt x="122" y="43"/>
                      <a:pt x="109" y="15"/>
                      <a:pt x="82" y="0"/>
                    </a:cubicBezTo>
                    <a:close/>
                  </a:path>
                </a:pathLst>
              </a:custGeom>
              <a:solidFill>
                <a:srgbClr val="0094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3" name="Freeform 64"/>
              <p:cNvSpPr/>
              <p:nvPr/>
            </p:nvSpPr>
            <p:spPr bwMode="auto">
              <a:xfrm>
                <a:off x="8819923" y="4477179"/>
                <a:ext cx="433388" cy="530225"/>
              </a:xfrm>
              <a:custGeom>
                <a:avLst/>
                <a:gdLst>
                  <a:gd name="T0" fmla="*/ 301 w 109"/>
                  <a:gd name="T1" fmla="*/ 1542 h 125"/>
                  <a:gd name="T2" fmla="*/ 676 w 109"/>
                  <a:gd name="T3" fmla="*/ 799 h 125"/>
                  <a:gd name="T4" fmla="*/ 1430 w 109"/>
                  <a:gd name="T5" fmla="*/ 307 h 125"/>
                  <a:gd name="T6" fmla="*/ 1538 w 109"/>
                  <a:gd name="T7" fmla="*/ 286 h 125"/>
                  <a:gd name="T8" fmla="*/ 1180 w 109"/>
                  <a:gd name="T9" fmla="*/ 150 h 125"/>
                  <a:gd name="T10" fmla="*/ 50 w 109"/>
                  <a:gd name="T11" fmla="*/ 1299 h 125"/>
                  <a:gd name="T12" fmla="*/ 376 w 109"/>
                  <a:gd name="T13" fmla="*/ 2383 h 125"/>
                  <a:gd name="T14" fmla="*/ 301 w 109"/>
                  <a:gd name="T15" fmla="*/ 1542 h 12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125">
                    <a:moveTo>
                      <a:pt x="19" y="81"/>
                    </a:moveTo>
                    <a:cubicBezTo>
                      <a:pt x="21" y="65"/>
                      <a:pt x="33" y="55"/>
                      <a:pt x="43" y="42"/>
                    </a:cubicBezTo>
                    <a:cubicBezTo>
                      <a:pt x="54" y="28"/>
                      <a:pt x="65" y="12"/>
                      <a:pt x="91" y="16"/>
                    </a:cubicBezTo>
                    <a:cubicBezTo>
                      <a:pt x="104" y="18"/>
                      <a:pt x="109" y="19"/>
                      <a:pt x="98" y="15"/>
                    </a:cubicBezTo>
                    <a:cubicBezTo>
                      <a:pt x="91" y="11"/>
                      <a:pt x="83" y="9"/>
                      <a:pt x="75" y="8"/>
                    </a:cubicBezTo>
                    <a:cubicBezTo>
                      <a:pt x="28" y="0"/>
                      <a:pt x="7" y="32"/>
                      <a:pt x="3" y="68"/>
                    </a:cubicBezTo>
                    <a:cubicBezTo>
                      <a:pt x="0" y="88"/>
                      <a:pt x="9" y="110"/>
                      <a:pt x="24" y="125"/>
                    </a:cubicBezTo>
                    <a:cubicBezTo>
                      <a:pt x="15" y="106"/>
                      <a:pt x="16" y="101"/>
                      <a:pt x="19" y="81"/>
                    </a:cubicBezTo>
                    <a:close/>
                  </a:path>
                </a:pathLst>
              </a:custGeom>
              <a:solidFill>
                <a:srgbClr val="DEEE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4" name="Freeform 65"/>
              <p:cNvSpPr/>
              <p:nvPr/>
            </p:nvSpPr>
            <p:spPr bwMode="auto">
              <a:xfrm>
                <a:off x="8907235" y="4197779"/>
                <a:ext cx="917575" cy="1274763"/>
              </a:xfrm>
              <a:custGeom>
                <a:avLst/>
                <a:gdLst>
                  <a:gd name="T0" fmla="*/ 2270 w 222"/>
                  <a:gd name="T1" fmla="*/ 0 h 301"/>
                  <a:gd name="T2" fmla="*/ 2895 w 222"/>
                  <a:gd name="T3" fmla="*/ 2428 h 301"/>
                  <a:gd name="T4" fmla="*/ 2125 w 222"/>
                  <a:gd name="T5" fmla="*/ 4212 h 301"/>
                  <a:gd name="T6" fmla="*/ 0 w 222"/>
                  <a:gd name="T7" fmla="*/ 5624 h 301"/>
                  <a:gd name="T8" fmla="*/ 708 w 222"/>
                  <a:gd name="T9" fmla="*/ 5714 h 301"/>
                  <a:gd name="T10" fmla="*/ 3438 w 222"/>
                  <a:gd name="T11" fmla="*/ 2620 h 301"/>
                  <a:gd name="T12" fmla="*/ 2270 w 222"/>
                  <a:gd name="T13" fmla="*/ 0 h 30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22" h="301">
                    <a:moveTo>
                      <a:pt x="145" y="0"/>
                    </a:moveTo>
                    <a:cubicBezTo>
                      <a:pt x="185" y="44"/>
                      <a:pt x="184" y="51"/>
                      <a:pt x="185" y="128"/>
                    </a:cubicBezTo>
                    <a:cubicBezTo>
                      <a:pt x="186" y="175"/>
                      <a:pt x="161" y="195"/>
                      <a:pt x="136" y="222"/>
                    </a:cubicBezTo>
                    <a:cubicBezTo>
                      <a:pt x="104" y="256"/>
                      <a:pt x="65" y="291"/>
                      <a:pt x="0" y="296"/>
                    </a:cubicBezTo>
                    <a:cubicBezTo>
                      <a:pt x="14" y="299"/>
                      <a:pt x="29" y="301"/>
                      <a:pt x="45" y="301"/>
                    </a:cubicBezTo>
                    <a:cubicBezTo>
                      <a:pt x="139" y="301"/>
                      <a:pt x="222" y="248"/>
                      <a:pt x="220" y="138"/>
                    </a:cubicBezTo>
                    <a:cubicBezTo>
                      <a:pt x="219" y="71"/>
                      <a:pt x="188" y="25"/>
                      <a:pt x="145" y="0"/>
                    </a:cubicBezTo>
                    <a:close/>
                  </a:path>
                </a:pathLst>
              </a:cu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5" name="Freeform 66"/>
              <p:cNvSpPr/>
              <p:nvPr/>
            </p:nvSpPr>
            <p:spPr bwMode="auto">
              <a:xfrm>
                <a:off x="8419873" y="4088242"/>
                <a:ext cx="661988" cy="693738"/>
              </a:xfrm>
              <a:custGeom>
                <a:avLst/>
                <a:gdLst>
                  <a:gd name="T0" fmla="*/ 30 w 167"/>
                  <a:gd name="T1" fmla="*/ 3102 h 164"/>
                  <a:gd name="T2" fmla="*/ 2599 w 167"/>
                  <a:gd name="T3" fmla="*/ 35 h 164"/>
                  <a:gd name="T4" fmla="*/ 30 w 167"/>
                  <a:gd name="T5" fmla="*/ 3102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7" h="164">
                    <a:moveTo>
                      <a:pt x="2" y="164"/>
                    </a:moveTo>
                    <a:cubicBezTo>
                      <a:pt x="0" y="61"/>
                      <a:pt x="80" y="2"/>
                      <a:pt x="167" y="2"/>
                    </a:cubicBezTo>
                    <a:cubicBezTo>
                      <a:pt x="119" y="0"/>
                      <a:pt x="29" y="50"/>
                      <a:pt x="2" y="164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6" name="Freeform 67"/>
              <p:cNvSpPr/>
              <p:nvPr/>
            </p:nvSpPr>
            <p:spPr bwMode="auto">
              <a:xfrm>
                <a:off x="9086623" y="4781979"/>
                <a:ext cx="701675" cy="690563"/>
              </a:xfrm>
              <a:custGeom>
                <a:avLst/>
                <a:gdLst>
                  <a:gd name="T0" fmla="*/ 0 w 177"/>
                  <a:gd name="T1" fmla="*/ 3098 h 163"/>
                  <a:gd name="T2" fmla="*/ 2724 w 177"/>
                  <a:gd name="T3" fmla="*/ 0 h 163"/>
                  <a:gd name="T4" fmla="*/ 0 w 177"/>
                  <a:gd name="T5" fmla="*/ 3098 h 16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7" h="163">
                    <a:moveTo>
                      <a:pt x="0" y="163"/>
                    </a:moveTo>
                    <a:cubicBezTo>
                      <a:pt x="94" y="163"/>
                      <a:pt x="177" y="110"/>
                      <a:pt x="175" y="0"/>
                    </a:cubicBezTo>
                    <a:cubicBezTo>
                      <a:pt x="148" y="70"/>
                      <a:pt x="121" y="149"/>
                      <a:pt x="0" y="163"/>
                    </a:cubicBezTo>
                    <a:close/>
                  </a:path>
                </a:pathLst>
              </a:cu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7" name="Freeform 68"/>
              <p:cNvSpPr/>
              <p:nvPr/>
            </p:nvSpPr>
            <p:spPr bwMode="auto">
              <a:xfrm>
                <a:off x="9094560" y="4829604"/>
                <a:ext cx="301625" cy="279400"/>
              </a:xfrm>
              <a:custGeom>
                <a:avLst/>
                <a:gdLst>
                  <a:gd name="T0" fmla="*/ 1188 w 76"/>
                  <a:gd name="T1" fmla="*/ 56 h 66"/>
                  <a:gd name="T2" fmla="*/ 0 w 76"/>
                  <a:gd name="T3" fmla="*/ 1229 h 66"/>
                  <a:gd name="T4" fmla="*/ 1175 w 76"/>
                  <a:gd name="T5" fmla="*/ 0 h 6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6" h="66">
                    <a:moveTo>
                      <a:pt x="76" y="3"/>
                    </a:moveTo>
                    <a:cubicBezTo>
                      <a:pt x="69" y="58"/>
                      <a:pt x="39" y="66"/>
                      <a:pt x="0" y="65"/>
                    </a:cubicBezTo>
                    <a:cubicBezTo>
                      <a:pt x="25" y="62"/>
                      <a:pt x="60" y="46"/>
                      <a:pt x="75" y="0"/>
                    </a:cubicBezTo>
                  </a:path>
                </a:pathLst>
              </a:custGeom>
              <a:solidFill>
                <a:srgbClr val="006C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8" name="Freeform 70"/>
              <p:cNvSpPr/>
              <p:nvPr/>
            </p:nvSpPr>
            <p:spPr bwMode="auto">
              <a:xfrm>
                <a:off x="8784996" y="4448605"/>
                <a:ext cx="650874" cy="688980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FFFFFF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29" name="Freeform 71"/>
              <p:cNvSpPr/>
              <p:nvPr/>
            </p:nvSpPr>
            <p:spPr bwMode="auto">
              <a:xfrm>
                <a:off x="8811985" y="4532742"/>
                <a:ext cx="111125" cy="119063"/>
              </a:xfrm>
              <a:custGeom>
                <a:avLst/>
                <a:gdLst>
                  <a:gd name="T0" fmla="*/ 20 w 28"/>
                  <a:gd name="T1" fmla="*/ 287 h 28"/>
                  <a:gd name="T2" fmla="*/ 208 w 28"/>
                  <a:gd name="T3" fmla="*/ 21 h 28"/>
                  <a:gd name="T4" fmla="*/ 425 w 28"/>
                  <a:gd name="T5" fmla="*/ 252 h 28"/>
                  <a:gd name="T6" fmla="*/ 238 w 28"/>
                  <a:gd name="T7" fmla="*/ 517 h 28"/>
                  <a:gd name="T8" fmla="*/ 20 w 28"/>
                  <a:gd name="T9" fmla="*/ 287 h 2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8" h="28">
                    <a:moveTo>
                      <a:pt x="1" y="15"/>
                    </a:moveTo>
                    <a:cubicBezTo>
                      <a:pt x="0" y="8"/>
                      <a:pt x="6" y="2"/>
                      <a:pt x="13" y="1"/>
                    </a:cubicBezTo>
                    <a:cubicBezTo>
                      <a:pt x="20" y="0"/>
                      <a:pt x="27" y="6"/>
                      <a:pt x="27" y="13"/>
                    </a:cubicBezTo>
                    <a:cubicBezTo>
                      <a:pt x="28" y="20"/>
                      <a:pt x="22" y="27"/>
                      <a:pt x="15" y="27"/>
                    </a:cubicBezTo>
                    <a:cubicBezTo>
                      <a:pt x="8" y="28"/>
                      <a:pt x="2" y="22"/>
                      <a:pt x="1" y="15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0" name="Freeform 72"/>
              <p:cNvSpPr/>
              <p:nvPr/>
            </p:nvSpPr>
            <p:spPr bwMode="auto">
              <a:xfrm>
                <a:off x="8907235" y="4474004"/>
                <a:ext cx="68263" cy="71438"/>
              </a:xfrm>
              <a:custGeom>
                <a:avLst/>
                <a:gdLst>
                  <a:gd name="T0" fmla="*/ 20 w 17"/>
                  <a:gd name="T1" fmla="*/ 169 h 17"/>
                  <a:gd name="T2" fmla="*/ 129 w 17"/>
                  <a:gd name="T3" fmla="*/ 0 h 17"/>
                  <a:gd name="T4" fmla="*/ 276 w 17"/>
                  <a:gd name="T5" fmla="*/ 148 h 17"/>
                  <a:gd name="T6" fmla="*/ 147 w 17"/>
                  <a:gd name="T7" fmla="*/ 315 h 17"/>
                  <a:gd name="T8" fmla="*/ 20 w 17"/>
                  <a:gd name="T9" fmla="*/ 169 h 1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" h="17">
                    <a:moveTo>
                      <a:pt x="1" y="9"/>
                    </a:moveTo>
                    <a:cubicBezTo>
                      <a:pt x="0" y="5"/>
                      <a:pt x="4" y="1"/>
                      <a:pt x="8" y="0"/>
                    </a:cubicBezTo>
                    <a:cubicBezTo>
                      <a:pt x="13" y="0"/>
                      <a:pt x="16" y="3"/>
                      <a:pt x="17" y="8"/>
                    </a:cubicBezTo>
                    <a:cubicBezTo>
                      <a:pt x="17" y="12"/>
                      <a:pt x="14" y="16"/>
                      <a:pt x="9" y="17"/>
                    </a:cubicBezTo>
                    <a:cubicBezTo>
                      <a:pt x="5" y="17"/>
                      <a:pt x="1" y="14"/>
                      <a:pt x="1" y="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1" name="Freeform 73"/>
              <p:cNvSpPr/>
              <p:nvPr/>
            </p:nvSpPr>
            <p:spPr bwMode="auto">
              <a:xfrm>
                <a:off x="8804048" y="4667679"/>
                <a:ext cx="52388" cy="60325"/>
              </a:xfrm>
              <a:custGeom>
                <a:avLst/>
                <a:gdLst>
                  <a:gd name="T0" fmla="*/ 0 w 13"/>
                  <a:gd name="T1" fmla="*/ 141 h 14"/>
                  <a:gd name="T2" fmla="*/ 96 w 13"/>
                  <a:gd name="T3" fmla="*/ 0 h 14"/>
                  <a:gd name="T4" fmla="*/ 213 w 13"/>
                  <a:gd name="T5" fmla="*/ 117 h 14"/>
                  <a:gd name="T6" fmla="*/ 117 w 13"/>
                  <a:gd name="T7" fmla="*/ 258 h 14"/>
                  <a:gd name="T8" fmla="*/ 0 w 13"/>
                  <a:gd name="T9" fmla="*/ 141 h 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3" h="14">
                    <a:moveTo>
                      <a:pt x="0" y="7"/>
                    </a:moveTo>
                    <a:cubicBezTo>
                      <a:pt x="0" y="4"/>
                      <a:pt x="2" y="1"/>
                      <a:pt x="6" y="0"/>
                    </a:cubicBezTo>
                    <a:cubicBezTo>
                      <a:pt x="10" y="0"/>
                      <a:pt x="13" y="3"/>
                      <a:pt x="13" y="6"/>
                    </a:cubicBezTo>
                    <a:cubicBezTo>
                      <a:pt x="13" y="10"/>
                      <a:pt x="11" y="13"/>
                      <a:pt x="7" y="13"/>
                    </a:cubicBezTo>
                    <a:cubicBezTo>
                      <a:pt x="3" y="14"/>
                      <a:pt x="0" y="11"/>
                      <a:pt x="0" y="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</p:grpSp>
        <p:grpSp>
          <p:nvGrpSpPr>
            <p:cNvPr id="232" name="组合 231"/>
            <p:cNvGrpSpPr/>
            <p:nvPr/>
          </p:nvGrpSpPr>
          <p:grpSpPr>
            <a:xfrm rot="6702604">
              <a:off x="3408976" y="3134306"/>
              <a:ext cx="170561" cy="61946"/>
              <a:chOff x="8377112" y="4045382"/>
              <a:chExt cx="1447698" cy="1473194"/>
            </a:xfrm>
          </p:grpSpPr>
          <p:sp>
            <p:nvSpPr>
              <p:cNvPr id="233" name="Freeform 58"/>
              <p:cNvSpPr/>
              <p:nvPr/>
            </p:nvSpPr>
            <p:spPr bwMode="auto">
              <a:xfrm>
                <a:off x="8377112" y="4045382"/>
                <a:ext cx="1444634" cy="1473194"/>
              </a:xfrm>
              <a:custGeom>
                <a:avLst/>
                <a:gdLst>
                  <a:gd name="T0" fmla="*/ 2813 w 364"/>
                  <a:gd name="T1" fmla="*/ 0 h 348"/>
                  <a:gd name="T2" fmla="*/ 33 w 364"/>
                  <a:gd name="T3" fmla="*/ 3299 h 348"/>
                  <a:gd name="T4" fmla="*/ 2750 w 364"/>
                  <a:gd name="T5" fmla="*/ 6600 h 348"/>
                  <a:gd name="T6" fmla="*/ 5658 w 364"/>
                  <a:gd name="T7" fmla="*/ 3299 h 348"/>
                  <a:gd name="T8" fmla="*/ 2813 w 364"/>
                  <a:gd name="T9" fmla="*/ 0 h 34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364" h="348">
                    <a:moveTo>
                      <a:pt x="180" y="0"/>
                    </a:moveTo>
                    <a:cubicBezTo>
                      <a:pt x="86" y="0"/>
                      <a:pt x="0" y="64"/>
                      <a:pt x="2" y="174"/>
                    </a:cubicBezTo>
                    <a:cubicBezTo>
                      <a:pt x="4" y="284"/>
                      <a:pt x="76" y="348"/>
                      <a:pt x="176" y="348"/>
                    </a:cubicBezTo>
                    <a:cubicBezTo>
                      <a:pt x="277" y="348"/>
                      <a:pt x="364" y="292"/>
                      <a:pt x="362" y="174"/>
                    </a:cubicBezTo>
                    <a:cubicBezTo>
                      <a:pt x="360" y="56"/>
                      <a:pt x="274" y="0"/>
                      <a:pt x="180" y="0"/>
                    </a:cubicBezTo>
                    <a:close/>
                  </a:path>
                </a:pathLst>
              </a:custGeom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4" name="Freeform 59"/>
              <p:cNvSpPr/>
              <p:nvPr/>
            </p:nvSpPr>
            <p:spPr bwMode="auto">
              <a:xfrm>
                <a:off x="8419873" y="4096179"/>
                <a:ext cx="1027113" cy="1346200"/>
              </a:xfrm>
              <a:custGeom>
                <a:avLst/>
                <a:gdLst>
                  <a:gd name="T0" fmla="*/ 575 w 259"/>
                  <a:gd name="T1" fmla="*/ 4288 h 318"/>
                  <a:gd name="T2" fmla="*/ 500 w 259"/>
                  <a:gd name="T3" fmla="*/ 3243 h 318"/>
                  <a:gd name="T4" fmla="*/ 1809 w 259"/>
                  <a:gd name="T5" fmla="*/ 512 h 318"/>
                  <a:gd name="T6" fmla="*/ 3195 w 259"/>
                  <a:gd name="T7" fmla="*/ 264 h 318"/>
                  <a:gd name="T8" fmla="*/ 4037 w 259"/>
                  <a:gd name="T9" fmla="*/ 419 h 318"/>
                  <a:gd name="T10" fmla="*/ 2603 w 259"/>
                  <a:gd name="T11" fmla="*/ 0 h 318"/>
                  <a:gd name="T12" fmla="*/ 30 w 259"/>
                  <a:gd name="T13" fmla="*/ 3072 h 318"/>
                  <a:gd name="T14" fmla="*/ 1791 w 259"/>
                  <a:gd name="T15" fmla="*/ 6029 h 318"/>
                  <a:gd name="T16" fmla="*/ 575 w 259"/>
                  <a:gd name="T17" fmla="*/ 4288 h 31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259" h="318">
                    <a:moveTo>
                      <a:pt x="37" y="226"/>
                    </a:moveTo>
                    <a:cubicBezTo>
                      <a:pt x="33" y="211"/>
                      <a:pt x="32" y="188"/>
                      <a:pt x="32" y="171"/>
                    </a:cubicBezTo>
                    <a:cubicBezTo>
                      <a:pt x="30" y="105"/>
                      <a:pt x="68" y="53"/>
                      <a:pt x="116" y="27"/>
                    </a:cubicBezTo>
                    <a:cubicBezTo>
                      <a:pt x="141" y="13"/>
                      <a:pt x="174" y="14"/>
                      <a:pt x="205" y="14"/>
                    </a:cubicBezTo>
                    <a:cubicBezTo>
                      <a:pt x="223" y="14"/>
                      <a:pt x="241" y="17"/>
                      <a:pt x="259" y="22"/>
                    </a:cubicBezTo>
                    <a:cubicBezTo>
                      <a:pt x="232" y="7"/>
                      <a:pt x="200" y="0"/>
                      <a:pt x="167" y="0"/>
                    </a:cubicBezTo>
                    <a:cubicBezTo>
                      <a:pt x="80" y="0"/>
                      <a:pt x="0" y="59"/>
                      <a:pt x="2" y="162"/>
                    </a:cubicBezTo>
                    <a:cubicBezTo>
                      <a:pt x="3" y="245"/>
                      <a:pt x="48" y="300"/>
                      <a:pt x="115" y="318"/>
                    </a:cubicBezTo>
                    <a:cubicBezTo>
                      <a:pt x="80" y="298"/>
                      <a:pt x="48" y="269"/>
                      <a:pt x="37" y="226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5" name="Freeform 60"/>
              <p:cNvSpPr/>
              <p:nvPr/>
            </p:nvSpPr>
            <p:spPr bwMode="auto">
              <a:xfrm>
                <a:off x="8848498" y="4507342"/>
                <a:ext cx="650875" cy="690563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404 h 163"/>
                  <a:gd name="T4" fmla="*/ 1208 w 164"/>
                  <a:gd name="T5" fmla="*/ 3064 h 163"/>
                  <a:gd name="T6" fmla="*/ 2500 w 164"/>
                  <a:gd name="T7" fmla="*/ 176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F1AE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6" name="Freeform 61"/>
              <p:cNvSpPr/>
              <p:nvPr/>
            </p:nvSpPr>
            <p:spPr bwMode="auto">
              <a:xfrm>
                <a:off x="9065985" y="4756579"/>
                <a:ext cx="409575" cy="398463"/>
              </a:xfrm>
              <a:custGeom>
                <a:avLst/>
                <a:gdLst>
                  <a:gd name="T0" fmla="*/ 0 w 103"/>
                  <a:gd name="T1" fmla="*/ 1677 h 94"/>
                  <a:gd name="T2" fmla="*/ 1147 w 103"/>
                  <a:gd name="T3" fmla="*/ 1503 h 94"/>
                  <a:gd name="T4" fmla="*/ 1368 w 103"/>
                  <a:gd name="T5" fmla="*/ 0 h 9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3" h="94">
                    <a:moveTo>
                      <a:pt x="0" y="88"/>
                    </a:moveTo>
                    <a:cubicBezTo>
                      <a:pt x="18" y="93"/>
                      <a:pt x="59" y="94"/>
                      <a:pt x="73" y="79"/>
                    </a:cubicBezTo>
                    <a:cubicBezTo>
                      <a:pt x="94" y="58"/>
                      <a:pt x="103" y="23"/>
                      <a:pt x="87" y="0"/>
                    </a:cubicBezTo>
                  </a:path>
                </a:pathLst>
              </a:custGeom>
              <a:solidFill>
                <a:srgbClr val="EB98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7" name="Freeform 62"/>
              <p:cNvSpPr/>
              <p:nvPr/>
            </p:nvSpPr>
            <p:spPr bwMode="auto">
              <a:xfrm>
                <a:off x="8784998" y="4448604"/>
                <a:ext cx="714375" cy="749301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solidFill>
                <a:srgbClr val="00ABC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8" name="Freeform 63"/>
              <p:cNvSpPr/>
              <p:nvPr/>
            </p:nvSpPr>
            <p:spPr bwMode="auto">
              <a:xfrm>
                <a:off x="8923110" y="4558142"/>
                <a:ext cx="484188" cy="550863"/>
              </a:xfrm>
              <a:custGeom>
                <a:avLst/>
                <a:gdLst>
                  <a:gd name="T0" fmla="*/ 1283 w 122"/>
                  <a:gd name="T1" fmla="*/ 0 h 130"/>
                  <a:gd name="T2" fmla="*/ 1625 w 122"/>
                  <a:gd name="T3" fmla="*/ 1046 h 130"/>
                  <a:gd name="T4" fmla="*/ 1313 w 122"/>
                  <a:gd name="T5" fmla="*/ 1674 h 130"/>
                  <a:gd name="T6" fmla="*/ 438 w 122"/>
                  <a:gd name="T7" fmla="*/ 2223 h 130"/>
                  <a:gd name="T8" fmla="*/ 0 w 122"/>
                  <a:gd name="T9" fmla="*/ 2074 h 130"/>
                  <a:gd name="T10" fmla="*/ 675 w 122"/>
                  <a:gd name="T11" fmla="*/ 2450 h 130"/>
                  <a:gd name="T12" fmla="*/ 1863 w 122"/>
                  <a:gd name="T13" fmla="*/ 1276 h 130"/>
                  <a:gd name="T14" fmla="*/ 1283 w 122"/>
                  <a:gd name="T15" fmla="*/ 0 h 130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22" h="130">
                    <a:moveTo>
                      <a:pt x="82" y="0"/>
                    </a:moveTo>
                    <a:cubicBezTo>
                      <a:pt x="98" y="15"/>
                      <a:pt x="106" y="36"/>
                      <a:pt x="104" y="55"/>
                    </a:cubicBezTo>
                    <a:cubicBezTo>
                      <a:pt x="101" y="74"/>
                      <a:pt x="90" y="79"/>
                      <a:pt x="84" y="88"/>
                    </a:cubicBezTo>
                    <a:cubicBezTo>
                      <a:pt x="70" y="107"/>
                      <a:pt x="54" y="118"/>
                      <a:pt x="28" y="117"/>
                    </a:cubicBezTo>
                    <a:cubicBezTo>
                      <a:pt x="18" y="117"/>
                      <a:pt x="9" y="113"/>
                      <a:pt x="0" y="109"/>
                    </a:cubicBezTo>
                    <a:cubicBezTo>
                      <a:pt x="12" y="120"/>
                      <a:pt x="27" y="128"/>
                      <a:pt x="43" y="129"/>
                    </a:cubicBezTo>
                    <a:cubicBezTo>
                      <a:pt x="82" y="130"/>
                      <a:pt x="112" y="122"/>
                      <a:pt x="119" y="67"/>
                    </a:cubicBezTo>
                    <a:cubicBezTo>
                      <a:pt x="122" y="43"/>
                      <a:pt x="109" y="15"/>
                      <a:pt x="82" y="0"/>
                    </a:cubicBezTo>
                    <a:close/>
                  </a:path>
                </a:pathLst>
              </a:custGeom>
              <a:solidFill>
                <a:srgbClr val="0094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39" name="Freeform 64"/>
              <p:cNvSpPr/>
              <p:nvPr/>
            </p:nvSpPr>
            <p:spPr bwMode="auto">
              <a:xfrm>
                <a:off x="8819923" y="4477179"/>
                <a:ext cx="433388" cy="530225"/>
              </a:xfrm>
              <a:custGeom>
                <a:avLst/>
                <a:gdLst>
                  <a:gd name="T0" fmla="*/ 301 w 109"/>
                  <a:gd name="T1" fmla="*/ 1542 h 125"/>
                  <a:gd name="T2" fmla="*/ 676 w 109"/>
                  <a:gd name="T3" fmla="*/ 799 h 125"/>
                  <a:gd name="T4" fmla="*/ 1430 w 109"/>
                  <a:gd name="T5" fmla="*/ 307 h 125"/>
                  <a:gd name="T6" fmla="*/ 1538 w 109"/>
                  <a:gd name="T7" fmla="*/ 286 h 125"/>
                  <a:gd name="T8" fmla="*/ 1180 w 109"/>
                  <a:gd name="T9" fmla="*/ 150 h 125"/>
                  <a:gd name="T10" fmla="*/ 50 w 109"/>
                  <a:gd name="T11" fmla="*/ 1299 h 125"/>
                  <a:gd name="T12" fmla="*/ 376 w 109"/>
                  <a:gd name="T13" fmla="*/ 2383 h 125"/>
                  <a:gd name="T14" fmla="*/ 301 w 109"/>
                  <a:gd name="T15" fmla="*/ 1542 h 125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</a:gdLst>
                <a:ahLst/>
                <a:cxnLst>
                  <a:cxn ang="T16">
                    <a:pos x="T0" y="T1"/>
                  </a:cxn>
                  <a:cxn ang="T17">
                    <a:pos x="T2" y="T3"/>
                  </a:cxn>
                  <a:cxn ang="T18">
                    <a:pos x="T4" y="T5"/>
                  </a:cxn>
                  <a:cxn ang="T19">
                    <a:pos x="T6" y="T7"/>
                  </a:cxn>
                  <a:cxn ang="T20">
                    <a:pos x="T8" y="T9"/>
                  </a:cxn>
                  <a:cxn ang="T21">
                    <a:pos x="T10" y="T11"/>
                  </a:cxn>
                  <a:cxn ang="T22">
                    <a:pos x="T12" y="T13"/>
                  </a:cxn>
                  <a:cxn ang="T23">
                    <a:pos x="T14" y="T15"/>
                  </a:cxn>
                </a:cxnLst>
                <a:rect l="0" t="0" r="r" b="b"/>
                <a:pathLst>
                  <a:path w="109" h="125">
                    <a:moveTo>
                      <a:pt x="19" y="81"/>
                    </a:moveTo>
                    <a:cubicBezTo>
                      <a:pt x="21" y="65"/>
                      <a:pt x="33" y="55"/>
                      <a:pt x="43" y="42"/>
                    </a:cubicBezTo>
                    <a:cubicBezTo>
                      <a:pt x="54" y="28"/>
                      <a:pt x="65" y="12"/>
                      <a:pt x="91" y="16"/>
                    </a:cubicBezTo>
                    <a:cubicBezTo>
                      <a:pt x="104" y="18"/>
                      <a:pt x="109" y="19"/>
                      <a:pt x="98" y="15"/>
                    </a:cubicBezTo>
                    <a:cubicBezTo>
                      <a:pt x="91" y="11"/>
                      <a:pt x="83" y="9"/>
                      <a:pt x="75" y="8"/>
                    </a:cubicBezTo>
                    <a:cubicBezTo>
                      <a:pt x="28" y="0"/>
                      <a:pt x="7" y="32"/>
                      <a:pt x="3" y="68"/>
                    </a:cubicBezTo>
                    <a:cubicBezTo>
                      <a:pt x="0" y="88"/>
                      <a:pt x="9" y="110"/>
                      <a:pt x="24" y="125"/>
                    </a:cubicBezTo>
                    <a:cubicBezTo>
                      <a:pt x="15" y="106"/>
                      <a:pt x="16" y="101"/>
                      <a:pt x="19" y="81"/>
                    </a:cubicBezTo>
                    <a:close/>
                  </a:path>
                </a:pathLst>
              </a:custGeom>
              <a:solidFill>
                <a:srgbClr val="DEEEF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0" name="Freeform 65"/>
              <p:cNvSpPr/>
              <p:nvPr/>
            </p:nvSpPr>
            <p:spPr bwMode="auto">
              <a:xfrm>
                <a:off x="8907235" y="4197779"/>
                <a:ext cx="917575" cy="1274763"/>
              </a:xfrm>
              <a:custGeom>
                <a:avLst/>
                <a:gdLst>
                  <a:gd name="T0" fmla="*/ 2270 w 222"/>
                  <a:gd name="T1" fmla="*/ 0 h 301"/>
                  <a:gd name="T2" fmla="*/ 2895 w 222"/>
                  <a:gd name="T3" fmla="*/ 2428 h 301"/>
                  <a:gd name="T4" fmla="*/ 2125 w 222"/>
                  <a:gd name="T5" fmla="*/ 4212 h 301"/>
                  <a:gd name="T6" fmla="*/ 0 w 222"/>
                  <a:gd name="T7" fmla="*/ 5624 h 301"/>
                  <a:gd name="T8" fmla="*/ 708 w 222"/>
                  <a:gd name="T9" fmla="*/ 5714 h 301"/>
                  <a:gd name="T10" fmla="*/ 3438 w 222"/>
                  <a:gd name="T11" fmla="*/ 2620 h 301"/>
                  <a:gd name="T12" fmla="*/ 2270 w 222"/>
                  <a:gd name="T13" fmla="*/ 0 h 301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60000 65536"/>
                  <a:gd name="T19" fmla="*/ 0 60000 65536"/>
                  <a:gd name="T20" fmla="*/ 0 60000 65536"/>
                </a:gdLst>
                <a:ahLst/>
                <a:cxnLst>
                  <a:cxn ang="T14">
                    <a:pos x="T0" y="T1"/>
                  </a:cxn>
                  <a:cxn ang="T15">
                    <a:pos x="T2" y="T3"/>
                  </a:cxn>
                  <a:cxn ang="T16">
                    <a:pos x="T4" y="T5"/>
                  </a:cxn>
                  <a:cxn ang="T17">
                    <a:pos x="T6" y="T7"/>
                  </a:cxn>
                  <a:cxn ang="T18">
                    <a:pos x="T8" y="T9"/>
                  </a:cxn>
                  <a:cxn ang="T19">
                    <a:pos x="T10" y="T11"/>
                  </a:cxn>
                  <a:cxn ang="T20">
                    <a:pos x="T12" y="T13"/>
                  </a:cxn>
                </a:cxnLst>
                <a:rect l="0" t="0" r="r" b="b"/>
                <a:pathLst>
                  <a:path w="222" h="301">
                    <a:moveTo>
                      <a:pt x="145" y="0"/>
                    </a:moveTo>
                    <a:cubicBezTo>
                      <a:pt x="185" y="44"/>
                      <a:pt x="184" y="51"/>
                      <a:pt x="185" y="128"/>
                    </a:cubicBezTo>
                    <a:cubicBezTo>
                      <a:pt x="186" y="175"/>
                      <a:pt x="161" y="195"/>
                      <a:pt x="136" y="222"/>
                    </a:cubicBezTo>
                    <a:cubicBezTo>
                      <a:pt x="104" y="256"/>
                      <a:pt x="65" y="291"/>
                      <a:pt x="0" y="296"/>
                    </a:cubicBezTo>
                    <a:cubicBezTo>
                      <a:pt x="14" y="299"/>
                      <a:pt x="29" y="301"/>
                      <a:pt x="45" y="301"/>
                    </a:cubicBezTo>
                    <a:cubicBezTo>
                      <a:pt x="139" y="301"/>
                      <a:pt x="222" y="248"/>
                      <a:pt x="220" y="138"/>
                    </a:cubicBezTo>
                    <a:cubicBezTo>
                      <a:pt x="219" y="71"/>
                      <a:pt x="188" y="25"/>
                      <a:pt x="145" y="0"/>
                    </a:cubicBezTo>
                    <a:close/>
                  </a:path>
                </a:pathLst>
              </a:cu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1" name="Freeform 66"/>
              <p:cNvSpPr/>
              <p:nvPr/>
            </p:nvSpPr>
            <p:spPr bwMode="auto">
              <a:xfrm>
                <a:off x="8419873" y="4088242"/>
                <a:ext cx="661988" cy="693738"/>
              </a:xfrm>
              <a:custGeom>
                <a:avLst/>
                <a:gdLst>
                  <a:gd name="T0" fmla="*/ 30 w 167"/>
                  <a:gd name="T1" fmla="*/ 3102 h 164"/>
                  <a:gd name="T2" fmla="*/ 2599 w 167"/>
                  <a:gd name="T3" fmla="*/ 35 h 164"/>
                  <a:gd name="T4" fmla="*/ 30 w 167"/>
                  <a:gd name="T5" fmla="*/ 3102 h 164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67" h="164">
                    <a:moveTo>
                      <a:pt x="2" y="164"/>
                    </a:moveTo>
                    <a:cubicBezTo>
                      <a:pt x="0" y="61"/>
                      <a:pt x="80" y="2"/>
                      <a:pt x="167" y="2"/>
                    </a:cubicBezTo>
                    <a:cubicBezTo>
                      <a:pt x="119" y="0"/>
                      <a:pt x="29" y="50"/>
                      <a:pt x="2" y="164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2" name="Freeform 67"/>
              <p:cNvSpPr/>
              <p:nvPr/>
            </p:nvSpPr>
            <p:spPr bwMode="auto">
              <a:xfrm>
                <a:off x="9086623" y="4781979"/>
                <a:ext cx="701675" cy="690563"/>
              </a:xfrm>
              <a:custGeom>
                <a:avLst/>
                <a:gdLst>
                  <a:gd name="T0" fmla="*/ 0 w 177"/>
                  <a:gd name="T1" fmla="*/ 3098 h 163"/>
                  <a:gd name="T2" fmla="*/ 2724 w 177"/>
                  <a:gd name="T3" fmla="*/ 0 h 163"/>
                  <a:gd name="T4" fmla="*/ 0 w 177"/>
                  <a:gd name="T5" fmla="*/ 3098 h 16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77" h="163">
                    <a:moveTo>
                      <a:pt x="0" y="163"/>
                    </a:moveTo>
                    <a:cubicBezTo>
                      <a:pt x="94" y="163"/>
                      <a:pt x="177" y="110"/>
                      <a:pt x="175" y="0"/>
                    </a:cubicBezTo>
                    <a:cubicBezTo>
                      <a:pt x="148" y="70"/>
                      <a:pt x="121" y="149"/>
                      <a:pt x="0" y="163"/>
                    </a:cubicBezTo>
                    <a:close/>
                  </a:path>
                </a:pathLst>
              </a:cu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3" name="Freeform 68"/>
              <p:cNvSpPr/>
              <p:nvPr/>
            </p:nvSpPr>
            <p:spPr bwMode="auto">
              <a:xfrm>
                <a:off x="9094560" y="4829604"/>
                <a:ext cx="301625" cy="279400"/>
              </a:xfrm>
              <a:custGeom>
                <a:avLst/>
                <a:gdLst>
                  <a:gd name="T0" fmla="*/ 1188 w 76"/>
                  <a:gd name="T1" fmla="*/ 56 h 66"/>
                  <a:gd name="T2" fmla="*/ 0 w 76"/>
                  <a:gd name="T3" fmla="*/ 1229 h 66"/>
                  <a:gd name="T4" fmla="*/ 1175 w 76"/>
                  <a:gd name="T5" fmla="*/ 0 h 6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76" h="66">
                    <a:moveTo>
                      <a:pt x="76" y="3"/>
                    </a:moveTo>
                    <a:cubicBezTo>
                      <a:pt x="69" y="58"/>
                      <a:pt x="39" y="66"/>
                      <a:pt x="0" y="65"/>
                    </a:cubicBezTo>
                    <a:cubicBezTo>
                      <a:pt x="25" y="62"/>
                      <a:pt x="60" y="46"/>
                      <a:pt x="75" y="0"/>
                    </a:cubicBezTo>
                  </a:path>
                </a:pathLst>
              </a:custGeom>
              <a:solidFill>
                <a:srgbClr val="006C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4" name="Freeform 70"/>
              <p:cNvSpPr/>
              <p:nvPr/>
            </p:nvSpPr>
            <p:spPr bwMode="auto">
              <a:xfrm>
                <a:off x="8784996" y="4448615"/>
                <a:ext cx="650874" cy="500547"/>
              </a:xfrm>
              <a:custGeom>
                <a:avLst/>
                <a:gdLst>
                  <a:gd name="T0" fmla="*/ 1333 w 164"/>
                  <a:gd name="T1" fmla="*/ 149 h 163"/>
                  <a:gd name="T2" fmla="*/ 83 w 164"/>
                  <a:gd name="T3" fmla="*/ 1398 h 163"/>
                  <a:gd name="T4" fmla="*/ 1208 w 164"/>
                  <a:gd name="T5" fmla="*/ 3041 h 163"/>
                  <a:gd name="T6" fmla="*/ 2500 w 164"/>
                  <a:gd name="T7" fmla="*/ 1757 h 163"/>
                  <a:gd name="T8" fmla="*/ 1333 w 164"/>
                  <a:gd name="T9" fmla="*/ 149 h 16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64" h="163">
                    <a:moveTo>
                      <a:pt x="85" y="8"/>
                    </a:moveTo>
                    <a:cubicBezTo>
                      <a:pt x="33" y="0"/>
                      <a:pt x="10" y="34"/>
                      <a:pt x="5" y="74"/>
                    </a:cubicBezTo>
                    <a:cubicBezTo>
                      <a:pt x="0" y="114"/>
                      <a:pt x="34" y="159"/>
                      <a:pt x="77" y="161"/>
                    </a:cubicBezTo>
                    <a:cubicBezTo>
                      <a:pt x="120" y="163"/>
                      <a:pt x="152" y="154"/>
                      <a:pt x="160" y="93"/>
                    </a:cubicBezTo>
                    <a:cubicBezTo>
                      <a:pt x="164" y="58"/>
                      <a:pt x="137" y="16"/>
                      <a:pt x="85" y="8"/>
                    </a:cubicBezTo>
                    <a:close/>
                  </a:path>
                </a:pathLst>
              </a:custGeom>
              <a:noFill/>
              <a:ln w="7938" cap="rnd">
                <a:solidFill>
                  <a:srgbClr val="FFFFFF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5" name="Freeform 71"/>
              <p:cNvSpPr/>
              <p:nvPr/>
            </p:nvSpPr>
            <p:spPr bwMode="auto">
              <a:xfrm>
                <a:off x="8811985" y="4532742"/>
                <a:ext cx="111125" cy="119063"/>
              </a:xfrm>
              <a:custGeom>
                <a:avLst/>
                <a:gdLst>
                  <a:gd name="T0" fmla="*/ 20 w 28"/>
                  <a:gd name="T1" fmla="*/ 287 h 28"/>
                  <a:gd name="T2" fmla="*/ 208 w 28"/>
                  <a:gd name="T3" fmla="*/ 21 h 28"/>
                  <a:gd name="T4" fmla="*/ 425 w 28"/>
                  <a:gd name="T5" fmla="*/ 252 h 28"/>
                  <a:gd name="T6" fmla="*/ 238 w 28"/>
                  <a:gd name="T7" fmla="*/ 517 h 28"/>
                  <a:gd name="T8" fmla="*/ 20 w 28"/>
                  <a:gd name="T9" fmla="*/ 287 h 2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28" h="28">
                    <a:moveTo>
                      <a:pt x="1" y="15"/>
                    </a:moveTo>
                    <a:cubicBezTo>
                      <a:pt x="0" y="8"/>
                      <a:pt x="6" y="2"/>
                      <a:pt x="13" y="1"/>
                    </a:cubicBezTo>
                    <a:cubicBezTo>
                      <a:pt x="20" y="0"/>
                      <a:pt x="27" y="6"/>
                      <a:pt x="27" y="13"/>
                    </a:cubicBezTo>
                    <a:cubicBezTo>
                      <a:pt x="28" y="20"/>
                      <a:pt x="22" y="27"/>
                      <a:pt x="15" y="27"/>
                    </a:cubicBezTo>
                    <a:cubicBezTo>
                      <a:pt x="8" y="28"/>
                      <a:pt x="2" y="22"/>
                      <a:pt x="1" y="15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6" name="Freeform 72"/>
              <p:cNvSpPr/>
              <p:nvPr/>
            </p:nvSpPr>
            <p:spPr bwMode="auto">
              <a:xfrm>
                <a:off x="8907235" y="4474004"/>
                <a:ext cx="68263" cy="71438"/>
              </a:xfrm>
              <a:custGeom>
                <a:avLst/>
                <a:gdLst>
                  <a:gd name="T0" fmla="*/ 20 w 17"/>
                  <a:gd name="T1" fmla="*/ 169 h 17"/>
                  <a:gd name="T2" fmla="*/ 129 w 17"/>
                  <a:gd name="T3" fmla="*/ 0 h 17"/>
                  <a:gd name="T4" fmla="*/ 276 w 17"/>
                  <a:gd name="T5" fmla="*/ 148 h 17"/>
                  <a:gd name="T6" fmla="*/ 147 w 17"/>
                  <a:gd name="T7" fmla="*/ 315 h 17"/>
                  <a:gd name="T8" fmla="*/ 20 w 17"/>
                  <a:gd name="T9" fmla="*/ 169 h 1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" h="17">
                    <a:moveTo>
                      <a:pt x="1" y="9"/>
                    </a:moveTo>
                    <a:cubicBezTo>
                      <a:pt x="0" y="5"/>
                      <a:pt x="4" y="1"/>
                      <a:pt x="8" y="0"/>
                    </a:cubicBezTo>
                    <a:cubicBezTo>
                      <a:pt x="13" y="0"/>
                      <a:pt x="16" y="3"/>
                      <a:pt x="17" y="8"/>
                    </a:cubicBezTo>
                    <a:cubicBezTo>
                      <a:pt x="17" y="12"/>
                      <a:pt x="14" y="16"/>
                      <a:pt x="9" y="17"/>
                    </a:cubicBezTo>
                    <a:cubicBezTo>
                      <a:pt x="5" y="17"/>
                      <a:pt x="1" y="14"/>
                      <a:pt x="1" y="9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  <p:sp>
            <p:nvSpPr>
              <p:cNvPr id="247" name="Freeform 73"/>
              <p:cNvSpPr/>
              <p:nvPr/>
            </p:nvSpPr>
            <p:spPr bwMode="auto">
              <a:xfrm>
                <a:off x="8804048" y="4667679"/>
                <a:ext cx="52388" cy="60325"/>
              </a:xfrm>
              <a:custGeom>
                <a:avLst/>
                <a:gdLst>
                  <a:gd name="T0" fmla="*/ 0 w 13"/>
                  <a:gd name="T1" fmla="*/ 141 h 14"/>
                  <a:gd name="T2" fmla="*/ 96 w 13"/>
                  <a:gd name="T3" fmla="*/ 0 h 14"/>
                  <a:gd name="T4" fmla="*/ 213 w 13"/>
                  <a:gd name="T5" fmla="*/ 117 h 14"/>
                  <a:gd name="T6" fmla="*/ 117 w 13"/>
                  <a:gd name="T7" fmla="*/ 258 h 14"/>
                  <a:gd name="T8" fmla="*/ 0 w 13"/>
                  <a:gd name="T9" fmla="*/ 141 h 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3" h="14">
                    <a:moveTo>
                      <a:pt x="0" y="7"/>
                    </a:moveTo>
                    <a:cubicBezTo>
                      <a:pt x="0" y="4"/>
                      <a:pt x="2" y="1"/>
                      <a:pt x="6" y="0"/>
                    </a:cubicBezTo>
                    <a:cubicBezTo>
                      <a:pt x="10" y="0"/>
                      <a:pt x="13" y="3"/>
                      <a:pt x="13" y="6"/>
                    </a:cubicBezTo>
                    <a:cubicBezTo>
                      <a:pt x="13" y="10"/>
                      <a:pt x="11" y="13"/>
                      <a:pt x="7" y="13"/>
                    </a:cubicBezTo>
                    <a:cubicBezTo>
                      <a:pt x="3" y="14"/>
                      <a:pt x="0" y="11"/>
                      <a:pt x="0" y="7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>
                <a:scene3d>
                  <a:camera prst="orthographicFront"/>
                  <a:lightRig rig="brightRoom" dir="t"/>
                </a:scene3d>
                <a:sp3d contourW="6350" prstMaterial="plastic">
                  <a:bevelT w="20320" h="20320" prst="angle"/>
                  <a:contourClr>
                    <a:schemeClr val="accent1">
                      <a:tint val="100000"/>
                      <a:shade val="100000"/>
                      <a:hueMod val="100000"/>
                      <a:satMod val="100000"/>
                    </a:schemeClr>
                  </a:contourClr>
                </a:sp3d>
              </a:bodyPr>
              <a:lstStyle/>
              <a:p>
                <a:endParaRPr lang="zh-CN" altLang="en-US" b="1" cap="all">
                  <a:solidFill>
                    <a:schemeClr val="accent1"/>
                  </a:solidFill>
                  <a:effectLst>
                    <a:outerShdw blurRad="19685" dist="12700" dir="5400000" algn="tl" rotWithShape="0">
                      <a:schemeClr val="accent1">
                        <a:satMod val="130000"/>
                        <a:alpha val="60000"/>
                      </a:schemeClr>
                    </a:outerShdw>
                    <a:reflection blurRad="10000" stA="55000" endPos="48000" dist="500" dir="5400000" sy="-100000" algn="bl" rotWithShape="0"/>
                  </a:effectLst>
                </a:endParaRP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819275" y="534035"/>
            <a:ext cx="9025255" cy="5264150"/>
            <a:chOff x="2865" y="841"/>
            <a:chExt cx="14213" cy="8290"/>
          </a:xfrm>
        </p:grpSpPr>
        <p:sp>
          <p:nvSpPr>
            <p:cNvPr id="40" name="矩形 39"/>
            <p:cNvSpPr/>
            <p:nvPr/>
          </p:nvSpPr>
          <p:spPr>
            <a:xfrm>
              <a:off x="2945" y="841"/>
              <a:ext cx="14052" cy="8267"/>
            </a:xfrm>
            <a:prstGeom prst="rect">
              <a:avLst/>
            </a:prstGeom>
            <a:gradFill flip="none" rotWithShape="1">
              <a:gsLst>
                <a:gs pos="37000">
                  <a:srgbClr val="FFF7E1"/>
                </a:gs>
                <a:gs pos="83000">
                  <a:schemeClr val="accent3">
                    <a:lumMod val="20000"/>
                    <a:lumOff val="80000"/>
                  </a:schemeClr>
                </a:gs>
                <a:gs pos="96000">
                  <a:schemeClr val="accent1">
                    <a:lumMod val="20000"/>
                    <a:lumOff val="80000"/>
                  </a:schemeClr>
                </a:gs>
                <a:gs pos="100000">
                  <a:schemeClr val="accent3">
                    <a:lumMod val="20000"/>
                    <a:lumOff val="80000"/>
                  </a:schemeClr>
                </a:gs>
              </a:gsLst>
              <a:lin ang="5400000" scaled="1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01" y="1355"/>
              <a:ext cx="816" cy="32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4" name="直接连接符 3"/>
            <p:cNvCxnSpPr/>
            <p:nvPr/>
          </p:nvCxnSpPr>
          <p:spPr>
            <a:xfrm flipH="1">
              <a:off x="12789" y="3835"/>
              <a:ext cx="1740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grpSp>
          <p:nvGrpSpPr>
            <p:cNvPr id="21" name="组合 20"/>
            <p:cNvGrpSpPr/>
            <p:nvPr/>
          </p:nvGrpSpPr>
          <p:grpSpPr>
            <a:xfrm rot="0">
              <a:off x="11837" y="4673"/>
              <a:ext cx="1520" cy="837"/>
              <a:chOff x="8301654" y="2428616"/>
              <a:chExt cx="2685143" cy="1422400"/>
            </a:xfrm>
          </p:grpSpPr>
          <p:sp>
            <p:nvSpPr>
              <p:cNvPr id="17" name="立方体 16"/>
              <p:cNvSpPr/>
              <p:nvPr/>
            </p:nvSpPr>
            <p:spPr>
              <a:xfrm>
                <a:off x="8301654" y="2428616"/>
                <a:ext cx="2685143" cy="1422400"/>
              </a:xfrm>
              <a:prstGeom prst="cub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8665575" y="3097906"/>
                <a:ext cx="653144" cy="400115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8541456" y="2938047"/>
                <a:ext cx="1135195" cy="679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b="1" dirty="0" smtClean="0">
                    <a:solidFill>
                      <a:srgbClr val="C00000"/>
                    </a:solidFill>
                  </a:rPr>
                  <a:t>KV</a:t>
                </a:r>
                <a:endParaRPr lang="zh-CN" altLang="en-US" sz="1050" b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20" name="椭圆 19"/>
              <p:cNvSpPr/>
              <p:nvPr/>
            </p:nvSpPr>
            <p:spPr>
              <a:xfrm>
                <a:off x="9600498" y="3101102"/>
                <a:ext cx="359999" cy="360001"/>
              </a:xfrm>
              <a:prstGeom prst="ellips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" name="椭圆 21"/>
              <p:cNvSpPr/>
              <p:nvPr/>
            </p:nvSpPr>
            <p:spPr>
              <a:xfrm>
                <a:off x="10144747" y="3097906"/>
                <a:ext cx="359999" cy="360001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cxnSp>
          <p:nvCxnSpPr>
            <p:cNvPr id="24" name="直接连接符 23"/>
            <p:cNvCxnSpPr/>
            <p:nvPr/>
          </p:nvCxnSpPr>
          <p:spPr>
            <a:xfrm>
              <a:off x="12562" y="5523"/>
              <a:ext cx="0" cy="2684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 flipH="1">
              <a:off x="12535" y="7871"/>
              <a:ext cx="607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pic>
          <p:nvPicPr>
            <p:cNvPr id="39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587" y="890"/>
              <a:ext cx="1647" cy="27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1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31" y="2364"/>
              <a:ext cx="1959" cy="22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35" name="TextBox 1034"/>
            <p:cNvSpPr txBox="1"/>
            <p:nvPr/>
          </p:nvSpPr>
          <p:spPr>
            <a:xfrm>
              <a:off x="3065" y="2806"/>
              <a:ext cx="2088" cy="1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LA/HFIP</a:t>
              </a:r>
              <a:endParaRPr lang="en-US" altLang="zh-CN" dirty="0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lution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6" name="TextBox 1035"/>
            <p:cNvSpPr txBox="1"/>
            <p:nvPr/>
          </p:nvSpPr>
          <p:spPr>
            <a:xfrm>
              <a:off x="6222" y="4554"/>
              <a:ext cx="2108" cy="1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dirty="0" err="1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HAp/HFIP</a:t>
              </a:r>
              <a:endParaRPr lang="en-US" altLang="zh-CN" dirty="0" err="1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lution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5" name="矩形 1044"/>
            <p:cNvSpPr/>
            <p:nvPr/>
          </p:nvSpPr>
          <p:spPr>
            <a:xfrm>
              <a:off x="8721" y="3687"/>
              <a:ext cx="3547" cy="5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irred </a:t>
              </a:r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r 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 hours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" name="Picture 2" descr="C:\Users\Administrator\Desktop\立体图纤维.pn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776" y="6571"/>
              <a:ext cx="4099" cy="230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7309" y="8216"/>
              <a:ext cx="2108" cy="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culture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4" name="组合 163"/>
            <p:cNvGrpSpPr/>
            <p:nvPr/>
          </p:nvGrpSpPr>
          <p:grpSpPr>
            <a:xfrm rot="0">
              <a:off x="7167" y="6293"/>
              <a:ext cx="2647" cy="2605"/>
              <a:chOff x="2250630" y="2284847"/>
              <a:chExt cx="1680587" cy="1654437"/>
            </a:xfrm>
          </p:grpSpPr>
          <p:sp>
            <p:nvSpPr>
              <p:cNvPr id="165" name="椭圆 164"/>
              <p:cNvSpPr/>
              <p:nvPr/>
            </p:nvSpPr>
            <p:spPr>
              <a:xfrm>
                <a:off x="2250630" y="2284847"/>
                <a:ext cx="1676264" cy="1596656"/>
              </a:xfrm>
              <a:prstGeom prst="ellipse">
                <a:avLst/>
              </a:prstGeom>
              <a:blipFill>
                <a:blip r:embed="rId5"/>
                <a:stretch>
                  <a:fillRect/>
                </a:stretch>
              </a:blipFill>
              <a:ln>
                <a:noFill/>
              </a:ln>
              <a:scene3d>
                <a:camera prst="isometricOffAxis2Top"/>
                <a:lightRig rig="balanced" dir="t">
                  <a:rot lat="0" lon="0" rev="16200000"/>
                </a:lightRig>
              </a:scene3d>
              <a:sp3d z="-63500" prstMaterial="clear">
                <a:bevelB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66" name="组合 165"/>
              <p:cNvGrpSpPr/>
              <p:nvPr/>
            </p:nvGrpSpPr>
            <p:grpSpPr>
              <a:xfrm rot="1447043">
                <a:off x="2626459" y="3155824"/>
                <a:ext cx="291733" cy="105954"/>
                <a:chOff x="8377112" y="4045382"/>
                <a:chExt cx="1447698" cy="1473194"/>
              </a:xfrm>
            </p:grpSpPr>
            <p:sp>
              <p:nvSpPr>
                <p:cNvPr id="248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9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0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1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2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3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4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5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6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7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8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59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60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61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62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sp>
            <p:nvSpPr>
              <p:cNvPr id="167" name="圆: 空心 30"/>
              <p:cNvSpPr/>
              <p:nvPr/>
            </p:nvSpPr>
            <p:spPr>
              <a:xfrm>
                <a:off x="2254953" y="2285069"/>
                <a:ext cx="1676264" cy="1654215"/>
              </a:xfrm>
              <a:prstGeom prst="donut">
                <a:avLst>
                  <a:gd name="adj" fmla="val 2544"/>
                </a:avLst>
              </a:prstGeom>
              <a:solidFill>
                <a:schemeClr val="accent1">
                  <a:lumMod val="50000"/>
                </a:schemeClr>
              </a:solidFill>
              <a:ln>
                <a:solidFill>
                  <a:schemeClr val="accent1">
                    <a:lumMod val="50000"/>
                  </a:schemeClr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isometricOffAxis2Top"/>
                <a:lightRig rig="balanced" dir="t">
                  <a:rot lat="0" lon="0" rev="16200000"/>
                </a:lightRig>
              </a:scene3d>
              <a:sp3d z="381000" extrusionH="381000" prstMaterial="clear"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168" name="组合 167"/>
              <p:cNvGrpSpPr/>
              <p:nvPr/>
            </p:nvGrpSpPr>
            <p:grpSpPr>
              <a:xfrm rot="3009645">
                <a:off x="3215564" y="3173454"/>
                <a:ext cx="265877" cy="96563"/>
                <a:chOff x="8377112" y="4045382"/>
                <a:chExt cx="1447698" cy="1473194"/>
              </a:xfrm>
            </p:grpSpPr>
            <p:sp>
              <p:nvSpPr>
                <p:cNvPr id="233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4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5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6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7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8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9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0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1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2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3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4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5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6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47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69" name="组合 168"/>
              <p:cNvGrpSpPr/>
              <p:nvPr/>
            </p:nvGrpSpPr>
            <p:grpSpPr>
              <a:xfrm>
                <a:off x="2841476" y="3056178"/>
                <a:ext cx="216416" cy="78600"/>
                <a:chOff x="8377112" y="4045382"/>
                <a:chExt cx="1447698" cy="1473194"/>
              </a:xfrm>
            </p:grpSpPr>
            <p:sp>
              <p:nvSpPr>
                <p:cNvPr id="218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9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0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1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2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3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4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5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6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7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8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29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0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1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32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70" name="组合 169"/>
              <p:cNvGrpSpPr/>
              <p:nvPr/>
            </p:nvGrpSpPr>
            <p:grpSpPr>
              <a:xfrm rot="6565485">
                <a:off x="2977130" y="3201446"/>
                <a:ext cx="245609" cy="89202"/>
                <a:chOff x="8377112" y="4045382"/>
                <a:chExt cx="1447698" cy="1473194"/>
              </a:xfrm>
            </p:grpSpPr>
            <p:sp>
              <p:nvSpPr>
                <p:cNvPr id="203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4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5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6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7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8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9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0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1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2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3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4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5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6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17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71" name="组合 170"/>
              <p:cNvGrpSpPr/>
              <p:nvPr/>
            </p:nvGrpSpPr>
            <p:grpSpPr>
              <a:xfrm rot="478775">
                <a:off x="3069581" y="2956250"/>
                <a:ext cx="312794" cy="113603"/>
                <a:chOff x="8377112" y="4045382"/>
                <a:chExt cx="1447698" cy="1473194"/>
              </a:xfrm>
            </p:grpSpPr>
            <p:sp>
              <p:nvSpPr>
                <p:cNvPr id="188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9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0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1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2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3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4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5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6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7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8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99" name="Freeform 70"/>
                <p:cNvSpPr/>
                <p:nvPr/>
              </p:nvSpPr>
              <p:spPr bwMode="auto">
                <a:xfrm>
                  <a:off x="8784996" y="4448605"/>
                  <a:ext cx="650874" cy="688980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0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1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202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  <p:grpSp>
            <p:nvGrpSpPr>
              <p:cNvPr id="172" name="组合 171"/>
              <p:cNvGrpSpPr/>
              <p:nvPr/>
            </p:nvGrpSpPr>
            <p:grpSpPr>
              <a:xfrm rot="6702604">
                <a:off x="3408976" y="3134306"/>
                <a:ext cx="170561" cy="61946"/>
                <a:chOff x="8377112" y="4045382"/>
                <a:chExt cx="1447698" cy="1473194"/>
              </a:xfrm>
            </p:grpSpPr>
            <p:sp>
              <p:nvSpPr>
                <p:cNvPr id="173" name="Freeform 58"/>
                <p:cNvSpPr/>
                <p:nvPr/>
              </p:nvSpPr>
              <p:spPr bwMode="auto">
                <a:xfrm>
                  <a:off x="8377112" y="4045382"/>
                  <a:ext cx="1444634" cy="1473194"/>
                </a:xfrm>
                <a:custGeom>
                  <a:avLst/>
                  <a:gdLst>
                    <a:gd name="T0" fmla="*/ 2813 w 364"/>
                    <a:gd name="T1" fmla="*/ 0 h 348"/>
                    <a:gd name="T2" fmla="*/ 33 w 364"/>
                    <a:gd name="T3" fmla="*/ 3299 h 348"/>
                    <a:gd name="T4" fmla="*/ 2750 w 364"/>
                    <a:gd name="T5" fmla="*/ 6600 h 348"/>
                    <a:gd name="T6" fmla="*/ 5658 w 364"/>
                    <a:gd name="T7" fmla="*/ 3299 h 348"/>
                    <a:gd name="T8" fmla="*/ 2813 w 364"/>
                    <a:gd name="T9" fmla="*/ 0 h 3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364" h="348">
                      <a:moveTo>
                        <a:pt x="180" y="0"/>
                      </a:moveTo>
                      <a:cubicBezTo>
                        <a:pt x="86" y="0"/>
                        <a:pt x="0" y="64"/>
                        <a:pt x="2" y="174"/>
                      </a:cubicBezTo>
                      <a:cubicBezTo>
                        <a:pt x="4" y="284"/>
                        <a:pt x="76" y="348"/>
                        <a:pt x="176" y="348"/>
                      </a:cubicBezTo>
                      <a:cubicBezTo>
                        <a:pt x="277" y="348"/>
                        <a:pt x="364" y="292"/>
                        <a:pt x="362" y="174"/>
                      </a:cubicBezTo>
                      <a:cubicBezTo>
                        <a:pt x="360" y="56"/>
                        <a:pt x="274" y="0"/>
                        <a:pt x="180" y="0"/>
                      </a:cubicBezTo>
                      <a:close/>
                    </a:path>
                  </a:pathLst>
                </a:custGeom>
              </p:spPr>
              <p:style>
                <a:lnRef idx="0">
                  <a:schemeClr val="accent1"/>
                </a:lnRef>
                <a:fillRef idx="3">
                  <a:schemeClr val="accent1"/>
                </a:fillRef>
                <a:effectRef idx="3">
                  <a:schemeClr val="accent1"/>
                </a:effectRef>
                <a:fontRef idx="minor">
                  <a:schemeClr val="lt1"/>
                </a:fontRef>
              </p:style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4" name="Freeform 59"/>
                <p:cNvSpPr/>
                <p:nvPr/>
              </p:nvSpPr>
              <p:spPr bwMode="auto">
                <a:xfrm>
                  <a:off x="8419873" y="4096179"/>
                  <a:ext cx="1027113" cy="1346200"/>
                </a:xfrm>
                <a:custGeom>
                  <a:avLst/>
                  <a:gdLst>
                    <a:gd name="T0" fmla="*/ 575 w 259"/>
                    <a:gd name="T1" fmla="*/ 4288 h 318"/>
                    <a:gd name="T2" fmla="*/ 500 w 259"/>
                    <a:gd name="T3" fmla="*/ 3243 h 318"/>
                    <a:gd name="T4" fmla="*/ 1809 w 259"/>
                    <a:gd name="T5" fmla="*/ 512 h 318"/>
                    <a:gd name="T6" fmla="*/ 3195 w 259"/>
                    <a:gd name="T7" fmla="*/ 264 h 318"/>
                    <a:gd name="T8" fmla="*/ 4037 w 259"/>
                    <a:gd name="T9" fmla="*/ 419 h 318"/>
                    <a:gd name="T10" fmla="*/ 2603 w 259"/>
                    <a:gd name="T11" fmla="*/ 0 h 318"/>
                    <a:gd name="T12" fmla="*/ 30 w 259"/>
                    <a:gd name="T13" fmla="*/ 3072 h 318"/>
                    <a:gd name="T14" fmla="*/ 1791 w 259"/>
                    <a:gd name="T15" fmla="*/ 6029 h 318"/>
                    <a:gd name="T16" fmla="*/ 575 w 259"/>
                    <a:gd name="T17" fmla="*/ 4288 h 318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  <a:gd name="T24" fmla="*/ 0 60000 65536"/>
                    <a:gd name="T25" fmla="*/ 0 60000 65536"/>
                    <a:gd name="T26" fmla="*/ 0 60000 65536"/>
                  </a:gdLst>
                  <a:ahLst/>
                  <a:cxnLst>
                    <a:cxn ang="T18">
                      <a:pos x="T0" y="T1"/>
                    </a:cxn>
                    <a:cxn ang="T19">
                      <a:pos x="T2" y="T3"/>
                    </a:cxn>
                    <a:cxn ang="T20">
                      <a:pos x="T4" y="T5"/>
                    </a:cxn>
                    <a:cxn ang="T21">
                      <a:pos x="T6" y="T7"/>
                    </a:cxn>
                    <a:cxn ang="T22">
                      <a:pos x="T8" y="T9"/>
                    </a:cxn>
                    <a:cxn ang="T23">
                      <a:pos x="T10" y="T11"/>
                    </a:cxn>
                    <a:cxn ang="T24">
                      <a:pos x="T12" y="T13"/>
                    </a:cxn>
                    <a:cxn ang="T25">
                      <a:pos x="T14" y="T15"/>
                    </a:cxn>
                    <a:cxn ang="T26">
                      <a:pos x="T16" y="T17"/>
                    </a:cxn>
                  </a:cxnLst>
                  <a:rect l="0" t="0" r="r" b="b"/>
                  <a:pathLst>
                    <a:path w="259" h="318">
                      <a:moveTo>
                        <a:pt x="37" y="226"/>
                      </a:moveTo>
                      <a:cubicBezTo>
                        <a:pt x="33" y="211"/>
                        <a:pt x="32" y="188"/>
                        <a:pt x="32" y="171"/>
                      </a:cubicBezTo>
                      <a:cubicBezTo>
                        <a:pt x="30" y="105"/>
                        <a:pt x="68" y="53"/>
                        <a:pt x="116" y="27"/>
                      </a:cubicBezTo>
                      <a:cubicBezTo>
                        <a:pt x="141" y="13"/>
                        <a:pt x="174" y="14"/>
                        <a:pt x="205" y="14"/>
                      </a:cubicBezTo>
                      <a:cubicBezTo>
                        <a:pt x="223" y="14"/>
                        <a:pt x="241" y="17"/>
                        <a:pt x="259" y="22"/>
                      </a:cubicBezTo>
                      <a:cubicBezTo>
                        <a:pt x="232" y="7"/>
                        <a:pt x="200" y="0"/>
                        <a:pt x="167" y="0"/>
                      </a:cubicBezTo>
                      <a:cubicBezTo>
                        <a:pt x="80" y="0"/>
                        <a:pt x="0" y="59"/>
                        <a:pt x="2" y="162"/>
                      </a:cubicBezTo>
                      <a:cubicBezTo>
                        <a:pt x="3" y="245"/>
                        <a:pt x="48" y="300"/>
                        <a:pt x="115" y="318"/>
                      </a:cubicBezTo>
                      <a:cubicBezTo>
                        <a:pt x="80" y="298"/>
                        <a:pt x="48" y="269"/>
                        <a:pt x="37" y="226"/>
                      </a:cubicBezTo>
                      <a:close/>
                    </a:path>
                  </a:pathLst>
                </a:custGeom>
                <a:solidFill>
                  <a:schemeClr val="accent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5" name="Freeform 60"/>
                <p:cNvSpPr/>
                <p:nvPr/>
              </p:nvSpPr>
              <p:spPr bwMode="auto">
                <a:xfrm>
                  <a:off x="8848498" y="4507342"/>
                  <a:ext cx="650875" cy="690563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404 h 163"/>
                    <a:gd name="T4" fmla="*/ 1208 w 164"/>
                    <a:gd name="T5" fmla="*/ 3064 h 163"/>
                    <a:gd name="T6" fmla="*/ 2500 w 164"/>
                    <a:gd name="T7" fmla="*/ 176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F1AE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6" name="Freeform 61"/>
                <p:cNvSpPr/>
                <p:nvPr/>
              </p:nvSpPr>
              <p:spPr bwMode="auto">
                <a:xfrm>
                  <a:off x="9065985" y="4756579"/>
                  <a:ext cx="409575" cy="398463"/>
                </a:xfrm>
                <a:custGeom>
                  <a:avLst/>
                  <a:gdLst>
                    <a:gd name="T0" fmla="*/ 0 w 103"/>
                    <a:gd name="T1" fmla="*/ 1677 h 94"/>
                    <a:gd name="T2" fmla="*/ 1147 w 103"/>
                    <a:gd name="T3" fmla="*/ 1503 h 94"/>
                    <a:gd name="T4" fmla="*/ 1368 w 103"/>
                    <a:gd name="T5" fmla="*/ 0 h 9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03" h="94">
                      <a:moveTo>
                        <a:pt x="0" y="88"/>
                      </a:moveTo>
                      <a:cubicBezTo>
                        <a:pt x="18" y="93"/>
                        <a:pt x="59" y="94"/>
                        <a:pt x="73" y="79"/>
                      </a:cubicBezTo>
                      <a:cubicBezTo>
                        <a:pt x="94" y="58"/>
                        <a:pt x="103" y="23"/>
                        <a:pt x="87" y="0"/>
                      </a:cubicBezTo>
                    </a:path>
                  </a:pathLst>
                </a:custGeom>
                <a:solidFill>
                  <a:srgbClr val="EB98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7" name="Freeform 62"/>
                <p:cNvSpPr/>
                <p:nvPr/>
              </p:nvSpPr>
              <p:spPr bwMode="auto">
                <a:xfrm>
                  <a:off x="8784998" y="4448604"/>
                  <a:ext cx="714375" cy="749301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solidFill>
                  <a:srgbClr val="00ABC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8" name="Freeform 63"/>
                <p:cNvSpPr/>
                <p:nvPr/>
              </p:nvSpPr>
              <p:spPr bwMode="auto">
                <a:xfrm>
                  <a:off x="8923110" y="4558142"/>
                  <a:ext cx="484188" cy="550863"/>
                </a:xfrm>
                <a:custGeom>
                  <a:avLst/>
                  <a:gdLst>
                    <a:gd name="T0" fmla="*/ 1283 w 122"/>
                    <a:gd name="T1" fmla="*/ 0 h 130"/>
                    <a:gd name="T2" fmla="*/ 1625 w 122"/>
                    <a:gd name="T3" fmla="*/ 1046 h 130"/>
                    <a:gd name="T4" fmla="*/ 1313 w 122"/>
                    <a:gd name="T5" fmla="*/ 1674 h 130"/>
                    <a:gd name="T6" fmla="*/ 438 w 122"/>
                    <a:gd name="T7" fmla="*/ 2223 h 130"/>
                    <a:gd name="T8" fmla="*/ 0 w 122"/>
                    <a:gd name="T9" fmla="*/ 2074 h 130"/>
                    <a:gd name="T10" fmla="*/ 675 w 122"/>
                    <a:gd name="T11" fmla="*/ 2450 h 130"/>
                    <a:gd name="T12" fmla="*/ 1863 w 122"/>
                    <a:gd name="T13" fmla="*/ 1276 h 130"/>
                    <a:gd name="T14" fmla="*/ 1283 w 122"/>
                    <a:gd name="T15" fmla="*/ 0 h 130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22" h="130">
                      <a:moveTo>
                        <a:pt x="82" y="0"/>
                      </a:moveTo>
                      <a:cubicBezTo>
                        <a:pt x="98" y="15"/>
                        <a:pt x="106" y="36"/>
                        <a:pt x="104" y="55"/>
                      </a:cubicBezTo>
                      <a:cubicBezTo>
                        <a:pt x="101" y="74"/>
                        <a:pt x="90" y="79"/>
                        <a:pt x="84" y="88"/>
                      </a:cubicBezTo>
                      <a:cubicBezTo>
                        <a:pt x="70" y="107"/>
                        <a:pt x="54" y="118"/>
                        <a:pt x="28" y="117"/>
                      </a:cubicBezTo>
                      <a:cubicBezTo>
                        <a:pt x="18" y="117"/>
                        <a:pt x="9" y="113"/>
                        <a:pt x="0" y="109"/>
                      </a:cubicBezTo>
                      <a:cubicBezTo>
                        <a:pt x="12" y="120"/>
                        <a:pt x="27" y="128"/>
                        <a:pt x="43" y="129"/>
                      </a:cubicBezTo>
                      <a:cubicBezTo>
                        <a:pt x="82" y="130"/>
                        <a:pt x="112" y="122"/>
                        <a:pt x="119" y="67"/>
                      </a:cubicBezTo>
                      <a:cubicBezTo>
                        <a:pt x="122" y="43"/>
                        <a:pt x="109" y="15"/>
                        <a:pt x="82" y="0"/>
                      </a:cubicBezTo>
                      <a:close/>
                    </a:path>
                  </a:pathLst>
                </a:custGeom>
                <a:solidFill>
                  <a:srgbClr val="0094B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79" name="Freeform 64"/>
                <p:cNvSpPr/>
                <p:nvPr/>
              </p:nvSpPr>
              <p:spPr bwMode="auto">
                <a:xfrm>
                  <a:off x="8819923" y="4477179"/>
                  <a:ext cx="433388" cy="530225"/>
                </a:xfrm>
                <a:custGeom>
                  <a:avLst/>
                  <a:gdLst>
                    <a:gd name="T0" fmla="*/ 301 w 109"/>
                    <a:gd name="T1" fmla="*/ 1542 h 125"/>
                    <a:gd name="T2" fmla="*/ 676 w 109"/>
                    <a:gd name="T3" fmla="*/ 799 h 125"/>
                    <a:gd name="T4" fmla="*/ 1430 w 109"/>
                    <a:gd name="T5" fmla="*/ 307 h 125"/>
                    <a:gd name="T6" fmla="*/ 1538 w 109"/>
                    <a:gd name="T7" fmla="*/ 286 h 125"/>
                    <a:gd name="T8" fmla="*/ 1180 w 109"/>
                    <a:gd name="T9" fmla="*/ 150 h 125"/>
                    <a:gd name="T10" fmla="*/ 50 w 109"/>
                    <a:gd name="T11" fmla="*/ 1299 h 125"/>
                    <a:gd name="T12" fmla="*/ 376 w 109"/>
                    <a:gd name="T13" fmla="*/ 2383 h 125"/>
                    <a:gd name="T14" fmla="*/ 301 w 109"/>
                    <a:gd name="T15" fmla="*/ 1542 h 125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  <a:gd name="T21" fmla="*/ 0 60000 65536"/>
                    <a:gd name="T22" fmla="*/ 0 60000 65536"/>
                    <a:gd name="T23" fmla="*/ 0 60000 65536"/>
                  </a:gdLst>
                  <a:ahLst/>
                  <a:cxnLst>
                    <a:cxn ang="T16">
                      <a:pos x="T0" y="T1"/>
                    </a:cxn>
                    <a:cxn ang="T17">
                      <a:pos x="T2" y="T3"/>
                    </a:cxn>
                    <a:cxn ang="T18">
                      <a:pos x="T4" y="T5"/>
                    </a:cxn>
                    <a:cxn ang="T19">
                      <a:pos x="T6" y="T7"/>
                    </a:cxn>
                    <a:cxn ang="T20">
                      <a:pos x="T8" y="T9"/>
                    </a:cxn>
                    <a:cxn ang="T21">
                      <a:pos x="T10" y="T11"/>
                    </a:cxn>
                    <a:cxn ang="T22">
                      <a:pos x="T12" y="T13"/>
                    </a:cxn>
                    <a:cxn ang="T23">
                      <a:pos x="T14" y="T15"/>
                    </a:cxn>
                  </a:cxnLst>
                  <a:rect l="0" t="0" r="r" b="b"/>
                  <a:pathLst>
                    <a:path w="109" h="125">
                      <a:moveTo>
                        <a:pt x="19" y="81"/>
                      </a:moveTo>
                      <a:cubicBezTo>
                        <a:pt x="21" y="65"/>
                        <a:pt x="33" y="55"/>
                        <a:pt x="43" y="42"/>
                      </a:cubicBezTo>
                      <a:cubicBezTo>
                        <a:pt x="54" y="28"/>
                        <a:pt x="65" y="12"/>
                        <a:pt x="91" y="16"/>
                      </a:cubicBezTo>
                      <a:cubicBezTo>
                        <a:pt x="104" y="18"/>
                        <a:pt x="109" y="19"/>
                        <a:pt x="98" y="15"/>
                      </a:cubicBezTo>
                      <a:cubicBezTo>
                        <a:pt x="91" y="11"/>
                        <a:pt x="83" y="9"/>
                        <a:pt x="75" y="8"/>
                      </a:cubicBezTo>
                      <a:cubicBezTo>
                        <a:pt x="28" y="0"/>
                        <a:pt x="7" y="32"/>
                        <a:pt x="3" y="68"/>
                      </a:cubicBezTo>
                      <a:cubicBezTo>
                        <a:pt x="0" y="88"/>
                        <a:pt x="9" y="110"/>
                        <a:pt x="24" y="125"/>
                      </a:cubicBezTo>
                      <a:cubicBezTo>
                        <a:pt x="15" y="106"/>
                        <a:pt x="16" y="101"/>
                        <a:pt x="19" y="81"/>
                      </a:cubicBezTo>
                      <a:close/>
                    </a:path>
                  </a:pathLst>
                </a:custGeom>
                <a:solidFill>
                  <a:srgbClr val="DEEEF2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0" name="Freeform 65"/>
                <p:cNvSpPr/>
                <p:nvPr/>
              </p:nvSpPr>
              <p:spPr bwMode="auto">
                <a:xfrm>
                  <a:off x="8907235" y="4197779"/>
                  <a:ext cx="917575" cy="1274763"/>
                </a:xfrm>
                <a:custGeom>
                  <a:avLst/>
                  <a:gdLst>
                    <a:gd name="T0" fmla="*/ 2270 w 222"/>
                    <a:gd name="T1" fmla="*/ 0 h 301"/>
                    <a:gd name="T2" fmla="*/ 2895 w 222"/>
                    <a:gd name="T3" fmla="*/ 2428 h 301"/>
                    <a:gd name="T4" fmla="*/ 2125 w 222"/>
                    <a:gd name="T5" fmla="*/ 4212 h 301"/>
                    <a:gd name="T6" fmla="*/ 0 w 222"/>
                    <a:gd name="T7" fmla="*/ 5624 h 301"/>
                    <a:gd name="T8" fmla="*/ 708 w 222"/>
                    <a:gd name="T9" fmla="*/ 5714 h 301"/>
                    <a:gd name="T10" fmla="*/ 3438 w 222"/>
                    <a:gd name="T11" fmla="*/ 2620 h 301"/>
                    <a:gd name="T12" fmla="*/ 2270 w 222"/>
                    <a:gd name="T13" fmla="*/ 0 h 301"/>
                    <a:gd name="T14" fmla="*/ 0 60000 65536"/>
                    <a:gd name="T15" fmla="*/ 0 60000 65536"/>
                    <a:gd name="T16" fmla="*/ 0 60000 65536"/>
                    <a:gd name="T17" fmla="*/ 0 60000 65536"/>
                    <a:gd name="T18" fmla="*/ 0 60000 65536"/>
                    <a:gd name="T19" fmla="*/ 0 60000 65536"/>
                    <a:gd name="T20" fmla="*/ 0 60000 65536"/>
                  </a:gdLst>
                  <a:ahLst/>
                  <a:cxnLst>
                    <a:cxn ang="T14">
                      <a:pos x="T0" y="T1"/>
                    </a:cxn>
                    <a:cxn ang="T15">
                      <a:pos x="T2" y="T3"/>
                    </a:cxn>
                    <a:cxn ang="T16">
                      <a:pos x="T4" y="T5"/>
                    </a:cxn>
                    <a:cxn ang="T17">
                      <a:pos x="T6" y="T7"/>
                    </a:cxn>
                    <a:cxn ang="T18">
                      <a:pos x="T8" y="T9"/>
                    </a:cxn>
                    <a:cxn ang="T19">
                      <a:pos x="T10" y="T11"/>
                    </a:cxn>
                    <a:cxn ang="T20">
                      <a:pos x="T12" y="T13"/>
                    </a:cxn>
                  </a:cxnLst>
                  <a:rect l="0" t="0" r="r" b="b"/>
                  <a:pathLst>
                    <a:path w="222" h="301">
                      <a:moveTo>
                        <a:pt x="145" y="0"/>
                      </a:moveTo>
                      <a:cubicBezTo>
                        <a:pt x="185" y="44"/>
                        <a:pt x="184" y="51"/>
                        <a:pt x="185" y="128"/>
                      </a:cubicBezTo>
                      <a:cubicBezTo>
                        <a:pt x="186" y="175"/>
                        <a:pt x="161" y="195"/>
                        <a:pt x="136" y="222"/>
                      </a:cubicBezTo>
                      <a:cubicBezTo>
                        <a:pt x="104" y="256"/>
                        <a:pt x="65" y="291"/>
                        <a:pt x="0" y="296"/>
                      </a:cubicBezTo>
                      <a:cubicBezTo>
                        <a:pt x="14" y="299"/>
                        <a:pt x="29" y="301"/>
                        <a:pt x="45" y="301"/>
                      </a:cubicBezTo>
                      <a:cubicBezTo>
                        <a:pt x="139" y="301"/>
                        <a:pt x="222" y="248"/>
                        <a:pt x="220" y="138"/>
                      </a:cubicBezTo>
                      <a:cubicBezTo>
                        <a:pt x="219" y="71"/>
                        <a:pt x="188" y="25"/>
                        <a:pt x="145" y="0"/>
                      </a:cubicBezTo>
                      <a:close/>
                    </a:path>
                  </a:pathLst>
                </a:custGeom>
                <a:solidFill>
                  <a:schemeClr val="tx2">
                    <a:lumMod val="60000"/>
                    <a:lumOff val="40000"/>
                  </a:schemeClr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1" name="Freeform 66"/>
                <p:cNvSpPr/>
                <p:nvPr/>
              </p:nvSpPr>
              <p:spPr bwMode="auto">
                <a:xfrm>
                  <a:off x="8419873" y="4088242"/>
                  <a:ext cx="661988" cy="693738"/>
                </a:xfrm>
                <a:custGeom>
                  <a:avLst/>
                  <a:gdLst>
                    <a:gd name="T0" fmla="*/ 30 w 167"/>
                    <a:gd name="T1" fmla="*/ 3102 h 164"/>
                    <a:gd name="T2" fmla="*/ 2599 w 167"/>
                    <a:gd name="T3" fmla="*/ 35 h 164"/>
                    <a:gd name="T4" fmla="*/ 30 w 167"/>
                    <a:gd name="T5" fmla="*/ 3102 h 164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67" h="164">
                      <a:moveTo>
                        <a:pt x="2" y="164"/>
                      </a:moveTo>
                      <a:cubicBezTo>
                        <a:pt x="0" y="61"/>
                        <a:pt x="80" y="2"/>
                        <a:pt x="167" y="2"/>
                      </a:cubicBezTo>
                      <a:cubicBezTo>
                        <a:pt x="119" y="0"/>
                        <a:pt x="29" y="50"/>
                        <a:pt x="2" y="164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2" name="Freeform 67"/>
                <p:cNvSpPr/>
                <p:nvPr/>
              </p:nvSpPr>
              <p:spPr bwMode="auto">
                <a:xfrm>
                  <a:off x="9086623" y="4781979"/>
                  <a:ext cx="701675" cy="690563"/>
                </a:xfrm>
                <a:custGeom>
                  <a:avLst/>
                  <a:gdLst>
                    <a:gd name="T0" fmla="*/ 0 w 177"/>
                    <a:gd name="T1" fmla="*/ 3098 h 163"/>
                    <a:gd name="T2" fmla="*/ 2724 w 177"/>
                    <a:gd name="T3" fmla="*/ 0 h 163"/>
                    <a:gd name="T4" fmla="*/ 0 w 177"/>
                    <a:gd name="T5" fmla="*/ 3098 h 163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177" h="163">
                      <a:moveTo>
                        <a:pt x="0" y="163"/>
                      </a:moveTo>
                      <a:cubicBezTo>
                        <a:pt x="94" y="163"/>
                        <a:pt x="177" y="110"/>
                        <a:pt x="175" y="0"/>
                      </a:cubicBezTo>
                      <a:cubicBezTo>
                        <a:pt x="148" y="70"/>
                        <a:pt x="121" y="149"/>
                        <a:pt x="0" y="163"/>
                      </a:cubicBezTo>
                      <a:close/>
                    </a:path>
                  </a:pathLst>
                </a:cu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3" name="Freeform 68"/>
                <p:cNvSpPr/>
                <p:nvPr/>
              </p:nvSpPr>
              <p:spPr bwMode="auto">
                <a:xfrm>
                  <a:off x="9094560" y="4829604"/>
                  <a:ext cx="301625" cy="279400"/>
                </a:xfrm>
                <a:custGeom>
                  <a:avLst/>
                  <a:gdLst>
                    <a:gd name="T0" fmla="*/ 1188 w 76"/>
                    <a:gd name="T1" fmla="*/ 56 h 66"/>
                    <a:gd name="T2" fmla="*/ 0 w 76"/>
                    <a:gd name="T3" fmla="*/ 1229 h 66"/>
                    <a:gd name="T4" fmla="*/ 1175 w 76"/>
                    <a:gd name="T5" fmla="*/ 0 h 66"/>
                    <a:gd name="T6" fmla="*/ 0 60000 65536"/>
                    <a:gd name="T7" fmla="*/ 0 60000 65536"/>
                    <a:gd name="T8" fmla="*/ 0 60000 65536"/>
                  </a:gdLst>
                  <a:ahLst/>
                  <a:cxnLst>
                    <a:cxn ang="T6">
                      <a:pos x="T0" y="T1"/>
                    </a:cxn>
                    <a:cxn ang="T7">
                      <a:pos x="T2" y="T3"/>
                    </a:cxn>
                    <a:cxn ang="T8">
                      <a:pos x="T4" y="T5"/>
                    </a:cxn>
                  </a:cxnLst>
                  <a:rect l="0" t="0" r="r" b="b"/>
                  <a:pathLst>
                    <a:path w="76" h="66">
                      <a:moveTo>
                        <a:pt x="76" y="3"/>
                      </a:moveTo>
                      <a:cubicBezTo>
                        <a:pt x="69" y="58"/>
                        <a:pt x="39" y="66"/>
                        <a:pt x="0" y="65"/>
                      </a:cubicBezTo>
                      <a:cubicBezTo>
                        <a:pt x="25" y="62"/>
                        <a:pt x="60" y="46"/>
                        <a:pt x="75" y="0"/>
                      </a:cubicBezTo>
                    </a:path>
                  </a:pathLst>
                </a:custGeom>
                <a:solidFill>
                  <a:srgbClr val="006C8B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4" name="Freeform 70"/>
                <p:cNvSpPr/>
                <p:nvPr/>
              </p:nvSpPr>
              <p:spPr bwMode="auto">
                <a:xfrm>
                  <a:off x="8784996" y="4448615"/>
                  <a:ext cx="650874" cy="500547"/>
                </a:xfrm>
                <a:custGeom>
                  <a:avLst/>
                  <a:gdLst>
                    <a:gd name="T0" fmla="*/ 1333 w 164"/>
                    <a:gd name="T1" fmla="*/ 149 h 163"/>
                    <a:gd name="T2" fmla="*/ 83 w 164"/>
                    <a:gd name="T3" fmla="*/ 1398 h 163"/>
                    <a:gd name="T4" fmla="*/ 1208 w 164"/>
                    <a:gd name="T5" fmla="*/ 3041 h 163"/>
                    <a:gd name="T6" fmla="*/ 2500 w 164"/>
                    <a:gd name="T7" fmla="*/ 1757 h 163"/>
                    <a:gd name="T8" fmla="*/ 1333 w 164"/>
                    <a:gd name="T9" fmla="*/ 149 h 163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64" h="163">
                      <a:moveTo>
                        <a:pt x="85" y="8"/>
                      </a:moveTo>
                      <a:cubicBezTo>
                        <a:pt x="33" y="0"/>
                        <a:pt x="10" y="34"/>
                        <a:pt x="5" y="74"/>
                      </a:cubicBezTo>
                      <a:cubicBezTo>
                        <a:pt x="0" y="114"/>
                        <a:pt x="34" y="159"/>
                        <a:pt x="77" y="161"/>
                      </a:cubicBezTo>
                      <a:cubicBezTo>
                        <a:pt x="120" y="163"/>
                        <a:pt x="152" y="154"/>
                        <a:pt x="160" y="93"/>
                      </a:cubicBezTo>
                      <a:cubicBezTo>
                        <a:pt x="164" y="58"/>
                        <a:pt x="137" y="16"/>
                        <a:pt x="85" y="8"/>
                      </a:cubicBezTo>
                      <a:close/>
                    </a:path>
                  </a:pathLst>
                </a:custGeom>
                <a:noFill/>
                <a:ln w="7938" cap="rnd">
                  <a:solidFill>
                    <a:srgbClr val="FFFFFF"/>
                  </a:solidFill>
                  <a:prstDash val="solid"/>
                  <a:rou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5" name="Freeform 71"/>
                <p:cNvSpPr/>
                <p:nvPr/>
              </p:nvSpPr>
              <p:spPr bwMode="auto">
                <a:xfrm>
                  <a:off x="8811985" y="4532742"/>
                  <a:ext cx="111125" cy="119063"/>
                </a:xfrm>
                <a:custGeom>
                  <a:avLst/>
                  <a:gdLst>
                    <a:gd name="T0" fmla="*/ 20 w 28"/>
                    <a:gd name="T1" fmla="*/ 287 h 28"/>
                    <a:gd name="T2" fmla="*/ 208 w 28"/>
                    <a:gd name="T3" fmla="*/ 21 h 28"/>
                    <a:gd name="T4" fmla="*/ 425 w 28"/>
                    <a:gd name="T5" fmla="*/ 252 h 28"/>
                    <a:gd name="T6" fmla="*/ 238 w 28"/>
                    <a:gd name="T7" fmla="*/ 517 h 28"/>
                    <a:gd name="T8" fmla="*/ 20 w 28"/>
                    <a:gd name="T9" fmla="*/ 287 h 2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28" h="28">
                      <a:moveTo>
                        <a:pt x="1" y="15"/>
                      </a:moveTo>
                      <a:cubicBezTo>
                        <a:pt x="0" y="8"/>
                        <a:pt x="6" y="2"/>
                        <a:pt x="13" y="1"/>
                      </a:cubicBezTo>
                      <a:cubicBezTo>
                        <a:pt x="20" y="0"/>
                        <a:pt x="27" y="6"/>
                        <a:pt x="27" y="13"/>
                      </a:cubicBezTo>
                      <a:cubicBezTo>
                        <a:pt x="28" y="20"/>
                        <a:pt x="22" y="27"/>
                        <a:pt x="15" y="27"/>
                      </a:cubicBezTo>
                      <a:cubicBezTo>
                        <a:pt x="8" y="28"/>
                        <a:pt x="2" y="22"/>
                        <a:pt x="1" y="15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6" name="Freeform 72"/>
                <p:cNvSpPr/>
                <p:nvPr/>
              </p:nvSpPr>
              <p:spPr bwMode="auto">
                <a:xfrm>
                  <a:off x="8907235" y="4474004"/>
                  <a:ext cx="68263" cy="71438"/>
                </a:xfrm>
                <a:custGeom>
                  <a:avLst/>
                  <a:gdLst>
                    <a:gd name="T0" fmla="*/ 20 w 17"/>
                    <a:gd name="T1" fmla="*/ 169 h 17"/>
                    <a:gd name="T2" fmla="*/ 129 w 17"/>
                    <a:gd name="T3" fmla="*/ 0 h 17"/>
                    <a:gd name="T4" fmla="*/ 276 w 17"/>
                    <a:gd name="T5" fmla="*/ 148 h 17"/>
                    <a:gd name="T6" fmla="*/ 147 w 17"/>
                    <a:gd name="T7" fmla="*/ 315 h 17"/>
                    <a:gd name="T8" fmla="*/ 20 w 17"/>
                    <a:gd name="T9" fmla="*/ 169 h 17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7" h="17">
                      <a:moveTo>
                        <a:pt x="1" y="9"/>
                      </a:moveTo>
                      <a:cubicBezTo>
                        <a:pt x="0" y="5"/>
                        <a:pt x="4" y="1"/>
                        <a:pt x="8" y="0"/>
                      </a:cubicBezTo>
                      <a:cubicBezTo>
                        <a:pt x="13" y="0"/>
                        <a:pt x="16" y="3"/>
                        <a:pt x="17" y="8"/>
                      </a:cubicBezTo>
                      <a:cubicBezTo>
                        <a:pt x="17" y="12"/>
                        <a:pt x="14" y="16"/>
                        <a:pt x="9" y="17"/>
                      </a:cubicBezTo>
                      <a:cubicBezTo>
                        <a:pt x="5" y="17"/>
                        <a:pt x="1" y="14"/>
                        <a:pt x="1" y="9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  <p:sp>
              <p:nvSpPr>
                <p:cNvPr id="187" name="Freeform 73"/>
                <p:cNvSpPr/>
                <p:nvPr/>
              </p:nvSpPr>
              <p:spPr bwMode="auto">
                <a:xfrm>
                  <a:off x="8804048" y="4667679"/>
                  <a:ext cx="52388" cy="60325"/>
                </a:xfrm>
                <a:custGeom>
                  <a:avLst/>
                  <a:gdLst>
                    <a:gd name="T0" fmla="*/ 0 w 13"/>
                    <a:gd name="T1" fmla="*/ 141 h 14"/>
                    <a:gd name="T2" fmla="*/ 96 w 13"/>
                    <a:gd name="T3" fmla="*/ 0 h 14"/>
                    <a:gd name="T4" fmla="*/ 213 w 13"/>
                    <a:gd name="T5" fmla="*/ 117 h 14"/>
                    <a:gd name="T6" fmla="*/ 117 w 13"/>
                    <a:gd name="T7" fmla="*/ 258 h 14"/>
                    <a:gd name="T8" fmla="*/ 0 w 13"/>
                    <a:gd name="T9" fmla="*/ 141 h 14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13" h="14">
                      <a:moveTo>
                        <a:pt x="0" y="7"/>
                      </a:moveTo>
                      <a:cubicBezTo>
                        <a:pt x="0" y="4"/>
                        <a:pt x="2" y="1"/>
                        <a:pt x="6" y="0"/>
                      </a:cubicBezTo>
                      <a:cubicBezTo>
                        <a:pt x="10" y="0"/>
                        <a:pt x="13" y="3"/>
                        <a:pt x="13" y="6"/>
                      </a:cubicBezTo>
                      <a:cubicBezTo>
                        <a:pt x="13" y="10"/>
                        <a:pt x="11" y="13"/>
                        <a:pt x="7" y="13"/>
                      </a:cubicBezTo>
                      <a:cubicBezTo>
                        <a:pt x="3" y="14"/>
                        <a:pt x="0" y="11"/>
                        <a:pt x="0" y="7"/>
                      </a:cubicBezTo>
                      <a:close/>
                    </a:path>
                  </a:pathLst>
                </a:cu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</a14:hiddenLine>
                  </a:ext>
                </a:extLst>
              </p:spPr>
              <p:txBody>
                <a:bodyPr>
                  <a:scene3d>
                    <a:camera prst="orthographicFront"/>
                    <a:lightRig rig="brightRoom" dir="t"/>
                  </a:scene3d>
                  <a:sp3d contourW="6350" prstMaterial="plastic">
                    <a:bevelT w="20320" h="20320" prst="angle"/>
                    <a:contourClr>
                      <a:schemeClr val="accent1">
                        <a:tint val="100000"/>
                        <a:shade val="100000"/>
                        <a:hueMod val="100000"/>
                        <a:satMod val="100000"/>
                      </a:schemeClr>
                    </a:contourClr>
                  </a:sp3d>
                </a:bodyPr>
                <a:lstStyle/>
                <a:p>
                  <a:endParaRPr lang="zh-CN" altLang="en-US" b="1" cap="all">
                    <a:solidFill>
                      <a:schemeClr val="accent1"/>
                    </a:solidFill>
                    <a:effectLst>
                      <a:outerShdw blurRad="19685" dist="12700" dir="5400000" algn="tl" rotWithShape="0">
                        <a:schemeClr val="accent1">
                          <a:satMod val="130000"/>
                          <a:alpha val="60000"/>
                        </a:schemeClr>
                      </a:outerShdw>
                      <a:reflection blurRad="10000" stA="55000" endPos="48000" dist="500" dir="5400000" sy="-100000" algn="bl" rotWithShape="0"/>
                    </a:effectLst>
                  </a:endParaRPr>
                </a:p>
              </p:txBody>
            </p:sp>
          </p:grpSp>
        </p:grpSp>
        <p:cxnSp>
          <p:nvCxnSpPr>
            <p:cNvPr id="141" name="直接连接符 140"/>
            <p:cNvCxnSpPr/>
            <p:nvPr/>
          </p:nvCxnSpPr>
          <p:spPr>
            <a:xfrm>
              <a:off x="12782" y="3810"/>
              <a:ext cx="11" cy="894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/>
            <p:cNvSpPr txBox="1"/>
            <p:nvPr/>
          </p:nvSpPr>
          <p:spPr>
            <a:xfrm>
              <a:off x="10575" y="8305"/>
              <a:ext cx="1624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ound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5354" y="6388"/>
              <a:ext cx="1725" cy="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lector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0694" y="5457"/>
              <a:ext cx="1321" cy="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wer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接连接符 151"/>
            <p:cNvCxnSpPr/>
            <p:nvPr/>
          </p:nvCxnSpPr>
          <p:spPr>
            <a:xfrm>
              <a:off x="12210" y="8211"/>
              <a:ext cx="680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sp>
          <p:nvSpPr>
            <p:cNvPr id="45" name="矩形 44"/>
            <p:cNvSpPr/>
            <p:nvPr/>
          </p:nvSpPr>
          <p:spPr>
            <a:xfrm>
              <a:off x="14801" y="2372"/>
              <a:ext cx="1523" cy="5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ringe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任意多边形 46"/>
            <p:cNvSpPr/>
            <p:nvPr/>
          </p:nvSpPr>
          <p:spPr>
            <a:xfrm>
              <a:off x="13657" y="4554"/>
              <a:ext cx="1628" cy="3446"/>
            </a:xfrm>
            <a:custGeom>
              <a:avLst/>
              <a:gdLst>
                <a:gd name="connsiteX0" fmla="*/ 606465 w 1033810"/>
                <a:gd name="connsiteY0" fmla="*/ 0 h 2188395"/>
                <a:gd name="connsiteX1" fmla="*/ 472901 w 1033810"/>
                <a:gd name="connsiteY1" fmla="*/ 236305 h 2188395"/>
                <a:gd name="connsiteX2" fmla="*/ 688658 w 1033810"/>
                <a:gd name="connsiteY2" fmla="*/ 452062 h 2188395"/>
                <a:gd name="connsiteX3" fmla="*/ 329062 w 1033810"/>
                <a:gd name="connsiteY3" fmla="*/ 688368 h 2188395"/>
                <a:gd name="connsiteX4" fmla="*/ 811948 w 1033810"/>
                <a:gd name="connsiteY4" fmla="*/ 976044 h 2188395"/>
                <a:gd name="connsiteX5" fmla="*/ 164676 w 1033810"/>
                <a:gd name="connsiteY5" fmla="*/ 1150705 h 2188395"/>
                <a:gd name="connsiteX6" fmla="*/ 914689 w 1033810"/>
                <a:gd name="connsiteY6" fmla="*/ 1417833 h 2188395"/>
                <a:gd name="connsiteX7" fmla="*/ 289 w 1033810"/>
                <a:gd name="connsiteY7" fmla="*/ 1623316 h 2188395"/>
                <a:gd name="connsiteX8" fmla="*/ 1027705 w 1033810"/>
                <a:gd name="connsiteY8" fmla="*/ 1859622 h 2188395"/>
                <a:gd name="connsiteX9" fmla="*/ 349611 w 1033810"/>
                <a:gd name="connsiteY9" fmla="*/ 2188395 h 21883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1033810" h="2188395">
                  <a:moveTo>
                    <a:pt x="606465" y="0"/>
                  </a:moveTo>
                  <a:cubicBezTo>
                    <a:pt x="532833" y="80480"/>
                    <a:pt x="459202" y="160961"/>
                    <a:pt x="472901" y="236305"/>
                  </a:cubicBezTo>
                  <a:cubicBezTo>
                    <a:pt x="486600" y="311649"/>
                    <a:pt x="712631" y="376718"/>
                    <a:pt x="688658" y="452062"/>
                  </a:cubicBezTo>
                  <a:cubicBezTo>
                    <a:pt x="664685" y="527406"/>
                    <a:pt x="308514" y="601038"/>
                    <a:pt x="329062" y="688368"/>
                  </a:cubicBezTo>
                  <a:cubicBezTo>
                    <a:pt x="349610" y="775698"/>
                    <a:pt x="839346" y="898988"/>
                    <a:pt x="811948" y="976044"/>
                  </a:cubicBezTo>
                  <a:cubicBezTo>
                    <a:pt x="784550" y="1053100"/>
                    <a:pt x="147552" y="1077074"/>
                    <a:pt x="164676" y="1150705"/>
                  </a:cubicBezTo>
                  <a:cubicBezTo>
                    <a:pt x="181799" y="1224337"/>
                    <a:pt x="942087" y="1339065"/>
                    <a:pt x="914689" y="1417833"/>
                  </a:cubicBezTo>
                  <a:cubicBezTo>
                    <a:pt x="887291" y="1496601"/>
                    <a:pt x="-18547" y="1549685"/>
                    <a:pt x="289" y="1623316"/>
                  </a:cubicBezTo>
                  <a:cubicBezTo>
                    <a:pt x="19125" y="1696947"/>
                    <a:pt x="969485" y="1765442"/>
                    <a:pt x="1027705" y="1859622"/>
                  </a:cubicBezTo>
                  <a:cubicBezTo>
                    <a:pt x="1085925" y="1953802"/>
                    <a:pt x="717768" y="2071098"/>
                    <a:pt x="349611" y="2188395"/>
                  </a:cubicBezTo>
                </a:path>
              </a:pathLst>
            </a:cu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58" name="直接连接符 157"/>
            <p:cNvCxnSpPr/>
            <p:nvPr/>
          </p:nvCxnSpPr>
          <p:spPr>
            <a:xfrm>
              <a:off x="12308" y="8372"/>
              <a:ext cx="454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159" name="直接连接符 158"/>
            <p:cNvCxnSpPr/>
            <p:nvPr/>
          </p:nvCxnSpPr>
          <p:spPr>
            <a:xfrm>
              <a:off x="12405" y="8550"/>
              <a:ext cx="227" cy="0"/>
            </a:xfrm>
            <a:prstGeom prst="line">
              <a:avLst/>
            </a:prstGeom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sp>
          <p:nvSpPr>
            <p:cNvPr id="160" name="文本框 159"/>
            <p:cNvSpPr txBox="1"/>
            <p:nvPr/>
          </p:nvSpPr>
          <p:spPr>
            <a:xfrm>
              <a:off x="11286" y="1571"/>
              <a:ext cx="2775" cy="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err="1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ectrospinning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1034"/>
            <p:cNvSpPr txBox="1"/>
            <p:nvPr/>
          </p:nvSpPr>
          <p:spPr>
            <a:xfrm>
              <a:off x="12941" y="8549"/>
              <a:ext cx="2694" cy="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err="1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anofibers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at</a:t>
              </a:r>
              <a:endParaRPr lang="en-US" altLang="zh-CN" dirty="0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直接连接符 161"/>
            <p:cNvCxnSpPr/>
            <p:nvPr/>
          </p:nvCxnSpPr>
          <p:spPr>
            <a:xfrm>
              <a:off x="16431" y="6926"/>
              <a:ext cx="204" cy="563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grpSp>
          <p:nvGrpSpPr>
            <p:cNvPr id="51" name="组合 50"/>
            <p:cNvGrpSpPr/>
            <p:nvPr/>
          </p:nvGrpSpPr>
          <p:grpSpPr>
            <a:xfrm rot="0">
              <a:off x="3314" y="6575"/>
              <a:ext cx="2340" cy="1428"/>
              <a:chOff x="214718" y="3351686"/>
              <a:chExt cx="1485721" cy="906929"/>
            </a:xfrm>
          </p:grpSpPr>
          <p:sp>
            <p:nvSpPr>
              <p:cNvPr id="264" name="Freeform 51"/>
              <p:cNvSpPr/>
              <p:nvPr/>
            </p:nvSpPr>
            <p:spPr bwMode="auto">
              <a:xfrm>
                <a:off x="214718" y="3384295"/>
                <a:ext cx="1485721" cy="874320"/>
              </a:xfrm>
              <a:custGeom>
                <a:avLst/>
                <a:gdLst>
                  <a:gd name="T0" fmla="*/ 3113 w 634"/>
                  <a:gd name="T1" fmla="*/ 0 h 322"/>
                  <a:gd name="T2" fmla="*/ 3470 w 634"/>
                  <a:gd name="T3" fmla="*/ 1386 h 322"/>
                  <a:gd name="T4" fmla="*/ 2675 w 634"/>
                  <a:gd name="T5" fmla="*/ 1740 h 322"/>
                  <a:gd name="T6" fmla="*/ 2020 w 634"/>
                  <a:gd name="T7" fmla="*/ 1100 h 322"/>
                  <a:gd name="T8" fmla="*/ 2050 w 634"/>
                  <a:gd name="T9" fmla="*/ 2363 h 322"/>
                  <a:gd name="T10" fmla="*/ 675 w 634"/>
                  <a:gd name="T11" fmla="*/ 2401 h 322"/>
                  <a:gd name="T12" fmla="*/ 1908 w 634"/>
                  <a:gd name="T13" fmla="*/ 2726 h 322"/>
                  <a:gd name="T14" fmla="*/ 1425 w 634"/>
                  <a:gd name="T15" fmla="*/ 4522 h 322"/>
                  <a:gd name="T16" fmla="*/ 0 w 634"/>
                  <a:gd name="T17" fmla="*/ 5788 h 322"/>
                  <a:gd name="T18" fmla="*/ 2125 w 634"/>
                  <a:gd name="T19" fmla="*/ 4487 h 322"/>
                  <a:gd name="T20" fmla="*/ 2583 w 634"/>
                  <a:gd name="T21" fmla="*/ 6091 h 322"/>
                  <a:gd name="T22" fmla="*/ 3720 w 634"/>
                  <a:gd name="T23" fmla="*/ 4274 h 322"/>
                  <a:gd name="T24" fmla="*/ 6083 w 634"/>
                  <a:gd name="T25" fmla="*/ 4218 h 322"/>
                  <a:gd name="T26" fmla="*/ 7720 w 634"/>
                  <a:gd name="T27" fmla="*/ 3579 h 322"/>
                  <a:gd name="T28" fmla="*/ 8863 w 634"/>
                  <a:gd name="T29" fmla="*/ 5468 h 322"/>
                  <a:gd name="T30" fmla="*/ 9908 w 634"/>
                  <a:gd name="T31" fmla="*/ 3805 h 322"/>
                  <a:gd name="T32" fmla="*/ 8625 w 634"/>
                  <a:gd name="T33" fmla="*/ 3080 h 322"/>
                  <a:gd name="T34" fmla="*/ 9533 w 634"/>
                  <a:gd name="T35" fmla="*/ 661 h 322"/>
                  <a:gd name="T36" fmla="*/ 8595 w 634"/>
                  <a:gd name="T37" fmla="*/ 1386 h 322"/>
                  <a:gd name="T38" fmla="*/ 7908 w 634"/>
                  <a:gd name="T39" fmla="*/ 1966 h 322"/>
                  <a:gd name="T40" fmla="*/ 6113 w 634"/>
                  <a:gd name="T41" fmla="*/ 1740 h 322"/>
                  <a:gd name="T42" fmla="*/ 3988 w 634"/>
                  <a:gd name="T43" fmla="*/ 930 h 322"/>
                  <a:gd name="T44" fmla="*/ 3113 w 634"/>
                  <a:gd name="T45" fmla="*/ 0 h 322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</a:gdLst>
                <a:ahLst/>
                <a:cxnLst>
                  <a:cxn ang="T46">
                    <a:pos x="T0" y="T1"/>
                  </a:cxn>
                  <a:cxn ang="T47">
                    <a:pos x="T2" y="T3"/>
                  </a:cxn>
                  <a:cxn ang="T48">
                    <a:pos x="T4" y="T5"/>
                  </a:cxn>
                  <a:cxn ang="T49">
                    <a:pos x="T6" y="T7"/>
                  </a:cxn>
                  <a:cxn ang="T50">
                    <a:pos x="T8" y="T9"/>
                  </a:cxn>
                  <a:cxn ang="T51">
                    <a:pos x="T10" y="T11"/>
                  </a:cxn>
                  <a:cxn ang="T52">
                    <a:pos x="T12" y="T13"/>
                  </a:cxn>
                  <a:cxn ang="T53">
                    <a:pos x="T14" y="T15"/>
                  </a:cxn>
                  <a:cxn ang="T54">
                    <a:pos x="T16" y="T17"/>
                  </a:cxn>
                  <a:cxn ang="T55">
                    <a:pos x="T18" y="T19"/>
                  </a:cxn>
                  <a:cxn ang="T56">
                    <a:pos x="T20" y="T21"/>
                  </a:cxn>
                  <a:cxn ang="T57">
                    <a:pos x="T22" y="T23"/>
                  </a:cxn>
                  <a:cxn ang="T58">
                    <a:pos x="T24" y="T25"/>
                  </a:cxn>
                  <a:cxn ang="T59">
                    <a:pos x="T26" y="T27"/>
                  </a:cxn>
                  <a:cxn ang="T60">
                    <a:pos x="T28" y="T29"/>
                  </a:cxn>
                  <a:cxn ang="T61">
                    <a:pos x="T30" y="T31"/>
                  </a:cxn>
                  <a:cxn ang="T62">
                    <a:pos x="T32" y="T33"/>
                  </a:cxn>
                  <a:cxn ang="T63">
                    <a:pos x="T34" y="T35"/>
                  </a:cxn>
                  <a:cxn ang="T64">
                    <a:pos x="T36" y="T37"/>
                  </a:cxn>
                  <a:cxn ang="T65">
                    <a:pos x="T38" y="T39"/>
                  </a:cxn>
                  <a:cxn ang="T66">
                    <a:pos x="T40" y="T41"/>
                  </a:cxn>
                  <a:cxn ang="T67">
                    <a:pos x="T42" y="T43"/>
                  </a:cxn>
                  <a:cxn ang="T68">
                    <a:pos x="T44" y="T45"/>
                  </a:cxn>
                </a:cxnLst>
                <a:rect l="0" t="0" r="r" b="b"/>
                <a:pathLst>
                  <a:path w="634" h="322">
                    <a:moveTo>
                      <a:pt x="199" y="0"/>
                    </a:moveTo>
                    <a:cubicBezTo>
                      <a:pt x="212" y="13"/>
                      <a:pt x="239" y="31"/>
                      <a:pt x="222" y="73"/>
                    </a:cubicBezTo>
                    <a:cubicBezTo>
                      <a:pt x="217" y="88"/>
                      <a:pt x="194" y="98"/>
                      <a:pt x="171" y="92"/>
                    </a:cubicBezTo>
                    <a:cubicBezTo>
                      <a:pt x="153" y="87"/>
                      <a:pt x="134" y="68"/>
                      <a:pt x="129" y="58"/>
                    </a:cubicBezTo>
                    <a:cubicBezTo>
                      <a:pt x="140" y="76"/>
                      <a:pt x="168" y="118"/>
                      <a:pt x="131" y="125"/>
                    </a:cubicBezTo>
                    <a:cubicBezTo>
                      <a:pt x="105" y="130"/>
                      <a:pt x="67" y="150"/>
                      <a:pt x="43" y="127"/>
                    </a:cubicBezTo>
                    <a:cubicBezTo>
                      <a:pt x="51" y="159"/>
                      <a:pt x="113" y="133"/>
                      <a:pt x="122" y="144"/>
                    </a:cubicBezTo>
                    <a:cubicBezTo>
                      <a:pt x="153" y="177"/>
                      <a:pt x="118" y="224"/>
                      <a:pt x="91" y="239"/>
                    </a:cubicBezTo>
                    <a:cubicBezTo>
                      <a:pt x="56" y="258"/>
                      <a:pt x="29" y="278"/>
                      <a:pt x="0" y="306"/>
                    </a:cubicBezTo>
                    <a:cubicBezTo>
                      <a:pt x="35" y="276"/>
                      <a:pt x="94" y="259"/>
                      <a:pt x="136" y="237"/>
                    </a:cubicBezTo>
                    <a:cubicBezTo>
                      <a:pt x="194" y="206"/>
                      <a:pt x="164" y="286"/>
                      <a:pt x="165" y="322"/>
                    </a:cubicBezTo>
                    <a:cubicBezTo>
                      <a:pt x="166" y="297"/>
                      <a:pt x="205" y="213"/>
                      <a:pt x="238" y="226"/>
                    </a:cubicBezTo>
                    <a:cubicBezTo>
                      <a:pt x="280" y="241"/>
                      <a:pt x="351" y="234"/>
                      <a:pt x="389" y="223"/>
                    </a:cubicBezTo>
                    <a:cubicBezTo>
                      <a:pt x="427" y="212"/>
                      <a:pt x="464" y="179"/>
                      <a:pt x="494" y="189"/>
                    </a:cubicBezTo>
                    <a:cubicBezTo>
                      <a:pt x="524" y="199"/>
                      <a:pt x="547" y="252"/>
                      <a:pt x="567" y="289"/>
                    </a:cubicBezTo>
                    <a:cubicBezTo>
                      <a:pt x="538" y="197"/>
                      <a:pt x="573" y="197"/>
                      <a:pt x="634" y="201"/>
                    </a:cubicBezTo>
                    <a:cubicBezTo>
                      <a:pt x="602" y="184"/>
                      <a:pt x="573" y="196"/>
                      <a:pt x="552" y="163"/>
                    </a:cubicBezTo>
                    <a:cubicBezTo>
                      <a:pt x="519" y="110"/>
                      <a:pt x="576" y="49"/>
                      <a:pt x="610" y="35"/>
                    </a:cubicBezTo>
                    <a:cubicBezTo>
                      <a:pt x="585" y="43"/>
                      <a:pt x="569" y="56"/>
                      <a:pt x="550" y="73"/>
                    </a:cubicBezTo>
                    <a:cubicBezTo>
                      <a:pt x="536" y="85"/>
                      <a:pt x="524" y="98"/>
                      <a:pt x="506" y="104"/>
                    </a:cubicBezTo>
                    <a:cubicBezTo>
                      <a:pt x="472" y="115"/>
                      <a:pt x="425" y="98"/>
                      <a:pt x="391" y="92"/>
                    </a:cubicBezTo>
                    <a:cubicBezTo>
                      <a:pt x="339" y="82"/>
                      <a:pt x="293" y="86"/>
                      <a:pt x="255" y="49"/>
                    </a:cubicBezTo>
                    <a:cubicBezTo>
                      <a:pt x="237" y="33"/>
                      <a:pt x="233" y="20"/>
                      <a:pt x="199" y="0"/>
                    </a:cubicBezTo>
                    <a:close/>
                  </a:path>
                </a:pathLst>
              </a:custGeom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5" name="Freeform 52"/>
              <p:cNvSpPr/>
              <p:nvPr/>
            </p:nvSpPr>
            <p:spPr bwMode="auto">
              <a:xfrm>
                <a:off x="384380" y="3779118"/>
                <a:ext cx="1183890" cy="319973"/>
              </a:xfrm>
              <a:custGeom>
                <a:avLst/>
                <a:gdLst>
                  <a:gd name="T0" fmla="*/ 0 w 505"/>
                  <a:gd name="T1" fmla="*/ 1996 h 118"/>
                  <a:gd name="T2" fmla="*/ 908 w 505"/>
                  <a:gd name="T3" fmla="*/ 1488 h 118"/>
                  <a:gd name="T4" fmla="*/ 1551 w 505"/>
                  <a:gd name="T5" fmla="*/ 1543 h 118"/>
                  <a:gd name="T6" fmla="*/ 1583 w 505"/>
                  <a:gd name="T7" fmla="*/ 2225 h 118"/>
                  <a:gd name="T8" fmla="*/ 2408 w 505"/>
                  <a:gd name="T9" fmla="*/ 1245 h 118"/>
                  <a:gd name="T10" fmla="*/ 3992 w 505"/>
                  <a:gd name="T11" fmla="*/ 1416 h 118"/>
                  <a:gd name="T12" fmla="*/ 5817 w 505"/>
                  <a:gd name="T13" fmla="*/ 695 h 118"/>
                  <a:gd name="T14" fmla="*/ 6850 w 505"/>
                  <a:gd name="T15" fmla="*/ 772 h 118"/>
                  <a:gd name="T16" fmla="*/ 7493 w 505"/>
                  <a:gd name="T17" fmla="*/ 1974 h 118"/>
                  <a:gd name="T18" fmla="*/ 7901 w 505"/>
                  <a:gd name="T19" fmla="*/ 865 h 118"/>
                  <a:gd name="T20" fmla="*/ 7318 w 505"/>
                  <a:gd name="T21" fmla="*/ 149 h 118"/>
                  <a:gd name="T22" fmla="*/ 7255 w 505"/>
                  <a:gd name="T23" fmla="*/ 865 h 118"/>
                  <a:gd name="T24" fmla="*/ 6525 w 505"/>
                  <a:gd name="T25" fmla="*/ 56 h 118"/>
                  <a:gd name="T26" fmla="*/ 5410 w 505"/>
                  <a:gd name="T27" fmla="*/ 490 h 118"/>
                  <a:gd name="T28" fmla="*/ 3379 w 505"/>
                  <a:gd name="T29" fmla="*/ 1035 h 118"/>
                  <a:gd name="T30" fmla="*/ 1813 w 505"/>
                  <a:gd name="T31" fmla="*/ 1075 h 118"/>
                  <a:gd name="T32" fmla="*/ 895 w 505"/>
                  <a:gd name="T33" fmla="*/ 1283 h 118"/>
                  <a:gd name="T34" fmla="*/ 0 w 505"/>
                  <a:gd name="T35" fmla="*/ 1996 h 118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</a:gdLst>
                <a:ahLst/>
                <a:cxnLst>
                  <a:cxn ang="T36">
                    <a:pos x="T0" y="T1"/>
                  </a:cxn>
                  <a:cxn ang="T37">
                    <a:pos x="T2" y="T3"/>
                  </a:cxn>
                  <a:cxn ang="T38">
                    <a:pos x="T4" y="T5"/>
                  </a:cxn>
                  <a:cxn ang="T39">
                    <a:pos x="T6" y="T7"/>
                  </a:cxn>
                  <a:cxn ang="T40">
                    <a:pos x="T8" y="T9"/>
                  </a:cxn>
                  <a:cxn ang="T41">
                    <a:pos x="T10" y="T11"/>
                  </a:cxn>
                  <a:cxn ang="T42">
                    <a:pos x="T12" y="T13"/>
                  </a:cxn>
                  <a:cxn ang="T43">
                    <a:pos x="T14" y="T15"/>
                  </a:cxn>
                  <a:cxn ang="T44">
                    <a:pos x="T16" y="T17"/>
                  </a:cxn>
                  <a:cxn ang="T45">
                    <a:pos x="T18" y="T19"/>
                  </a:cxn>
                  <a:cxn ang="T46">
                    <a:pos x="T20" y="T21"/>
                  </a:cxn>
                  <a:cxn ang="T47">
                    <a:pos x="T22" y="T23"/>
                  </a:cxn>
                  <a:cxn ang="T48">
                    <a:pos x="T24" y="T25"/>
                  </a:cxn>
                  <a:cxn ang="T49">
                    <a:pos x="T26" y="T27"/>
                  </a:cxn>
                  <a:cxn ang="T50">
                    <a:pos x="T28" y="T29"/>
                  </a:cxn>
                  <a:cxn ang="T51">
                    <a:pos x="T30" y="T31"/>
                  </a:cxn>
                  <a:cxn ang="T52">
                    <a:pos x="T32" y="T33"/>
                  </a:cxn>
                  <a:cxn ang="T53">
                    <a:pos x="T34" y="T35"/>
                  </a:cxn>
                </a:cxnLst>
                <a:rect l="0" t="0" r="r" b="b"/>
                <a:pathLst>
                  <a:path w="505" h="118">
                    <a:moveTo>
                      <a:pt x="0" y="106"/>
                    </a:moveTo>
                    <a:cubicBezTo>
                      <a:pt x="22" y="98"/>
                      <a:pt x="34" y="90"/>
                      <a:pt x="58" y="79"/>
                    </a:cubicBezTo>
                    <a:cubicBezTo>
                      <a:pt x="82" y="68"/>
                      <a:pt x="93" y="67"/>
                      <a:pt x="99" y="82"/>
                    </a:cubicBezTo>
                    <a:cubicBezTo>
                      <a:pt x="105" y="97"/>
                      <a:pt x="101" y="118"/>
                      <a:pt x="101" y="118"/>
                    </a:cubicBezTo>
                    <a:cubicBezTo>
                      <a:pt x="117" y="74"/>
                      <a:pt x="136" y="68"/>
                      <a:pt x="154" y="66"/>
                    </a:cubicBezTo>
                    <a:cubicBezTo>
                      <a:pt x="172" y="64"/>
                      <a:pt x="197" y="82"/>
                      <a:pt x="255" y="75"/>
                    </a:cubicBezTo>
                    <a:cubicBezTo>
                      <a:pt x="313" y="68"/>
                      <a:pt x="330" y="55"/>
                      <a:pt x="372" y="37"/>
                    </a:cubicBezTo>
                    <a:cubicBezTo>
                      <a:pt x="414" y="19"/>
                      <a:pt x="421" y="23"/>
                      <a:pt x="438" y="41"/>
                    </a:cubicBezTo>
                    <a:cubicBezTo>
                      <a:pt x="455" y="59"/>
                      <a:pt x="476" y="95"/>
                      <a:pt x="479" y="105"/>
                    </a:cubicBezTo>
                    <a:cubicBezTo>
                      <a:pt x="476" y="83"/>
                      <a:pt x="470" y="53"/>
                      <a:pt x="505" y="46"/>
                    </a:cubicBezTo>
                    <a:cubicBezTo>
                      <a:pt x="497" y="45"/>
                      <a:pt x="472" y="28"/>
                      <a:pt x="468" y="8"/>
                    </a:cubicBezTo>
                    <a:cubicBezTo>
                      <a:pt x="472" y="23"/>
                      <a:pt x="474" y="44"/>
                      <a:pt x="464" y="46"/>
                    </a:cubicBezTo>
                    <a:cubicBezTo>
                      <a:pt x="454" y="48"/>
                      <a:pt x="452" y="0"/>
                      <a:pt x="417" y="3"/>
                    </a:cubicBezTo>
                    <a:cubicBezTo>
                      <a:pt x="382" y="6"/>
                      <a:pt x="370" y="12"/>
                      <a:pt x="346" y="26"/>
                    </a:cubicBezTo>
                    <a:cubicBezTo>
                      <a:pt x="322" y="40"/>
                      <a:pt x="281" y="65"/>
                      <a:pt x="216" y="55"/>
                    </a:cubicBezTo>
                    <a:cubicBezTo>
                      <a:pt x="151" y="45"/>
                      <a:pt x="135" y="45"/>
                      <a:pt x="116" y="57"/>
                    </a:cubicBezTo>
                    <a:cubicBezTo>
                      <a:pt x="97" y="69"/>
                      <a:pt x="83" y="51"/>
                      <a:pt x="57" y="68"/>
                    </a:cubicBezTo>
                    <a:cubicBezTo>
                      <a:pt x="31" y="85"/>
                      <a:pt x="0" y="106"/>
                      <a:pt x="0" y="106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6" name="Freeform 53"/>
              <p:cNvSpPr/>
              <p:nvPr/>
            </p:nvSpPr>
            <p:spPr bwMode="auto">
              <a:xfrm>
                <a:off x="821192" y="3785789"/>
                <a:ext cx="403066" cy="185462"/>
              </a:xfrm>
              <a:custGeom>
                <a:avLst/>
                <a:gdLst>
                  <a:gd name="T0" fmla="*/ 0 w 172"/>
                  <a:gd name="T1" fmla="*/ 444 h 68"/>
                  <a:gd name="T2" fmla="*/ 1188 w 172"/>
                  <a:gd name="T3" fmla="*/ 1226 h 68"/>
                  <a:gd name="T4" fmla="*/ 2458 w 172"/>
                  <a:gd name="T5" fmla="*/ 731 h 68"/>
                  <a:gd name="T6" fmla="*/ 2408 w 172"/>
                  <a:gd name="T7" fmla="*/ 0 h 68"/>
                  <a:gd name="T8" fmla="*/ 0 60000 65536"/>
                  <a:gd name="T9" fmla="*/ 0 60000 65536"/>
                  <a:gd name="T10" fmla="*/ 0 60000 65536"/>
                  <a:gd name="T11" fmla="*/ 0 60000 65536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0" t="0" r="r" b="b"/>
                <a:pathLst>
                  <a:path w="172" h="68">
                    <a:moveTo>
                      <a:pt x="0" y="23"/>
                    </a:moveTo>
                    <a:cubicBezTo>
                      <a:pt x="2" y="57"/>
                      <a:pt x="29" y="68"/>
                      <a:pt x="76" y="64"/>
                    </a:cubicBezTo>
                    <a:cubicBezTo>
                      <a:pt x="123" y="60"/>
                      <a:pt x="157" y="38"/>
                      <a:pt x="157" y="38"/>
                    </a:cubicBezTo>
                    <a:cubicBezTo>
                      <a:pt x="157" y="38"/>
                      <a:pt x="172" y="2"/>
                      <a:pt x="154" y="0"/>
                    </a:cubicBezTo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7" name="Freeform 54"/>
              <p:cNvSpPr/>
              <p:nvPr/>
            </p:nvSpPr>
            <p:spPr bwMode="auto">
              <a:xfrm>
                <a:off x="880246" y="3848968"/>
                <a:ext cx="304643" cy="143682"/>
              </a:xfrm>
              <a:custGeom>
                <a:avLst/>
                <a:gdLst>
                  <a:gd name="T0" fmla="*/ 0 w 130"/>
                  <a:gd name="T1" fmla="*/ 431 h 53"/>
                  <a:gd name="T2" fmla="*/ 2033 w 130"/>
                  <a:gd name="T3" fmla="*/ 0 h 5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130" h="53">
                    <a:moveTo>
                      <a:pt x="0" y="23"/>
                    </a:moveTo>
                    <a:cubicBezTo>
                      <a:pt x="29" y="36"/>
                      <a:pt x="116" y="53"/>
                      <a:pt x="130" y="0"/>
                    </a:cubicBezTo>
                  </a:path>
                </a:pathLst>
              </a:custGeom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8" name="Freeform 55"/>
              <p:cNvSpPr/>
              <p:nvPr/>
            </p:nvSpPr>
            <p:spPr bwMode="auto">
              <a:xfrm>
                <a:off x="791196" y="3702229"/>
                <a:ext cx="403066" cy="228261"/>
              </a:xfrm>
              <a:custGeom>
                <a:avLst/>
                <a:gdLst>
                  <a:gd name="T0" fmla="*/ 188 w 172"/>
                  <a:gd name="T1" fmla="*/ 605 h 84"/>
                  <a:gd name="T2" fmla="*/ 1533 w 172"/>
                  <a:gd name="T3" fmla="*/ 1515 h 84"/>
                  <a:gd name="T4" fmla="*/ 2658 w 172"/>
                  <a:gd name="T5" fmla="*/ 683 h 84"/>
                  <a:gd name="T6" fmla="*/ 1438 w 172"/>
                  <a:gd name="T7" fmla="*/ 227 h 84"/>
                  <a:gd name="T8" fmla="*/ 188 w 172"/>
                  <a:gd name="T9" fmla="*/ 605 h 8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2" h="84">
                    <a:moveTo>
                      <a:pt x="12" y="32"/>
                    </a:moveTo>
                    <a:cubicBezTo>
                      <a:pt x="0" y="82"/>
                      <a:pt x="58" y="84"/>
                      <a:pt x="98" y="80"/>
                    </a:cubicBezTo>
                    <a:cubicBezTo>
                      <a:pt x="138" y="76"/>
                      <a:pt x="172" y="64"/>
                      <a:pt x="170" y="36"/>
                    </a:cubicBezTo>
                    <a:cubicBezTo>
                      <a:pt x="168" y="8"/>
                      <a:pt x="126" y="20"/>
                      <a:pt x="92" y="12"/>
                    </a:cubicBezTo>
                    <a:cubicBezTo>
                      <a:pt x="58" y="4"/>
                      <a:pt x="22" y="0"/>
                      <a:pt x="12" y="32"/>
                    </a:cubicBezTo>
                    <a:close/>
                  </a:path>
                </a:pathLst>
              </a:custGeom>
              <a:solidFill>
                <a:srgbClr val="8019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9" name="Freeform 56"/>
              <p:cNvSpPr/>
              <p:nvPr/>
            </p:nvSpPr>
            <p:spPr bwMode="auto">
              <a:xfrm>
                <a:off x="519361" y="3531034"/>
                <a:ext cx="703023" cy="377038"/>
              </a:xfrm>
              <a:custGeom>
                <a:avLst/>
                <a:gdLst>
                  <a:gd name="T0" fmla="*/ 113 w 300"/>
                  <a:gd name="T1" fmla="*/ 2622 h 139"/>
                  <a:gd name="T2" fmla="*/ 63 w 300"/>
                  <a:gd name="T3" fmla="*/ 1680 h 139"/>
                  <a:gd name="T4" fmla="*/ 270 w 300"/>
                  <a:gd name="T5" fmla="*/ 1360 h 139"/>
                  <a:gd name="T6" fmla="*/ 520 w 300"/>
                  <a:gd name="T7" fmla="*/ 921 h 139"/>
                  <a:gd name="T8" fmla="*/ 1238 w 300"/>
                  <a:gd name="T9" fmla="*/ 751 h 139"/>
                  <a:gd name="T10" fmla="*/ 1645 w 300"/>
                  <a:gd name="T11" fmla="*/ 170 h 139"/>
                  <a:gd name="T12" fmla="*/ 2363 w 300"/>
                  <a:gd name="T13" fmla="*/ 418 h 139"/>
                  <a:gd name="T14" fmla="*/ 3708 w 300"/>
                  <a:gd name="T15" fmla="*/ 737 h 139"/>
                  <a:gd name="T16" fmla="*/ 4688 w 300"/>
                  <a:gd name="T17" fmla="*/ 998 h 139"/>
                  <a:gd name="T18" fmla="*/ 3458 w 300"/>
                  <a:gd name="T19" fmla="*/ 886 h 139"/>
                  <a:gd name="T20" fmla="*/ 1833 w 300"/>
                  <a:gd name="T21" fmla="*/ 793 h 139"/>
                  <a:gd name="T22" fmla="*/ 750 w 300"/>
                  <a:gd name="T23" fmla="*/ 1416 h 139"/>
                  <a:gd name="T24" fmla="*/ 113 w 300"/>
                  <a:gd name="T25" fmla="*/ 2622 h 139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0" t="0" r="r" b="b"/>
                <a:pathLst>
                  <a:path w="300" h="139">
                    <a:moveTo>
                      <a:pt x="7" y="139"/>
                    </a:moveTo>
                    <a:cubicBezTo>
                      <a:pt x="15" y="115"/>
                      <a:pt x="8" y="99"/>
                      <a:pt x="4" y="89"/>
                    </a:cubicBezTo>
                    <a:cubicBezTo>
                      <a:pt x="0" y="79"/>
                      <a:pt x="4" y="80"/>
                      <a:pt x="17" y="72"/>
                    </a:cubicBezTo>
                    <a:cubicBezTo>
                      <a:pt x="30" y="64"/>
                      <a:pt x="25" y="57"/>
                      <a:pt x="33" y="49"/>
                    </a:cubicBezTo>
                    <a:cubicBezTo>
                      <a:pt x="41" y="41"/>
                      <a:pt x="50" y="54"/>
                      <a:pt x="79" y="40"/>
                    </a:cubicBezTo>
                    <a:cubicBezTo>
                      <a:pt x="108" y="26"/>
                      <a:pt x="94" y="18"/>
                      <a:pt x="105" y="9"/>
                    </a:cubicBezTo>
                    <a:cubicBezTo>
                      <a:pt x="116" y="0"/>
                      <a:pt x="125" y="9"/>
                      <a:pt x="151" y="22"/>
                    </a:cubicBezTo>
                    <a:cubicBezTo>
                      <a:pt x="177" y="35"/>
                      <a:pt x="206" y="37"/>
                      <a:pt x="237" y="39"/>
                    </a:cubicBezTo>
                    <a:cubicBezTo>
                      <a:pt x="268" y="41"/>
                      <a:pt x="291" y="51"/>
                      <a:pt x="300" y="53"/>
                    </a:cubicBezTo>
                    <a:cubicBezTo>
                      <a:pt x="276" y="48"/>
                      <a:pt x="253" y="46"/>
                      <a:pt x="221" y="47"/>
                    </a:cubicBezTo>
                    <a:cubicBezTo>
                      <a:pt x="189" y="48"/>
                      <a:pt x="146" y="27"/>
                      <a:pt x="117" y="42"/>
                    </a:cubicBezTo>
                    <a:cubicBezTo>
                      <a:pt x="88" y="57"/>
                      <a:pt x="78" y="59"/>
                      <a:pt x="48" y="75"/>
                    </a:cubicBezTo>
                    <a:cubicBezTo>
                      <a:pt x="18" y="91"/>
                      <a:pt x="26" y="116"/>
                      <a:pt x="7" y="139"/>
                    </a:cubicBezTo>
                    <a:close/>
                  </a:path>
                </a:pathLst>
              </a:custGeom>
              <a:solidFill>
                <a:schemeClr val="accent1">
                  <a:lumMod val="20000"/>
                  <a:lumOff val="8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0" name="Freeform 57"/>
              <p:cNvSpPr/>
              <p:nvPr/>
            </p:nvSpPr>
            <p:spPr bwMode="auto">
              <a:xfrm>
                <a:off x="539983" y="3585042"/>
                <a:ext cx="307455" cy="220109"/>
              </a:xfrm>
              <a:custGeom>
                <a:avLst/>
                <a:gdLst>
                  <a:gd name="T0" fmla="*/ 50 w 131"/>
                  <a:gd name="T1" fmla="*/ 1288 h 81"/>
                  <a:gd name="T2" fmla="*/ 83 w 131"/>
                  <a:gd name="T3" fmla="*/ 1536 h 81"/>
                  <a:gd name="T4" fmla="*/ 488 w 131"/>
                  <a:gd name="T5" fmla="*/ 989 h 81"/>
                  <a:gd name="T6" fmla="*/ 971 w 131"/>
                  <a:gd name="T7" fmla="*/ 704 h 81"/>
                  <a:gd name="T8" fmla="*/ 2056 w 131"/>
                  <a:gd name="T9" fmla="*/ 171 h 81"/>
                  <a:gd name="T10" fmla="*/ 1755 w 131"/>
                  <a:gd name="T11" fmla="*/ 21 h 81"/>
                  <a:gd name="T12" fmla="*/ 1585 w 131"/>
                  <a:gd name="T13" fmla="*/ 136 h 81"/>
                  <a:gd name="T14" fmla="*/ 992 w 131"/>
                  <a:gd name="T15" fmla="*/ 533 h 81"/>
                  <a:gd name="T16" fmla="*/ 709 w 131"/>
                  <a:gd name="T17" fmla="*/ 704 h 81"/>
                  <a:gd name="T18" fmla="*/ 426 w 131"/>
                  <a:gd name="T19" fmla="*/ 760 h 81"/>
                  <a:gd name="T20" fmla="*/ 238 w 131"/>
                  <a:gd name="T21" fmla="*/ 1059 h 81"/>
                  <a:gd name="T22" fmla="*/ 0 w 131"/>
                  <a:gd name="T23" fmla="*/ 1272 h 81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</a:gdLst>
                <a:ahLst/>
                <a:cxnLst>
                  <a:cxn ang="T24">
                    <a:pos x="T0" y="T1"/>
                  </a:cxn>
                  <a:cxn ang="T25">
                    <a:pos x="T2" y="T3"/>
                  </a:cxn>
                  <a:cxn ang="T26">
                    <a:pos x="T4" y="T5"/>
                  </a:cxn>
                  <a:cxn ang="T27">
                    <a:pos x="T6" y="T7"/>
                  </a:cxn>
                  <a:cxn ang="T28">
                    <a:pos x="T8" y="T9"/>
                  </a:cxn>
                  <a:cxn ang="T29">
                    <a:pos x="T10" y="T11"/>
                  </a:cxn>
                  <a:cxn ang="T30">
                    <a:pos x="T12" y="T13"/>
                  </a:cxn>
                  <a:cxn ang="T31">
                    <a:pos x="T14" y="T15"/>
                  </a:cxn>
                  <a:cxn ang="T32">
                    <a:pos x="T16" y="T17"/>
                  </a:cxn>
                  <a:cxn ang="T33">
                    <a:pos x="T18" y="T19"/>
                  </a:cxn>
                  <a:cxn ang="T34">
                    <a:pos x="T20" y="T21"/>
                  </a:cxn>
                  <a:cxn ang="T35">
                    <a:pos x="T22" y="T23"/>
                  </a:cxn>
                </a:cxnLst>
                <a:rect l="0" t="0" r="r" b="b"/>
                <a:pathLst>
                  <a:path w="131" h="81">
                    <a:moveTo>
                      <a:pt x="3" y="68"/>
                    </a:moveTo>
                    <a:cubicBezTo>
                      <a:pt x="4" y="72"/>
                      <a:pt x="5" y="77"/>
                      <a:pt x="5" y="81"/>
                    </a:cubicBezTo>
                    <a:cubicBezTo>
                      <a:pt x="14" y="70"/>
                      <a:pt x="18" y="60"/>
                      <a:pt x="31" y="52"/>
                    </a:cubicBezTo>
                    <a:cubicBezTo>
                      <a:pt x="41" y="46"/>
                      <a:pt x="52" y="42"/>
                      <a:pt x="62" y="37"/>
                    </a:cubicBezTo>
                    <a:cubicBezTo>
                      <a:pt x="84" y="27"/>
                      <a:pt x="106" y="9"/>
                      <a:pt x="131" y="9"/>
                    </a:cubicBezTo>
                    <a:cubicBezTo>
                      <a:pt x="125" y="7"/>
                      <a:pt x="118" y="2"/>
                      <a:pt x="112" y="1"/>
                    </a:cubicBezTo>
                    <a:cubicBezTo>
                      <a:pt x="104" y="0"/>
                      <a:pt x="106" y="1"/>
                      <a:pt x="101" y="7"/>
                    </a:cubicBezTo>
                    <a:cubicBezTo>
                      <a:pt x="91" y="18"/>
                      <a:pt x="76" y="21"/>
                      <a:pt x="63" y="28"/>
                    </a:cubicBezTo>
                    <a:cubicBezTo>
                      <a:pt x="57" y="31"/>
                      <a:pt x="52" y="36"/>
                      <a:pt x="45" y="37"/>
                    </a:cubicBezTo>
                    <a:cubicBezTo>
                      <a:pt x="38" y="38"/>
                      <a:pt x="34" y="35"/>
                      <a:pt x="27" y="40"/>
                    </a:cubicBezTo>
                    <a:cubicBezTo>
                      <a:pt x="22" y="44"/>
                      <a:pt x="20" y="51"/>
                      <a:pt x="15" y="56"/>
                    </a:cubicBezTo>
                    <a:cubicBezTo>
                      <a:pt x="11" y="60"/>
                      <a:pt x="5" y="63"/>
                      <a:pt x="0" y="67"/>
                    </a:cubicBezTo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1" name="Freeform 58"/>
              <p:cNvSpPr/>
              <p:nvPr/>
            </p:nvSpPr>
            <p:spPr bwMode="auto">
              <a:xfrm>
                <a:off x="655279" y="3829607"/>
                <a:ext cx="812694" cy="211956"/>
              </a:xfrm>
              <a:custGeom>
                <a:avLst/>
                <a:gdLst>
                  <a:gd name="T0" fmla="*/ 0 w 347"/>
                  <a:gd name="T1" fmla="*/ 1480 h 78"/>
                  <a:gd name="T2" fmla="*/ 842 w 347"/>
                  <a:gd name="T3" fmla="*/ 1024 h 78"/>
                  <a:gd name="T4" fmla="*/ 2946 w 347"/>
                  <a:gd name="T5" fmla="*/ 989 h 78"/>
                  <a:gd name="T6" fmla="*/ 4757 w 347"/>
                  <a:gd name="T7" fmla="*/ 248 h 78"/>
                  <a:gd name="T8" fmla="*/ 5412 w 347"/>
                  <a:gd name="T9" fmla="*/ 1045 h 78"/>
                  <a:gd name="T10" fmla="*/ 4745 w 347"/>
                  <a:gd name="T11" fmla="*/ 21 h 78"/>
                  <a:gd name="T12" fmla="*/ 3291 w 347"/>
                  <a:gd name="T13" fmla="*/ 589 h 78"/>
                  <a:gd name="T14" fmla="*/ 1229 w 347"/>
                  <a:gd name="T15" fmla="*/ 875 h 78"/>
                  <a:gd name="T16" fmla="*/ 0 w 347"/>
                  <a:gd name="T17" fmla="*/ 1480 h 78"/>
                  <a:gd name="T18" fmla="*/ 0 60000 65536"/>
                  <a:gd name="T19" fmla="*/ 0 60000 65536"/>
                  <a:gd name="T20" fmla="*/ 0 60000 65536"/>
                  <a:gd name="T21" fmla="*/ 0 60000 6553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</a:gdLst>
                <a:ahLst/>
                <a:cxnLst>
                  <a:cxn ang="T18">
                    <a:pos x="T0" y="T1"/>
                  </a:cxn>
                  <a:cxn ang="T19">
                    <a:pos x="T2" y="T3"/>
                  </a:cxn>
                  <a:cxn ang="T20">
                    <a:pos x="T4" y="T5"/>
                  </a:cxn>
                  <a:cxn ang="T21">
                    <a:pos x="T6" y="T7"/>
                  </a:cxn>
                  <a:cxn ang="T22">
                    <a:pos x="T8" y="T9"/>
                  </a:cxn>
                  <a:cxn ang="T23">
                    <a:pos x="T10" y="T11"/>
                  </a:cxn>
                  <a:cxn ang="T24">
                    <a:pos x="T12" y="T13"/>
                  </a:cxn>
                  <a:cxn ang="T25">
                    <a:pos x="T14" y="T15"/>
                  </a:cxn>
                  <a:cxn ang="T26">
                    <a:pos x="T16" y="T17"/>
                  </a:cxn>
                </a:cxnLst>
                <a:rect l="0" t="0" r="r" b="b"/>
                <a:pathLst>
                  <a:path w="347" h="78">
                    <a:moveTo>
                      <a:pt x="0" y="78"/>
                    </a:moveTo>
                    <a:cubicBezTo>
                      <a:pt x="19" y="59"/>
                      <a:pt x="24" y="47"/>
                      <a:pt x="54" y="54"/>
                    </a:cubicBezTo>
                    <a:cubicBezTo>
                      <a:pt x="84" y="61"/>
                      <a:pt x="124" y="72"/>
                      <a:pt x="189" y="52"/>
                    </a:cubicBezTo>
                    <a:cubicBezTo>
                      <a:pt x="254" y="32"/>
                      <a:pt x="282" y="7"/>
                      <a:pt x="305" y="13"/>
                    </a:cubicBezTo>
                    <a:cubicBezTo>
                      <a:pt x="328" y="19"/>
                      <a:pt x="341" y="45"/>
                      <a:pt x="347" y="55"/>
                    </a:cubicBezTo>
                    <a:cubicBezTo>
                      <a:pt x="343" y="34"/>
                      <a:pt x="317" y="2"/>
                      <a:pt x="304" y="1"/>
                    </a:cubicBezTo>
                    <a:cubicBezTo>
                      <a:pt x="291" y="0"/>
                      <a:pt x="240" y="18"/>
                      <a:pt x="211" y="31"/>
                    </a:cubicBezTo>
                    <a:cubicBezTo>
                      <a:pt x="182" y="44"/>
                      <a:pt x="109" y="54"/>
                      <a:pt x="79" y="46"/>
                    </a:cubicBezTo>
                    <a:cubicBezTo>
                      <a:pt x="49" y="38"/>
                      <a:pt x="16" y="46"/>
                      <a:pt x="0" y="78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2" name="Freeform 59"/>
              <p:cNvSpPr/>
              <p:nvPr/>
            </p:nvSpPr>
            <p:spPr bwMode="auto">
              <a:xfrm>
                <a:off x="828691" y="3710382"/>
                <a:ext cx="295269" cy="165081"/>
              </a:xfrm>
              <a:custGeom>
                <a:avLst/>
                <a:gdLst>
                  <a:gd name="T0" fmla="*/ 1970 w 126"/>
                  <a:gd name="T1" fmla="*/ 353 h 61"/>
                  <a:gd name="T2" fmla="*/ 1125 w 126"/>
                  <a:gd name="T3" fmla="*/ 247 h 61"/>
                  <a:gd name="T4" fmla="*/ 20 w 126"/>
                  <a:gd name="T5" fmla="*/ 656 h 61"/>
                  <a:gd name="T6" fmla="*/ 145 w 126"/>
                  <a:gd name="T7" fmla="*/ 1142 h 61"/>
                  <a:gd name="T8" fmla="*/ 583 w 126"/>
                  <a:gd name="T9" fmla="*/ 451 h 61"/>
                  <a:gd name="T10" fmla="*/ 1970 w 126"/>
                  <a:gd name="T11" fmla="*/ 353 h 61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0" t="0" r="r" b="b"/>
                <a:pathLst>
                  <a:path w="126" h="61">
                    <a:moveTo>
                      <a:pt x="126" y="19"/>
                    </a:moveTo>
                    <a:cubicBezTo>
                      <a:pt x="105" y="18"/>
                      <a:pt x="94" y="17"/>
                      <a:pt x="72" y="13"/>
                    </a:cubicBezTo>
                    <a:cubicBezTo>
                      <a:pt x="49" y="8"/>
                      <a:pt x="9" y="0"/>
                      <a:pt x="1" y="35"/>
                    </a:cubicBezTo>
                    <a:cubicBezTo>
                      <a:pt x="0" y="45"/>
                      <a:pt x="6" y="54"/>
                      <a:pt x="9" y="61"/>
                    </a:cubicBezTo>
                    <a:cubicBezTo>
                      <a:pt x="5" y="46"/>
                      <a:pt x="19" y="30"/>
                      <a:pt x="37" y="24"/>
                    </a:cubicBezTo>
                    <a:cubicBezTo>
                      <a:pt x="55" y="17"/>
                      <a:pt x="108" y="29"/>
                      <a:pt x="126" y="19"/>
                    </a:cubicBezTo>
                    <a:close/>
                  </a:path>
                </a:pathLst>
              </a:custGeom>
              <a:solidFill>
                <a:srgbClr val="B789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3" name="Freeform 60"/>
              <p:cNvSpPr/>
              <p:nvPr/>
            </p:nvSpPr>
            <p:spPr bwMode="auto">
              <a:xfrm>
                <a:off x="894306" y="3764390"/>
                <a:ext cx="290583" cy="154891"/>
              </a:xfrm>
              <a:custGeom>
                <a:avLst/>
                <a:gdLst>
                  <a:gd name="T0" fmla="*/ 0 w 124"/>
                  <a:gd name="T1" fmla="*/ 947 h 57"/>
                  <a:gd name="T2" fmla="*/ 1908 w 124"/>
                  <a:gd name="T3" fmla="*/ 264 h 57"/>
                  <a:gd name="T4" fmla="*/ 1708 w 124"/>
                  <a:gd name="T5" fmla="*/ 0 h 57"/>
                  <a:gd name="T6" fmla="*/ 1395 w 124"/>
                  <a:gd name="T7" fmla="*/ 605 h 57"/>
                  <a:gd name="T8" fmla="*/ 0 w 124"/>
                  <a:gd name="T9" fmla="*/ 947 h 5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24" h="57">
                    <a:moveTo>
                      <a:pt x="0" y="50"/>
                    </a:moveTo>
                    <a:cubicBezTo>
                      <a:pt x="35" y="57"/>
                      <a:pt x="118" y="55"/>
                      <a:pt x="122" y="14"/>
                    </a:cubicBezTo>
                    <a:cubicBezTo>
                      <a:pt x="124" y="3"/>
                      <a:pt x="109" y="0"/>
                      <a:pt x="109" y="0"/>
                    </a:cubicBezTo>
                    <a:cubicBezTo>
                      <a:pt x="116" y="8"/>
                      <a:pt x="119" y="18"/>
                      <a:pt x="89" y="32"/>
                    </a:cubicBezTo>
                    <a:cubicBezTo>
                      <a:pt x="60" y="45"/>
                      <a:pt x="8" y="50"/>
                      <a:pt x="0" y="50"/>
                    </a:cubicBezTo>
                    <a:close/>
                  </a:path>
                </a:pathLst>
              </a:custGeom>
              <a:solidFill>
                <a:srgbClr val="6B136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4" name="Freeform 61"/>
              <p:cNvSpPr/>
              <p:nvPr/>
            </p:nvSpPr>
            <p:spPr bwMode="auto">
              <a:xfrm>
                <a:off x="835253" y="3728724"/>
                <a:ext cx="119983" cy="89674"/>
              </a:xfrm>
              <a:custGeom>
                <a:avLst/>
                <a:gdLst>
                  <a:gd name="T0" fmla="*/ 806 w 51"/>
                  <a:gd name="T1" fmla="*/ 35 h 33"/>
                  <a:gd name="T2" fmla="*/ 0 w 51"/>
                  <a:gd name="T3" fmla="*/ 627 h 33"/>
                  <a:gd name="T4" fmla="*/ 806 w 51"/>
                  <a:gd name="T5" fmla="*/ 35 h 33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51" h="33">
                    <a:moveTo>
                      <a:pt x="51" y="2"/>
                    </a:moveTo>
                    <a:cubicBezTo>
                      <a:pt x="30" y="0"/>
                      <a:pt x="0" y="2"/>
                      <a:pt x="0" y="33"/>
                    </a:cubicBezTo>
                    <a:cubicBezTo>
                      <a:pt x="8" y="17"/>
                      <a:pt x="31" y="0"/>
                      <a:pt x="51" y="2"/>
                    </a:cubicBezTo>
                    <a:close/>
                  </a:path>
                </a:pathLst>
              </a:custGeom>
              <a:solidFill>
                <a:srgbClr val="E7DAE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5" name="Freeform 62"/>
              <p:cNvSpPr/>
              <p:nvPr/>
            </p:nvSpPr>
            <p:spPr bwMode="auto">
              <a:xfrm>
                <a:off x="844626" y="3604403"/>
                <a:ext cx="23434" cy="16304"/>
              </a:xfrm>
              <a:custGeom>
                <a:avLst/>
                <a:gdLst>
                  <a:gd name="T0" fmla="*/ 83 w 10"/>
                  <a:gd name="T1" fmla="*/ 0 h 6"/>
                  <a:gd name="T2" fmla="*/ 158 w 10"/>
                  <a:gd name="T3" fmla="*/ 115 h 6"/>
                  <a:gd name="T4" fmla="*/ 95 w 10"/>
                  <a:gd name="T5" fmla="*/ 21 h 6"/>
                  <a:gd name="T6" fmla="*/ 0 60000 65536"/>
                  <a:gd name="T7" fmla="*/ 0 60000 65536"/>
                  <a:gd name="T8" fmla="*/ 0 60000 6553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0" t="0" r="r" b="b"/>
                <a:pathLst>
                  <a:path w="10" h="6">
                    <a:moveTo>
                      <a:pt x="5" y="0"/>
                    </a:moveTo>
                    <a:cubicBezTo>
                      <a:pt x="0" y="4"/>
                      <a:pt x="6" y="6"/>
                      <a:pt x="10" y="6"/>
                    </a:cubicBezTo>
                    <a:cubicBezTo>
                      <a:pt x="10" y="4"/>
                      <a:pt x="8" y="2"/>
                      <a:pt x="6" y="1"/>
                    </a:cubicBezTo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6" name="Freeform 63"/>
              <p:cNvSpPr/>
              <p:nvPr/>
            </p:nvSpPr>
            <p:spPr bwMode="auto">
              <a:xfrm>
                <a:off x="214718" y="3384295"/>
                <a:ext cx="1485721" cy="874320"/>
              </a:xfrm>
              <a:custGeom>
                <a:avLst/>
                <a:gdLst>
                  <a:gd name="T0" fmla="*/ 3113 w 634"/>
                  <a:gd name="T1" fmla="*/ 0 h 322"/>
                  <a:gd name="T2" fmla="*/ 3470 w 634"/>
                  <a:gd name="T3" fmla="*/ 1386 h 322"/>
                  <a:gd name="T4" fmla="*/ 2675 w 634"/>
                  <a:gd name="T5" fmla="*/ 1740 h 322"/>
                  <a:gd name="T6" fmla="*/ 2020 w 634"/>
                  <a:gd name="T7" fmla="*/ 1100 h 322"/>
                  <a:gd name="T8" fmla="*/ 2050 w 634"/>
                  <a:gd name="T9" fmla="*/ 2363 h 322"/>
                  <a:gd name="T10" fmla="*/ 675 w 634"/>
                  <a:gd name="T11" fmla="*/ 2401 h 322"/>
                  <a:gd name="T12" fmla="*/ 1908 w 634"/>
                  <a:gd name="T13" fmla="*/ 2726 h 322"/>
                  <a:gd name="T14" fmla="*/ 1425 w 634"/>
                  <a:gd name="T15" fmla="*/ 4522 h 322"/>
                  <a:gd name="T16" fmla="*/ 0 w 634"/>
                  <a:gd name="T17" fmla="*/ 5788 h 322"/>
                  <a:gd name="T18" fmla="*/ 2125 w 634"/>
                  <a:gd name="T19" fmla="*/ 4487 h 322"/>
                  <a:gd name="T20" fmla="*/ 2583 w 634"/>
                  <a:gd name="T21" fmla="*/ 6091 h 322"/>
                  <a:gd name="T22" fmla="*/ 3720 w 634"/>
                  <a:gd name="T23" fmla="*/ 4274 h 322"/>
                  <a:gd name="T24" fmla="*/ 6083 w 634"/>
                  <a:gd name="T25" fmla="*/ 4218 h 322"/>
                  <a:gd name="T26" fmla="*/ 7720 w 634"/>
                  <a:gd name="T27" fmla="*/ 3579 h 322"/>
                  <a:gd name="T28" fmla="*/ 8863 w 634"/>
                  <a:gd name="T29" fmla="*/ 5468 h 322"/>
                  <a:gd name="T30" fmla="*/ 9908 w 634"/>
                  <a:gd name="T31" fmla="*/ 3805 h 322"/>
                  <a:gd name="T32" fmla="*/ 8625 w 634"/>
                  <a:gd name="T33" fmla="*/ 3080 h 322"/>
                  <a:gd name="T34" fmla="*/ 9533 w 634"/>
                  <a:gd name="T35" fmla="*/ 661 h 322"/>
                  <a:gd name="T36" fmla="*/ 8595 w 634"/>
                  <a:gd name="T37" fmla="*/ 1386 h 322"/>
                  <a:gd name="T38" fmla="*/ 7908 w 634"/>
                  <a:gd name="T39" fmla="*/ 1966 h 322"/>
                  <a:gd name="T40" fmla="*/ 6113 w 634"/>
                  <a:gd name="T41" fmla="*/ 1740 h 322"/>
                  <a:gd name="T42" fmla="*/ 3988 w 634"/>
                  <a:gd name="T43" fmla="*/ 930 h 322"/>
                  <a:gd name="T44" fmla="*/ 3113 w 634"/>
                  <a:gd name="T45" fmla="*/ 0 h 322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  <a:gd name="T51" fmla="*/ 0 60000 65536"/>
                  <a:gd name="T52" fmla="*/ 0 60000 65536"/>
                  <a:gd name="T53" fmla="*/ 0 60000 65536"/>
                  <a:gd name="T54" fmla="*/ 0 60000 65536"/>
                  <a:gd name="T55" fmla="*/ 0 60000 65536"/>
                  <a:gd name="T56" fmla="*/ 0 60000 65536"/>
                  <a:gd name="T57" fmla="*/ 0 60000 65536"/>
                  <a:gd name="T58" fmla="*/ 0 60000 65536"/>
                  <a:gd name="T59" fmla="*/ 0 60000 65536"/>
                  <a:gd name="T60" fmla="*/ 0 60000 65536"/>
                  <a:gd name="T61" fmla="*/ 0 60000 65536"/>
                  <a:gd name="T62" fmla="*/ 0 60000 65536"/>
                  <a:gd name="T63" fmla="*/ 0 60000 65536"/>
                  <a:gd name="T64" fmla="*/ 0 60000 65536"/>
                  <a:gd name="T65" fmla="*/ 0 60000 65536"/>
                  <a:gd name="T66" fmla="*/ 0 60000 65536"/>
                  <a:gd name="T67" fmla="*/ 0 60000 65536"/>
                  <a:gd name="T68" fmla="*/ 0 60000 65536"/>
                </a:gdLst>
                <a:ahLst/>
                <a:cxnLst>
                  <a:cxn ang="T46">
                    <a:pos x="T0" y="T1"/>
                  </a:cxn>
                  <a:cxn ang="T47">
                    <a:pos x="T2" y="T3"/>
                  </a:cxn>
                  <a:cxn ang="T48">
                    <a:pos x="T4" y="T5"/>
                  </a:cxn>
                  <a:cxn ang="T49">
                    <a:pos x="T6" y="T7"/>
                  </a:cxn>
                  <a:cxn ang="T50">
                    <a:pos x="T8" y="T9"/>
                  </a:cxn>
                  <a:cxn ang="T51">
                    <a:pos x="T10" y="T11"/>
                  </a:cxn>
                  <a:cxn ang="T52">
                    <a:pos x="T12" y="T13"/>
                  </a:cxn>
                  <a:cxn ang="T53">
                    <a:pos x="T14" y="T15"/>
                  </a:cxn>
                  <a:cxn ang="T54">
                    <a:pos x="T16" y="T17"/>
                  </a:cxn>
                  <a:cxn ang="T55">
                    <a:pos x="T18" y="T19"/>
                  </a:cxn>
                  <a:cxn ang="T56">
                    <a:pos x="T20" y="T21"/>
                  </a:cxn>
                  <a:cxn ang="T57">
                    <a:pos x="T22" y="T23"/>
                  </a:cxn>
                  <a:cxn ang="T58">
                    <a:pos x="T24" y="T25"/>
                  </a:cxn>
                  <a:cxn ang="T59">
                    <a:pos x="T26" y="T27"/>
                  </a:cxn>
                  <a:cxn ang="T60">
                    <a:pos x="T28" y="T29"/>
                  </a:cxn>
                  <a:cxn ang="T61">
                    <a:pos x="T30" y="T31"/>
                  </a:cxn>
                  <a:cxn ang="T62">
                    <a:pos x="T32" y="T33"/>
                  </a:cxn>
                  <a:cxn ang="T63">
                    <a:pos x="T34" y="T35"/>
                  </a:cxn>
                  <a:cxn ang="T64">
                    <a:pos x="T36" y="T37"/>
                  </a:cxn>
                  <a:cxn ang="T65">
                    <a:pos x="T38" y="T39"/>
                  </a:cxn>
                  <a:cxn ang="T66">
                    <a:pos x="T40" y="T41"/>
                  </a:cxn>
                  <a:cxn ang="T67">
                    <a:pos x="T42" y="T43"/>
                  </a:cxn>
                  <a:cxn ang="T68">
                    <a:pos x="T44" y="T45"/>
                  </a:cxn>
                </a:cxnLst>
                <a:rect l="0" t="0" r="r" b="b"/>
                <a:pathLst>
                  <a:path w="634" h="322">
                    <a:moveTo>
                      <a:pt x="199" y="0"/>
                    </a:moveTo>
                    <a:cubicBezTo>
                      <a:pt x="212" y="13"/>
                      <a:pt x="239" y="31"/>
                      <a:pt x="222" y="73"/>
                    </a:cubicBezTo>
                    <a:cubicBezTo>
                      <a:pt x="217" y="88"/>
                      <a:pt x="194" y="98"/>
                      <a:pt x="171" y="92"/>
                    </a:cubicBezTo>
                    <a:cubicBezTo>
                      <a:pt x="153" y="87"/>
                      <a:pt x="134" y="68"/>
                      <a:pt x="129" y="58"/>
                    </a:cubicBezTo>
                    <a:cubicBezTo>
                      <a:pt x="140" y="76"/>
                      <a:pt x="168" y="118"/>
                      <a:pt x="131" y="125"/>
                    </a:cubicBezTo>
                    <a:cubicBezTo>
                      <a:pt x="105" y="130"/>
                      <a:pt x="67" y="150"/>
                      <a:pt x="43" y="127"/>
                    </a:cubicBezTo>
                    <a:cubicBezTo>
                      <a:pt x="51" y="159"/>
                      <a:pt x="113" y="133"/>
                      <a:pt x="122" y="144"/>
                    </a:cubicBezTo>
                    <a:cubicBezTo>
                      <a:pt x="153" y="177"/>
                      <a:pt x="118" y="224"/>
                      <a:pt x="91" y="239"/>
                    </a:cubicBezTo>
                    <a:cubicBezTo>
                      <a:pt x="56" y="258"/>
                      <a:pt x="29" y="278"/>
                      <a:pt x="0" y="306"/>
                    </a:cubicBezTo>
                    <a:cubicBezTo>
                      <a:pt x="35" y="276"/>
                      <a:pt x="94" y="259"/>
                      <a:pt x="136" y="237"/>
                    </a:cubicBezTo>
                    <a:cubicBezTo>
                      <a:pt x="194" y="206"/>
                      <a:pt x="164" y="286"/>
                      <a:pt x="165" y="322"/>
                    </a:cubicBezTo>
                    <a:cubicBezTo>
                      <a:pt x="166" y="297"/>
                      <a:pt x="205" y="213"/>
                      <a:pt x="238" y="226"/>
                    </a:cubicBezTo>
                    <a:cubicBezTo>
                      <a:pt x="280" y="241"/>
                      <a:pt x="351" y="234"/>
                      <a:pt x="389" y="223"/>
                    </a:cubicBezTo>
                    <a:cubicBezTo>
                      <a:pt x="427" y="212"/>
                      <a:pt x="464" y="179"/>
                      <a:pt x="494" y="189"/>
                    </a:cubicBezTo>
                    <a:cubicBezTo>
                      <a:pt x="524" y="199"/>
                      <a:pt x="547" y="252"/>
                      <a:pt x="567" y="289"/>
                    </a:cubicBezTo>
                    <a:cubicBezTo>
                      <a:pt x="538" y="197"/>
                      <a:pt x="573" y="197"/>
                      <a:pt x="634" y="201"/>
                    </a:cubicBezTo>
                    <a:cubicBezTo>
                      <a:pt x="602" y="184"/>
                      <a:pt x="573" y="196"/>
                      <a:pt x="552" y="163"/>
                    </a:cubicBezTo>
                    <a:cubicBezTo>
                      <a:pt x="519" y="110"/>
                      <a:pt x="576" y="49"/>
                      <a:pt x="610" y="35"/>
                    </a:cubicBezTo>
                    <a:cubicBezTo>
                      <a:pt x="585" y="43"/>
                      <a:pt x="569" y="56"/>
                      <a:pt x="550" y="73"/>
                    </a:cubicBezTo>
                    <a:cubicBezTo>
                      <a:pt x="536" y="85"/>
                      <a:pt x="524" y="98"/>
                      <a:pt x="506" y="104"/>
                    </a:cubicBezTo>
                    <a:cubicBezTo>
                      <a:pt x="472" y="115"/>
                      <a:pt x="425" y="98"/>
                      <a:pt x="391" y="92"/>
                    </a:cubicBezTo>
                    <a:cubicBezTo>
                      <a:pt x="339" y="82"/>
                      <a:pt x="293" y="86"/>
                      <a:pt x="255" y="49"/>
                    </a:cubicBezTo>
                    <a:cubicBezTo>
                      <a:pt x="237" y="33"/>
                      <a:pt x="233" y="20"/>
                      <a:pt x="199" y="0"/>
                    </a:cubicBezTo>
                    <a:close/>
                  </a:path>
                </a:pathLst>
              </a:custGeom>
              <a:noFill/>
              <a:ln w="11113" cap="rnd">
                <a:solidFill>
                  <a:srgbClr val="000000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7" name="Freeform 64"/>
              <p:cNvSpPr/>
              <p:nvPr/>
            </p:nvSpPr>
            <p:spPr bwMode="auto">
              <a:xfrm>
                <a:off x="791196" y="3702229"/>
                <a:ext cx="403066" cy="228261"/>
              </a:xfrm>
              <a:custGeom>
                <a:avLst/>
                <a:gdLst>
                  <a:gd name="T0" fmla="*/ 188 w 172"/>
                  <a:gd name="T1" fmla="*/ 605 h 84"/>
                  <a:gd name="T2" fmla="*/ 1533 w 172"/>
                  <a:gd name="T3" fmla="*/ 1515 h 84"/>
                  <a:gd name="T4" fmla="*/ 2658 w 172"/>
                  <a:gd name="T5" fmla="*/ 683 h 84"/>
                  <a:gd name="T6" fmla="*/ 1438 w 172"/>
                  <a:gd name="T7" fmla="*/ 227 h 84"/>
                  <a:gd name="T8" fmla="*/ 188 w 172"/>
                  <a:gd name="T9" fmla="*/ 605 h 8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0" t="0" r="r" b="b"/>
                <a:pathLst>
                  <a:path w="172" h="84">
                    <a:moveTo>
                      <a:pt x="12" y="32"/>
                    </a:moveTo>
                    <a:cubicBezTo>
                      <a:pt x="0" y="82"/>
                      <a:pt x="58" y="84"/>
                      <a:pt x="98" y="80"/>
                    </a:cubicBezTo>
                    <a:cubicBezTo>
                      <a:pt x="138" y="76"/>
                      <a:pt x="172" y="64"/>
                      <a:pt x="170" y="36"/>
                    </a:cubicBezTo>
                    <a:cubicBezTo>
                      <a:pt x="168" y="8"/>
                      <a:pt x="126" y="20"/>
                      <a:pt x="92" y="12"/>
                    </a:cubicBezTo>
                    <a:cubicBezTo>
                      <a:pt x="58" y="4"/>
                      <a:pt x="22" y="0"/>
                      <a:pt x="12" y="32"/>
                    </a:cubicBezTo>
                    <a:close/>
                  </a:path>
                </a:pathLst>
              </a:custGeom>
              <a:noFill/>
              <a:ln w="11113" cap="rnd">
                <a:solidFill>
                  <a:srgbClr val="000000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8" name="Freeform 65"/>
              <p:cNvSpPr/>
              <p:nvPr/>
            </p:nvSpPr>
            <p:spPr bwMode="auto">
              <a:xfrm>
                <a:off x="586851" y="3351686"/>
                <a:ext cx="98423" cy="34647"/>
              </a:xfrm>
              <a:custGeom>
                <a:avLst/>
                <a:gdLst>
                  <a:gd name="T0" fmla="*/ 0 w 42"/>
                  <a:gd name="T1" fmla="*/ 0 h 13"/>
                  <a:gd name="T2" fmla="*/ 658 w 42"/>
                  <a:gd name="T3" fmla="*/ 233 h 13"/>
                  <a:gd name="T4" fmla="*/ 0 60000 65536"/>
                  <a:gd name="T5" fmla="*/ 0 60000 65536"/>
                </a:gdLst>
                <a:ahLst/>
                <a:cxnLst>
                  <a:cxn ang="T4">
                    <a:pos x="T0" y="T1"/>
                  </a:cxn>
                  <a:cxn ang="T5">
                    <a:pos x="T2" y="T3"/>
                  </a:cxn>
                </a:cxnLst>
                <a:rect l="0" t="0" r="r" b="b"/>
                <a:pathLst>
                  <a:path w="42" h="13">
                    <a:moveTo>
                      <a:pt x="0" y="0"/>
                    </a:moveTo>
                    <a:cubicBezTo>
                      <a:pt x="16" y="1"/>
                      <a:pt x="33" y="5"/>
                      <a:pt x="42" y="13"/>
                    </a:cubicBezTo>
                  </a:path>
                </a:pathLst>
              </a:custGeom>
              <a:noFill/>
              <a:ln w="11113" cap="rnd">
                <a:solidFill>
                  <a:srgbClr val="000000"/>
                </a:solidFill>
                <a:prstDash val="solid"/>
                <a:rou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79" name="Oval 66"/>
              <p:cNvSpPr>
                <a:spLocks noChangeArrowheads="1"/>
              </p:cNvSpPr>
              <p:nvPr/>
            </p:nvSpPr>
            <p:spPr bwMode="auto">
              <a:xfrm>
                <a:off x="821192" y="3715477"/>
                <a:ext cx="35620" cy="40761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pPr eaLnBrk="1" hangingPunct="1"/>
                <a:endParaRPr lang="zh-CN"/>
              </a:p>
            </p:txBody>
          </p:sp>
          <p:sp>
            <p:nvSpPr>
              <p:cNvPr id="280" name="Oval 67"/>
              <p:cNvSpPr>
                <a:spLocks noChangeArrowheads="1"/>
              </p:cNvSpPr>
              <p:nvPr/>
            </p:nvSpPr>
            <p:spPr bwMode="auto">
              <a:xfrm>
                <a:off x="863373" y="3710382"/>
                <a:ext cx="18747" cy="21399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pPr eaLnBrk="1" hangingPunct="1"/>
                <a:endParaRPr lang="zh-CN"/>
              </a:p>
            </p:txBody>
          </p:sp>
          <p:sp>
            <p:nvSpPr>
              <p:cNvPr id="281" name="Oval 68"/>
              <p:cNvSpPr>
                <a:spLocks noChangeArrowheads="1"/>
              </p:cNvSpPr>
              <p:nvPr/>
            </p:nvSpPr>
            <p:spPr bwMode="auto">
              <a:xfrm>
                <a:off x="811818" y="3759295"/>
                <a:ext cx="18747" cy="24457"/>
              </a:xfrm>
              <a:prstGeom prst="ellipse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/>
              <a:lstStyle/>
              <a:p>
                <a:pPr eaLnBrk="1" hangingPunct="1"/>
                <a:endParaRPr lang="zh-CN"/>
              </a:p>
            </p:txBody>
          </p:sp>
        </p:grpSp>
        <p:sp>
          <p:nvSpPr>
            <p:cNvPr id="283" name="TextBox 26"/>
            <p:cNvSpPr txBox="1"/>
            <p:nvPr/>
          </p:nvSpPr>
          <p:spPr>
            <a:xfrm>
              <a:off x="2865" y="8008"/>
              <a:ext cx="3562" cy="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rfectly </a:t>
              </a:r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enotypic</a:t>
              </a:r>
              <a:endParaRPr lang="en-US" altLang="zh-CN" dirty="0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one cell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 rot="0">
              <a:off x="3362" y="3860"/>
              <a:ext cx="1435" cy="1589"/>
              <a:chOff x="-171" y="3538"/>
              <a:chExt cx="1435" cy="1589"/>
            </a:xfrm>
          </p:grpSpPr>
          <p:sp>
            <p:nvSpPr>
              <p:cNvPr id="9" name="同侧圆角矩形 16"/>
              <p:cNvSpPr/>
              <p:nvPr/>
            </p:nvSpPr>
            <p:spPr>
              <a:xfrm flipV="1">
                <a:off x="70" y="4407"/>
                <a:ext cx="1123" cy="666"/>
              </a:xfrm>
              <a:prstGeom prst="round2SameRect">
                <a:avLst>
                  <a:gd name="adj1" fmla="val 30111"/>
                  <a:gd name="adj2" fmla="val 0"/>
                </a:avLst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0" name="椭圆 9"/>
              <p:cNvSpPr/>
              <p:nvPr/>
            </p:nvSpPr>
            <p:spPr>
              <a:xfrm>
                <a:off x="70" y="4277"/>
                <a:ext cx="1123" cy="239"/>
              </a:xfrm>
              <a:prstGeom prst="ellipse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11" name="任意多边形 24"/>
              <p:cNvSpPr/>
              <p:nvPr/>
            </p:nvSpPr>
            <p:spPr>
              <a:xfrm flipV="1">
                <a:off x="-171" y="3673"/>
                <a:ext cx="1424" cy="1455"/>
              </a:xfrm>
              <a:custGeom>
                <a:avLst/>
                <a:gdLst>
                  <a:gd name="x2" fmla="*/ w 3 4"/>
                </a:gdLst>
                <a:ahLst/>
                <a:cxnLst>
                  <a:cxn ang="3">
                    <a:pos x="hc" y="t"/>
                  </a:cxn>
                  <a:cxn ang="cd2">
                    <a:pos x="wd4" y="vc"/>
                  </a:cxn>
                  <a:cxn ang="cd4">
                    <a:pos x="hc" y="b"/>
                  </a:cxn>
                  <a:cxn ang="0">
                    <a:pos x="x2" y="vc"/>
                  </a:cxn>
                </a:cxnLst>
                <a:rect l="l" t="t" r="r" b="b"/>
                <a:pathLst>
                  <a:path w="3335" h="3402">
                    <a:moveTo>
                      <a:pt x="927" y="0"/>
                    </a:moveTo>
                    <a:lnTo>
                      <a:pt x="2785" y="0"/>
                    </a:lnTo>
                    <a:cubicBezTo>
                      <a:pt x="3055" y="0"/>
                      <a:pt x="3273" y="219"/>
                      <a:pt x="3273" y="489"/>
                    </a:cubicBezTo>
                    <a:lnTo>
                      <a:pt x="3273" y="3137"/>
                    </a:lnTo>
                    <a:lnTo>
                      <a:pt x="3335" y="3402"/>
                    </a:lnTo>
                    <a:lnTo>
                      <a:pt x="3273" y="3402"/>
                    </a:lnTo>
                    <a:lnTo>
                      <a:pt x="2958" y="3402"/>
                    </a:lnTo>
                    <a:lnTo>
                      <a:pt x="439" y="3402"/>
                    </a:lnTo>
                    <a:lnTo>
                      <a:pt x="439" y="3377"/>
                    </a:lnTo>
                    <a:lnTo>
                      <a:pt x="426" y="3375"/>
                    </a:lnTo>
                    <a:cubicBezTo>
                      <a:pt x="293" y="3351"/>
                      <a:pt x="137" y="3267"/>
                      <a:pt x="0" y="3135"/>
                    </a:cubicBezTo>
                    <a:cubicBezTo>
                      <a:pt x="140" y="3130"/>
                      <a:pt x="259" y="3085"/>
                      <a:pt x="344" y="2997"/>
                    </a:cubicBezTo>
                    <a:cubicBezTo>
                      <a:pt x="386" y="2953"/>
                      <a:pt x="418" y="2901"/>
                      <a:pt x="439" y="2842"/>
                    </a:cubicBezTo>
                    <a:lnTo>
                      <a:pt x="439" y="2842"/>
                    </a:lnTo>
                    <a:lnTo>
                      <a:pt x="439" y="489"/>
                    </a:lnTo>
                    <a:cubicBezTo>
                      <a:pt x="439" y="219"/>
                      <a:pt x="658" y="0"/>
                      <a:pt x="927" y="0"/>
                    </a:cubicBezTo>
                    <a:close/>
                  </a:path>
                </a:pathLst>
              </a:custGeom>
              <a:gradFill>
                <a:gsLst>
                  <a:gs pos="20000">
                    <a:schemeClr val="bg1">
                      <a:alpha val="80000"/>
                      <a:lumMod val="99000"/>
                    </a:schemeClr>
                  </a:gs>
                  <a:gs pos="0">
                    <a:schemeClr val="accent1">
                      <a:lumMod val="20000"/>
                      <a:lumOff val="80000"/>
                      <a:alpha val="40000"/>
                    </a:schemeClr>
                  </a:gs>
                  <a:gs pos="85000">
                    <a:schemeClr val="accent1">
                      <a:lumMod val="45000"/>
                      <a:lumOff val="55000"/>
                      <a:alpha val="40000"/>
                    </a:schemeClr>
                  </a:gs>
                  <a:gs pos="100000">
                    <a:schemeClr val="accent1">
                      <a:lumMod val="60000"/>
                      <a:lumOff val="40000"/>
                      <a:alpha val="40000"/>
                    </a:schemeClr>
                  </a:gs>
                </a:gsLst>
                <a:lin ang="0" scaled="0"/>
              </a:gra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p>
                <a:pPr algn="ctr"/>
                <a:endParaRPr lang="zh-CN" altLang="en-US" dirty="0"/>
              </a:p>
            </p:txBody>
          </p:sp>
          <p:sp>
            <p:nvSpPr>
              <p:cNvPr id="12" name="任意多边形 7"/>
              <p:cNvSpPr/>
              <p:nvPr/>
            </p:nvSpPr>
            <p:spPr>
              <a:xfrm rot="16200000" flipV="1">
                <a:off x="430" y="2942"/>
                <a:ext cx="239" cy="1430"/>
              </a:xfrm>
              <a:custGeom>
                <a:avLst/>
                <a:gdLst>
                  <a:gd name="connsiteX0" fmla="*/ 0 w 560"/>
                  <a:gd name="connsiteY0" fmla="*/ 2647 h 2647"/>
                  <a:gd name="connsiteX1" fmla="*/ 173 w 560"/>
                  <a:gd name="connsiteY1" fmla="*/ 2253 h 2647"/>
                  <a:gd name="connsiteX2" fmla="*/ 41 w 560"/>
                  <a:gd name="connsiteY2" fmla="*/ 1204 h 2647"/>
                  <a:gd name="connsiteX3" fmla="*/ 301 w 560"/>
                  <a:gd name="connsiteY3" fmla="*/ 0 h 2647"/>
                  <a:gd name="connsiteX4" fmla="*/ 560 w 560"/>
                  <a:gd name="connsiteY4" fmla="*/ 1204 h 2647"/>
                  <a:gd name="connsiteX5" fmla="*/ 220 w 560"/>
                  <a:gd name="connsiteY5" fmla="*/ 2442 h 2647"/>
                  <a:gd name="connsiteX6" fmla="*/ 267 w 560"/>
                  <a:gd name="connsiteY6" fmla="*/ 2399 h 2647"/>
                  <a:gd name="connsiteX7" fmla="*/ 0 w 560"/>
                  <a:gd name="connsiteY7" fmla="*/ 2647 h 2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560" h="2647">
                    <a:moveTo>
                      <a:pt x="0" y="2647"/>
                    </a:moveTo>
                    <a:lnTo>
                      <a:pt x="173" y="2253"/>
                    </a:lnTo>
                    <a:cubicBezTo>
                      <a:pt x="94" y="2047"/>
                      <a:pt x="41" y="1654"/>
                      <a:pt x="41" y="1204"/>
                    </a:cubicBezTo>
                    <a:cubicBezTo>
                      <a:pt x="41" y="539"/>
                      <a:pt x="157" y="0"/>
                      <a:pt x="301" y="0"/>
                    </a:cubicBezTo>
                    <a:cubicBezTo>
                      <a:pt x="444" y="0"/>
                      <a:pt x="560" y="539"/>
                      <a:pt x="560" y="1204"/>
                    </a:cubicBezTo>
                    <a:cubicBezTo>
                      <a:pt x="560" y="1869"/>
                      <a:pt x="363" y="2442"/>
                      <a:pt x="220" y="2442"/>
                    </a:cubicBezTo>
                    <a:cubicBezTo>
                      <a:pt x="208" y="2442"/>
                      <a:pt x="278" y="2405"/>
                      <a:pt x="267" y="2399"/>
                    </a:cubicBezTo>
                    <a:lnTo>
                      <a:pt x="0" y="2647"/>
                    </a:lnTo>
                    <a:close/>
                  </a:path>
                </a:pathLst>
              </a:custGeom>
              <a:solidFill>
                <a:schemeClr val="bg1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dirty="0"/>
              </a:p>
            </p:txBody>
          </p:sp>
        </p:grpSp>
        <p:grpSp>
          <p:nvGrpSpPr>
            <p:cNvPr id="16" name="组合 15"/>
            <p:cNvGrpSpPr/>
            <p:nvPr/>
          </p:nvGrpSpPr>
          <p:grpSpPr>
            <a:xfrm rot="0">
              <a:off x="3357" y="1175"/>
              <a:ext cx="1434" cy="1583"/>
              <a:chOff x="-171" y="1050"/>
              <a:chExt cx="1434" cy="1583"/>
            </a:xfrm>
          </p:grpSpPr>
          <p:sp>
            <p:nvSpPr>
              <p:cNvPr id="6" name="同侧圆角矩形 16"/>
              <p:cNvSpPr/>
              <p:nvPr/>
            </p:nvSpPr>
            <p:spPr>
              <a:xfrm flipV="1">
                <a:off x="69" y="1919"/>
                <a:ext cx="1123" cy="666"/>
              </a:xfrm>
              <a:prstGeom prst="round2SameRect">
                <a:avLst>
                  <a:gd name="adj1" fmla="val 30111"/>
                  <a:gd name="adj2" fmla="val 0"/>
                </a:avLst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7" name="椭圆 6"/>
              <p:cNvSpPr/>
              <p:nvPr/>
            </p:nvSpPr>
            <p:spPr>
              <a:xfrm>
                <a:off x="69" y="1789"/>
                <a:ext cx="1123" cy="239"/>
              </a:xfrm>
              <a:prstGeom prst="ellipse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8" name="任意多边形 24"/>
              <p:cNvSpPr/>
              <p:nvPr/>
            </p:nvSpPr>
            <p:spPr>
              <a:xfrm flipV="1">
                <a:off x="-171" y="1179"/>
                <a:ext cx="1424" cy="1455"/>
              </a:xfrm>
              <a:custGeom>
                <a:avLst/>
                <a:gdLst>
                  <a:gd name="x2" fmla="*/ w 3 4"/>
                </a:gdLst>
                <a:ahLst/>
                <a:cxnLst>
                  <a:cxn ang="3">
                    <a:pos x="hc" y="t"/>
                  </a:cxn>
                  <a:cxn ang="cd2">
                    <a:pos x="wd4" y="vc"/>
                  </a:cxn>
                  <a:cxn ang="cd4">
                    <a:pos x="hc" y="b"/>
                  </a:cxn>
                  <a:cxn ang="0">
                    <a:pos x="x2" y="vc"/>
                  </a:cxn>
                </a:cxnLst>
                <a:rect l="l" t="t" r="r" b="b"/>
                <a:pathLst>
                  <a:path w="3335" h="3402">
                    <a:moveTo>
                      <a:pt x="927" y="0"/>
                    </a:moveTo>
                    <a:lnTo>
                      <a:pt x="2785" y="0"/>
                    </a:lnTo>
                    <a:cubicBezTo>
                      <a:pt x="3055" y="0"/>
                      <a:pt x="3273" y="219"/>
                      <a:pt x="3273" y="489"/>
                    </a:cubicBezTo>
                    <a:lnTo>
                      <a:pt x="3273" y="3137"/>
                    </a:lnTo>
                    <a:lnTo>
                      <a:pt x="3335" y="3402"/>
                    </a:lnTo>
                    <a:lnTo>
                      <a:pt x="3273" y="3402"/>
                    </a:lnTo>
                    <a:lnTo>
                      <a:pt x="2958" y="3402"/>
                    </a:lnTo>
                    <a:lnTo>
                      <a:pt x="439" y="3402"/>
                    </a:lnTo>
                    <a:lnTo>
                      <a:pt x="439" y="3377"/>
                    </a:lnTo>
                    <a:lnTo>
                      <a:pt x="426" y="3375"/>
                    </a:lnTo>
                    <a:cubicBezTo>
                      <a:pt x="293" y="3351"/>
                      <a:pt x="137" y="3267"/>
                      <a:pt x="0" y="3135"/>
                    </a:cubicBezTo>
                    <a:cubicBezTo>
                      <a:pt x="140" y="3130"/>
                      <a:pt x="259" y="3085"/>
                      <a:pt x="344" y="2997"/>
                    </a:cubicBezTo>
                    <a:cubicBezTo>
                      <a:pt x="386" y="2953"/>
                      <a:pt x="418" y="2901"/>
                      <a:pt x="439" y="2842"/>
                    </a:cubicBezTo>
                    <a:lnTo>
                      <a:pt x="439" y="2842"/>
                    </a:lnTo>
                    <a:lnTo>
                      <a:pt x="439" y="489"/>
                    </a:lnTo>
                    <a:cubicBezTo>
                      <a:pt x="439" y="219"/>
                      <a:pt x="658" y="0"/>
                      <a:pt x="927" y="0"/>
                    </a:cubicBezTo>
                    <a:close/>
                  </a:path>
                </a:pathLst>
              </a:custGeom>
              <a:gradFill>
                <a:gsLst>
                  <a:gs pos="20000">
                    <a:schemeClr val="bg1">
                      <a:alpha val="80000"/>
                      <a:lumMod val="99000"/>
                    </a:schemeClr>
                  </a:gs>
                  <a:gs pos="0">
                    <a:schemeClr val="accent1">
                      <a:lumMod val="20000"/>
                      <a:lumOff val="80000"/>
                      <a:alpha val="40000"/>
                    </a:schemeClr>
                  </a:gs>
                  <a:gs pos="85000">
                    <a:schemeClr val="accent1">
                      <a:lumMod val="45000"/>
                      <a:lumOff val="55000"/>
                      <a:alpha val="40000"/>
                    </a:schemeClr>
                  </a:gs>
                  <a:gs pos="100000">
                    <a:schemeClr val="accent1">
                      <a:lumMod val="60000"/>
                      <a:lumOff val="40000"/>
                      <a:alpha val="40000"/>
                    </a:schemeClr>
                  </a:gs>
                </a:gsLst>
                <a:lin ang="0" scaled="0"/>
              </a:gra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p>
                <a:pPr algn="ctr"/>
                <a:endParaRPr lang="zh-CN" altLang="en-US" dirty="0"/>
              </a:p>
            </p:txBody>
          </p:sp>
          <p:sp>
            <p:nvSpPr>
              <p:cNvPr id="14" name="任意多边形 7"/>
              <p:cNvSpPr/>
              <p:nvPr/>
            </p:nvSpPr>
            <p:spPr>
              <a:xfrm rot="16200000" flipV="1">
                <a:off x="429" y="454"/>
                <a:ext cx="239" cy="1430"/>
              </a:xfrm>
              <a:custGeom>
                <a:avLst/>
                <a:gdLst>
                  <a:gd name="connsiteX0" fmla="*/ 0 w 560"/>
                  <a:gd name="connsiteY0" fmla="*/ 2647 h 2647"/>
                  <a:gd name="connsiteX1" fmla="*/ 173 w 560"/>
                  <a:gd name="connsiteY1" fmla="*/ 2253 h 2647"/>
                  <a:gd name="connsiteX2" fmla="*/ 41 w 560"/>
                  <a:gd name="connsiteY2" fmla="*/ 1204 h 2647"/>
                  <a:gd name="connsiteX3" fmla="*/ 301 w 560"/>
                  <a:gd name="connsiteY3" fmla="*/ 0 h 2647"/>
                  <a:gd name="connsiteX4" fmla="*/ 560 w 560"/>
                  <a:gd name="connsiteY4" fmla="*/ 1204 h 2647"/>
                  <a:gd name="connsiteX5" fmla="*/ 220 w 560"/>
                  <a:gd name="connsiteY5" fmla="*/ 2442 h 2647"/>
                  <a:gd name="connsiteX6" fmla="*/ 267 w 560"/>
                  <a:gd name="connsiteY6" fmla="*/ 2399 h 2647"/>
                  <a:gd name="connsiteX7" fmla="*/ 0 w 560"/>
                  <a:gd name="connsiteY7" fmla="*/ 2647 h 264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560" h="2647">
                    <a:moveTo>
                      <a:pt x="0" y="2647"/>
                    </a:moveTo>
                    <a:lnTo>
                      <a:pt x="173" y="2253"/>
                    </a:lnTo>
                    <a:cubicBezTo>
                      <a:pt x="94" y="2047"/>
                      <a:pt x="41" y="1654"/>
                      <a:pt x="41" y="1204"/>
                    </a:cubicBezTo>
                    <a:cubicBezTo>
                      <a:pt x="41" y="539"/>
                      <a:pt x="157" y="0"/>
                      <a:pt x="301" y="0"/>
                    </a:cubicBezTo>
                    <a:cubicBezTo>
                      <a:pt x="444" y="0"/>
                      <a:pt x="560" y="539"/>
                      <a:pt x="560" y="1204"/>
                    </a:cubicBezTo>
                    <a:cubicBezTo>
                      <a:pt x="560" y="1869"/>
                      <a:pt x="363" y="2442"/>
                      <a:pt x="220" y="2442"/>
                    </a:cubicBezTo>
                    <a:cubicBezTo>
                      <a:pt x="208" y="2442"/>
                      <a:pt x="278" y="2405"/>
                      <a:pt x="267" y="2399"/>
                    </a:cubicBezTo>
                    <a:lnTo>
                      <a:pt x="0" y="2647"/>
                    </a:lnTo>
                    <a:close/>
                  </a:path>
                </a:pathLst>
              </a:custGeom>
              <a:solidFill>
                <a:schemeClr val="bg1"/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 dirty="0"/>
              </a:p>
            </p:txBody>
          </p:sp>
        </p:grpSp>
        <p:sp>
          <p:nvSpPr>
            <p:cNvPr id="25" name="TextBox 1034"/>
            <p:cNvSpPr txBox="1"/>
            <p:nvPr/>
          </p:nvSpPr>
          <p:spPr>
            <a:xfrm>
              <a:off x="3194" y="5450"/>
              <a:ext cx="1928" cy="1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SA/HFIP</a:t>
              </a:r>
              <a:endParaRPr lang="en-US" altLang="zh-CN" dirty="0" smtClean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dirty="0" smtClean="0">
                  <a:solidFill>
                    <a:schemeClr val="accent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lution</a:t>
              </a:r>
              <a:endParaRPr lang="zh-CN" altLang="en-US" dirty="0">
                <a:solidFill>
                  <a:schemeClr val="accent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任意多边形: 形状 58"/>
            <p:cNvSpPr/>
            <p:nvPr/>
          </p:nvSpPr>
          <p:spPr>
            <a:xfrm rot="5400000">
              <a:off x="12501" y="1343"/>
              <a:ext cx="401" cy="2640"/>
            </a:xfrm>
            <a:custGeom>
              <a:avLst/>
              <a:gdLst>
                <a:gd name="connsiteX0" fmla="*/ 233265 w 466530"/>
                <a:gd name="connsiteY0" fmla="*/ 0 h 1389148"/>
                <a:gd name="connsiteX1" fmla="*/ 466530 w 466530"/>
                <a:gd name="connsiteY1" fmla="*/ 550506 h 1389148"/>
                <a:gd name="connsiteX2" fmla="*/ 317241 w 466530"/>
                <a:gd name="connsiteY2" fmla="*/ 550506 h 1389148"/>
                <a:gd name="connsiteX3" fmla="*/ 393268 w 466530"/>
                <a:gd name="connsiteY3" fmla="*/ 1389148 h 1389148"/>
                <a:gd name="connsiteX4" fmla="*/ 233265 w 466530"/>
                <a:gd name="connsiteY4" fmla="*/ 1174978 h 1389148"/>
                <a:gd name="connsiteX5" fmla="*/ 73263 w 466530"/>
                <a:gd name="connsiteY5" fmla="*/ 1389148 h 1389148"/>
                <a:gd name="connsiteX6" fmla="*/ 149290 w 466530"/>
                <a:gd name="connsiteY6" fmla="*/ 550506 h 1389148"/>
                <a:gd name="connsiteX7" fmla="*/ 0 w 466530"/>
                <a:gd name="connsiteY7" fmla="*/ 550506 h 13891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66530" h="1389148">
                  <a:moveTo>
                    <a:pt x="233265" y="0"/>
                  </a:moveTo>
                  <a:lnTo>
                    <a:pt x="466530" y="550506"/>
                  </a:lnTo>
                  <a:lnTo>
                    <a:pt x="317241" y="550506"/>
                  </a:lnTo>
                  <a:lnTo>
                    <a:pt x="393268" y="1389148"/>
                  </a:lnTo>
                  <a:lnTo>
                    <a:pt x="233265" y="1174978"/>
                  </a:lnTo>
                  <a:lnTo>
                    <a:pt x="73263" y="1389148"/>
                  </a:lnTo>
                  <a:lnTo>
                    <a:pt x="149290" y="550506"/>
                  </a:lnTo>
                  <a:lnTo>
                    <a:pt x="0" y="550506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</a:schemeClr>
            </a:solidFill>
            <a:ln w="412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p>
              <a:pPr algn="ctr"/>
              <a:endParaRPr lang="zh-CN" altLang="en-US"/>
            </a:p>
          </p:txBody>
        </p:sp>
        <p:sp>
          <p:nvSpPr>
            <p:cNvPr id="53" name="任意多边形: 形状 58"/>
            <p:cNvSpPr/>
            <p:nvPr/>
          </p:nvSpPr>
          <p:spPr>
            <a:xfrm rot="6960000">
              <a:off x="5547" y="1579"/>
              <a:ext cx="401" cy="1633"/>
            </a:xfrm>
            <a:custGeom>
              <a:avLst/>
              <a:gdLst>
                <a:gd name="connsiteX0" fmla="*/ 233265 w 466530"/>
                <a:gd name="connsiteY0" fmla="*/ 0 h 1389148"/>
                <a:gd name="connsiteX1" fmla="*/ 466530 w 466530"/>
                <a:gd name="connsiteY1" fmla="*/ 550506 h 1389148"/>
                <a:gd name="connsiteX2" fmla="*/ 317241 w 466530"/>
                <a:gd name="connsiteY2" fmla="*/ 550506 h 1389148"/>
                <a:gd name="connsiteX3" fmla="*/ 393268 w 466530"/>
                <a:gd name="connsiteY3" fmla="*/ 1389148 h 1389148"/>
                <a:gd name="connsiteX4" fmla="*/ 233265 w 466530"/>
                <a:gd name="connsiteY4" fmla="*/ 1174978 h 1389148"/>
                <a:gd name="connsiteX5" fmla="*/ 73263 w 466530"/>
                <a:gd name="connsiteY5" fmla="*/ 1389148 h 1389148"/>
                <a:gd name="connsiteX6" fmla="*/ 149290 w 466530"/>
                <a:gd name="connsiteY6" fmla="*/ 550506 h 1389148"/>
                <a:gd name="connsiteX7" fmla="*/ 0 w 466530"/>
                <a:gd name="connsiteY7" fmla="*/ 550506 h 13891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66530" h="1389148">
                  <a:moveTo>
                    <a:pt x="233265" y="0"/>
                  </a:moveTo>
                  <a:lnTo>
                    <a:pt x="466530" y="550506"/>
                  </a:lnTo>
                  <a:lnTo>
                    <a:pt x="317241" y="550506"/>
                  </a:lnTo>
                  <a:lnTo>
                    <a:pt x="393268" y="1389148"/>
                  </a:lnTo>
                  <a:lnTo>
                    <a:pt x="233265" y="1174978"/>
                  </a:lnTo>
                  <a:lnTo>
                    <a:pt x="73263" y="1389148"/>
                  </a:lnTo>
                  <a:lnTo>
                    <a:pt x="149290" y="550506"/>
                  </a:lnTo>
                  <a:lnTo>
                    <a:pt x="0" y="550506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</a:schemeClr>
            </a:solidFill>
            <a:ln w="412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p>
              <a:pPr algn="ctr"/>
              <a:endParaRPr lang="zh-CN" altLang="en-US"/>
            </a:p>
          </p:txBody>
        </p:sp>
        <p:sp>
          <p:nvSpPr>
            <p:cNvPr id="54" name="任意多边形: 形状 58"/>
            <p:cNvSpPr/>
            <p:nvPr/>
          </p:nvSpPr>
          <p:spPr>
            <a:xfrm rot="3600000">
              <a:off x="5533" y="3575"/>
              <a:ext cx="401" cy="1633"/>
            </a:xfrm>
            <a:custGeom>
              <a:avLst/>
              <a:gdLst>
                <a:gd name="connsiteX0" fmla="*/ 233265 w 466530"/>
                <a:gd name="connsiteY0" fmla="*/ 0 h 1389148"/>
                <a:gd name="connsiteX1" fmla="*/ 466530 w 466530"/>
                <a:gd name="connsiteY1" fmla="*/ 550506 h 1389148"/>
                <a:gd name="connsiteX2" fmla="*/ 317241 w 466530"/>
                <a:gd name="connsiteY2" fmla="*/ 550506 h 1389148"/>
                <a:gd name="connsiteX3" fmla="*/ 393268 w 466530"/>
                <a:gd name="connsiteY3" fmla="*/ 1389148 h 1389148"/>
                <a:gd name="connsiteX4" fmla="*/ 233265 w 466530"/>
                <a:gd name="connsiteY4" fmla="*/ 1174978 h 1389148"/>
                <a:gd name="connsiteX5" fmla="*/ 73263 w 466530"/>
                <a:gd name="connsiteY5" fmla="*/ 1389148 h 1389148"/>
                <a:gd name="connsiteX6" fmla="*/ 149290 w 466530"/>
                <a:gd name="connsiteY6" fmla="*/ 550506 h 1389148"/>
                <a:gd name="connsiteX7" fmla="*/ 0 w 466530"/>
                <a:gd name="connsiteY7" fmla="*/ 550506 h 13891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66530" h="1389148">
                  <a:moveTo>
                    <a:pt x="233265" y="0"/>
                  </a:moveTo>
                  <a:lnTo>
                    <a:pt x="466530" y="550506"/>
                  </a:lnTo>
                  <a:lnTo>
                    <a:pt x="317241" y="550506"/>
                  </a:lnTo>
                  <a:lnTo>
                    <a:pt x="393268" y="1389148"/>
                  </a:lnTo>
                  <a:lnTo>
                    <a:pt x="233265" y="1174978"/>
                  </a:lnTo>
                  <a:lnTo>
                    <a:pt x="73263" y="1389148"/>
                  </a:lnTo>
                  <a:lnTo>
                    <a:pt x="149290" y="550506"/>
                  </a:lnTo>
                  <a:lnTo>
                    <a:pt x="0" y="550506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</a:schemeClr>
            </a:solidFill>
            <a:ln w="412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p>
              <a:pPr algn="ctr"/>
              <a:endParaRPr lang="zh-CN" altLang="en-US"/>
            </a:p>
          </p:txBody>
        </p:sp>
        <p:sp>
          <p:nvSpPr>
            <p:cNvPr id="55" name="任意多边形: 形状 58"/>
            <p:cNvSpPr/>
            <p:nvPr/>
          </p:nvSpPr>
          <p:spPr>
            <a:xfrm rot="3600000">
              <a:off x="8798" y="2388"/>
              <a:ext cx="401" cy="1633"/>
            </a:xfrm>
            <a:custGeom>
              <a:avLst/>
              <a:gdLst>
                <a:gd name="connsiteX0" fmla="*/ 233265 w 466530"/>
                <a:gd name="connsiteY0" fmla="*/ 0 h 1389148"/>
                <a:gd name="connsiteX1" fmla="*/ 466530 w 466530"/>
                <a:gd name="connsiteY1" fmla="*/ 550506 h 1389148"/>
                <a:gd name="connsiteX2" fmla="*/ 317241 w 466530"/>
                <a:gd name="connsiteY2" fmla="*/ 550506 h 1389148"/>
                <a:gd name="connsiteX3" fmla="*/ 393268 w 466530"/>
                <a:gd name="connsiteY3" fmla="*/ 1389148 h 1389148"/>
                <a:gd name="connsiteX4" fmla="*/ 233265 w 466530"/>
                <a:gd name="connsiteY4" fmla="*/ 1174978 h 1389148"/>
                <a:gd name="connsiteX5" fmla="*/ 73263 w 466530"/>
                <a:gd name="connsiteY5" fmla="*/ 1389148 h 1389148"/>
                <a:gd name="connsiteX6" fmla="*/ 149290 w 466530"/>
                <a:gd name="connsiteY6" fmla="*/ 550506 h 1389148"/>
                <a:gd name="connsiteX7" fmla="*/ 0 w 466530"/>
                <a:gd name="connsiteY7" fmla="*/ 550506 h 13891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66530" h="1389148">
                  <a:moveTo>
                    <a:pt x="233265" y="0"/>
                  </a:moveTo>
                  <a:lnTo>
                    <a:pt x="466530" y="550506"/>
                  </a:lnTo>
                  <a:lnTo>
                    <a:pt x="317241" y="550506"/>
                  </a:lnTo>
                  <a:lnTo>
                    <a:pt x="393268" y="1389148"/>
                  </a:lnTo>
                  <a:lnTo>
                    <a:pt x="233265" y="1174978"/>
                  </a:lnTo>
                  <a:lnTo>
                    <a:pt x="73263" y="1389148"/>
                  </a:lnTo>
                  <a:lnTo>
                    <a:pt x="149290" y="550506"/>
                  </a:lnTo>
                  <a:lnTo>
                    <a:pt x="0" y="550506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</a:schemeClr>
            </a:solidFill>
            <a:ln w="412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p>
              <a:pPr algn="ctr"/>
              <a:endParaRPr lang="zh-CN" altLang="en-US"/>
            </a:p>
          </p:txBody>
        </p:sp>
        <p:sp>
          <p:nvSpPr>
            <p:cNvPr id="56" name="任意多边形: 形状 58"/>
            <p:cNvSpPr/>
            <p:nvPr/>
          </p:nvSpPr>
          <p:spPr>
            <a:xfrm rot="16200000">
              <a:off x="10941" y="6268"/>
              <a:ext cx="414" cy="2225"/>
            </a:xfrm>
            <a:custGeom>
              <a:avLst/>
              <a:gdLst>
                <a:gd name="connsiteX0" fmla="*/ 233265 w 466530"/>
                <a:gd name="connsiteY0" fmla="*/ 0 h 1389148"/>
                <a:gd name="connsiteX1" fmla="*/ 466530 w 466530"/>
                <a:gd name="connsiteY1" fmla="*/ 550506 h 1389148"/>
                <a:gd name="connsiteX2" fmla="*/ 317241 w 466530"/>
                <a:gd name="connsiteY2" fmla="*/ 550506 h 1389148"/>
                <a:gd name="connsiteX3" fmla="*/ 393268 w 466530"/>
                <a:gd name="connsiteY3" fmla="*/ 1389148 h 1389148"/>
                <a:gd name="connsiteX4" fmla="*/ 233265 w 466530"/>
                <a:gd name="connsiteY4" fmla="*/ 1174978 h 1389148"/>
                <a:gd name="connsiteX5" fmla="*/ 73263 w 466530"/>
                <a:gd name="connsiteY5" fmla="*/ 1389148 h 1389148"/>
                <a:gd name="connsiteX6" fmla="*/ 149290 w 466530"/>
                <a:gd name="connsiteY6" fmla="*/ 550506 h 1389148"/>
                <a:gd name="connsiteX7" fmla="*/ 0 w 466530"/>
                <a:gd name="connsiteY7" fmla="*/ 550506 h 13891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66530" h="1389148">
                  <a:moveTo>
                    <a:pt x="233265" y="0"/>
                  </a:moveTo>
                  <a:lnTo>
                    <a:pt x="466530" y="550506"/>
                  </a:lnTo>
                  <a:lnTo>
                    <a:pt x="317241" y="550506"/>
                  </a:lnTo>
                  <a:lnTo>
                    <a:pt x="393268" y="1389148"/>
                  </a:lnTo>
                  <a:lnTo>
                    <a:pt x="233265" y="1174978"/>
                  </a:lnTo>
                  <a:lnTo>
                    <a:pt x="73263" y="1389148"/>
                  </a:lnTo>
                  <a:lnTo>
                    <a:pt x="149290" y="550506"/>
                  </a:lnTo>
                  <a:lnTo>
                    <a:pt x="0" y="550506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</a:schemeClr>
            </a:solidFill>
            <a:ln w="412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p>
              <a:pPr algn="ctr"/>
              <a:endParaRPr lang="zh-CN" altLang="en-US"/>
            </a:p>
          </p:txBody>
        </p:sp>
        <p:sp>
          <p:nvSpPr>
            <p:cNvPr id="58" name="任意多边形: 形状 58"/>
            <p:cNvSpPr/>
            <p:nvPr/>
          </p:nvSpPr>
          <p:spPr>
            <a:xfrm rot="16200000">
              <a:off x="6168" y="6728"/>
              <a:ext cx="401" cy="1333"/>
            </a:xfrm>
            <a:custGeom>
              <a:avLst/>
              <a:gdLst>
                <a:gd name="connsiteX0" fmla="*/ 233265 w 466530"/>
                <a:gd name="connsiteY0" fmla="*/ 0 h 1389148"/>
                <a:gd name="connsiteX1" fmla="*/ 466530 w 466530"/>
                <a:gd name="connsiteY1" fmla="*/ 550506 h 1389148"/>
                <a:gd name="connsiteX2" fmla="*/ 317241 w 466530"/>
                <a:gd name="connsiteY2" fmla="*/ 550506 h 1389148"/>
                <a:gd name="connsiteX3" fmla="*/ 393268 w 466530"/>
                <a:gd name="connsiteY3" fmla="*/ 1389148 h 1389148"/>
                <a:gd name="connsiteX4" fmla="*/ 233265 w 466530"/>
                <a:gd name="connsiteY4" fmla="*/ 1174978 h 1389148"/>
                <a:gd name="connsiteX5" fmla="*/ 73263 w 466530"/>
                <a:gd name="connsiteY5" fmla="*/ 1389148 h 1389148"/>
                <a:gd name="connsiteX6" fmla="*/ 149290 w 466530"/>
                <a:gd name="connsiteY6" fmla="*/ 550506 h 1389148"/>
                <a:gd name="connsiteX7" fmla="*/ 0 w 466530"/>
                <a:gd name="connsiteY7" fmla="*/ 550506 h 13891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66530" h="1389148">
                  <a:moveTo>
                    <a:pt x="233265" y="0"/>
                  </a:moveTo>
                  <a:lnTo>
                    <a:pt x="466530" y="550506"/>
                  </a:lnTo>
                  <a:lnTo>
                    <a:pt x="317241" y="550506"/>
                  </a:lnTo>
                  <a:lnTo>
                    <a:pt x="393268" y="1389148"/>
                  </a:lnTo>
                  <a:lnTo>
                    <a:pt x="233265" y="1174978"/>
                  </a:lnTo>
                  <a:lnTo>
                    <a:pt x="73263" y="1389148"/>
                  </a:lnTo>
                  <a:lnTo>
                    <a:pt x="149290" y="550506"/>
                  </a:lnTo>
                  <a:lnTo>
                    <a:pt x="0" y="550506"/>
                  </a:lnTo>
                  <a:close/>
                </a:path>
              </a:pathLst>
            </a:custGeom>
            <a:solidFill>
              <a:schemeClr val="accent1">
                <a:lumMod val="60000"/>
                <a:lumOff val="40000"/>
              </a:schemeClr>
            </a:solidFill>
            <a:ln w="412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9</Words>
  <Application>WPS 演示</Application>
  <PresentationFormat>宽屏</PresentationFormat>
  <Paragraphs>5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Arial</vt:lpstr>
      <vt:lpstr>宋体</vt:lpstr>
      <vt:lpstr>Wingdings</vt:lpstr>
      <vt:lpstr>Calibri</vt:lpstr>
      <vt:lpstr>微软雅黑</vt:lpstr>
      <vt:lpstr>Arial Unicode MS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段十三</dc:creator>
  <cp:lastModifiedBy>Administrator</cp:lastModifiedBy>
  <cp:revision>116</cp:revision>
  <dcterms:created xsi:type="dcterms:W3CDTF">2019-11-21T12:38:00Z</dcterms:created>
  <dcterms:modified xsi:type="dcterms:W3CDTF">2021-04-01T02:22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56</vt:lpwstr>
  </property>
  <property fmtid="{D5CDD505-2E9C-101B-9397-08002B2CF9AE}" pid="3" name="ICV">
    <vt:lpwstr>18F6F6E5B1594BC09A8993A53E4CAA1E</vt:lpwstr>
  </property>
</Properties>
</file>